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charts/chart18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charts/chart19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ppt/charts/chart20.xml" ContentType="application/vnd.openxmlformats-officedocument.drawingml.chart+xml"/>
  <Override PartName="/ppt/charts/style20.xml" ContentType="application/vnd.ms-office.chartstyle+xml"/>
  <Override PartName="/ppt/charts/colors20.xml" ContentType="application/vnd.ms-office.chartcolorstyle+xml"/>
  <Override PartName="/ppt/charts/chart21.xml" ContentType="application/vnd.openxmlformats-officedocument.drawingml.chart+xml"/>
  <Override PartName="/ppt/charts/style21.xml" ContentType="application/vnd.ms-office.chartstyle+xml"/>
  <Override PartName="/ppt/charts/colors21.xml" ContentType="application/vnd.ms-office.chartcolorstyle+xml"/>
  <Override PartName="/ppt/charts/chart22.xml" ContentType="application/vnd.openxmlformats-officedocument.drawingml.chart+xml"/>
  <Override PartName="/ppt/charts/style22.xml" ContentType="application/vnd.ms-office.chartstyle+xml"/>
  <Override PartName="/ppt/charts/colors22.xml" ContentType="application/vnd.ms-office.chartcolorstyle+xml"/>
  <Override PartName="/ppt/charts/chart23.xml" ContentType="application/vnd.openxmlformats-officedocument.drawingml.chart+xml"/>
  <Override PartName="/ppt/charts/style23.xml" ContentType="application/vnd.ms-office.chartstyle+xml"/>
  <Override PartName="/ppt/charts/colors23.xml" ContentType="application/vnd.ms-office.chartcolorstyle+xml"/>
  <Override PartName="/ppt/charts/chart24.xml" ContentType="application/vnd.openxmlformats-officedocument.drawingml.chart+xml"/>
  <Override PartName="/ppt/charts/style24.xml" ContentType="application/vnd.ms-office.chartstyle+xml"/>
  <Override PartName="/ppt/charts/colors24.xml" ContentType="application/vnd.ms-office.chartcolorstyle+xml"/>
  <Override PartName="/ppt/charts/chart25.xml" ContentType="application/vnd.openxmlformats-officedocument.drawingml.chart+xml"/>
  <Override PartName="/ppt/charts/style25.xml" ContentType="application/vnd.ms-office.chartstyle+xml"/>
  <Override PartName="/ppt/charts/colors25.xml" ContentType="application/vnd.ms-office.chartcolorstyle+xml"/>
  <Override PartName="/ppt/charts/chart26.xml" ContentType="application/vnd.openxmlformats-officedocument.drawingml.chart+xml"/>
  <Override PartName="/ppt/charts/style26.xml" ContentType="application/vnd.ms-office.chartstyle+xml"/>
  <Override PartName="/ppt/charts/colors2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0" d="100"/>
          <a:sy n="80" d="100"/>
        </p:scale>
        <p:origin x="58" y="2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DCTA\Manuscripts\LMAP_S\Submission%20to%20BMC%20Bioinformatics\LMAP_S_Revision\LMAP_S%20Revision%20submission\LMA_S_Revision2_Rebuttal\Additional%20file%206\CephaResultsHISTG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DCTA\Manuscripts\LMAP_S\Submission%20to%20BMC%20Bioinformatics\LMAP_S_Revision\LMAP_S%20Revision%20submission\LMA_S_Revision2_Rebuttal\Additional%20file%206\CephaResultsARC_HISTG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DCTA\Manuscripts\LMAP_S\Submission%20to%20BMC%20Bioinformatics\LMAP_S_Revision\LMAP_S%20Revision%20submission\LMA_S_Revision2_Rebuttal\Additional%20file%206\CephaResultsARC_HISTG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DCTA\Manuscripts\LMAP_S\Submission%20to%20BMC%20Bioinformatics\LMAP_S_Revision\LMAP_S%20Revision%20submission\LMA_S_Revision2_Rebuttal\Additional%20file%206\CephaResultsHISTG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DCTA\Manuscripts\LMAP_S\Submission%20to%20BMC%20Bioinformatics\LMAP_S_Revision\LMAP_S%20Revision%20submission\LMA_S_Revision2_Rebuttal\Additional%20file%206\CephaResultsHISTG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DCTA\Manuscripts\LMAP_S\Submission%20to%20BMC%20Bioinformatics\LMAP_S_Revision\LMAP_S%20Revision%20submission\LMA_S_Revision2_Rebuttal\Additional%20file%206\CephaResultsARC_HISTG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DCTA\Manuscripts\LMAP_S\Submission%20to%20BMC%20Bioinformatics\LMAP_S_Revision\LMAP_S%20Revision%20submission\LMA_S_Revision2_Rebuttal\Additional%20file%206\CephaResultsARC_HISTG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DCTA\Manuscripts\LMAP_S\Submission%20to%20BMC%20Bioinformatics\LMAP_S_Revision\LMAP_S%20Revision%20submission\LMA_S_Revision2_Rebuttal\Additional%20file%206\CephaResultsHISTG.xlsx" TargetMode="External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DCTA\Manuscripts\LMAP_S\Submission%20to%20BMC%20Bioinformatics\LMAP_S_Revision\LMAP_S%20Revision%20submission\LMA_S_Revision2_Rebuttal\Additional%20file%206\CephaResultsHISTG.xlsx" TargetMode="External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DCTA\Manuscripts\LMAP_S\Submission%20to%20BMC%20Bioinformatics\LMAP_S_Revision\LMAP_S%20Revision%20submission\LMA_S_Revision2_Rebuttal\Additional%20file%206\CephaResultsARC_HISTG.xlsx" TargetMode="External"/><Relationship Id="rId2" Type="http://schemas.microsoft.com/office/2011/relationships/chartColorStyle" Target="colors18.xml"/><Relationship Id="rId1" Type="http://schemas.microsoft.com/office/2011/relationships/chartStyle" Target="style18.xm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DCTA\Manuscripts\LMAP_S\Submission%20to%20BMC%20Bioinformatics\LMAP_S_Revision\LMAP_S%20Revision%20submission\LMA_S_Revision2_Rebuttal\Additional%20file%206\CephaResultsARC_HISTG.xlsx" TargetMode="External"/><Relationship Id="rId2" Type="http://schemas.microsoft.com/office/2011/relationships/chartColorStyle" Target="colors19.xml"/><Relationship Id="rId1" Type="http://schemas.microsoft.com/office/2011/relationships/chartStyle" Target="style19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DCTA\Manuscripts\LMAP_S\Submission%20to%20BMC%20Bioinformatics\LMAP_S_Revision\LMAP_S%20Revision%20submission\LMA_S_Revision2_Rebuttal\Additional%20file%206\CephaResultsARC_HISTG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20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DCTA\Manuscripts\LMAP_S\Submission%20to%20BMC%20Bioinformatics\LMAP_S_Revision\LMAP_S%20Revision%20submission\LMA_S_Revision2_Rebuttal\Additional%20file%206\CephaResultsHISTG.xlsx" TargetMode="External"/><Relationship Id="rId2" Type="http://schemas.microsoft.com/office/2011/relationships/chartColorStyle" Target="colors20.xml"/><Relationship Id="rId1" Type="http://schemas.microsoft.com/office/2011/relationships/chartStyle" Target="style20.xml"/></Relationships>
</file>

<file path=ppt/charts/_rels/chart2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DCTA\Manuscripts\LMAP_S\Submission%20to%20BMC%20Bioinformatics\LMAP_S_Revision\LMAP_S%20Revision%20submission\LMA_S_Revision2_Rebuttal\Additional%20file%206\CephaResultsHISTG.xlsx" TargetMode="External"/><Relationship Id="rId2" Type="http://schemas.microsoft.com/office/2011/relationships/chartColorStyle" Target="colors21.xml"/><Relationship Id="rId1" Type="http://schemas.microsoft.com/office/2011/relationships/chartStyle" Target="style21.xml"/></Relationships>
</file>

<file path=ppt/charts/_rels/chart2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DCTA\Manuscripts\LMAP_S\Submission%20to%20BMC%20Bioinformatics\LMAP_S_Revision\LMAP_S%20Revision%20submission\LMA_S_Revision2_Rebuttal\Additional%20file%206\CephaResultsARC_HISTG.xlsx" TargetMode="External"/><Relationship Id="rId2" Type="http://schemas.microsoft.com/office/2011/relationships/chartColorStyle" Target="colors22.xml"/><Relationship Id="rId1" Type="http://schemas.microsoft.com/office/2011/relationships/chartStyle" Target="style22.xml"/></Relationships>
</file>

<file path=ppt/charts/_rels/chart23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DCTA\Manuscripts\LMAP_S\Submission%20to%20BMC%20Bioinformatics\LMAP_S_Revision\LMAP_S%20Revision%20submission\LMA_S_Revision2_Rebuttal\Additional%20file%206\CephaResultsARC_HISTG.xlsx" TargetMode="External"/><Relationship Id="rId2" Type="http://schemas.microsoft.com/office/2011/relationships/chartColorStyle" Target="colors23.xml"/><Relationship Id="rId1" Type="http://schemas.microsoft.com/office/2011/relationships/chartStyle" Target="style23.xml"/></Relationships>
</file>

<file path=ppt/charts/_rels/chart24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DCTA\Manuscripts\LMAP_S\Submission%20to%20BMC%20Bioinformatics\LMAP_S_Revision\LMAP_S%20Revision%20submission\LMA_S_Revision2_Rebuttal\Additional%20file%206\CephaResultsHISTG.xlsx" TargetMode="External"/><Relationship Id="rId2" Type="http://schemas.microsoft.com/office/2011/relationships/chartColorStyle" Target="colors24.xml"/><Relationship Id="rId1" Type="http://schemas.microsoft.com/office/2011/relationships/chartStyle" Target="style24.xml"/></Relationships>
</file>

<file path=ppt/charts/_rels/chart25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DCTA\Manuscripts\LMAP_S\Submission%20to%20BMC%20Bioinformatics\LMAP_S_Revision\LMAP_S%20Revision%20submission\LMA_S_Revision2_Rebuttal\Additional%20file%206\CephaResultsHISTG.xlsx" TargetMode="External"/><Relationship Id="rId2" Type="http://schemas.microsoft.com/office/2011/relationships/chartColorStyle" Target="colors25.xml"/><Relationship Id="rId1" Type="http://schemas.microsoft.com/office/2011/relationships/chartStyle" Target="style25.xml"/></Relationships>
</file>

<file path=ppt/charts/_rels/chart26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DCTA\Manuscripts\LMAP_S\Submission%20to%20BMC%20Bioinformatics\LMAP_S_Revision\LMAP_S%20Revision%20submission\LMA_S_Revision2_Rebuttal\Additional%20file%206\CephaResultsARC_HISTG.xlsx" TargetMode="External"/><Relationship Id="rId2" Type="http://schemas.microsoft.com/office/2011/relationships/chartColorStyle" Target="colors26.xml"/><Relationship Id="rId1" Type="http://schemas.microsoft.com/office/2011/relationships/chartStyle" Target="style26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DCTA\Manuscripts\LMAP_S\Submission%20to%20BMC%20Bioinformatics\LMAP_S_Revision\LMAP_S%20Revision%20submission\LMA_S_Revision2_Rebuttal\Additional%20file%206\CephaResultsARC_HISTG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DCTA\Manuscripts\LMAP_S\Submission%20to%20BMC%20Bioinformatics\LMAP_S_Revision\LMAP_S%20Revision%20submission\LMA_S_Revision2_Rebuttal\Additional%20file%206\CephaResultsHISTG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DCTA\Manuscripts\LMAP_S\Submission%20to%20BMC%20Bioinformatics\LMAP_S_Revision\LMAP_S%20Revision%20submission\LMA_S_Revision2_Rebuttal\Additional%20file%206\CephaResultsHISTG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DCTA\Manuscripts\LMAP_S\Submission%20to%20BMC%20Bioinformatics\LMAP_S_Revision\LMAP_S%20Revision%20submission\LMA_S_Revision2_Rebuttal\Additional%20file%206\CephaResultsARC_HISTG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DCTA\Manuscripts\LMAP_S\Submission%20to%20BMC%20Bioinformatics\LMAP_S_Revision\LMAP_S%20Revision%20submission\LMA_S_Revision2_Rebuttal\Additional%20file%206\CephaResultsARC_HISTG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DCTA\Manuscripts\LMAP_S\Submission%20to%20BMC%20Bioinformatics\LMAP_S_Revision\LMAP_S%20Revision%20submission\LMA_S_Revision2_Rebuttal\Additional%20file%206\CephaResultsHISTG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DCTA\Manuscripts\LMAP_S\Submission%20to%20BMC%20Bioinformatics\LMAP_S_Revision\LMAP_S%20Revision%20submission\LMA_S_Revision2_Rebuttal\Additional%20file%206\CephaResultsHISTG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930118110236223"/>
          <c:y val="4.4979150930706591E-2"/>
          <c:w val="0.73181430446194229"/>
          <c:h val="0.92318230260639234"/>
        </c:manualLayout>
      </c:layout>
      <c:pieChart>
        <c:varyColors val="1"/>
        <c:ser>
          <c:idx val="0"/>
          <c:order val="0"/>
          <c:tx>
            <c:strRef>
              <c:f>ATP6_CONSENSUS_PHYLOGENY_HISTG_!$B$1</c:f>
              <c:strCache>
                <c:ptCount val="1"/>
                <c:pt idx="0">
                  <c:v>Total Topological Support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0330-4686-8724-7F63C4AEC923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0330-4686-8724-7F63C4AEC923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0330-4686-8724-7F63C4AEC923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0330-4686-8724-7F63C4AEC923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0330-4686-8724-7F63C4AEC923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pPr>
                <a:endParaRPr lang="en-US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ATP6_CONSENSUS_PHYLOGENY_HISTG_!$A$2:$A$6</c:f>
              <c:strCache>
                <c:ptCount val="5"/>
                <c:pt idx="0">
                  <c:v> ***  # ATP6_FSANP_2AA_UB #  *** </c:v>
                </c:pt>
                <c:pt idx="1">
                  <c:v> ***  # ATP6_MAFFTGI_CDN_UB #  *** </c:v>
                </c:pt>
                <c:pt idx="2">
                  <c:v> ***  # ATP6_FSANP_DEG_UB #  *** </c:v>
                </c:pt>
                <c:pt idx="3">
                  <c:v> ***  # ATP6_FSANP_RYt_UB #  *** </c:v>
                </c:pt>
                <c:pt idx="4">
                  <c:v> ***  # ATP6_GRAMALIGN_DNA_UB #  *** </c:v>
                </c:pt>
              </c:strCache>
            </c:strRef>
          </c:cat>
          <c:val>
            <c:numRef>
              <c:f>ATP6_CONSENSUS_PHYLOGENY_HISTG_!$B$2:$B$6</c:f>
              <c:numCache>
                <c:formatCode>General</c:formatCode>
                <c:ptCount val="5"/>
                <c:pt idx="0">
                  <c:v>10</c:v>
                </c:pt>
                <c:pt idx="1">
                  <c:v>10</c:v>
                </c:pt>
                <c:pt idx="2">
                  <c:v>6</c:v>
                </c:pt>
                <c:pt idx="3">
                  <c:v>4</c:v>
                </c:pt>
                <c:pt idx="4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0330-4686-8724-7F63C4AEC923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62270031078204779"/>
          <c:y val="9.6469891694572658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bg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3178725793604157"/>
          <c:y val="4.7388338311159378E-2"/>
          <c:w val="0.80725000326451735"/>
          <c:h val="0.93251293480556308"/>
        </c:manualLayout>
      </c:layout>
      <c:pieChart>
        <c:varyColors val="1"/>
        <c:ser>
          <c:idx val="0"/>
          <c:order val="0"/>
          <c:tx>
            <c:strRef>
              <c:f>COX3_CONSENSUS_PHYLOGENY_HISTG_!$B$1</c:f>
              <c:strCache>
                <c:ptCount val="1"/>
                <c:pt idx="0">
                  <c:v>Total Topological Support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CD5-4478-A092-77CD677143F2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9CD5-4478-A092-77CD677143F2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9CD5-4478-A092-77CD677143F2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9CD5-4478-A092-77CD677143F2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9CD5-4478-A092-77CD677143F2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9CD5-4478-A092-77CD677143F2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9CD5-4478-A092-77CD677143F2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9CD5-4478-A092-77CD677143F2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9CD5-4478-A092-77CD677143F2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9CD5-4478-A092-77CD677143F2}"/>
              </c:ext>
            </c:extLst>
          </c:dPt>
          <c:dPt>
            <c:idx val="10"/>
            <c:bubble3D val="0"/>
            <c:spPr>
              <a:solidFill>
                <a:schemeClr val="accent5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9CD5-4478-A092-77CD677143F2}"/>
              </c:ext>
            </c:extLst>
          </c:dPt>
          <c:dPt>
            <c:idx val="11"/>
            <c:bubble3D val="0"/>
            <c:spPr>
              <a:solidFill>
                <a:schemeClr val="accent6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9CD5-4478-A092-77CD677143F2}"/>
              </c:ext>
            </c:extLst>
          </c:dPt>
          <c:dPt>
            <c:idx val="12"/>
            <c:bubble3D val="0"/>
            <c:spPr>
              <a:solidFill>
                <a:schemeClr val="accent1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9CD5-4478-A092-77CD677143F2}"/>
              </c:ext>
            </c:extLst>
          </c:dPt>
          <c:dPt>
            <c:idx val="13"/>
            <c:bubble3D val="0"/>
            <c:spPr>
              <a:solidFill>
                <a:schemeClr val="accent2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9CD5-4478-A092-77CD677143F2}"/>
              </c:ext>
            </c:extLst>
          </c:dPt>
          <c:dPt>
            <c:idx val="14"/>
            <c:bubble3D val="0"/>
            <c:spPr>
              <a:solidFill>
                <a:schemeClr val="accent3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9CD5-4478-A092-77CD677143F2}"/>
              </c:ext>
            </c:extLst>
          </c:dPt>
          <c:dPt>
            <c:idx val="15"/>
            <c:bubble3D val="0"/>
            <c:spPr>
              <a:solidFill>
                <a:schemeClr val="accent4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F-9CD5-4478-A092-77CD677143F2}"/>
              </c:ext>
            </c:extLst>
          </c:dPt>
          <c:dPt>
            <c:idx val="16"/>
            <c:bubble3D val="0"/>
            <c:spPr>
              <a:solidFill>
                <a:schemeClr val="accent5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1-9CD5-4478-A092-77CD677143F2}"/>
              </c:ext>
            </c:extLst>
          </c:dPt>
          <c:dPt>
            <c:idx val="17"/>
            <c:bubble3D val="0"/>
            <c:spPr>
              <a:solidFill>
                <a:schemeClr val="accent6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3-9CD5-4478-A092-77CD677143F2}"/>
              </c:ext>
            </c:extLst>
          </c:dPt>
          <c:dPt>
            <c:idx val="18"/>
            <c:bubble3D val="0"/>
            <c:spPr>
              <a:solidFill>
                <a:schemeClr val="accent1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5-9CD5-4478-A092-77CD677143F2}"/>
              </c:ext>
            </c:extLst>
          </c:dPt>
          <c:dPt>
            <c:idx val="19"/>
            <c:bubble3D val="0"/>
            <c:spPr>
              <a:solidFill>
                <a:schemeClr val="accent2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7-9CD5-4478-A092-77CD677143F2}"/>
              </c:ext>
            </c:extLst>
          </c:dPt>
          <c:dPt>
            <c:idx val="20"/>
            <c:bubble3D val="0"/>
            <c:spPr>
              <a:solidFill>
                <a:schemeClr val="accent3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9-9CD5-4478-A092-77CD677143F2}"/>
              </c:ext>
            </c:extLst>
          </c:dPt>
          <c:dPt>
            <c:idx val="21"/>
            <c:bubble3D val="0"/>
            <c:spPr>
              <a:solidFill>
                <a:schemeClr val="accent4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B-9CD5-4478-A092-77CD677143F2}"/>
              </c:ext>
            </c:extLst>
          </c:dPt>
          <c:dPt>
            <c:idx val="22"/>
            <c:bubble3D val="0"/>
            <c:spPr>
              <a:solidFill>
                <a:schemeClr val="accent5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D-9CD5-4478-A092-77CD677143F2}"/>
              </c:ext>
            </c:extLst>
          </c:dPt>
          <c:dPt>
            <c:idx val="23"/>
            <c:bubble3D val="0"/>
            <c:spPr>
              <a:solidFill>
                <a:schemeClr val="accent6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F-9CD5-4478-A092-77CD677143F2}"/>
              </c:ext>
            </c:extLst>
          </c:dPt>
          <c:dPt>
            <c:idx val="24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1-9CD5-4478-A092-77CD677143F2}"/>
              </c:ext>
            </c:extLst>
          </c:dPt>
          <c:dPt>
            <c:idx val="25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3-9CD5-4478-A092-77CD677143F2}"/>
              </c:ext>
            </c:extLst>
          </c:dPt>
          <c:dPt>
            <c:idx val="26"/>
            <c:bubble3D val="0"/>
            <c:spPr>
              <a:solidFill>
                <a:schemeClr val="accent3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5-9CD5-4478-A092-77CD677143F2}"/>
              </c:ext>
            </c:extLst>
          </c:dPt>
          <c:dPt>
            <c:idx val="27"/>
            <c:bubble3D val="0"/>
            <c:spPr>
              <a:solidFill>
                <a:schemeClr val="accent4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7-9CD5-4478-A092-77CD677143F2}"/>
              </c:ext>
            </c:extLst>
          </c:dPt>
          <c:dPt>
            <c:idx val="28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9-9CD5-4478-A092-77CD677143F2}"/>
              </c:ext>
            </c:extLst>
          </c:dPt>
          <c:dPt>
            <c:idx val="29"/>
            <c:bubble3D val="0"/>
            <c:spPr>
              <a:solidFill>
                <a:schemeClr val="accent6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B-9CD5-4478-A092-77CD677143F2}"/>
              </c:ext>
            </c:extLst>
          </c:dPt>
          <c:dPt>
            <c:idx val="30"/>
            <c:bubble3D val="0"/>
            <c:spPr>
              <a:solidFill>
                <a:schemeClr val="accent1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D-9CD5-4478-A092-77CD677143F2}"/>
              </c:ext>
            </c:extLst>
          </c:dPt>
          <c:dPt>
            <c:idx val="31"/>
            <c:bubble3D val="0"/>
            <c:spPr>
              <a:solidFill>
                <a:schemeClr val="accent2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F-9CD5-4478-A092-77CD677143F2}"/>
              </c:ext>
            </c:extLst>
          </c:dPt>
          <c:dPt>
            <c:idx val="32"/>
            <c:bubble3D val="0"/>
            <c:spPr>
              <a:solidFill>
                <a:schemeClr val="accent3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1-9CD5-4478-A092-77CD677143F2}"/>
              </c:ext>
            </c:extLst>
          </c:dPt>
          <c:dPt>
            <c:idx val="33"/>
            <c:bubble3D val="0"/>
            <c:spPr>
              <a:solidFill>
                <a:schemeClr val="accent4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3-9CD5-4478-A092-77CD677143F2}"/>
              </c:ext>
            </c:extLst>
          </c:dPt>
          <c:dPt>
            <c:idx val="34"/>
            <c:bubble3D val="0"/>
            <c:spPr>
              <a:solidFill>
                <a:schemeClr val="accent5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5-9CD5-4478-A092-77CD677143F2}"/>
              </c:ext>
            </c:extLst>
          </c:dPt>
          <c:dPt>
            <c:idx val="35"/>
            <c:bubble3D val="0"/>
            <c:spPr>
              <a:solidFill>
                <a:schemeClr val="accent6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7-9CD5-4478-A092-77CD677143F2}"/>
              </c:ext>
            </c:extLst>
          </c:dPt>
          <c:dPt>
            <c:idx val="36"/>
            <c:bubble3D val="0"/>
            <c:spPr>
              <a:solidFill>
                <a:schemeClr val="accent1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9-9CD5-4478-A092-77CD677143F2}"/>
              </c:ext>
            </c:extLst>
          </c:dPt>
          <c:dPt>
            <c:idx val="37"/>
            <c:bubble3D val="0"/>
            <c:spPr>
              <a:solidFill>
                <a:schemeClr val="accent2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B-9CD5-4478-A092-77CD677143F2}"/>
              </c:ext>
            </c:extLst>
          </c:dPt>
          <c:dPt>
            <c:idx val="38"/>
            <c:bubble3D val="0"/>
            <c:spPr>
              <a:solidFill>
                <a:schemeClr val="accent3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D-9CD5-4478-A092-77CD677143F2}"/>
              </c:ext>
            </c:extLst>
          </c:dPt>
          <c:dPt>
            <c:idx val="39"/>
            <c:bubble3D val="0"/>
            <c:spPr>
              <a:solidFill>
                <a:schemeClr val="accent4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F-9CD5-4478-A092-77CD677143F2}"/>
              </c:ext>
            </c:extLst>
          </c:dPt>
          <c:dPt>
            <c:idx val="40"/>
            <c:bubble3D val="0"/>
            <c:spPr>
              <a:solidFill>
                <a:schemeClr val="accent5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1-9CD5-4478-A092-77CD677143F2}"/>
              </c:ext>
            </c:extLst>
          </c:dPt>
          <c:dPt>
            <c:idx val="41"/>
            <c:bubble3D val="0"/>
            <c:spPr>
              <a:solidFill>
                <a:schemeClr val="accent6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3-9CD5-4478-A092-77CD677143F2}"/>
              </c:ext>
            </c:extLst>
          </c:dPt>
          <c:dPt>
            <c:idx val="42"/>
            <c:bubble3D val="0"/>
            <c:spPr>
              <a:solidFill>
                <a:schemeClr val="accent1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5-9CD5-4478-A092-77CD677143F2}"/>
              </c:ext>
            </c:extLst>
          </c:dPt>
          <c:dPt>
            <c:idx val="43"/>
            <c:bubble3D val="0"/>
            <c:spPr>
              <a:solidFill>
                <a:schemeClr val="accent2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7-9CD5-4478-A092-77CD677143F2}"/>
              </c:ext>
            </c:extLst>
          </c:dPt>
          <c:dPt>
            <c:idx val="44"/>
            <c:bubble3D val="0"/>
            <c:spPr>
              <a:solidFill>
                <a:schemeClr val="accent3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9-9CD5-4478-A092-77CD677143F2}"/>
              </c:ext>
            </c:extLst>
          </c:dPt>
          <c:dPt>
            <c:idx val="45"/>
            <c:bubble3D val="0"/>
            <c:spPr>
              <a:solidFill>
                <a:schemeClr val="accent4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B-9CD5-4478-A092-77CD677143F2}"/>
              </c:ext>
            </c:extLst>
          </c:dPt>
          <c:dPt>
            <c:idx val="46"/>
            <c:bubble3D val="0"/>
            <c:spPr>
              <a:solidFill>
                <a:schemeClr val="accent5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D-9CD5-4478-A092-77CD677143F2}"/>
              </c:ext>
            </c:extLst>
          </c:dPt>
          <c:dPt>
            <c:idx val="47"/>
            <c:bubble3D val="0"/>
            <c:spPr>
              <a:solidFill>
                <a:schemeClr val="accent6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F-9CD5-4478-A092-77CD677143F2}"/>
              </c:ext>
            </c:extLst>
          </c:dPt>
          <c:dPt>
            <c:idx val="48"/>
            <c:bubble3D val="0"/>
            <c:spPr>
              <a:solidFill>
                <a:schemeClr val="accent1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1-9CD5-4478-A092-77CD677143F2}"/>
              </c:ext>
            </c:extLst>
          </c:dPt>
          <c:dPt>
            <c:idx val="49"/>
            <c:bubble3D val="0"/>
            <c:spPr>
              <a:solidFill>
                <a:schemeClr val="accent2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3-9CD5-4478-A092-77CD677143F2}"/>
              </c:ext>
            </c:extLst>
          </c:dPt>
          <c:dPt>
            <c:idx val="50"/>
            <c:bubble3D val="0"/>
            <c:spPr>
              <a:solidFill>
                <a:schemeClr val="accent3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5-9CD5-4478-A092-77CD677143F2}"/>
              </c:ext>
            </c:extLst>
          </c:dPt>
          <c:dPt>
            <c:idx val="51"/>
            <c:bubble3D val="0"/>
            <c:spPr>
              <a:solidFill>
                <a:schemeClr val="accent4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7-9CD5-4478-A092-77CD677143F2}"/>
              </c:ext>
            </c:extLst>
          </c:dPt>
          <c:dPt>
            <c:idx val="52"/>
            <c:bubble3D val="0"/>
            <c:spPr>
              <a:solidFill>
                <a:schemeClr val="accent5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9-9CD5-4478-A092-77CD677143F2}"/>
              </c:ext>
            </c:extLst>
          </c:dPt>
          <c:dPt>
            <c:idx val="53"/>
            <c:bubble3D val="0"/>
            <c:spPr>
              <a:solidFill>
                <a:schemeClr val="accent6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B-9CD5-4478-A092-77CD677143F2}"/>
              </c:ext>
            </c:extLst>
          </c:dPt>
          <c:dPt>
            <c:idx val="54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D-9CD5-4478-A092-77CD677143F2}"/>
              </c:ext>
            </c:extLst>
          </c:dPt>
          <c:dPt>
            <c:idx val="55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F-9CD5-4478-A092-77CD677143F2}"/>
              </c:ext>
            </c:extLst>
          </c:dPt>
          <c:dPt>
            <c:idx val="56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1-9CD5-4478-A092-77CD677143F2}"/>
              </c:ext>
            </c:extLst>
          </c:dPt>
          <c:dPt>
            <c:idx val="57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3-9CD5-4478-A092-77CD677143F2}"/>
              </c:ext>
            </c:extLst>
          </c:dPt>
          <c:dPt>
            <c:idx val="58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5-9CD5-4478-A092-77CD677143F2}"/>
              </c:ext>
            </c:extLst>
          </c:dPt>
          <c:dPt>
            <c:idx val="59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7-9CD5-4478-A092-77CD677143F2}"/>
              </c:ext>
            </c:extLst>
          </c:dPt>
          <c:dPt>
            <c:idx val="60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9-9CD5-4478-A092-77CD677143F2}"/>
              </c:ext>
            </c:extLst>
          </c:dPt>
          <c:dPt>
            <c:idx val="61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B-9CD5-4478-A092-77CD677143F2}"/>
              </c:ext>
            </c:extLst>
          </c:dPt>
          <c:dPt>
            <c:idx val="62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D-9CD5-4478-A092-77CD677143F2}"/>
              </c:ext>
            </c:extLst>
          </c:dPt>
          <c:dPt>
            <c:idx val="63"/>
            <c:bubble3D val="0"/>
            <c:spPr>
              <a:solidFill>
                <a:schemeClr val="accent4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F-9CD5-4478-A092-77CD677143F2}"/>
              </c:ext>
            </c:extLst>
          </c:dPt>
          <c:dPt>
            <c:idx val="64"/>
            <c:bubble3D val="0"/>
            <c:spPr>
              <a:solidFill>
                <a:schemeClr val="accent5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1-9CD5-4478-A092-77CD677143F2}"/>
              </c:ext>
            </c:extLst>
          </c:dPt>
          <c:dPt>
            <c:idx val="65"/>
            <c:bubble3D val="0"/>
            <c:spPr>
              <a:solidFill>
                <a:schemeClr val="accent6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3-9CD5-4478-A092-77CD677143F2}"/>
              </c:ext>
            </c:extLst>
          </c:dPt>
          <c:dPt>
            <c:idx val="66"/>
            <c:bubble3D val="0"/>
            <c:spPr>
              <a:solidFill>
                <a:schemeClr val="accent1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5-9CD5-4478-A092-77CD677143F2}"/>
              </c:ext>
            </c:extLst>
          </c:dPt>
          <c:dPt>
            <c:idx val="67"/>
            <c:bubble3D val="0"/>
            <c:spPr>
              <a:solidFill>
                <a:schemeClr val="accent2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7-9CD5-4478-A092-77CD677143F2}"/>
              </c:ext>
            </c:extLst>
          </c:dPt>
          <c:dPt>
            <c:idx val="68"/>
            <c:bubble3D val="0"/>
            <c:spPr>
              <a:solidFill>
                <a:schemeClr val="accent3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9-9CD5-4478-A092-77CD677143F2}"/>
              </c:ext>
            </c:extLst>
          </c:dPt>
          <c:dPt>
            <c:idx val="69"/>
            <c:bubble3D val="0"/>
            <c:spPr>
              <a:solidFill>
                <a:schemeClr val="accent4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B-9CD5-4478-A092-77CD677143F2}"/>
              </c:ext>
            </c:extLst>
          </c:dPt>
          <c:dPt>
            <c:idx val="70"/>
            <c:bubble3D val="0"/>
            <c:spPr>
              <a:solidFill>
                <a:schemeClr val="accent5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D-9CD5-4478-A092-77CD677143F2}"/>
              </c:ext>
            </c:extLst>
          </c:dPt>
          <c:dPt>
            <c:idx val="71"/>
            <c:bubble3D val="0"/>
            <c:spPr>
              <a:solidFill>
                <a:schemeClr val="accent6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F-9CD5-4478-A092-77CD677143F2}"/>
              </c:ext>
            </c:extLst>
          </c:dPt>
          <c:dPt>
            <c:idx val="72"/>
            <c:bubble3D val="0"/>
            <c:spPr>
              <a:solidFill>
                <a:schemeClr val="accent1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91-9CD5-4478-A092-77CD677143F2}"/>
              </c:ext>
            </c:extLst>
          </c:dPt>
          <c:dPt>
            <c:idx val="73"/>
            <c:bubble3D val="0"/>
            <c:spPr>
              <a:solidFill>
                <a:schemeClr val="accent2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93-9CD5-4478-A092-77CD677143F2}"/>
              </c:ext>
            </c:extLst>
          </c:dPt>
          <c:dPt>
            <c:idx val="74"/>
            <c:bubble3D val="0"/>
            <c:spPr>
              <a:solidFill>
                <a:schemeClr val="accent3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95-9CD5-4478-A092-77CD677143F2}"/>
              </c:ext>
            </c:extLst>
          </c:dPt>
          <c:dPt>
            <c:idx val="75"/>
            <c:bubble3D val="0"/>
            <c:spPr>
              <a:solidFill>
                <a:schemeClr val="accent4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97-9CD5-4478-A092-77CD677143F2}"/>
              </c:ext>
            </c:extLst>
          </c:dPt>
          <c:dPt>
            <c:idx val="76"/>
            <c:bubble3D val="0"/>
            <c:spPr>
              <a:solidFill>
                <a:schemeClr val="accent5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99-9CD5-4478-A092-77CD677143F2}"/>
              </c:ext>
            </c:extLst>
          </c:dPt>
          <c:dPt>
            <c:idx val="77"/>
            <c:bubble3D val="0"/>
            <c:spPr>
              <a:solidFill>
                <a:schemeClr val="accent6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9B-9CD5-4478-A092-77CD677143F2}"/>
              </c:ext>
            </c:extLst>
          </c:dPt>
          <c:dPt>
            <c:idx val="78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9D-9CD5-4478-A092-77CD677143F2}"/>
              </c:ext>
            </c:extLst>
          </c:dPt>
          <c:dPt>
            <c:idx val="79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9F-9CD5-4478-A092-77CD677143F2}"/>
              </c:ext>
            </c:extLst>
          </c:dPt>
          <c:dPt>
            <c:idx val="80"/>
            <c:bubble3D val="0"/>
            <c:spPr>
              <a:solidFill>
                <a:schemeClr val="accent3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A1-9CD5-4478-A092-77CD677143F2}"/>
              </c:ext>
            </c:extLst>
          </c:dPt>
          <c:dPt>
            <c:idx val="81"/>
            <c:bubble3D val="0"/>
            <c:spPr>
              <a:solidFill>
                <a:schemeClr val="accent4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A3-9CD5-4478-A092-77CD677143F2}"/>
              </c:ext>
            </c:extLst>
          </c:dPt>
          <c:dPt>
            <c:idx val="82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A5-9CD5-4478-A092-77CD677143F2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pPr>
                <a:endParaRPr lang="en-US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COX3_CONSENSUS_PHYLOGENY_HISTG_!$A$2:$A$84</c:f>
              <c:strCache>
                <c:ptCount val="83"/>
                <c:pt idx="0">
                  <c:v> ***  # COX3_CLUSTALW_MAXALIGN_DNA_UB #  *** </c:v>
                </c:pt>
                <c:pt idx="1">
                  <c:v> ***  # COX3_CLUSTALW_TCSFMf_DNA_UB #  *** </c:v>
                </c:pt>
                <c:pt idx="2">
                  <c:v> ***  # COX3_CLUSTALW_TCSf_DNA_UB #  *** </c:v>
                </c:pt>
                <c:pt idx="3">
                  <c:v> ***  # COX3_CLUSTALW_TRIMAL_DNA_UB #  *** </c:v>
                </c:pt>
                <c:pt idx="4">
                  <c:v> ***  # COX3_FSANP_TCSFMw_RYt_UB #  *** </c:v>
                </c:pt>
                <c:pt idx="5">
                  <c:v> ***  # COX3_FSA_TCSw_RYt_UB #  *** </c:v>
                </c:pt>
                <c:pt idx="6">
                  <c:v> ***  # COX3_GRAMALIGN_GBLOCKSC_DNA_UB #  *** </c:v>
                </c:pt>
                <c:pt idx="7">
                  <c:v> ***  # COX3_MACSE_GBLOCKS_DNA_UB #  *** </c:v>
                </c:pt>
                <c:pt idx="8">
                  <c:v> ***  # COX3_MAFFTA_MAXALIGN_DNA_UB #  *** </c:v>
                </c:pt>
                <c:pt idx="9">
                  <c:v> ***  # COX3_MAFFTF1_TCSw_DNA_UB #  *** </c:v>
                </c:pt>
                <c:pt idx="10">
                  <c:v> ***  # COX3_MAFFTFI_GBLOCKS_DNA_UB #  *** </c:v>
                </c:pt>
                <c:pt idx="11">
                  <c:v> ***  # COX3_MAFFTFI_TCSFMf_DNA_UB #  *** </c:v>
                </c:pt>
                <c:pt idx="12">
                  <c:v> ***  # COX3_MAFFTLI_TCSFMf_DNA_UB #  *** </c:v>
                </c:pt>
                <c:pt idx="13">
                  <c:v> ***  # COX3_OPAL_TCSw_RYt_UB #  *** </c:v>
                </c:pt>
                <c:pt idx="14">
                  <c:v> ***  # COX3_PRANKO_TRIMALA_DNA_UB #  *** </c:v>
                </c:pt>
                <c:pt idx="15">
                  <c:v> ***  # COX3_PRANK_MAXALIGN_DNA_UB #  *** </c:v>
                </c:pt>
                <c:pt idx="16">
                  <c:v> *** COX3_ALL_TRIMALC_DNA_UB *** </c:v>
                </c:pt>
                <c:pt idx="17">
                  <c:v> *** COX3_ALL_WEAVEALIGN_DNA_UB *** </c:v>
                </c:pt>
                <c:pt idx="18">
                  <c:v> ***  # COX3_PROBCONS_PSARALIGN_DNA_UB #  *** </c:v>
                </c:pt>
                <c:pt idx="19">
                  <c:v> ***  # COX3_PROBCONS_TCSf_DNA_UB #  *** </c:v>
                </c:pt>
                <c:pt idx="20">
                  <c:v> ***  # COX3_PROBCONS_TRIMALG_DNA_UB #  *** </c:v>
                </c:pt>
                <c:pt idx="21">
                  <c:v> ***  # COX3_TCOFFEEPL_MAXALIGN_DNA_UB #  *** </c:v>
                </c:pt>
                <c:pt idx="22">
                  <c:v> ***  # COX3_TCOFFEETC_GBLOCKS_DNA_UB #  *** </c:v>
                </c:pt>
                <c:pt idx="23">
                  <c:v> ***  # COX3_TCOFFEETC_TCSw_DEG_UB #  *** </c:v>
                </c:pt>
                <c:pt idx="24">
                  <c:v> ***  # COX3_FSANP_MAXALIGN_DEG_UB #  *** </c:v>
                </c:pt>
                <c:pt idx="25">
                  <c:v> ***  # COX3_FSANP_TRIMALG_DEG_UB #  *** </c:v>
                </c:pt>
                <c:pt idx="26">
                  <c:v> ***  # COX3_FSA_TCSf_DEG_UB #  *** </c:v>
                </c:pt>
                <c:pt idx="27">
                  <c:v> ***  # COX3_KALIGN_TRIMAL_DEG_UB #  *** </c:v>
                </c:pt>
                <c:pt idx="28">
                  <c:v> ***  # COX3_MAFFTA_GBLOCKS_DEG_UB #  *** </c:v>
                </c:pt>
                <c:pt idx="29">
                  <c:v> ***  # COX3_MAFFTA_TRIMALA_DEG_UB #  *** </c:v>
                </c:pt>
                <c:pt idx="30">
                  <c:v> ***  # COX3_MAFFTF1_TCSf_DEG_UB #  *** </c:v>
                </c:pt>
                <c:pt idx="31">
                  <c:v> ***  # COX3_MAFFTLI_PSARALIGN_DEG_UB #  *** </c:v>
                </c:pt>
                <c:pt idx="32">
                  <c:v> ***  # COX3_PRANKO_GBLOCKSC_DEG_UB #  *** </c:v>
                </c:pt>
                <c:pt idx="33">
                  <c:v> ***  # COX3_TCOFFEEPL_TCSFMf_DEG_UB #  *** </c:v>
                </c:pt>
                <c:pt idx="34">
                  <c:v> ***  # COX3_MACSE_GBLOCKSC_CDN_UB #  *** </c:v>
                </c:pt>
                <c:pt idx="35">
                  <c:v> ***  # COX3_MACSE_TRIMALG_CDN_UB #  *** </c:v>
                </c:pt>
                <c:pt idx="36">
                  <c:v> ***  # COX3_MAFFTA_TCSFMf_CDN_UB #  *** </c:v>
                </c:pt>
                <c:pt idx="37">
                  <c:v> ***  # COX3_MAFFTA_TRIMALA_CDN_UB #  *** </c:v>
                </c:pt>
                <c:pt idx="38">
                  <c:v> ***  # COX3_MAFFTGI_MAXALIGN_CDN_UB #  *** </c:v>
                </c:pt>
                <c:pt idx="39">
                  <c:v> ***  # COX3_MUSCLE_PSARALIGN_CDN_UB #  *** </c:v>
                </c:pt>
                <c:pt idx="40">
                  <c:v> ***  # COX3_OPAL_TRIMAL_CDN_UB #  *** </c:v>
                </c:pt>
                <c:pt idx="41">
                  <c:v> ***  # COX3_FSA_TRIMALG_RYt_UB #  *** </c:v>
                </c:pt>
                <c:pt idx="42">
                  <c:v> ***  # COX3_MACSE_MAXALIGN_RYt_UB #  *** </c:v>
                </c:pt>
                <c:pt idx="43">
                  <c:v> ***  # COX3_MACSE_TCSFMf_RYt_UB #  *** </c:v>
                </c:pt>
                <c:pt idx="44">
                  <c:v> ***  # COX3_MUSCLE_GBLOCKSC_RYt_UB #  *** </c:v>
                </c:pt>
                <c:pt idx="45">
                  <c:v> ***  # COX3_MUSCLE_GBLOCKS_RYt_UB #  *** </c:v>
                </c:pt>
                <c:pt idx="46">
                  <c:v> ***  # COX3_MUSCLE_TRIMAL_RYt_UB #  *** </c:v>
                </c:pt>
                <c:pt idx="47">
                  <c:v> ***  # COX3_PRANKF_PSARALIGN_RYt_UB #  *** </c:v>
                </c:pt>
                <c:pt idx="48">
                  <c:v> *** COX3_ALL_TRIMALC_DEG_UB *** </c:v>
                </c:pt>
                <c:pt idx="49">
                  <c:v> *** COX3_ALL_WEAVEALIGN_DEG_UB *** </c:v>
                </c:pt>
                <c:pt idx="50">
                  <c:v> ***  # COX3_GRAMALIGN_GBLOCKSC_2AA_UB #  *** </c:v>
                </c:pt>
                <c:pt idx="51">
                  <c:v> ***  # COX3_MACSE_TRIMALA_2AA_UB #  *** </c:v>
                </c:pt>
                <c:pt idx="52">
                  <c:v> ***  # COX3_MAFFTF1_MAXALIGN_2AA_UB #  *** </c:v>
                </c:pt>
                <c:pt idx="53">
                  <c:v> ***  # COX3_MAFFTF1_TCSFMf_2AA_UB #  *** </c:v>
                </c:pt>
                <c:pt idx="54">
                  <c:v> ***  # COX3_MAFFTFI_MAXALIGN_2AA_UB #  *** </c:v>
                </c:pt>
                <c:pt idx="55">
                  <c:v> ***  # COX3_MAFFTFI_TCSf_2AA_UB #  *** </c:v>
                </c:pt>
                <c:pt idx="56">
                  <c:v> ***  # COX3_PRANKF_TRIMALG_2AA_UB #  *** </c:v>
                </c:pt>
                <c:pt idx="57">
                  <c:v> ***  # COX3_PRANKO_GBLOCKSC_2AA_UB #  *** </c:v>
                </c:pt>
                <c:pt idx="58">
                  <c:v> ***  # COX3_PRANK_TRIMALG_2AA_UB #  *** </c:v>
                </c:pt>
                <c:pt idx="59">
                  <c:v> ***  # COX3_PROBCONS_PSARALIGN_2AA_UB #  *** </c:v>
                </c:pt>
                <c:pt idx="60">
                  <c:v> ***  # COX3_TCOFFEEPL_TRIMALA_2AA_UB #  *** </c:v>
                </c:pt>
                <c:pt idx="61">
                  <c:v> ***  # COX3_TCOFFEE_TCSf_RYt_UB #  *** </c:v>
                </c:pt>
                <c:pt idx="62">
                  <c:v> ***  # COX3_TCOFFEETC_TRIMAL_2AA_UB #  *** </c:v>
                </c:pt>
                <c:pt idx="63">
                  <c:v> ***  # COX3_TCOFFEE_MAXALIGN_2AA_UB #  *** </c:v>
                </c:pt>
                <c:pt idx="64">
                  <c:v> *** COX3_ALL_TRIMALC_CDN_UB *** </c:v>
                </c:pt>
                <c:pt idx="65">
                  <c:v> *** COX3_ALL_WEAVEALIGN_CDN_UB *** </c:v>
                </c:pt>
                <c:pt idx="66">
                  <c:v> *** COX3_ALL_TRIMALC_RYt_UB *** </c:v>
                </c:pt>
                <c:pt idx="67">
                  <c:v> *** COX3_ALL_WEAVEALIGN_RYt_UB *** </c:v>
                </c:pt>
                <c:pt idx="68">
                  <c:v> *** COX3_ALL_TRIMALC_2AA_UB *** </c:v>
                </c:pt>
                <c:pt idx="69">
                  <c:v> *** COX3_ALL_WEAVEALIGN_2AA_UB *** </c:v>
                </c:pt>
                <c:pt idx="70">
                  <c:v> ***  # COX3_CLUSTALO_TCSOGw_RYt_UB #  *** </c:v>
                </c:pt>
                <c:pt idx="71">
                  <c:v> ***  # COX3_MAFFTGI_TCSFMw_DNA_UB #  *** </c:v>
                </c:pt>
                <c:pt idx="72">
                  <c:v> ***  # COX3_MAFFTGI_TRIMALS_DNA_UB #  *** </c:v>
                </c:pt>
                <c:pt idx="73">
                  <c:v> ***  # COX3_PRANK_TRIMALP_DNA_UB #  *** </c:v>
                </c:pt>
                <c:pt idx="74">
                  <c:v> ***  # COX3_MAFFTF1_TCSOGw_DNA_UB #  *** </c:v>
                </c:pt>
                <c:pt idx="75">
                  <c:v> ***  # COX3_CLUSTALO_NOISY_DNA_UB #  *** </c:v>
                </c:pt>
                <c:pt idx="76">
                  <c:v> ***  # COX3_PROBCONS_TRIMALS_DEG_UB #  *** </c:v>
                </c:pt>
                <c:pt idx="77">
                  <c:v> ***  # COX3_TCOFFEEPL_TCSOGw_DEG_UB #  *** </c:v>
                </c:pt>
                <c:pt idx="78">
                  <c:v> ***  # COX3_TCOFFEE_TRIMALP_DEG_UB #  *** </c:v>
                </c:pt>
                <c:pt idx="79">
                  <c:v> ***  # COX3_PRANKO_TRIMALP_RYt_UB #  *** </c:v>
                </c:pt>
                <c:pt idx="80">
                  <c:v> ***  # COX3_MAFFTF1_NOISY_DEG_UB #  *** </c:v>
                </c:pt>
                <c:pt idx="81">
                  <c:v> ***  # COX3_TCOFFEEPL_TRIMALS_RYt_UB #  *** </c:v>
                </c:pt>
                <c:pt idx="82">
                  <c:v> ***  # COX3_MAFFTEI_NOISY_RYt_UB #  *** </c:v>
                </c:pt>
              </c:strCache>
            </c:strRef>
          </c:cat>
          <c:val>
            <c:numRef>
              <c:f>COX3_CONSENSUS_PHYLOGENY_HISTG_!$B$2:$B$84</c:f>
              <c:numCache>
                <c:formatCode>General</c:formatCode>
                <c:ptCount val="83"/>
                <c:pt idx="0">
                  <c:v>462</c:v>
                </c:pt>
                <c:pt idx="1">
                  <c:v>462</c:v>
                </c:pt>
                <c:pt idx="2">
                  <c:v>462</c:v>
                </c:pt>
                <c:pt idx="3">
                  <c:v>462</c:v>
                </c:pt>
                <c:pt idx="4">
                  <c:v>462</c:v>
                </c:pt>
                <c:pt idx="5">
                  <c:v>462</c:v>
                </c:pt>
                <c:pt idx="6">
                  <c:v>462</c:v>
                </c:pt>
                <c:pt idx="7">
                  <c:v>462</c:v>
                </c:pt>
                <c:pt idx="8">
                  <c:v>462</c:v>
                </c:pt>
                <c:pt idx="9">
                  <c:v>462</c:v>
                </c:pt>
                <c:pt idx="10">
                  <c:v>462</c:v>
                </c:pt>
                <c:pt idx="11">
                  <c:v>462</c:v>
                </c:pt>
                <c:pt idx="12">
                  <c:v>462</c:v>
                </c:pt>
                <c:pt idx="13">
                  <c:v>462</c:v>
                </c:pt>
                <c:pt idx="14">
                  <c:v>462</c:v>
                </c:pt>
                <c:pt idx="15">
                  <c:v>458</c:v>
                </c:pt>
                <c:pt idx="16">
                  <c:v>445</c:v>
                </c:pt>
                <c:pt idx="17">
                  <c:v>445</c:v>
                </c:pt>
                <c:pt idx="18">
                  <c:v>441</c:v>
                </c:pt>
                <c:pt idx="19">
                  <c:v>437</c:v>
                </c:pt>
                <c:pt idx="20">
                  <c:v>432</c:v>
                </c:pt>
                <c:pt idx="21">
                  <c:v>428</c:v>
                </c:pt>
                <c:pt idx="22">
                  <c:v>414</c:v>
                </c:pt>
                <c:pt idx="23">
                  <c:v>406</c:v>
                </c:pt>
                <c:pt idx="24">
                  <c:v>244</c:v>
                </c:pt>
                <c:pt idx="25">
                  <c:v>244</c:v>
                </c:pt>
                <c:pt idx="26">
                  <c:v>244</c:v>
                </c:pt>
                <c:pt idx="27">
                  <c:v>244</c:v>
                </c:pt>
                <c:pt idx="28">
                  <c:v>244</c:v>
                </c:pt>
                <c:pt idx="29">
                  <c:v>244</c:v>
                </c:pt>
                <c:pt idx="30">
                  <c:v>244</c:v>
                </c:pt>
                <c:pt idx="31">
                  <c:v>244</c:v>
                </c:pt>
                <c:pt idx="32">
                  <c:v>244</c:v>
                </c:pt>
                <c:pt idx="33">
                  <c:v>220</c:v>
                </c:pt>
                <c:pt idx="34">
                  <c:v>217</c:v>
                </c:pt>
                <c:pt idx="35">
                  <c:v>217</c:v>
                </c:pt>
                <c:pt idx="36">
                  <c:v>217</c:v>
                </c:pt>
                <c:pt idx="37">
                  <c:v>217</c:v>
                </c:pt>
                <c:pt idx="38">
                  <c:v>217</c:v>
                </c:pt>
                <c:pt idx="39">
                  <c:v>217</c:v>
                </c:pt>
                <c:pt idx="40">
                  <c:v>217</c:v>
                </c:pt>
                <c:pt idx="41">
                  <c:v>205</c:v>
                </c:pt>
                <c:pt idx="42">
                  <c:v>205</c:v>
                </c:pt>
                <c:pt idx="43">
                  <c:v>205</c:v>
                </c:pt>
                <c:pt idx="44">
                  <c:v>205</c:v>
                </c:pt>
                <c:pt idx="45">
                  <c:v>205</c:v>
                </c:pt>
                <c:pt idx="46">
                  <c:v>205</c:v>
                </c:pt>
                <c:pt idx="47">
                  <c:v>205</c:v>
                </c:pt>
                <c:pt idx="48">
                  <c:v>196</c:v>
                </c:pt>
                <c:pt idx="49">
                  <c:v>196</c:v>
                </c:pt>
                <c:pt idx="50">
                  <c:v>181</c:v>
                </c:pt>
                <c:pt idx="51">
                  <c:v>181</c:v>
                </c:pt>
                <c:pt idx="52">
                  <c:v>181</c:v>
                </c:pt>
                <c:pt idx="53">
                  <c:v>181</c:v>
                </c:pt>
                <c:pt idx="54">
                  <c:v>181</c:v>
                </c:pt>
                <c:pt idx="55">
                  <c:v>181</c:v>
                </c:pt>
                <c:pt idx="56">
                  <c:v>181</c:v>
                </c:pt>
                <c:pt idx="57">
                  <c:v>181</c:v>
                </c:pt>
                <c:pt idx="58">
                  <c:v>174</c:v>
                </c:pt>
                <c:pt idx="59">
                  <c:v>171</c:v>
                </c:pt>
                <c:pt idx="60">
                  <c:v>161</c:v>
                </c:pt>
                <c:pt idx="61">
                  <c:v>161</c:v>
                </c:pt>
                <c:pt idx="62">
                  <c:v>153</c:v>
                </c:pt>
                <c:pt idx="63">
                  <c:v>151</c:v>
                </c:pt>
                <c:pt idx="64">
                  <c:v>144</c:v>
                </c:pt>
                <c:pt idx="65">
                  <c:v>144</c:v>
                </c:pt>
                <c:pt idx="66">
                  <c:v>143</c:v>
                </c:pt>
                <c:pt idx="67">
                  <c:v>143</c:v>
                </c:pt>
                <c:pt idx="68">
                  <c:v>135</c:v>
                </c:pt>
                <c:pt idx="69">
                  <c:v>135</c:v>
                </c:pt>
                <c:pt idx="70">
                  <c:v>75</c:v>
                </c:pt>
                <c:pt idx="71">
                  <c:v>75</c:v>
                </c:pt>
                <c:pt idx="72">
                  <c:v>58</c:v>
                </c:pt>
                <c:pt idx="73">
                  <c:v>57</c:v>
                </c:pt>
                <c:pt idx="74">
                  <c:v>34</c:v>
                </c:pt>
                <c:pt idx="75">
                  <c:v>26</c:v>
                </c:pt>
                <c:pt idx="76">
                  <c:v>24</c:v>
                </c:pt>
                <c:pt idx="77">
                  <c:v>24</c:v>
                </c:pt>
                <c:pt idx="78">
                  <c:v>21</c:v>
                </c:pt>
                <c:pt idx="79">
                  <c:v>18</c:v>
                </c:pt>
                <c:pt idx="80">
                  <c:v>15</c:v>
                </c:pt>
                <c:pt idx="81">
                  <c:v>15</c:v>
                </c:pt>
                <c:pt idx="82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A6-9CD5-4478-A092-77CD677143F2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2889961231439065E-2"/>
          <c:y val="3.8526329619250163E-2"/>
          <c:w val="0.86309543984583414"/>
          <c:h val="0.9325367805985243"/>
        </c:manualLayout>
      </c:layout>
      <c:pieChart>
        <c:varyColors val="1"/>
        <c:ser>
          <c:idx val="0"/>
          <c:order val="0"/>
          <c:tx>
            <c:strRef>
              <c:f>CYTB_CONSENSUS_PHYLOGENY_HISTG_!$B$1</c:f>
              <c:strCache>
                <c:ptCount val="1"/>
                <c:pt idx="0">
                  <c:v>Total Topological Support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F228-4B9C-98BB-7ACB5F74B85E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F228-4B9C-98BB-7ACB5F74B85E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F228-4B9C-98BB-7ACB5F74B85E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F228-4B9C-98BB-7ACB5F74B85E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F228-4B9C-98BB-7ACB5F74B85E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F228-4B9C-98BB-7ACB5F74B85E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F228-4B9C-98BB-7ACB5F74B85E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F228-4B9C-98BB-7ACB5F74B85E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F228-4B9C-98BB-7ACB5F74B85E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F228-4B9C-98BB-7ACB5F74B85E}"/>
              </c:ext>
            </c:extLst>
          </c:dPt>
          <c:dPt>
            <c:idx val="10"/>
            <c:bubble3D val="0"/>
            <c:spPr>
              <a:solidFill>
                <a:schemeClr val="accent5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F228-4B9C-98BB-7ACB5F74B85E}"/>
              </c:ext>
            </c:extLst>
          </c:dPt>
          <c:dPt>
            <c:idx val="11"/>
            <c:bubble3D val="0"/>
            <c:spPr>
              <a:solidFill>
                <a:schemeClr val="accent6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F228-4B9C-98BB-7ACB5F74B85E}"/>
              </c:ext>
            </c:extLst>
          </c:dPt>
          <c:dPt>
            <c:idx val="12"/>
            <c:bubble3D val="0"/>
            <c:spPr>
              <a:solidFill>
                <a:schemeClr val="accent1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F228-4B9C-98BB-7ACB5F74B85E}"/>
              </c:ext>
            </c:extLst>
          </c:dPt>
          <c:dPt>
            <c:idx val="13"/>
            <c:bubble3D val="0"/>
            <c:spPr>
              <a:solidFill>
                <a:schemeClr val="accent2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F228-4B9C-98BB-7ACB5F74B85E}"/>
              </c:ext>
            </c:extLst>
          </c:dPt>
          <c:dPt>
            <c:idx val="14"/>
            <c:bubble3D val="0"/>
            <c:spPr>
              <a:solidFill>
                <a:schemeClr val="accent3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F228-4B9C-98BB-7ACB5F74B85E}"/>
              </c:ext>
            </c:extLst>
          </c:dPt>
          <c:dPt>
            <c:idx val="15"/>
            <c:bubble3D val="0"/>
            <c:spPr>
              <a:solidFill>
                <a:schemeClr val="accent4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F-F228-4B9C-98BB-7ACB5F74B85E}"/>
              </c:ext>
            </c:extLst>
          </c:dPt>
          <c:dPt>
            <c:idx val="16"/>
            <c:bubble3D val="0"/>
            <c:spPr>
              <a:solidFill>
                <a:schemeClr val="accent5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1-F228-4B9C-98BB-7ACB5F74B85E}"/>
              </c:ext>
            </c:extLst>
          </c:dPt>
          <c:dPt>
            <c:idx val="17"/>
            <c:bubble3D val="0"/>
            <c:spPr>
              <a:solidFill>
                <a:schemeClr val="accent6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3-F228-4B9C-98BB-7ACB5F74B85E}"/>
              </c:ext>
            </c:extLst>
          </c:dPt>
          <c:dPt>
            <c:idx val="18"/>
            <c:bubble3D val="0"/>
            <c:spPr>
              <a:solidFill>
                <a:schemeClr val="accent1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5-F228-4B9C-98BB-7ACB5F74B85E}"/>
              </c:ext>
            </c:extLst>
          </c:dPt>
          <c:dPt>
            <c:idx val="19"/>
            <c:bubble3D val="0"/>
            <c:spPr>
              <a:solidFill>
                <a:schemeClr val="accent2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7-F228-4B9C-98BB-7ACB5F74B85E}"/>
              </c:ext>
            </c:extLst>
          </c:dPt>
          <c:dPt>
            <c:idx val="20"/>
            <c:bubble3D val="0"/>
            <c:spPr>
              <a:solidFill>
                <a:schemeClr val="accent3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9-F228-4B9C-98BB-7ACB5F74B85E}"/>
              </c:ext>
            </c:extLst>
          </c:dPt>
          <c:dPt>
            <c:idx val="21"/>
            <c:bubble3D val="0"/>
            <c:spPr>
              <a:solidFill>
                <a:schemeClr val="accent4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B-F228-4B9C-98BB-7ACB5F74B85E}"/>
              </c:ext>
            </c:extLst>
          </c:dPt>
          <c:dPt>
            <c:idx val="22"/>
            <c:bubble3D val="0"/>
            <c:spPr>
              <a:solidFill>
                <a:schemeClr val="accent5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D-F228-4B9C-98BB-7ACB5F74B85E}"/>
              </c:ext>
            </c:extLst>
          </c:dPt>
          <c:dPt>
            <c:idx val="23"/>
            <c:bubble3D val="0"/>
            <c:spPr>
              <a:solidFill>
                <a:schemeClr val="accent6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F-F228-4B9C-98BB-7ACB5F74B85E}"/>
              </c:ext>
            </c:extLst>
          </c:dPt>
          <c:dPt>
            <c:idx val="24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1-F228-4B9C-98BB-7ACB5F74B85E}"/>
              </c:ext>
            </c:extLst>
          </c:dPt>
          <c:dPt>
            <c:idx val="25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3-F228-4B9C-98BB-7ACB5F74B85E}"/>
              </c:ext>
            </c:extLst>
          </c:dPt>
          <c:dPt>
            <c:idx val="26"/>
            <c:bubble3D val="0"/>
            <c:spPr>
              <a:solidFill>
                <a:schemeClr val="accent3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5-F228-4B9C-98BB-7ACB5F74B85E}"/>
              </c:ext>
            </c:extLst>
          </c:dPt>
          <c:dPt>
            <c:idx val="27"/>
            <c:bubble3D val="0"/>
            <c:spPr>
              <a:solidFill>
                <a:schemeClr val="accent4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7-F228-4B9C-98BB-7ACB5F74B85E}"/>
              </c:ext>
            </c:extLst>
          </c:dPt>
          <c:dPt>
            <c:idx val="28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9-F228-4B9C-98BB-7ACB5F74B85E}"/>
              </c:ext>
            </c:extLst>
          </c:dPt>
          <c:dPt>
            <c:idx val="29"/>
            <c:bubble3D val="0"/>
            <c:spPr>
              <a:solidFill>
                <a:schemeClr val="accent6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B-F228-4B9C-98BB-7ACB5F74B85E}"/>
              </c:ext>
            </c:extLst>
          </c:dPt>
          <c:dPt>
            <c:idx val="30"/>
            <c:bubble3D val="0"/>
            <c:spPr>
              <a:solidFill>
                <a:schemeClr val="accent1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D-F228-4B9C-98BB-7ACB5F74B85E}"/>
              </c:ext>
            </c:extLst>
          </c:dPt>
          <c:dPt>
            <c:idx val="31"/>
            <c:bubble3D val="0"/>
            <c:spPr>
              <a:solidFill>
                <a:schemeClr val="accent2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F-F228-4B9C-98BB-7ACB5F74B85E}"/>
              </c:ext>
            </c:extLst>
          </c:dPt>
          <c:dPt>
            <c:idx val="32"/>
            <c:bubble3D val="0"/>
            <c:spPr>
              <a:solidFill>
                <a:schemeClr val="accent3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1-F228-4B9C-98BB-7ACB5F74B85E}"/>
              </c:ext>
            </c:extLst>
          </c:dPt>
          <c:dPt>
            <c:idx val="33"/>
            <c:bubble3D val="0"/>
            <c:spPr>
              <a:solidFill>
                <a:schemeClr val="accent4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3-F228-4B9C-98BB-7ACB5F74B85E}"/>
              </c:ext>
            </c:extLst>
          </c:dPt>
          <c:dPt>
            <c:idx val="34"/>
            <c:bubble3D val="0"/>
            <c:spPr>
              <a:solidFill>
                <a:schemeClr val="accent5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5-F228-4B9C-98BB-7ACB5F74B85E}"/>
              </c:ext>
            </c:extLst>
          </c:dPt>
          <c:dPt>
            <c:idx val="35"/>
            <c:bubble3D val="0"/>
            <c:spPr>
              <a:solidFill>
                <a:schemeClr val="accent6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7-F228-4B9C-98BB-7ACB5F74B85E}"/>
              </c:ext>
            </c:extLst>
          </c:dPt>
          <c:dPt>
            <c:idx val="36"/>
            <c:bubble3D val="0"/>
            <c:spPr>
              <a:solidFill>
                <a:schemeClr val="accent1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9-F228-4B9C-98BB-7ACB5F74B85E}"/>
              </c:ext>
            </c:extLst>
          </c:dPt>
          <c:dPt>
            <c:idx val="37"/>
            <c:bubble3D val="0"/>
            <c:spPr>
              <a:solidFill>
                <a:schemeClr val="accent2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B-F228-4B9C-98BB-7ACB5F74B85E}"/>
              </c:ext>
            </c:extLst>
          </c:dPt>
          <c:dPt>
            <c:idx val="38"/>
            <c:bubble3D val="0"/>
            <c:spPr>
              <a:solidFill>
                <a:schemeClr val="accent3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D-F228-4B9C-98BB-7ACB5F74B85E}"/>
              </c:ext>
            </c:extLst>
          </c:dPt>
          <c:dPt>
            <c:idx val="39"/>
            <c:bubble3D val="0"/>
            <c:spPr>
              <a:solidFill>
                <a:schemeClr val="accent4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F-F228-4B9C-98BB-7ACB5F74B85E}"/>
              </c:ext>
            </c:extLst>
          </c:dPt>
          <c:dPt>
            <c:idx val="40"/>
            <c:bubble3D val="0"/>
            <c:spPr>
              <a:solidFill>
                <a:schemeClr val="accent5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1-F228-4B9C-98BB-7ACB5F74B85E}"/>
              </c:ext>
            </c:extLst>
          </c:dPt>
          <c:dPt>
            <c:idx val="41"/>
            <c:bubble3D val="0"/>
            <c:spPr>
              <a:solidFill>
                <a:schemeClr val="accent6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3-F228-4B9C-98BB-7ACB5F74B85E}"/>
              </c:ext>
            </c:extLst>
          </c:dPt>
          <c:dPt>
            <c:idx val="42"/>
            <c:bubble3D val="0"/>
            <c:spPr>
              <a:solidFill>
                <a:schemeClr val="accent1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5-F228-4B9C-98BB-7ACB5F74B85E}"/>
              </c:ext>
            </c:extLst>
          </c:dPt>
          <c:dPt>
            <c:idx val="43"/>
            <c:bubble3D val="0"/>
            <c:spPr>
              <a:solidFill>
                <a:schemeClr val="accent2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7-F228-4B9C-98BB-7ACB5F74B85E}"/>
              </c:ext>
            </c:extLst>
          </c:dPt>
          <c:dPt>
            <c:idx val="44"/>
            <c:bubble3D val="0"/>
            <c:spPr>
              <a:solidFill>
                <a:schemeClr val="accent3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9-F228-4B9C-98BB-7ACB5F74B85E}"/>
              </c:ext>
            </c:extLst>
          </c:dPt>
          <c:dPt>
            <c:idx val="45"/>
            <c:bubble3D val="0"/>
            <c:spPr>
              <a:solidFill>
                <a:schemeClr val="accent4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B-F228-4B9C-98BB-7ACB5F74B85E}"/>
              </c:ext>
            </c:extLst>
          </c:dPt>
          <c:dPt>
            <c:idx val="46"/>
            <c:bubble3D val="0"/>
            <c:spPr>
              <a:solidFill>
                <a:schemeClr val="accent5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D-F228-4B9C-98BB-7ACB5F74B85E}"/>
              </c:ext>
            </c:extLst>
          </c:dPt>
          <c:dPt>
            <c:idx val="47"/>
            <c:bubble3D val="0"/>
            <c:spPr>
              <a:solidFill>
                <a:schemeClr val="accent6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F-F228-4B9C-98BB-7ACB5F74B85E}"/>
              </c:ext>
            </c:extLst>
          </c:dPt>
          <c:dPt>
            <c:idx val="48"/>
            <c:bubble3D val="0"/>
            <c:spPr>
              <a:solidFill>
                <a:schemeClr val="accent1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1-F228-4B9C-98BB-7ACB5F74B85E}"/>
              </c:ext>
            </c:extLst>
          </c:dPt>
          <c:dPt>
            <c:idx val="49"/>
            <c:bubble3D val="0"/>
            <c:spPr>
              <a:solidFill>
                <a:schemeClr val="accent2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3-F228-4B9C-98BB-7ACB5F74B85E}"/>
              </c:ext>
            </c:extLst>
          </c:dPt>
          <c:dPt>
            <c:idx val="50"/>
            <c:bubble3D val="0"/>
            <c:spPr>
              <a:solidFill>
                <a:schemeClr val="accent3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5-F228-4B9C-98BB-7ACB5F74B85E}"/>
              </c:ext>
            </c:extLst>
          </c:dPt>
          <c:dPt>
            <c:idx val="51"/>
            <c:bubble3D val="0"/>
            <c:spPr>
              <a:solidFill>
                <a:schemeClr val="accent4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7-F228-4B9C-98BB-7ACB5F74B85E}"/>
              </c:ext>
            </c:extLst>
          </c:dPt>
          <c:dPt>
            <c:idx val="52"/>
            <c:bubble3D val="0"/>
            <c:spPr>
              <a:solidFill>
                <a:schemeClr val="accent5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9-F228-4B9C-98BB-7ACB5F74B85E}"/>
              </c:ext>
            </c:extLst>
          </c:dPt>
          <c:dPt>
            <c:idx val="53"/>
            <c:bubble3D val="0"/>
            <c:spPr>
              <a:solidFill>
                <a:schemeClr val="accent6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B-F228-4B9C-98BB-7ACB5F74B85E}"/>
              </c:ext>
            </c:extLst>
          </c:dPt>
          <c:dPt>
            <c:idx val="54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D-F228-4B9C-98BB-7ACB5F74B85E}"/>
              </c:ext>
            </c:extLst>
          </c:dPt>
          <c:dPt>
            <c:idx val="55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F-F228-4B9C-98BB-7ACB5F74B85E}"/>
              </c:ext>
            </c:extLst>
          </c:dPt>
          <c:dPt>
            <c:idx val="56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1-F228-4B9C-98BB-7ACB5F74B85E}"/>
              </c:ext>
            </c:extLst>
          </c:dPt>
          <c:dPt>
            <c:idx val="57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3-F228-4B9C-98BB-7ACB5F74B85E}"/>
              </c:ext>
            </c:extLst>
          </c:dPt>
          <c:dPt>
            <c:idx val="58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5-F228-4B9C-98BB-7ACB5F74B85E}"/>
              </c:ext>
            </c:extLst>
          </c:dPt>
          <c:dPt>
            <c:idx val="59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7-F228-4B9C-98BB-7ACB5F74B85E}"/>
              </c:ext>
            </c:extLst>
          </c:dPt>
          <c:dPt>
            <c:idx val="60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9-F228-4B9C-98BB-7ACB5F74B85E}"/>
              </c:ext>
            </c:extLst>
          </c:dPt>
          <c:dPt>
            <c:idx val="61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B-F228-4B9C-98BB-7ACB5F74B85E}"/>
              </c:ext>
            </c:extLst>
          </c:dPt>
          <c:dPt>
            <c:idx val="62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D-F228-4B9C-98BB-7ACB5F74B85E}"/>
              </c:ext>
            </c:extLst>
          </c:dPt>
          <c:dPt>
            <c:idx val="63"/>
            <c:bubble3D val="0"/>
            <c:spPr>
              <a:solidFill>
                <a:schemeClr val="accent4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F-F228-4B9C-98BB-7ACB5F74B85E}"/>
              </c:ext>
            </c:extLst>
          </c:dPt>
          <c:dPt>
            <c:idx val="64"/>
            <c:bubble3D val="0"/>
            <c:spPr>
              <a:solidFill>
                <a:schemeClr val="accent5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1-F228-4B9C-98BB-7ACB5F74B85E}"/>
              </c:ext>
            </c:extLst>
          </c:dPt>
          <c:dPt>
            <c:idx val="65"/>
            <c:bubble3D val="0"/>
            <c:spPr>
              <a:solidFill>
                <a:schemeClr val="accent6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3-F228-4B9C-98BB-7ACB5F74B85E}"/>
              </c:ext>
            </c:extLst>
          </c:dPt>
          <c:dPt>
            <c:idx val="66"/>
            <c:bubble3D val="0"/>
            <c:spPr>
              <a:solidFill>
                <a:schemeClr val="accent1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5-F228-4B9C-98BB-7ACB5F74B85E}"/>
              </c:ext>
            </c:extLst>
          </c:dPt>
          <c:dPt>
            <c:idx val="67"/>
            <c:bubble3D val="0"/>
            <c:spPr>
              <a:solidFill>
                <a:schemeClr val="accent2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7-F228-4B9C-98BB-7ACB5F74B85E}"/>
              </c:ext>
            </c:extLst>
          </c:dPt>
          <c:dPt>
            <c:idx val="68"/>
            <c:bubble3D val="0"/>
            <c:spPr>
              <a:solidFill>
                <a:schemeClr val="accent3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9-F228-4B9C-98BB-7ACB5F74B85E}"/>
              </c:ext>
            </c:extLst>
          </c:dPt>
          <c:dPt>
            <c:idx val="69"/>
            <c:bubble3D val="0"/>
            <c:spPr>
              <a:solidFill>
                <a:schemeClr val="accent4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B-F228-4B9C-98BB-7ACB5F74B85E}"/>
              </c:ext>
            </c:extLst>
          </c:dPt>
          <c:dPt>
            <c:idx val="70"/>
            <c:bubble3D val="0"/>
            <c:spPr>
              <a:solidFill>
                <a:schemeClr val="accent5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D-F228-4B9C-98BB-7ACB5F74B85E}"/>
              </c:ext>
            </c:extLst>
          </c:dPt>
          <c:dPt>
            <c:idx val="71"/>
            <c:bubble3D val="0"/>
            <c:spPr>
              <a:solidFill>
                <a:schemeClr val="accent6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F-F228-4B9C-98BB-7ACB5F74B85E}"/>
              </c:ext>
            </c:extLst>
          </c:dPt>
          <c:dPt>
            <c:idx val="72"/>
            <c:bubble3D val="0"/>
            <c:spPr>
              <a:solidFill>
                <a:schemeClr val="accent1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91-F228-4B9C-98BB-7ACB5F74B85E}"/>
              </c:ext>
            </c:extLst>
          </c:dPt>
          <c:dPt>
            <c:idx val="73"/>
            <c:bubble3D val="0"/>
            <c:spPr>
              <a:solidFill>
                <a:schemeClr val="accent2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93-F228-4B9C-98BB-7ACB5F74B85E}"/>
              </c:ext>
            </c:extLst>
          </c:dPt>
          <c:dPt>
            <c:idx val="74"/>
            <c:bubble3D val="0"/>
            <c:spPr>
              <a:solidFill>
                <a:schemeClr val="accent3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95-F228-4B9C-98BB-7ACB5F74B85E}"/>
              </c:ext>
            </c:extLst>
          </c:dPt>
          <c:dPt>
            <c:idx val="75"/>
            <c:bubble3D val="0"/>
            <c:spPr>
              <a:solidFill>
                <a:schemeClr val="accent4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97-F228-4B9C-98BB-7ACB5F74B85E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pPr>
                <a:endParaRPr lang="en-US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CYTB_CONSENSUS_PHYLOGENY_HISTG_!$A$2:$A$77</c:f>
              <c:strCache>
                <c:ptCount val="76"/>
                <c:pt idx="0">
                  <c:v> ***  # CYTB_CLUSTALW_PSARALIGN_DNA_UB #  *** </c:v>
                </c:pt>
                <c:pt idx="1">
                  <c:v> ***  # CYTB_KALIGN_MAXALIGN_DNA_UB #  *** </c:v>
                </c:pt>
                <c:pt idx="2">
                  <c:v> ***  # CYTB_KALIGN_TCSFMf_DNA_UB #  *** </c:v>
                </c:pt>
                <c:pt idx="3">
                  <c:v> ***  # CYTB_KALIGN_TCSf_DNA_UB #  *** </c:v>
                </c:pt>
                <c:pt idx="4">
                  <c:v> ***  # CYTB_KALIGN_TRIMAL_DNA_UB #  *** </c:v>
                </c:pt>
                <c:pt idx="5">
                  <c:v> ***  # CYTB_MAFFTGI_GBLOCKS_DNA_UB #  *** </c:v>
                </c:pt>
                <c:pt idx="6">
                  <c:v> ***  # CYTB_MAFFTGI_TRIMALA_DNA_UB #  *** </c:v>
                </c:pt>
                <c:pt idx="7">
                  <c:v> ***  # CYTB_MAFFTGI_TRIMALG_DNA_UB #  *** </c:v>
                </c:pt>
                <c:pt idx="8">
                  <c:v> ***  # CYTB_MAFFT_GBLOCKSC_DNA_UB #  *** </c:v>
                </c:pt>
                <c:pt idx="9">
                  <c:v> ***  # CYTB_MAFFT_TCSFMw_DNA_UB #  *** </c:v>
                </c:pt>
                <c:pt idx="10">
                  <c:v> ***  # CYTB_MUSCLE_TCSOGw_DEG_UB #  *** </c:v>
                </c:pt>
                <c:pt idx="11">
                  <c:v> ***  # CYTB_OPAL_TCSFMw_RYt_UB #  *** </c:v>
                </c:pt>
                <c:pt idx="12">
                  <c:v> ***  # CYTB_OPAL_TCSw_RYt_UB #  *** </c:v>
                </c:pt>
                <c:pt idx="13">
                  <c:v> *** CYTB_ALL_TRIMALC_DNA_UB *** </c:v>
                </c:pt>
                <c:pt idx="14">
                  <c:v> *** CYTB_ALL_TRIMALC_RYt_UB *** </c:v>
                </c:pt>
                <c:pt idx="15">
                  <c:v> *** CYTB_ALL_WEAVEALIGN_DNA_UB *** </c:v>
                </c:pt>
                <c:pt idx="16">
                  <c:v> ***  # CYTB_CLUSTALW_PSARALIGN_DEG_UB #  *** </c:v>
                </c:pt>
                <c:pt idx="17">
                  <c:v> ***  # CYTB_KALIGN_MAXALIGN_DEG_UB #  *** </c:v>
                </c:pt>
                <c:pt idx="18">
                  <c:v> ***  # CYTB_KALIGN_TCSf_DEG_UB #  *** </c:v>
                </c:pt>
                <c:pt idx="19">
                  <c:v> ***  # CYTB_OPAL_GBLOCKSC_DEG_UB #  *** </c:v>
                </c:pt>
                <c:pt idx="20">
                  <c:v> *** CYTB_ALL_MERGEALIGN_DEG_UB *** </c:v>
                </c:pt>
                <c:pt idx="21">
                  <c:v> *** CYTB_ALL_TRIMALC_DEG_UB *** </c:v>
                </c:pt>
                <c:pt idx="22">
                  <c:v> *** CYTB_ALL_WEAVEALIGN_DEG_UB *** </c:v>
                </c:pt>
                <c:pt idx="23">
                  <c:v> ***  # CYTB_FSANP_GBLOCKS_2AA_UB #  *** </c:v>
                </c:pt>
                <c:pt idx="24">
                  <c:v> ***  # CYTB_FSANP_MAXALIGN_2AA_UB #  *** </c:v>
                </c:pt>
                <c:pt idx="25">
                  <c:v> ***  # CYTB_FSANP_TCSf_2AA_UB #  *** </c:v>
                </c:pt>
                <c:pt idx="26">
                  <c:v> ***  # CYTB_FSANP_TRIMAL_2AA_UB #  *** </c:v>
                </c:pt>
                <c:pt idx="27">
                  <c:v> ***  # CYTB_MACSE_TCSFMf_2AA_UB #  *** </c:v>
                </c:pt>
                <c:pt idx="28">
                  <c:v> ***  # CYTB_MACSE_TCSf_2AA_UB #  *** </c:v>
                </c:pt>
                <c:pt idx="29">
                  <c:v> ***  # CYTB_MACSE_TRIMAL_2AA_UB #  *** </c:v>
                </c:pt>
                <c:pt idx="30">
                  <c:v> ***  # CYTB_MAFFTF1_TRIMALA_2AA_UB #  *** </c:v>
                </c:pt>
                <c:pt idx="31">
                  <c:v> ***  # CYTB_MAFFTF2_GBLOCKSC_2AA_UB #  *** </c:v>
                </c:pt>
                <c:pt idx="32">
                  <c:v> ***  # CYTB_MAFFTF2_TRIMALA_2AA_UB #  *** </c:v>
                </c:pt>
                <c:pt idx="33">
                  <c:v> ***  # CYTB_MAFFTF2_TRIMALG_2AA_UB #  *** </c:v>
                </c:pt>
                <c:pt idx="34">
                  <c:v> ***  # CYTB_MAFFTGI_GBLOCKS_DEG_UB #  *** </c:v>
                </c:pt>
                <c:pt idx="35">
                  <c:v> ***  # CYTB_MAFFT_TRIMALA_2AA_UB #  *** </c:v>
                </c:pt>
                <c:pt idx="36">
                  <c:v> ***  # CYTB_MAFFT_TRIMALG_2AA_UB #  *** </c:v>
                </c:pt>
                <c:pt idx="37">
                  <c:v> ***  # CYTB_OPAL_TRIMALA_2AA_UB #  *** </c:v>
                </c:pt>
                <c:pt idx="38">
                  <c:v> ***  # CYTB_PRANKCD_PSARALIGN_2AA_UB #  *** </c:v>
                </c:pt>
                <c:pt idx="39">
                  <c:v> *** CYTB_ALL_TRIMALC_2AA_UB *** </c:v>
                </c:pt>
                <c:pt idx="40">
                  <c:v> *** CYTB_ALL_WEAVEALIGN_2AA_UB *** </c:v>
                </c:pt>
                <c:pt idx="41">
                  <c:v> ***  # CYTB_GRAMALIGN_GBLOCKSC_RYt_UB #  *** </c:v>
                </c:pt>
                <c:pt idx="42">
                  <c:v> ***  # CYTB_KALIGN_MAXALIGN_RYt_UB #  *** </c:v>
                </c:pt>
                <c:pt idx="43">
                  <c:v> ***  # CYTB_KALIGN_TCSFMf_RYt_UB #  *** </c:v>
                </c:pt>
                <c:pt idx="44">
                  <c:v> ***  # CYTB_KALIGN_TCSf_RYt_UB #  *** </c:v>
                </c:pt>
                <c:pt idx="45">
                  <c:v> ***  # CYTB_KALIGN_TRIMAL_RYt_UB #  *** </c:v>
                </c:pt>
                <c:pt idx="46">
                  <c:v> ***  # CYTB_MAFFTF1_TCSw_DEG_UB #  *** </c:v>
                </c:pt>
                <c:pt idx="47">
                  <c:v> ***  # CYTB_MAFFT_TCSFMw_DEG_UB #  *** </c:v>
                </c:pt>
                <c:pt idx="48">
                  <c:v> ***  # CYTB_KALIGN_MAXALIGN_CDN_UB #  *** </c:v>
                </c:pt>
                <c:pt idx="49">
                  <c:v> ***  # CYTB_KALIGN_TRIMAL_CDN_UB #  *** </c:v>
                </c:pt>
                <c:pt idx="50">
                  <c:v> ***  # CYTB_MAFFTF1_TCSf_CDN_UB #  *** </c:v>
                </c:pt>
                <c:pt idx="51">
                  <c:v> ***  # CYTB_MAFFTGI_TRIMALA_CDN_UB #  *** </c:v>
                </c:pt>
                <c:pt idx="52">
                  <c:v> ***  # CYTB_MAFFTGI_TRIMALG_CDN_UB #  *** </c:v>
                </c:pt>
                <c:pt idx="53">
                  <c:v> ***  # CYTB_MAFFTLI_TCSFMf_CDN_UB #  *** </c:v>
                </c:pt>
                <c:pt idx="54">
                  <c:v> *** CYTB_ALL_WEAVEALIGN_RYt_UB *** </c:v>
                </c:pt>
                <c:pt idx="55">
                  <c:v> *** CYTB_ALL_TRIMALC_CDN_UB *** </c:v>
                </c:pt>
                <c:pt idx="56">
                  <c:v> *** CYTB_ALL_WEAVEALIGN_CDN_UB *** </c:v>
                </c:pt>
                <c:pt idx="57">
                  <c:v> ***  # CYTB_OPAL_TRIMALS_DNA_UB #  *** </c:v>
                </c:pt>
                <c:pt idx="58">
                  <c:v> ***  # CYTB_CLUSTALW_PSARALIGN_RYt_UB #  *** </c:v>
                </c:pt>
                <c:pt idx="59">
                  <c:v> ***  # CYTB_CLUSTALO_GBLOCKS_CDN_UB #  *** </c:v>
                </c:pt>
                <c:pt idx="60">
                  <c:v> ***  # CYTB_MAFFTFI_GBLOCKSC_CDN_UB #  *** </c:v>
                </c:pt>
                <c:pt idx="61">
                  <c:v> ***  # CYTB_PRANKCD_PSARALIGN_CDN_UB #  *** </c:v>
                </c:pt>
                <c:pt idx="62">
                  <c:v> ***  # CYTB_MAFFTF2_TRIMALS_DEG_UB #  *** </c:v>
                </c:pt>
                <c:pt idx="63">
                  <c:v> ***  # CYTB_MAFFTF1_TRIMALP_DNA_UB #  *** </c:v>
                </c:pt>
                <c:pt idx="64">
                  <c:v> ***  # CYTB_MAFFTF2_TRIMALP_DEG_UB #  *** </c:v>
                </c:pt>
                <c:pt idx="65">
                  <c:v> ***  # CYTB_OPAL_TRIMALA_RYt_UB #  *** </c:v>
                </c:pt>
                <c:pt idx="66">
                  <c:v> ***  # CYTB_OPAL_TRIMALG_RYt_UB #  *** </c:v>
                </c:pt>
                <c:pt idx="67">
                  <c:v> ***  # CYTB_OPAL_GBLOCKS_RYt_UB #  *** </c:v>
                </c:pt>
                <c:pt idx="68">
                  <c:v> ***  # CYTB_GRAMALIGN_TRIMALP_RYt_UB #  *** </c:v>
                </c:pt>
                <c:pt idx="69">
                  <c:v> ***  # CYTB_PROBCONS_NOISY_DNA_UB #  *** </c:v>
                </c:pt>
                <c:pt idx="70">
                  <c:v> ***  # CYTB_GRAMALIGN_TRIMALS_RYt_UB #  *** </c:v>
                </c:pt>
                <c:pt idx="71">
                  <c:v> ***  # CYTB_MUSCLE_TCSOGw_RYt_UB #  *** </c:v>
                </c:pt>
                <c:pt idx="72">
                  <c:v> ***  # CYTB_CLUSTALO_NOISY_DEG_UB #  *** </c:v>
                </c:pt>
                <c:pt idx="73">
                  <c:v> ***  # CYTB_MAFFTGI_TRIMALA_DEG_UB #  *** </c:v>
                </c:pt>
                <c:pt idx="74">
                  <c:v> ***  # CYTB_MAFFTGI_TRIMALG_DEG_UB #  *** </c:v>
                </c:pt>
                <c:pt idx="75">
                  <c:v> # CYTB_CLUSTALO_NOISY_RYt_UB # </c:v>
                </c:pt>
              </c:strCache>
            </c:strRef>
          </c:cat>
          <c:val>
            <c:numRef>
              <c:f>CYTB_CONSENSUS_PHYLOGENY_HISTG_!$B$2:$B$77</c:f>
              <c:numCache>
                <c:formatCode>General</c:formatCode>
                <c:ptCount val="76"/>
                <c:pt idx="0">
                  <c:v>496</c:v>
                </c:pt>
                <c:pt idx="1">
                  <c:v>496</c:v>
                </c:pt>
                <c:pt idx="2">
                  <c:v>496</c:v>
                </c:pt>
                <c:pt idx="3">
                  <c:v>496</c:v>
                </c:pt>
                <c:pt idx="4">
                  <c:v>496</c:v>
                </c:pt>
                <c:pt idx="5">
                  <c:v>496</c:v>
                </c:pt>
                <c:pt idx="6">
                  <c:v>496</c:v>
                </c:pt>
                <c:pt idx="7">
                  <c:v>496</c:v>
                </c:pt>
                <c:pt idx="8">
                  <c:v>496</c:v>
                </c:pt>
                <c:pt idx="9">
                  <c:v>496</c:v>
                </c:pt>
                <c:pt idx="10">
                  <c:v>496</c:v>
                </c:pt>
                <c:pt idx="11">
                  <c:v>496</c:v>
                </c:pt>
                <c:pt idx="12">
                  <c:v>496</c:v>
                </c:pt>
                <c:pt idx="13">
                  <c:v>476</c:v>
                </c:pt>
                <c:pt idx="14">
                  <c:v>476</c:v>
                </c:pt>
                <c:pt idx="15">
                  <c:v>476</c:v>
                </c:pt>
                <c:pt idx="16">
                  <c:v>215</c:v>
                </c:pt>
                <c:pt idx="17">
                  <c:v>215</c:v>
                </c:pt>
                <c:pt idx="18">
                  <c:v>215</c:v>
                </c:pt>
                <c:pt idx="19">
                  <c:v>215</c:v>
                </c:pt>
                <c:pt idx="20">
                  <c:v>201</c:v>
                </c:pt>
                <c:pt idx="21">
                  <c:v>201</c:v>
                </c:pt>
                <c:pt idx="22">
                  <c:v>201</c:v>
                </c:pt>
                <c:pt idx="23">
                  <c:v>172</c:v>
                </c:pt>
                <c:pt idx="24">
                  <c:v>172</c:v>
                </c:pt>
                <c:pt idx="25">
                  <c:v>172</c:v>
                </c:pt>
                <c:pt idx="26">
                  <c:v>172</c:v>
                </c:pt>
                <c:pt idx="27">
                  <c:v>172</c:v>
                </c:pt>
                <c:pt idx="28">
                  <c:v>172</c:v>
                </c:pt>
                <c:pt idx="29">
                  <c:v>172</c:v>
                </c:pt>
                <c:pt idx="30">
                  <c:v>172</c:v>
                </c:pt>
                <c:pt idx="31">
                  <c:v>172</c:v>
                </c:pt>
                <c:pt idx="32">
                  <c:v>172</c:v>
                </c:pt>
                <c:pt idx="33">
                  <c:v>172</c:v>
                </c:pt>
                <c:pt idx="34">
                  <c:v>172</c:v>
                </c:pt>
                <c:pt idx="35">
                  <c:v>172</c:v>
                </c:pt>
                <c:pt idx="36">
                  <c:v>172</c:v>
                </c:pt>
                <c:pt idx="37">
                  <c:v>172</c:v>
                </c:pt>
                <c:pt idx="38">
                  <c:v>172</c:v>
                </c:pt>
                <c:pt idx="39">
                  <c:v>138</c:v>
                </c:pt>
                <c:pt idx="40">
                  <c:v>138</c:v>
                </c:pt>
                <c:pt idx="41">
                  <c:v>135</c:v>
                </c:pt>
                <c:pt idx="42">
                  <c:v>135</c:v>
                </c:pt>
                <c:pt idx="43">
                  <c:v>135</c:v>
                </c:pt>
                <c:pt idx="44">
                  <c:v>135</c:v>
                </c:pt>
                <c:pt idx="45">
                  <c:v>135</c:v>
                </c:pt>
                <c:pt idx="46">
                  <c:v>135</c:v>
                </c:pt>
                <c:pt idx="47">
                  <c:v>135</c:v>
                </c:pt>
                <c:pt idx="48">
                  <c:v>99</c:v>
                </c:pt>
                <c:pt idx="49">
                  <c:v>99</c:v>
                </c:pt>
                <c:pt idx="50">
                  <c:v>99</c:v>
                </c:pt>
                <c:pt idx="51">
                  <c:v>99</c:v>
                </c:pt>
                <c:pt idx="52">
                  <c:v>99</c:v>
                </c:pt>
                <c:pt idx="53">
                  <c:v>99</c:v>
                </c:pt>
                <c:pt idx="54">
                  <c:v>89</c:v>
                </c:pt>
                <c:pt idx="55">
                  <c:v>66</c:v>
                </c:pt>
                <c:pt idx="56">
                  <c:v>66</c:v>
                </c:pt>
                <c:pt idx="57">
                  <c:v>42</c:v>
                </c:pt>
                <c:pt idx="58">
                  <c:v>33</c:v>
                </c:pt>
                <c:pt idx="59">
                  <c:v>32</c:v>
                </c:pt>
                <c:pt idx="60">
                  <c:v>32</c:v>
                </c:pt>
                <c:pt idx="61">
                  <c:v>32</c:v>
                </c:pt>
                <c:pt idx="62">
                  <c:v>26</c:v>
                </c:pt>
                <c:pt idx="63">
                  <c:v>22</c:v>
                </c:pt>
                <c:pt idx="64">
                  <c:v>18</c:v>
                </c:pt>
                <c:pt idx="65">
                  <c:v>18</c:v>
                </c:pt>
                <c:pt idx="66">
                  <c:v>18</c:v>
                </c:pt>
                <c:pt idx="67">
                  <c:v>15</c:v>
                </c:pt>
                <c:pt idx="68">
                  <c:v>14</c:v>
                </c:pt>
                <c:pt idx="69">
                  <c:v>9</c:v>
                </c:pt>
                <c:pt idx="70">
                  <c:v>7</c:v>
                </c:pt>
                <c:pt idx="71">
                  <c:v>5</c:v>
                </c:pt>
                <c:pt idx="72">
                  <c:v>3</c:v>
                </c:pt>
                <c:pt idx="73">
                  <c:v>1</c:v>
                </c:pt>
                <c:pt idx="74">
                  <c:v>1</c:v>
                </c:pt>
                <c:pt idx="7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98-F228-4B9C-98BB-7ACB5F74B85E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294567488424677"/>
          <c:y val="6.3189399322322273E-2"/>
          <c:w val="0.74352446098347291"/>
          <c:h val="0.89962351909050042"/>
        </c:manualLayout>
      </c:layout>
      <c:pieChart>
        <c:varyColors val="1"/>
        <c:ser>
          <c:idx val="0"/>
          <c:order val="0"/>
          <c:tx>
            <c:strRef>
              <c:f>CYTB_CONSENSUS_PHYLOGENY_HISTG_!$B$1</c:f>
              <c:strCache>
                <c:ptCount val="1"/>
                <c:pt idx="0">
                  <c:v>Total Topological Support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309-4B69-A42D-D381709B580C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309-4B69-A42D-D381709B580C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1309-4B69-A42D-D381709B580C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1309-4B69-A42D-D381709B580C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1309-4B69-A42D-D381709B580C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pPr>
                <a:endParaRPr lang="en-US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CYTB_CONSENSUS_PHYLOGENY_HISTG_!$A$2:$A$6</c:f>
              <c:strCache>
                <c:ptCount val="5"/>
                <c:pt idx="0">
                  <c:v> ***  # CYTB_KALIGN_DNA_UB #  *** </c:v>
                </c:pt>
                <c:pt idx="1">
                  <c:v> ***  # CYTB_FSANP_2AA_UB #  *** </c:v>
                </c:pt>
                <c:pt idx="2">
                  <c:v> ***  # CYTB_MACSE_2AA_UB #  *** </c:v>
                </c:pt>
                <c:pt idx="3">
                  <c:v> ***  # CYTB_CLUSTALO_CDN_UB #  *** </c:v>
                </c:pt>
                <c:pt idx="4">
                  <c:v> ***  # CYTB_KALIGN_RYt_UB #  *** </c:v>
                </c:pt>
              </c:strCache>
            </c:strRef>
          </c:cat>
          <c:val>
            <c:numRef>
              <c:f>CYTB_CONSENSUS_PHYLOGENY_HISTG_!$B$2:$B$6</c:f>
              <c:numCache>
                <c:formatCode>General</c:formatCode>
                <c:ptCount val="5"/>
                <c:pt idx="0">
                  <c:v>37</c:v>
                </c:pt>
                <c:pt idx="1">
                  <c:v>23</c:v>
                </c:pt>
                <c:pt idx="2">
                  <c:v>23</c:v>
                </c:pt>
                <c:pt idx="3">
                  <c:v>14</c:v>
                </c:pt>
                <c:pt idx="4">
                  <c:v>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1309-4B69-A42D-D381709B580C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658474054898389"/>
          <c:y val="6.6485344373389793E-2"/>
          <c:w val="0.74022739166736573"/>
          <c:h val="0.89563424737653652"/>
        </c:manualLayout>
      </c:layout>
      <c:pieChart>
        <c:varyColors val="1"/>
        <c:ser>
          <c:idx val="0"/>
          <c:order val="0"/>
          <c:tx>
            <c:strRef>
              <c:f>ND1_CONSENSUS_PHYLOGENY_HISTG_!$B$1</c:f>
              <c:strCache>
                <c:ptCount val="1"/>
                <c:pt idx="0">
                  <c:v>Total Topological Support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33BC-4E08-A3DB-88D4DDD3BDC3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33BC-4E08-A3DB-88D4DDD3BDC3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33BC-4E08-A3DB-88D4DDD3BDC3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33BC-4E08-A3DB-88D4DDD3BDC3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33BC-4E08-A3DB-88D4DDD3BDC3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pPr>
                <a:endParaRPr lang="en-US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ND1_CONSENSUS_PHYLOGENY_HISTG_!$A$2:$A$6</c:f>
              <c:strCache>
                <c:ptCount val="5"/>
                <c:pt idx="0">
                  <c:v> ***  # ND1_MAFFTEI_DEG_UB #  *** </c:v>
                </c:pt>
                <c:pt idx="1">
                  <c:v> ***  # ND1_OPAL_DNA_UB #  *** </c:v>
                </c:pt>
                <c:pt idx="2">
                  <c:v> ***  # ND1_OPAL_RYt_UB #  *** </c:v>
                </c:pt>
                <c:pt idx="3">
                  <c:v> ***  # ND1_PRANKCDO_CDN_UB #  *** </c:v>
                </c:pt>
                <c:pt idx="4">
                  <c:v> ***  # ND1_PRANKCD_2AA_UB #  *** </c:v>
                </c:pt>
              </c:strCache>
            </c:strRef>
          </c:cat>
          <c:val>
            <c:numRef>
              <c:f>ND1_CONSENSUS_PHYLOGENY_HISTG_!$B$2:$B$6</c:f>
              <c:numCache>
                <c:formatCode>General</c:formatCode>
                <c:ptCount val="5"/>
                <c:pt idx="0">
                  <c:v>42</c:v>
                </c:pt>
                <c:pt idx="1">
                  <c:v>39</c:v>
                </c:pt>
                <c:pt idx="2">
                  <c:v>38</c:v>
                </c:pt>
                <c:pt idx="3">
                  <c:v>3</c:v>
                </c:pt>
                <c:pt idx="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33BC-4E08-A3DB-88D4DDD3BDC3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4745717585273897E-2"/>
          <c:y val="2.893688978222533E-2"/>
          <c:w val="0.83684856875659364"/>
          <c:h val="0.94931830031331776"/>
        </c:manualLayout>
      </c:layout>
      <c:pieChart>
        <c:varyColors val="1"/>
        <c:ser>
          <c:idx val="0"/>
          <c:order val="0"/>
          <c:tx>
            <c:strRef>
              <c:f>ND1_CONSENSUS_PHYLOGENY_HISTG_!$B$1</c:f>
              <c:strCache>
                <c:ptCount val="1"/>
                <c:pt idx="0">
                  <c:v>Total Topological Support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A71-4F4D-90B2-6709EC50468A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2A71-4F4D-90B2-6709EC50468A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2A71-4F4D-90B2-6709EC50468A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2A71-4F4D-90B2-6709EC50468A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2A71-4F4D-90B2-6709EC50468A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2A71-4F4D-90B2-6709EC50468A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2A71-4F4D-90B2-6709EC50468A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2A71-4F4D-90B2-6709EC50468A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2A71-4F4D-90B2-6709EC50468A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2A71-4F4D-90B2-6709EC50468A}"/>
              </c:ext>
            </c:extLst>
          </c:dPt>
          <c:dPt>
            <c:idx val="10"/>
            <c:bubble3D val="0"/>
            <c:spPr>
              <a:solidFill>
                <a:schemeClr val="accent5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2A71-4F4D-90B2-6709EC50468A}"/>
              </c:ext>
            </c:extLst>
          </c:dPt>
          <c:dPt>
            <c:idx val="11"/>
            <c:bubble3D val="0"/>
            <c:spPr>
              <a:solidFill>
                <a:schemeClr val="accent6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2A71-4F4D-90B2-6709EC50468A}"/>
              </c:ext>
            </c:extLst>
          </c:dPt>
          <c:dPt>
            <c:idx val="12"/>
            <c:bubble3D val="0"/>
            <c:spPr>
              <a:solidFill>
                <a:schemeClr val="accent1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2A71-4F4D-90B2-6709EC50468A}"/>
              </c:ext>
            </c:extLst>
          </c:dPt>
          <c:dPt>
            <c:idx val="13"/>
            <c:bubble3D val="0"/>
            <c:spPr>
              <a:solidFill>
                <a:schemeClr val="accent2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2A71-4F4D-90B2-6709EC50468A}"/>
              </c:ext>
            </c:extLst>
          </c:dPt>
          <c:dPt>
            <c:idx val="14"/>
            <c:bubble3D val="0"/>
            <c:spPr>
              <a:solidFill>
                <a:schemeClr val="accent3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2A71-4F4D-90B2-6709EC50468A}"/>
              </c:ext>
            </c:extLst>
          </c:dPt>
          <c:dPt>
            <c:idx val="15"/>
            <c:bubble3D val="0"/>
            <c:spPr>
              <a:solidFill>
                <a:schemeClr val="accent4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F-2A71-4F4D-90B2-6709EC50468A}"/>
              </c:ext>
            </c:extLst>
          </c:dPt>
          <c:dPt>
            <c:idx val="16"/>
            <c:bubble3D val="0"/>
            <c:spPr>
              <a:solidFill>
                <a:schemeClr val="accent5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1-2A71-4F4D-90B2-6709EC50468A}"/>
              </c:ext>
            </c:extLst>
          </c:dPt>
          <c:dPt>
            <c:idx val="17"/>
            <c:bubble3D val="0"/>
            <c:spPr>
              <a:solidFill>
                <a:schemeClr val="accent6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3-2A71-4F4D-90B2-6709EC50468A}"/>
              </c:ext>
            </c:extLst>
          </c:dPt>
          <c:dPt>
            <c:idx val="18"/>
            <c:bubble3D val="0"/>
            <c:spPr>
              <a:solidFill>
                <a:schemeClr val="accent1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5-2A71-4F4D-90B2-6709EC50468A}"/>
              </c:ext>
            </c:extLst>
          </c:dPt>
          <c:dPt>
            <c:idx val="19"/>
            <c:bubble3D val="0"/>
            <c:spPr>
              <a:solidFill>
                <a:schemeClr val="accent2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7-2A71-4F4D-90B2-6709EC50468A}"/>
              </c:ext>
            </c:extLst>
          </c:dPt>
          <c:dPt>
            <c:idx val="20"/>
            <c:bubble3D val="0"/>
            <c:spPr>
              <a:solidFill>
                <a:schemeClr val="accent3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9-2A71-4F4D-90B2-6709EC50468A}"/>
              </c:ext>
            </c:extLst>
          </c:dPt>
          <c:dPt>
            <c:idx val="21"/>
            <c:bubble3D val="0"/>
            <c:spPr>
              <a:solidFill>
                <a:schemeClr val="accent4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B-2A71-4F4D-90B2-6709EC50468A}"/>
              </c:ext>
            </c:extLst>
          </c:dPt>
          <c:dPt>
            <c:idx val="22"/>
            <c:bubble3D val="0"/>
            <c:spPr>
              <a:solidFill>
                <a:schemeClr val="accent5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D-2A71-4F4D-90B2-6709EC50468A}"/>
              </c:ext>
            </c:extLst>
          </c:dPt>
          <c:dPt>
            <c:idx val="23"/>
            <c:bubble3D val="0"/>
            <c:spPr>
              <a:solidFill>
                <a:schemeClr val="accent6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F-2A71-4F4D-90B2-6709EC50468A}"/>
              </c:ext>
            </c:extLst>
          </c:dPt>
          <c:dPt>
            <c:idx val="24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1-2A71-4F4D-90B2-6709EC50468A}"/>
              </c:ext>
            </c:extLst>
          </c:dPt>
          <c:dPt>
            <c:idx val="25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3-2A71-4F4D-90B2-6709EC50468A}"/>
              </c:ext>
            </c:extLst>
          </c:dPt>
          <c:dPt>
            <c:idx val="26"/>
            <c:bubble3D val="0"/>
            <c:spPr>
              <a:solidFill>
                <a:schemeClr val="accent3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5-2A71-4F4D-90B2-6709EC50468A}"/>
              </c:ext>
            </c:extLst>
          </c:dPt>
          <c:dPt>
            <c:idx val="27"/>
            <c:bubble3D val="0"/>
            <c:spPr>
              <a:solidFill>
                <a:schemeClr val="accent4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7-2A71-4F4D-90B2-6709EC50468A}"/>
              </c:ext>
            </c:extLst>
          </c:dPt>
          <c:dPt>
            <c:idx val="28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9-2A71-4F4D-90B2-6709EC50468A}"/>
              </c:ext>
            </c:extLst>
          </c:dPt>
          <c:dPt>
            <c:idx val="29"/>
            <c:bubble3D val="0"/>
            <c:spPr>
              <a:solidFill>
                <a:schemeClr val="accent6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B-2A71-4F4D-90B2-6709EC50468A}"/>
              </c:ext>
            </c:extLst>
          </c:dPt>
          <c:dPt>
            <c:idx val="30"/>
            <c:bubble3D val="0"/>
            <c:spPr>
              <a:solidFill>
                <a:schemeClr val="accent1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D-2A71-4F4D-90B2-6709EC50468A}"/>
              </c:ext>
            </c:extLst>
          </c:dPt>
          <c:dPt>
            <c:idx val="31"/>
            <c:bubble3D val="0"/>
            <c:spPr>
              <a:solidFill>
                <a:schemeClr val="accent2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F-2A71-4F4D-90B2-6709EC50468A}"/>
              </c:ext>
            </c:extLst>
          </c:dPt>
          <c:dPt>
            <c:idx val="32"/>
            <c:bubble3D val="0"/>
            <c:spPr>
              <a:solidFill>
                <a:schemeClr val="accent3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1-2A71-4F4D-90B2-6709EC50468A}"/>
              </c:ext>
            </c:extLst>
          </c:dPt>
          <c:dPt>
            <c:idx val="33"/>
            <c:bubble3D val="0"/>
            <c:spPr>
              <a:solidFill>
                <a:schemeClr val="accent4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3-2A71-4F4D-90B2-6709EC50468A}"/>
              </c:ext>
            </c:extLst>
          </c:dPt>
          <c:dPt>
            <c:idx val="34"/>
            <c:bubble3D val="0"/>
            <c:spPr>
              <a:solidFill>
                <a:schemeClr val="accent5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5-2A71-4F4D-90B2-6709EC50468A}"/>
              </c:ext>
            </c:extLst>
          </c:dPt>
          <c:dPt>
            <c:idx val="35"/>
            <c:bubble3D val="0"/>
            <c:spPr>
              <a:solidFill>
                <a:schemeClr val="accent6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7-2A71-4F4D-90B2-6709EC50468A}"/>
              </c:ext>
            </c:extLst>
          </c:dPt>
          <c:dPt>
            <c:idx val="36"/>
            <c:bubble3D val="0"/>
            <c:spPr>
              <a:solidFill>
                <a:schemeClr val="accent1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9-2A71-4F4D-90B2-6709EC50468A}"/>
              </c:ext>
            </c:extLst>
          </c:dPt>
          <c:dPt>
            <c:idx val="37"/>
            <c:bubble3D val="0"/>
            <c:spPr>
              <a:solidFill>
                <a:schemeClr val="accent2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B-2A71-4F4D-90B2-6709EC50468A}"/>
              </c:ext>
            </c:extLst>
          </c:dPt>
          <c:dPt>
            <c:idx val="38"/>
            <c:bubble3D val="0"/>
            <c:spPr>
              <a:solidFill>
                <a:schemeClr val="accent3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D-2A71-4F4D-90B2-6709EC50468A}"/>
              </c:ext>
            </c:extLst>
          </c:dPt>
          <c:dPt>
            <c:idx val="39"/>
            <c:bubble3D val="0"/>
            <c:spPr>
              <a:solidFill>
                <a:schemeClr val="accent4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F-2A71-4F4D-90B2-6709EC50468A}"/>
              </c:ext>
            </c:extLst>
          </c:dPt>
          <c:dPt>
            <c:idx val="40"/>
            <c:bubble3D val="0"/>
            <c:spPr>
              <a:solidFill>
                <a:schemeClr val="accent5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1-2A71-4F4D-90B2-6709EC50468A}"/>
              </c:ext>
            </c:extLst>
          </c:dPt>
          <c:dPt>
            <c:idx val="41"/>
            <c:bubble3D val="0"/>
            <c:spPr>
              <a:solidFill>
                <a:schemeClr val="accent6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3-2A71-4F4D-90B2-6709EC50468A}"/>
              </c:ext>
            </c:extLst>
          </c:dPt>
          <c:dPt>
            <c:idx val="42"/>
            <c:bubble3D val="0"/>
            <c:spPr>
              <a:solidFill>
                <a:schemeClr val="accent1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5-2A71-4F4D-90B2-6709EC50468A}"/>
              </c:ext>
            </c:extLst>
          </c:dPt>
          <c:dPt>
            <c:idx val="43"/>
            <c:bubble3D val="0"/>
            <c:spPr>
              <a:solidFill>
                <a:schemeClr val="accent2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7-2A71-4F4D-90B2-6709EC50468A}"/>
              </c:ext>
            </c:extLst>
          </c:dPt>
          <c:dPt>
            <c:idx val="44"/>
            <c:bubble3D val="0"/>
            <c:spPr>
              <a:solidFill>
                <a:schemeClr val="accent3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9-2A71-4F4D-90B2-6709EC50468A}"/>
              </c:ext>
            </c:extLst>
          </c:dPt>
          <c:dPt>
            <c:idx val="45"/>
            <c:bubble3D val="0"/>
            <c:spPr>
              <a:solidFill>
                <a:schemeClr val="accent4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B-2A71-4F4D-90B2-6709EC50468A}"/>
              </c:ext>
            </c:extLst>
          </c:dPt>
          <c:dPt>
            <c:idx val="46"/>
            <c:bubble3D val="0"/>
            <c:spPr>
              <a:solidFill>
                <a:schemeClr val="accent5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D-2A71-4F4D-90B2-6709EC50468A}"/>
              </c:ext>
            </c:extLst>
          </c:dPt>
          <c:dPt>
            <c:idx val="47"/>
            <c:bubble3D val="0"/>
            <c:spPr>
              <a:solidFill>
                <a:schemeClr val="accent6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F-2A71-4F4D-90B2-6709EC50468A}"/>
              </c:ext>
            </c:extLst>
          </c:dPt>
          <c:dPt>
            <c:idx val="48"/>
            <c:bubble3D val="0"/>
            <c:spPr>
              <a:solidFill>
                <a:schemeClr val="accent1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1-2A71-4F4D-90B2-6709EC50468A}"/>
              </c:ext>
            </c:extLst>
          </c:dPt>
          <c:dPt>
            <c:idx val="49"/>
            <c:bubble3D val="0"/>
            <c:spPr>
              <a:solidFill>
                <a:schemeClr val="accent2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3-2A71-4F4D-90B2-6709EC50468A}"/>
              </c:ext>
            </c:extLst>
          </c:dPt>
          <c:dPt>
            <c:idx val="50"/>
            <c:bubble3D val="0"/>
            <c:spPr>
              <a:solidFill>
                <a:schemeClr val="accent3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5-2A71-4F4D-90B2-6709EC50468A}"/>
              </c:ext>
            </c:extLst>
          </c:dPt>
          <c:dPt>
            <c:idx val="51"/>
            <c:bubble3D val="0"/>
            <c:spPr>
              <a:solidFill>
                <a:schemeClr val="accent4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7-2A71-4F4D-90B2-6709EC50468A}"/>
              </c:ext>
            </c:extLst>
          </c:dPt>
          <c:dPt>
            <c:idx val="52"/>
            <c:bubble3D val="0"/>
            <c:spPr>
              <a:solidFill>
                <a:schemeClr val="accent5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9-2A71-4F4D-90B2-6709EC50468A}"/>
              </c:ext>
            </c:extLst>
          </c:dPt>
          <c:dPt>
            <c:idx val="53"/>
            <c:bubble3D val="0"/>
            <c:spPr>
              <a:solidFill>
                <a:schemeClr val="accent6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B-2A71-4F4D-90B2-6709EC50468A}"/>
              </c:ext>
            </c:extLst>
          </c:dPt>
          <c:dPt>
            <c:idx val="54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D-2A71-4F4D-90B2-6709EC50468A}"/>
              </c:ext>
            </c:extLst>
          </c:dPt>
          <c:dPt>
            <c:idx val="55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F-2A71-4F4D-90B2-6709EC50468A}"/>
              </c:ext>
            </c:extLst>
          </c:dPt>
          <c:dPt>
            <c:idx val="56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1-2A71-4F4D-90B2-6709EC50468A}"/>
              </c:ext>
            </c:extLst>
          </c:dPt>
          <c:dPt>
            <c:idx val="57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3-2A71-4F4D-90B2-6709EC50468A}"/>
              </c:ext>
            </c:extLst>
          </c:dPt>
          <c:dPt>
            <c:idx val="58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5-2A71-4F4D-90B2-6709EC50468A}"/>
              </c:ext>
            </c:extLst>
          </c:dPt>
          <c:dPt>
            <c:idx val="59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7-2A71-4F4D-90B2-6709EC50468A}"/>
              </c:ext>
            </c:extLst>
          </c:dPt>
          <c:dPt>
            <c:idx val="60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9-2A71-4F4D-90B2-6709EC50468A}"/>
              </c:ext>
            </c:extLst>
          </c:dPt>
          <c:dPt>
            <c:idx val="61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B-2A71-4F4D-90B2-6709EC50468A}"/>
              </c:ext>
            </c:extLst>
          </c:dPt>
          <c:dPt>
            <c:idx val="62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D-2A71-4F4D-90B2-6709EC50468A}"/>
              </c:ext>
            </c:extLst>
          </c:dPt>
          <c:dPt>
            <c:idx val="63"/>
            <c:bubble3D val="0"/>
            <c:spPr>
              <a:solidFill>
                <a:schemeClr val="accent4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F-2A71-4F4D-90B2-6709EC50468A}"/>
              </c:ext>
            </c:extLst>
          </c:dPt>
          <c:dPt>
            <c:idx val="64"/>
            <c:bubble3D val="0"/>
            <c:spPr>
              <a:solidFill>
                <a:schemeClr val="accent5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1-2A71-4F4D-90B2-6709EC50468A}"/>
              </c:ext>
            </c:extLst>
          </c:dPt>
          <c:dPt>
            <c:idx val="65"/>
            <c:bubble3D val="0"/>
            <c:spPr>
              <a:solidFill>
                <a:schemeClr val="accent6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3-2A71-4F4D-90B2-6709EC50468A}"/>
              </c:ext>
            </c:extLst>
          </c:dPt>
          <c:dPt>
            <c:idx val="66"/>
            <c:bubble3D val="0"/>
            <c:spPr>
              <a:solidFill>
                <a:schemeClr val="accent1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5-2A71-4F4D-90B2-6709EC50468A}"/>
              </c:ext>
            </c:extLst>
          </c:dPt>
          <c:dPt>
            <c:idx val="67"/>
            <c:bubble3D val="0"/>
            <c:spPr>
              <a:solidFill>
                <a:schemeClr val="accent2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7-2A71-4F4D-90B2-6709EC50468A}"/>
              </c:ext>
            </c:extLst>
          </c:dPt>
          <c:dPt>
            <c:idx val="68"/>
            <c:bubble3D val="0"/>
            <c:spPr>
              <a:solidFill>
                <a:schemeClr val="accent3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9-2A71-4F4D-90B2-6709EC50468A}"/>
              </c:ext>
            </c:extLst>
          </c:dPt>
          <c:dPt>
            <c:idx val="69"/>
            <c:bubble3D val="0"/>
            <c:spPr>
              <a:solidFill>
                <a:schemeClr val="accent4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B-2A71-4F4D-90B2-6709EC50468A}"/>
              </c:ext>
            </c:extLst>
          </c:dPt>
          <c:dPt>
            <c:idx val="70"/>
            <c:bubble3D val="0"/>
            <c:spPr>
              <a:solidFill>
                <a:schemeClr val="accent5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D-2A71-4F4D-90B2-6709EC50468A}"/>
              </c:ext>
            </c:extLst>
          </c:dPt>
          <c:dPt>
            <c:idx val="71"/>
            <c:bubble3D val="0"/>
            <c:spPr>
              <a:solidFill>
                <a:schemeClr val="accent6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F-2A71-4F4D-90B2-6709EC50468A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pPr>
                <a:endParaRPr lang="en-US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ND1_CONSENSUS_PHYLOGENY_HISTG_!$A$2:$A$73</c:f>
              <c:strCache>
                <c:ptCount val="72"/>
                <c:pt idx="0">
                  <c:v> ***  # ND1_FSANP_TRIMALA_DNA_UB #  *** </c:v>
                </c:pt>
                <c:pt idx="1">
                  <c:v> ***  # ND1_FSANP_TRIMALG_DNA_UB #  *** </c:v>
                </c:pt>
                <c:pt idx="2">
                  <c:v> ***  # ND1_MAFFTEI_TCSFMf_DEG_UB #  *** </c:v>
                </c:pt>
                <c:pt idx="3">
                  <c:v> ***  # ND1_MAFFTF2_GBLOCKSC_DNA_UB #  *** </c:v>
                </c:pt>
                <c:pt idx="4">
                  <c:v> ***  # ND1_OPAL_MAXALIGN_DNA_UB #  *** </c:v>
                </c:pt>
                <c:pt idx="5">
                  <c:v> ***  # ND1_OPAL_MAXALIGN_RYt_UB #  *** </c:v>
                </c:pt>
                <c:pt idx="6">
                  <c:v> ***  # ND1_OPAL_TCSFMf_DNA_UB #  *** </c:v>
                </c:pt>
                <c:pt idx="7">
                  <c:v> ***  # ND1_OPAL_TCSFMf_RYt_UB #  *** </c:v>
                </c:pt>
                <c:pt idx="8">
                  <c:v> ***  # ND1_OPAL_TCSOGw_DNA_UB #  *** </c:v>
                </c:pt>
                <c:pt idx="9">
                  <c:v> ***  # ND1_OPAL_TCSf_DNA_UB #  *** </c:v>
                </c:pt>
                <c:pt idx="10">
                  <c:v> ***  # ND1_OPAL_TCSf_RYt_UB #  *** </c:v>
                </c:pt>
                <c:pt idx="11">
                  <c:v> ***  # ND1_OPAL_TRIMAL_DNA_UB #  *** </c:v>
                </c:pt>
                <c:pt idx="12">
                  <c:v> ***  # ND1_OPAL_TRIMAL_RYt_UB #  *** </c:v>
                </c:pt>
                <c:pt idx="13">
                  <c:v> ***  # ND1_PRANKCD_TCSw_RYt_UB #  *** </c:v>
                </c:pt>
                <c:pt idx="14">
                  <c:v> ***  # ND1_PROBCONS_GBLOCKSC_RYt_UB #  *** </c:v>
                </c:pt>
                <c:pt idx="15">
                  <c:v> ***  # ND1_TCOFFEEPL_TCSFMw_DNA_UB #  *** </c:v>
                </c:pt>
                <c:pt idx="16">
                  <c:v> ***  # ND1_TCOFFEEPL_TCSFMw_RYt_UB #  *** </c:v>
                </c:pt>
                <c:pt idx="17">
                  <c:v> ***  # ND1_TCOFFEETC_TCSFMw_DNA_UB #  *** </c:v>
                </c:pt>
                <c:pt idx="18">
                  <c:v> ***  # ND1_TCOFFEETC_TCSFMw_RYt_UB #  *** </c:v>
                </c:pt>
                <c:pt idx="19">
                  <c:v> ***  # ND1_TCOFFEE_PSARALIGN_DNA_UB #  *** </c:v>
                </c:pt>
                <c:pt idx="20">
                  <c:v> ***  # ND1_TCOFFEE_TCSFMw_DEG_UB #  *** </c:v>
                </c:pt>
                <c:pt idx="21">
                  <c:v> ***  # ND1_TCOFFEE_TCSFMw_DNA_UB #  *** </c:v>
                </c:pt>
                <c:pt idx="22">
                  <c:v> ***  # ND1_TCOFFEE_TCSFMw_RYt_UB #  *** </c:v>
                </c:pt>
                <c:pt idx="23">
                  <c:v> *** ND1_ALL_TRIMALC_DNA_UB *** </c:v>
                </c:pt>
                <c:pt idx="24">
                  <c:v> *** ND1_ALL_TRIMALC_RYt_UB *** </c:v>
                </c:pt>
                <c:pt idx="25">
                  <c:v> *** ND1_ALL_WEAVEALIGN_DNA_UB *** </c:v>
                </c:pt>
                <c:pt idx="26">
                  <c:v> *** ND1_ALL_WEAVEALIGN_RYt_UB *** </c:v>
                </c:pt>
                <c:pt idx="27">
                  <c:v> ***  # ND1_FSANP_TRIMALA_RYt_UB #  *** </c:v>
                </c:pt>
                <c:pt idx="28">
                  <c:v> ***  # ND1_FSANP_TRIMALG_RYt_UB #  *** </c:v>
                </c:pt>
                <c:pt idx="29">
                  <c:v> ***  # ND1_PRANKCDO_TCSw_DEG_UB #  *** </c:v>
                </c:pt>
                <c:pt idx="30">
                  <c:v> ***  # ND1_FSANP_TRIMALA_DEG_UB #  *** </c:v>
                </c:pt>
                <c:pt idx="31">
                  <c:v> ***  # ND1_FSANP_TRIMALG_DEG_UB #  *** </c:v>
                </c:pt>
                <c:pt idx="32">
                  <c:v> *** ND1_ALL_MERGEALIGN_DEG_UB *** </c:v>
                </c:pt>
                <c:pt idx="33">
                  <c:v> ***  # ND1_MAFFT_GBLOCKSC_DEG_UB #  *** </c:v>
                </c:pt>
                <c:pt idx="34">
                  <c:v> ***  # ND1_PRANKO_TCSw_DNA_UB #  *** </c:v>
                </c:pt>
                <c:pt idx="35">
                  <c:v> ***  # ND1_OPAL_PSARALIGN_CDN_UB #  *** </c:v>
                </c:pt>
                <c:pt idx="36">
                  <c:v> ***  # ND1_TCOFFEEPL_GBLOCKS_DEG_UB #  *** </c:v>
                </c:pt>
                <c:pt idx="37">
                  <c:v> ***  # ND1_TCOFFEETC_GBLOCKS_DEG_UB #  *** </c:v>
                </c:pt>
                <c:pt idx="38">
                  <c:v> ***  # ND1_OPAL_PSARALIGN_2AA_UB #  *** </c:v>
                </c:pt>
                <c:pt idx="39">
                  <c:v> ***  # ND1_TCOFFEE_GBLOCKS_DEG_UB #  *** </c:v>
                </c:pt>
                <c:pt idx="40">
                  <c:v> ***  # ND1_TCOFFEEPL_PSARALIGN_RYt_UB #  *** </c:v>
                </c:pt>
                <c:pt idx="41">
                  <c:v> ***  # ND1_MAFFTEI_MAXALIGN_DEG_UB #  *** </c:v>
                </c:pt>
                <c:pt idx="42">
                  <c:v> ***  # ND1_MAFFTEI_TRIMAL_DEG_UB #  *** </c:v>
                </c:pt>
                <c:pt idx="43">
                  <c:v> ***  # ND1_OPAL_TCSf_DEG_UB #  *** </c:v>
                </c:pt>
                <c:pt idx="44">
                  <c:v> ***  # ND1_FSANP_TRIMALA_CDN_UB #  *** </c:v>
                </c:pt>
                <c:pt idx="45">
                  <c:v> ***  # ND1_PRANKCDO_TCSFMf_CDN_UB #  *** </c:v>
                </c:pt>
                <c:pt idx="46">
                  <c:v> ***  # ND1_PRANKCDO_TCSf_CDN_UB #  *** </c:v>
                </c:pt>
                <c:pt idx="47">
                  <c:v> ***  # ND1_MAFFTF1_TRIMALP_DNA_UB #  *** </c:v>
                </c:pt>
                <c:pt idx="48">
                  <c:v> ***  # ND1_PRANKCD_TRIMAL_CDN_UB #  *** </c:v>
                </c:pt>
                <c:pt idx="49">
                  <c:v> ***  # ND1_CLUSTALO_TRIMALS_DEG_UB #  *** </c:v>
                </c:pt>
                <c:pt idx="50">
                  <c:v> ***  # ND1_CLUSTALO_TRIMALS_RYt_UB #  *** </c:v>
                </c:pt>
                <c:pt idx="51">
                  <c:v> ***  # ND1_KALIGN_TRIMALP_RYt_UB #  *** </c:v>
                </c:pt>
                <c:pt idx="52">
                  <c:v> ***  # ND1_MAFFTA_TRIMALP_DEG_UB #  *** </c:v>
                </c:pt>
                <c:pt idx="53">
                  <c:v> *** ND1_ALL_TRIMALC_DEG_UB *** </c:v>
                </c:pt>
                <c:pt idx="54">
                  <c:v> *** ND1_ALL_WEAVEALIGN_DEG_UB *** </c:v>
                </c:pt>
                <c:pt idx="55">
                  <c:v> ***  # ND1_PRANKCDO_TCSf_2AA_UB #  *** </c:v>
                </c:pt>
                <c:pt idx="56">
                  <c:v> ***  # ND1_PRANKF_TRIMALS_DNA_UB #  *** </c:v>
                </c:pt>
                <c:pt idx="57">
                  <c:v> ***  # ND1_MAFFTGI_TCSOGw_DEG_UB #  *** </c:v>
                </c:pt>
                <c:pt idx="58">
                  <c:v> ***  # ND1_FSANP_TRIMALA_2AA_UB #  *** </c:v>
                </c:pt>
                <c:pt idx="59">
                  <c:v> ***  # ND1_FSANP_TRIMALG_2AA_UB #  *** </c:v>
                </c:pt>
                <c:pt idx="60">
                  <c:v> ***  # ND1_OPAL_TCSOGw_RYt_UB #  *** </c:v>
                </c:pt>
                <c:pt idx="61">
                  <c:v> ***  # ND1_PRANKCDO_TRIMAL_2AA_UB #  *** </c:v>
                </c:pt>
                <c:pt idx="62">
                  <c:v> ***  # ND1_PRANKCDO_GBLOCKSC_CDN_UB #  *** </c:v>
                </c:pt>
                <c:pt idx="63">
                  <c:v> ***  # ND1_PRANKCD_TCSFMf_2AA_UB #  *** </c:v>
                </c:pt>
                <c:pt idx="64">
                  <c:v> ***  # ND1_MAFFTGI_NOISY_DNA_UB #  *** </c:v>
                </c:pt>
                <c:pt idx="65">
                  <c:v> ***  # ND1_TCOFFEETC_GBLOCKS_RYt_UB #  *** </c:v>
                </c:pt>
                <c:pt idx="66">
                  <c:v> ***  # ND1_TCOFFEE_GBLOCKS_DNA_UB #  *** </c:v>
                </c:pt>
                <c:pt idx="67">
                  <c:v> ***  # ND1_TCOFFEE_PSARALIGN_DEG_UB #  *** </c:v>
                </c:pt>
                <c:pt idx="68">
                  <c:v> ***  # ND1_FSANP_TRIMALG_CDN_UB #  *** </c:v>
                </c:pt>
                <c:pt idx="69">
                  <c:v> ***  # ND1_PRANKCDO_GBLOCKSC_2AA_UB #  *** </c:v>
                </c:pt>
                <c:pt idx="70">
                  <c:v> ***  # ND1_MAFFTLI_NOISY_DEG_UB #  *** </c:v>
                </c:pt>
                <c:pt idx="71">
                  <c:v> ***  # ND1_MAFFTLI_NOISY_RYt_UB #  *** </c:v>
                </c:pt>
              </c:strCache>
            </c:strRef>
          </c:cat>
          <c:val>
            <c:numRef>
              <c:f>ND1_CONSENSUS_PHYLOGENY_HISTG_!$B$2:$B$73</c:f>
              <c:numCache>
                <c:formatCode>General</c:formatCode>
                <c:ptCount val="72"/>
                <c:pt idx="0">
                  <c:v>536</c:v>
                </c:pt>
                <c:pt idx="1">
                  <c:v>536</c:v>
                </c:pt>
                <c:pt idx="2">
                  <c:v>536</c:v>
                </c:pt>
                <c:pt idx="3">
                  <c:v>536</c:v>
                </c:pt>
                <c:pt idx="4">
                  <c:v>536</c:v>
                </c:pt>
                <c:pt idx="5">
                  <c:v>536</c:v>
                </c:pt>
                <c:pt idx="6">
                  <c:v>536</c:v>
                </c:pt>
                <c:pt idx="7">
                  <c:v>536</c:v>
                </c:pt>
                <c:pt idx="8">
                  <c:v>536</c:v>
                </c:pt>
                <c:pt idx="9">
                  <c:v>536</c:v>
                </c:pt>
                <c:pt idx="10">
                  <c:v>536</c:v>
                </c:pt>
                <c:pt idx="11">
                  <c:v>536</c:v>
                </c:pt>
                <c:pt idx="12">
                  <c:v>536</c:v>
                </c:pt>
                <c:pt idx="13">
                  <c:v>529</c:v>
                </c:pt>
                <c:pt idx="14">
                  <c:v>522</c:v>
                </c:pt>
                <c:pt idx="15">
                  <c:v>491</c:v>
                </c:pt>
                <c:pt idx="16">
                  <c:v>490</c:v>
                </c:pt>
                <c:pt idx="17">
                  <c:v>476</c:v>
                </c:pt>
                <c:pt idx="18">
                  <c:v>475</c:v>
                </c:pt>
                <c:pt idx="19">
                  <c:v>463</c:v>
                </c:pt>
                <c:pt idx="20">
                  <c:v>461</c:v>
                </c:pt>
                <c:pt idx="21">
                  <c:v>460</c:v>
                </c:pt>
                <c:pt idx="22">
                  <c:v>459</c:v>
                </c:pt>
                <c:pt idx="23">
                  <c:v>433</c:v>
                </c:pt>
                <c:pt idx="24">
                  <c:v>433</c:v>
                </c:pt>
                <c:pt idx="25">
                  <c:v>433</c:v>
                </c:pt>
                <c:pt idx="26">
                  <c:v>433</c:v>
                </c:pt>
                <c:pt idx="27">
                  <c:v>85</c:v>
                </c:pt>
                <c:pt idx="28">
                  <c:v>85</c:v>
                </c:pt>
                <c:pt idx="29">
                  <c:v>60</c:v>
                </c:pt>
                <c:pt idx="30">
                  <c:v>51</c:v>
                </c:pt>
                <c:pt idx="31">
                  <c:v>51</c:v>
                </c:pt>
                <c:pt idx="32">
                  <c:v>48</c:v>
                </c:pt>
                <c:pt idx="33">
                  <c:v>39</c:v>
                </c:pt>
                <c:pt idx="34">
                  <c:v>39</c:v>
                </c:pt>
                <c:pt idx="35">
                  <c:v>37</c:v>
                </c:pt>
                <c:pt idx="36">
                  <c:v>36</c:v>
                </c:pt>
                <c:pt idx="37">
                  <c:v>35</c:v>
                </c:pt>
                <c:pt idx="38">
                  <c:v>34</c:v>
                </c:pt>
                <c:pt idx="39">
                  <c:v>34</c:v>
                </c:pt>
                <c:pt idx="40">
                  <c:v>32</c:v>
                </c:pt>
                <c:pt idx="41">
                  <c:v>31</c:v>
                </c:pt>
                <c:pt idx="42">
                  <c:v>31</c:v>
                </c:pt>
                <c:pt idx="43">
                  <c:v>31</c:v>
                </c:pt>
                <c:pt idx="44">
                  <c:v>30</c:v>
                </c:pt>
                <c:pt idx="45">
                  <c:v>30</c:v>
                </c:pt>
                <c:pt idx="46">
                  <c:v>29</c:v>
                </c:pt>
                <c:pt idx="47">
                  <c:v>21</c:v>
                </c:pt>
                <c:pt idx="48">
                  <c:v>20</c:v>
                </c:pt>
                <c:pt idx="49">
                  <c:v>18</c:v>
                </c:pt>
                <c:pt idx="50">
                  <c:v>18</c:v>
                </c:pt>
                <c:pt idx="51">
                  <c:v>18</c:v>
                </c:pt>
                <c:pt idx="52">
                  <c:v>18</c:v>
                </c:pt>
                <c:pt idx="53">
                  <c:v>18</c:v>
                </c:pt>
                <c:pt idx="54">
                  <c:v>18</c:v>
                </c:pt>
                <c:pt idx="55">
                  <c:v>10</c:v>
                </c:pt>
                <c:pt idx="56">
                  <c:v>10</c:v>
                </c:pt>
                <c:pt idx="57">
                  <c:v>9</c:v>
                </c:pt>
                <c:pt idx="58">
                  <c:v>8</c:v>
                </c:pt>
                <c:pt idx="59">
                  <c:v>8</c:v>
                </c:pt>
                <c:pt idx="60">
                  <c:v>7</c:v>
                </c:pt>
                <c:pt idx="61">
                  <c:v>7</c:v>
                </c:pt>
                <c:pt idx="62">
                  <c:v>5</c:v>
                </c:pt>
                <c:pt idx="63">
                  <c:v>5</c:v>
                </c:pt>
                <c:pt idx="64">
                  <c:v>4</c:v>
                </c:pt>
                <c:pt idx="65">
                  <c:v>3</c:v>
                </c:pt>
                <c:pt idx="66">
                  <c:v>3</c:v>
                </c:pt>
                <c:pt idx="67">
                  <c:v>3</c:v>
                </c:pt>
                <c:pt idx="68">
                  <c:v>2</c:v>
                </c:pt>
                <c:pt idx="69">
                  <c:v>2</c:v>
                </c:pt>
                <c:pt idx="70">
                  <c:v>1</c:v>
                </c:pt>
                <c:pt idx="7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90-2A71-4F4D-90B2-6709EC50468A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5823420488453382E-2"/>
          <c:y val="4.0405319332986037E-2"/>
          <c:w val="0.88458764147945768"/>
          <c:h val="0.93637406598037365"/>
        </c:manualLayout>
      </c:layout>
      <c:pieChart>
        <c:varyColors val="1"/>
        <c:ser>
          <c:idx val="0"/>
          <c:order val="0"/>
          <c:tx>
            <c:strRef>
              <c:f>ND2_CONSENSUS_PHYLOGENY_HISTG_!$B$1</c:f>
              <c:strCache>
                <c:ptCount val="1"/>
                <c:pt idx="0">
                  <c:v>Total Topological Support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4BE-4460-9AA4-94A3A74D122B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24BE-4460-9AA4-94A3A74D122B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24BE-4460-9AA4-94A3A74D122B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24BE-4460-9AA4-94A3A74D122B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24BE-4460-9AA4-94A3A74D122B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24BE-4460-9AA4-94A3A74D122B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24BE-4460-9AA4-94A3A74D122B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24BE-4460-9AA4-94A3A74D122B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24BE-4460-9AA4-94A3A74D122B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24BE-4460-9AA4-94A3A74D122B}"/>
              </c:ext>
            </c:extLst>
          </c:dPt>
          <c:dPt>
            <c:idx val="10"/>
            <c:bubble3D val="0"/>
            <c:spPr>
              <a:solidFill>
                <a:schemeClr val="accent5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24BE-4460-9AA4-94A3A74D122B}"/>
              </c:ext>
            </c:extLst>
          </c:dPt>
          <c:dPt>
            <c:idx val="11"/>
            <c:bubble3D val="0"/>
            <c:spPr>
              <a:solidFill>
                <a:schemeClr val="accent6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24BE-4460-9AA4-94A3A74D122B}"/>
              </c:ext>
            </c:extLst>
          </c:dPt>
          <c:dPt>
            <c:idx val="12"/>
            <c:bubble3D val="0"/>
            <c:spPr>
              <a:solidFill>
                <a:schemeClr val="accent1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24BE-4460-9AA4-94A3A74D122B}"/>
              </c:ext>
            </c:extLst>
          </c:dPt>
          <c:dPt>
            <c:idx val="13"/>
            <c:bubble3D val="0"/>
            <c:spPr>
              <a:solidFill>
                <a:schemeClr val="accent2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24BE-4460-9AA4-94A3A74D122B}"/>
              </c:ext>
            </c:extLst>
          </c:dPt>
          <c:dPt>
            <c:idx val="14"/>
            <c:bubble3D val="0"/>
            <c:spPr>
              <a:solidFill>
                <a:schemeClr val="accent3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24BE-4460-9AA4-94A3A74D122B}"/>
              </c:ext>
            </c:extLst>
          </c:dPt>
          <c:dPt>
            <c:idx val="15"/>
            <c:bubble3D val="0"/>
            <c:spPr>
              <a:solidFill>
                <a:schemeClr val="accent4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F-24BE-4460-9AA4-94A3A74D122B}"/>
              </c:ext>
            </c:extLst>
          </c:dPt>
          <c:dPt>
            <c:idx val="16"/>
            <c:bubble3D val="0"/>
            <c:spPr>
              <a:solidFill>
                <a:schemeClr val="accent5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1-24BE-4460-9AA4-94A3A74D122B}"/>
              </c:ext>
            </c:extLst>
          </c:dPt>
          <c:dPt>
            <c:idx val="17"/>
            <c:bubble3D val="0"/>
            <c:spPr>
              <a:solidFill>
                <a:schemeClr val="accent6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3-24BE-4460-9AA4-94A3A74D122B}"/>
              </c:ext>
            </c:extLst>
          </c:dPt>
          <c:dPt>
            <c:idx val="18"/>
            <c:bubble3D val="0"/>
            <c:spPr>
              <a:solidFill>
                <a:schemeClr val="accent1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5-24BE-4460-9AA4-94A3A74D122B}"/>
              </c:ext>
            </c:extLst>
          </c:dPt>
          <c:dPt>
            <c:idx val="19"/>
            <c:bubble3D val="0"/>
            <c:spPr>
              <a:solidFill>
                <a:schemeClr val="accent2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7-24BE-4460-9AA4-94A3A74D122B}"/>
              </c:ext>
            </c:extLst>
          </c:dPt>
          <c:dPt>
            <c:idx val="20"/>
            <c:bubble3D val="0"/>
            <c:spPr>
              <a:solidFill>
                <a:schemeClr val="accent3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9-24BE-4460-9AA4-94A3A74D122B}"/>
              </c:ext>
            </c:extLst>
          </c:dPt>
          <c:dPt>
            <c:idx val="21"/>
            <c:bubble3D val="0"/>
            <c:spPr>
              <a:solidFill>
                <a:schemeClr val="accent4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B-24BE-4460-9AA4-94A3A74D122B}"/>
              </c:ext>
            </c:extLst>
          </c:dPt>
          <c:dPt>
            <c:idx val="22"/>
            <c:bubble3D val="0"/>
            <c:spPr>
              <a:solidFill>
                <a:schemeClr val="accent5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D-24BE-4460-9AA4-94A3A74D122B}"/>
              </c:ext>
            </c:extLst>
          </c:dPt>
          <c:dPt>
            <c:idx val="23"/>
            <c:bubble3D val="0"/>
            <c:spPr>
              <a:solidFill>
                <a:schemeClr val="accent6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F-24BE-4460-9AA4-94A3A74D122B}"/>
              </c:ext>
            </c:extLst>
          </c:dPt>
          <c:dPt>
            <c:idx val="24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1-24BE-4460-9AA4-94A3A74D122B}"/>
              </c:ext>
            </c:extLst>
          </c:dPt>
          <c:dPt>
            <c:idx val="25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3-24BE-4460-9AA4-94A3A74D122B}"/>
              </c:ext>
            </c:extLst>
          </c:dPt>
          <c:dPt>
            <c:idx val="26"/>
            <c:bubble3D val="0"/>
            <c:spPr>
              <a:solidFill>
                <a:schemeClr val="accent3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5-24BE-4460-9AA4-94A3A74D122B}"/>
              </c:ext>
            </c:extLst>
          </c:dPt>
          <c:dPt>
            <c:idx val="27"/>
            <c:bubble3D val="0"/>
            <c:spPr>
              <a:solidFill>
                <a:schemeClr val="accent4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7-24BE-4460-9AA4-94A3A74D122B}"/>
              </c:ext>
            </c:extLst>
          </c:dPt>
          <c:dPt>
            <c:idx val="28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9-24BE-4460-9AA4-94A3A74D122B}"/>
              </c:ext>
            </c:extLst>
          </c:dPt>
          <c:dPt>
            <c:idx val="29"/>
            <c:bubble3D val="0"/>
            <c:spPr>
              <a:solidFill>
                <a:schemeClr val="accent6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B-24BE-4460-9AA4-94A3A74D122B}"/>
              </c:ext>
            </c:extLst>
          </c:dPt>
          <c:dPt>
            <c:idx val="30"/>
            <c:bubble3D val="0"/>
            <c:spPr>
              <a:solidFill>
                <a:schemeClr val="accent1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D-24BE-4460-9AA4-94A3A74D122B}"/>
              </c:ext>
            </c:extLst>
          </c:dPt>
          <c:dPt>
            <c:idx val="31"/>
            <c:bubble3D val="0"/>
            <c:spPr>
              <a:solidFill>
                <a:schemeClr val="accent2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F-24BE-4460-9AA4-94A3A74D122B}"/>
              </c:ext>
            </c:extLst>
          </c:dPt>
          <c:dPt>
            <c:idx val="32"/>
            <c:bubble3D val="0"/>
            <c:spPr>
              <a:solidFill>
                <a:schemeClr val="accent3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1-24BE-4460-9AA4-94A3A74D122B}"/>
              </c:ext>
            </c:extLst>
          </c:dPt>
          <c:dPt>
            <c:idx val="33"/>
            <c:bubble3D val="0"/>
            <c:spPr>
              <a:solidFill>
                <a:schemeClr val="accent4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3-24BE-4460-9AA4-94A3A74D122B}"/>
              </c:ext>
            </c:extLst>
          </c:dPt>
          <c:dPt>
            <c:idx val="34"/>
            <c:bubble3D val="0"/>
            <c:spPr>
              <a:solidFill>
                <a:schemeClr val="accent5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5-24BE-4460-9AA4-94A3A74D122B}"/>
              </c:ext>
            </c:extLst>
          </c:dPt>
          <c:dPt>
            <c:idx val="35"/>
            <c:bubble3D val="0"/>
            <c:spPr>
              <a:solidFill>
                <a:schemeClr val="accent6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7-24BE-4460-9AA4-94A3A74D122B}"/>
              </c:ext>
            </c:extLst>
          </c:dPt>
          <c:dPt>
            <c:idx val="36"/>
            <c:bubble3D val="0"/>
            <c:spPr>
              <a:solidFill>
                <a:schemeClr val="accent1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9-24BE-4460-9AA4-94A3A74D122B}"/>
              </c:ext>
            </c:extLst>
          </c:dPt>
          <c:dPt>
            <c:idx val="37"/>
            <c:bubble3D val="0"/>
            <c:spPr>
              <a:solidFill>
                <a:schemeClr val="accent2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B-24BE-4460-9AA4-94A3A74D122B}"/>
              </c:ext>
            </c:extLst>
          </c:dPt>
          <c:dPt>
            <c:idx val="38"/>
            <c:bubble3D val="0"/>
            <c:spPr>
              <a:solidFill>
                <a:schemeClr val="accent3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D-24BE-4460-9AA4-94A3A74D122B}"/>
              </c:ext>
            </c:extLst>
          </c:dPt>
          <c:dPt>
            <c:idx val="39"/>
            <c:bubble3D val="0"/>
            <c:spPr>
              <a:solidFill>
                <a:schemeClr val="accent4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F-24BE-4460-9AA4-94A3A74D122B}"/>
              </c:ext>
            </c:extLst>
          </c:dPt>
          <c:dPt>
            <c:idx val="40"/>
            <c:bubble3D val="0"/>
            <c:spPr>
              <a:solidFill>
                <a:schemeClr val="accent5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1-24BE-4460-9AA4-94A3A74D122B}"/>
              </c:ext>
            </c:extLst>
          </c:dPt>
          <c:dPt>
            <c:idx val="41"/>
            <c:bubble3D val="0"/>
            <c:spPr>
              <a:solidFill>
                <a:schemeClr val="accent6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3-24BE-4460-9AA4-94A3A74D122B}"/>
              </c:ext>
            </c:extLst>
          </c:dPt>
          <c:dPt>
            <c:idx val="42"/>
            <c:bubble3D val="0"/>
            <c:spPr>
              <a:solidFill>
                <a:schemeClr val="accent1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5-24BE-4460-9AA4-94A3A74D122B}"/>
              </c:ext>
            </c:extLst>
          </c:dPt>
          <c:dPt>
            <c:idx val="43"/>
            <c:bubble3D val="0"/>
            <c:spPr>
              <a:solidFill>
                <a:schemeClr val="accent2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7-24BE-4460-9AA4-94A3A74D122B}"/>
              </c:ext>
            </c:extLst>
          </c:dPt>
          <c:dPt>
            <c:idx val="44"/>
            <c:bubble3D val="0"/>
            <c:spPr>
              <a:solidFill>
                <a:schemeClr val="accent3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9-24BE-4460-9AA4-94A3A74D122B}"/>
              </c:ext>
            </c:extLst>
          </c:dPt>
          <c:dPt>
            <c:idx val="45"/>
            <c:bubble3D val="0"/>
            <c:spPr>
              <a:solidFill>
                <a:schemeClr val="accent4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B-24BE-4460-9AA4-94A3A74D122B}"/>
              </c:ext>
            </c:extLst>
          </c:dPt>
          <c:dPt>
            <c:idx val="46"/>
            <c:bubble3D val="0"/>
            <c:spPr>
              <a:solidFill>
                <a:schemeClr val="accent5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D-24BE-4460-9AA4-94A3A74D122B}"/>
              </c:ext>
            </c:extLst>
          </c:dPt>
          <c:dPt>
            <c:idx val="47"/>
            <c:bubble3D val="0"/>
            <c:spPr>
              <a:solidFill>
                <a:schemeClr val="accent6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F-24BE-4460-9AA4-94A3A74D122B}"/>
              </c:ext>
            </c:extLst>
          </c:dPt>
          <c:dPt>
            <c:idx val="48"/>
            <c:bubble3D val="0"/>
            <c:spPr>
              <a:solidFill>
                <a:schemeClr val="accent1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1-24BE-4460-9AA4-94A3A74D122B}"/>
              </c:ext>
            </c:extLst>
          </c:dPt>
          <c:dPt>
            <c:idx val="49"/>
            <c:bubble3D val="0"/>
            <c:spPr>
              <a:solidFill>
                <a:schemeClr val="accent2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3-24BE-4460-9AA4-94A3A74D122B}"/>
              </c:ext>
            </c:extLst>
          </c:dPt>
          <c:dPt>
            <c:idx val="50"/>
            <c:bubble3D val="0"/>
            <c:spPr>
              <a:solidFill>
                <a:schemeClr val="accent3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5-24BE-4460-9AA4-94A3A74D122B}"/>
              </c:ext>
            </c:extLst>
          </c:dPt>
          <c:dPt>
            <c:idx val="51"/>
            <c:bubble3D val="0"/>
            <c:spPr>
              <a:solidFill>
                <a:schemeClr val="accent4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7-24BE-4460-9AA4-94A3A74D122B}"/>
              </c:ext>
            </c:extLst>
          </c:dPt>
          <c:dPt>
            <c:idx val="52"/>
            <c:bubble3D val="0"/>
            <c:spPr>
              <a:solidFill>
                <a:schemeClr val="accent5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9-24BE-4460-9AA4-94A3A74D122B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pPr>
                <a:endParaRPr lang="en-US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ND2_CONSENSUS_PHYLOGENY_HISTG_!$A$2:$A$54</c:f>
              <c:strCache>
                <c:ptCount val="53"/>
                <c:pt idx="0">
                  <c:v> ***  # ND2_MAFFTA_TCSOGw_DNA_UB #  *** </c:v>
                </c:pt>
                <c:pt idx="1">
                  <c:v> ***  # ND2_MAFFTA_TCSf_DNA_UB #  *** </c:v>
                </c:pt>
                <c:pt idx="2">
                  <c:v> ***  # ND2_MAFFTLI_PSARALIGN_DNA_UB #  *** </c:v>
                </c:pt>
                <c:pt idx="3">
                  <c:v> ***  # ND2_MAFFTLI_TCSFMf_DNA_UB #  *** </c:v>
                </c:pt>
                <c:pt idx="4">
                  <c:v> *** ND2_ALL_TRIMALC_DNA_UB *** </c:v>
                </c:pt>
                <c:pt idx="5">
                  <c:v> ***  # ND2_TCOFFEETC_TRIMALP_DNA_UB #  *** </c:v>
                </c:pt>
                <c:pt idx="6">
                  <c:v> ***  # ND2_TCOFFEEPL_TCSFMw_DEG_UB #  *** </c:v>
                </c:pt>
                <c:pt idx="7">
                  <c:v> ***  # ND2_MAFFTGI_TRIMALA_DNA_UB #  *** </c:v>
                </c:pt>
                <c:pt idx="8">
                  <c:v> ***  # ND2_MAFFTA_TCSf_CDN_UB #  *** </c:v>
                </c:pt>
                <c:pt idx="9">
                  <c:v> ***  # ND2_MAFFTGI_TCSFMf_CDN_UB #  *** </c:v>
                </c:pt>
                <c:pt idx="10">
                  <c:v> ***  # ND2_MAFFTGI_TRIMALG_DNA_UB #  *** </c:v>
                </c:pt>
                <c:pt idx="11">
                  <c:v> ***  # ND2_MAFFTGI_TRIMALA_CDN_UB #  *** </c:v>
                </c:pt>
                <c:pt idx="12">
                  <c:v> ***  # ND2_MAFFTGI_TRIMAL_CDN_UB #  *** </c:v>
                </c:pt>
                <c:pt idx="13">
                  <c:v> ***  # ND2_MAFFTLI_PSARALIGN_CDN_UB #  *** </c:v>
                </c:pt>
                <c:pt idx="14">
                  <c:v> ***  # ND2_MAFFTLI_TRIMAL_DNA_UB #  *** </c:v>
                </c:pt>
                <c:pt idx="15">
                  <c:v> *** ND2_ALL_WEAVEALIGN_DNA_UB *** </c:v>
                </c:pt>
                <c:pt idx="16">
                  <c:v> *** ND2_ALL_WEAVEALIGN_RYt_UB *** </c:v>
                </c:pt>
                <c:pt idx="17">
                  <c:v> ***  # ND2_MACSE_TCSFMf_RYt_UB #  *** </c:v>
                </c:pt>
                <c:pt idx="18">
                  <c:v> ***  # ND2_MACSE_TRIMAL_RYt_UB #  *** </c:v>
                </c:pt>
                <c:pt idx="19">
                  <c:v> ***  # ND2_TCOFFEEPL_TCSw_DEG_UB #  *** </c:v>
                </c:pt>
                <c:pt idx="20">
                  <c:v> ***  # ND2_TCOFFEEPL_TCSw_DNA_UB #  *** </c:v>
                </c:pt>
                <c:pt idx="21">
                  <c:v> ***  # ND2_TCOFFEEPL_TCSw_RYt_UB #  *** </c:v>
                </c:pt>
                <c:pt idx="22">
                  <c:v> ***  # ND2_TCOFFEETC_TCSFMw_DNA_UB #  *** </c:v>
                </c:pt>
                <c:pt idx="23">
                  <c:v> ***  # ND2_TCOFFEE_TRIMALP_RYt_UB #  *** </c:v>
                </c:pt>
                <c:pt idx="24">
                  <c:v> ***  # ND2_MAFFTEI_PSARALIGN_2AA_UB #  *** </c:v>
                </c:pt>
                <c:pt idx="25">
                  <c:v> ***  # ND2_MAFFTGI_TCSFMf_2AA_UB #  *** </c:v>
                </c:pt>
                <c:pt idx="26">
                  <c:v> ***  # ND2_MACSE_TCSFMf_DEG_UB #  *** </c:v>
                </c:pt>
                <c:pt idx="27">
                  <c:v> ***  # ND2_MAFFTGI_TCSf_2AA_UB #  *** </c:v>
                </c:pt>
                <c:pt idx="28">
                  <c:v> ***  # ND2_MAFFTGI_TRIMALA_2AA_UB #  *** </c:v>
                </c:pt>
                <c:pt idx="29">
                  <c:v> ***  # ND2_MAFFTGI_TRIMALG_2AA_UB #  *** </c:v>
                </c:pt>
                <c:pt idx="30">
                  <c:v> ***  # ND2_MAFFTGI_TRIMAL_2AA_UB #  *** </c:v>
                </c:pt>
                <c:pt idx="31">
                  <c:v> ***  # ND2_TCOFFEEPL_TCSFMw_RYt_UB #  *** </c:v>
                </c:pt>
                <c:pt idx="32">
                  <c:v> ***  # ND2_TCOFFEE_GBLOCKS_DNA_UB #  *** </c:v>
                </c:pt>
                <c:pt idx="33">
                  <c:v> ***  # ND2_MAFFTF1_NOISY_DEG_UB #  *** </c:v>
                </c:pt>
                <c:pt idx="34">
                  <c:v> ***  # ND2_MAFFTF1_NOISY_DNA_UB #  *** </c:v>
                </c:pt>
                <c:pt idx="35">
                  <c:v> ***  # ND2_MAFFTF1_NOISY_RYt_UB #  *** </c:v>
                </c:pt>
                <c:pt idx="36">
                  <c:v> ***  # ND2_MAFFTA_TRIMALG_DEG_UB #  *** </c:v>
                </c:pt>
                <c:pt idx="37">
                  <c:v> ***  # ND2_MAFFTLI_TRIMALA_DEG_UB #  *** </c:v>
                </c:pt>
                <c:pt idx="38">
                  <c:v> ***  # ND2_FSA_TRIMALS_RYt_UB #  *** </c:v>
                </c:pt>
                <c:pt idx="39">
                  <c:v> ***  # ND2_MAFFTLI_GBLOCKSC_CDN_UB #  *** </c:v>
                </c:pt>
                <c:pt idx="40">
                  <c:v> ***  # ND2_CLUSTALW_GBLOCKSC_DNA_UB #  *** </c:v>
                </c:pt>
                <c:pt idx="41">
                  <c:v> ***  # ND2_MAFFTF2_GBLOCKS_DEG_UB #  *** </c:v>
                </c:pt>
                <c:pt idx="42">
                  <c:v> ***  # ND2_TCOFFEEPL_TRIMALP_DEG_UB #  *** </c:v>
                </c:pt>
                <c:pt idx="43">
                  <c:v> ***  # ND2_FSANP_GBLOCKS_RYt_UB #  *** </c:v>
                </c:pt>
                <c:pt idx="44">
                  <c:v> ***  # ND2_MAFFTGI_TRIMALG_CDN_UB #  *** </c:v>
                </c:pt>
                <c:pt idx="45">
                  <c:v> # ND2_CLUSTALO_GBLOCKSC_DEG_UB # </c:v>
                </c:pt>
                <c:pt idx="46">
                  <c:v> # ND2_CLUSTALO_GBLOCKSC_RYt_UB # </c:v>
                </c:pt>
                <c:pt idx="47">
                  <c:v> # ND2_FSA_TRIMALS_DEG_UB # </c:v>
                </c:pt>
                <c:pt idx="48">
                  <c:v> # ND2_FSA_TRIMALS_DNA_UB # </c:v>
                </c:pt>
                <c:pt idx="49">
                  <c:v> # ND2_MACSE_TCSOGw_RYt_UB # </c:v>
                </c:pt>
                <c:pt idx="50">
                  <c:v> # ND2_MAFFTGI_GBLOCKSC_2AA_UB # </c:v>
                </c:pt>
                <c:pt idx="51">
                  <c:v> # ND2_MAFFTGI_TCSOGw_DEG_UB # </c:v>
                </c:pt>
                <c:pt idx="52">
                  <c:v> ***  # ND2_TCOFFEE_TRIMALP_DEG_UB #  *** </c:v>
                </c:pt>
              </c:strCache>
            </c:strRef>
          </c:cat>
          <c:val>
            <c:numRef>
              <c:f>ND2_CONSENSUS_PHYLOGENY_HISTG_!$B$2:$B$54</c:f>
              <c:numCache>
                <c:formatCode>General</c:formatCode>
                <c:ptCount val="53"/>
                <c:pt idx="0">
                  <c:v>249</c:v>
                </c:pt>
                <c:pt idx="1">
                  <c:v>249</c:v>
                </c:pt>
                <c:pt idx="2">
                  <c:v>218</c:v>
                </c:pt>
                <c:pt idx="3">
                  <c:v>216</c:v>
                </c:pt>
                <c:pt idx="4">
                  <c:v>149</c:v>
                </c:pt>
                <c:pt idx="5">
                  <c:v>141</c:v>
                </c:pt>
                <c:pt idx="6">
                  <c:v>66</c:v>
                </c:pt>
                <c:pt idx="7">
                  <c:v>57</c:v>
                </c:pt>
                <c:pt idx="8">
                  <c:v>56</c:v>
                </c:pt>
                <c:pt idx="9">
                  <c:v>55</c:v>
                </c:pt>
                <c:pt idx="10">
                  <c:v>55</c:v>
                </c:pt>
                <c:pt idx="11">
                  <c:v>54</c:v>
                </c:pt>
                <c:pt idx="12">
                  <c:v>53</c:v>
                </c:pt>
                <c:pt idx="13">
                  <c:v>52</c:v>
                </c:pt>
                <c:pt idx="14">
                  <c:v>48</c:v>
                </c:pt>
                <c:pt idx="15">
                  <c:v>45</c:v>
                </c:pt>
                <c:pt idx="16">
                  <c:v>45</c:v>
                </c:pt>
                <c:pt idx="17">
                  <c:v>39</c:v>
                </c:pt>
                <c:pt idx="18">
                  <c:v>39</c:v>
                </c:pt>
                <c:pt idx="19">
                  <c:v>39</c:v>
                </c:pt>
                <c:pt idx="20">
                  <c:v>38</c:v>
                </c:pt>
                <c:pt idx="21">
                  <c:v>37</c:v>
                </c:pt>
                <c:pt idx="22">
                  <c:v>31</c:v>
                </c:pt>
                <c:pt idx="23">
                  <c:v>30</c:v>
                </c:pt>
                <c:pt idx="24">
                  <c:v>27</c:v>
                </c:pt>
                <c:pt idx="25">
                  <c:v>26</c:v>
                </c:pt>
                <c:pt idx="26">
                  <c:v>25</c:v>
                </c:pt>
                <c:pt idx="27">
                  <c:v>25</c:v>
                </c:pt>
                <c:pt idx="28">
                  <c:v>24</c:v>
                </c:pt>
                <c:pt idx="29">
                  <c:v>23</c:v>
                </c:pt>
                <c:pt idx="30">
                  <c:v>22</c:v>
                </c:pt>
                <c:pt idx="31">
                  <c:v>18</c:v>
                </c:pt>
                <c:pt idx="32">
                  <c:v>17</c:v>
                </c:pt>
                <c:pt idx="33">
                  <c:v>9</c:v>
                </c:pt>
                <c:pt idx="34">
                  <c:v>9</c:v>
                </c:pt>
                <c:pt idx="35">
                  <c:v>9</c:v>
                </c:pt>
                <c:pt idx="36">
                  <c:v>6</c:v>
                </c:pt>
                <c:pt idx="37">
                  <c:v>6</c:v>
                </c:pt>
                <c:pt idx="38">
                  <c:v>4</c:v>
                </c:pt>
                <c:pt idx="39">
                  <c:v>4</c:v>
                </c:pt>
                <c:pt idx="40">
                  <c:v>3</c:v>
                </c:pt>
                <c:pt idx="41">
                  <c:v>3</c:v>
                </c:pt>
                <c:pt idx="42">
                  <c:v>2</c:v>
                </c:pt>
                <c:pt idx="43">
                  <c:v>1</c:v>
                </c:pt>
                <c:pt idx="44">
                  <c:v>1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6A-24BE-4460-9AA4-94A3A74D122B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038342381859802"/>
          <c:y val="6.5862105634585721E-2"/>
          <c:w val="0.72913695434189452"/>
          <c:h val="0.88221543094406019"/>
        </c:manualLayout>
      </c:layout>
      <c:pieChart>
        <c:varyColors val="1"/>
        <c:ser>
          <c:idx val="0"/>
          <c:order val="0"/>
          <c:tx>
            <c:strRef>
              <c:f>ND2_CONSENSUS_PHYLOGENY_HISTG_!$B$1</c:f>
              <c:strCache>
                <c:ptCount val="1"/>
                <c:pt idx="0">
                  <c:v>Total Topological Support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822-480F-88A0-4B2EDE0B777C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A822-480F-88A0-4B2EDE0B777C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A822-480F-88A0-4B2EDE0B777C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A822-480F-88A0-4B2EDE0B777C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A822-480F-88A0-4B2EDE0B777C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pPr>
                <a:endParaRPr lang="en-US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ND2_CONSENSUS_PHYLOGENY_HISTG_!$A$2:$A$6</c:f>
              <c:strCache>
                <c:ptCount val="5"/>
                <c:pt idx="0">
                  <c:v> ***  # ND2_MAFFTA_DNA_UB #  *** </c:v>
                </c:pt>
                <c:pt idx="1">
                  <c:v> ***  # ND2_MAFFTGI_CDN_UB #  *** </c:v>
                </c:pt>
                <c:pt idx="2">
                  <c:v> ***  # ND2_MACSE_RYt_UB #  *** </c:v>
                </c:pt>
                <c:pt idx="3">
                  <c:v> ***  # ND2_MAFFTGI_2AA_UB #  *** </c:v>
                </c:pt>
                <c:pt idx="4">
                  <c:v> ***  # ND2_MACSE_DEG_UB #  *** </c:v>
                </c:pt>
              </c:strCache>
            </c:strRef>
          </c:cat>
          <c:val>
            <c:numRef>
              <c:f>ND2_CONSENSUS_PHYLOGENY_HISTG_!$B$2:$B$6</c:f>
              <c:numCache>
                <c:formatCode>General</c:formatCode>
                <c:ptCount val="5"/>
                <c:pt idx="0">
                  <c:v>21</c:v>
                </c:pt>
                <c:pt idx="1">
                  <c:v>9</c:v>
                </c:pt>
                <c:pt idx="2">
                  <c:v>7</c:v>
                </c:pt>
                <c:pt idx="3">
                  <c:v>4</c:v>
                </c:pt>
                <c:pt idx="4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A822-480F-88A0-4B2EDE0B777C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208013802743934"/>
          <c:y val="5.8469248175900615E-2"/>
          <c:w val="0.75230058286093238"/>
          <c:h val="0.91024214169361428"/>
        </c:manualLayout>
      </c:layout>
      <c:pieChart>
        <c:varyColors val="1"/>
        <c:ser>
          <c:idx val="0"/>
          <c:order val="0"/>
          <c:tx>
            <c:strRef>
              <c:f>ND3_CONSENSUS_PHYLOGENY_HISTG_!$B$1</c:f>
              <c:strCache>
                <c:ptCount val="1"/>
                <c:pt idx="0">
                  <c:v>Total Topological Support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EAB6-4489-96B1-FF7764C67730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EAB6-4489-96B1-FF7764C67730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EAB6-4489-96B1-FF7764C67730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EAB6-4489-96B1-FF7764C67730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EAB6-4489-96B1-FF7764C67730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pPr>
                <a:endParaRPr lang="en-US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ND3_CONSENSUS_PHYLOGENY_HISTG_!$A$2:$A$6</c:f>
              <c:strCache>
                <c:ptCount val="5"/>
                <c:pt idx="0">
                  <c:v> ***  # ND3_OPAL_DNA_UB #  *** </c:v>
                </c:pt>
                <c:pt idx="1">
                  <c:v> ***  # ND3_PROBCONS_2AA_UB #  *** </c:v>
                </c:pt>
                <c:pt idx="2">
                  <c:v> ***  # ND3_CLUSTALW_RYt_UB #  *** </c:v>
                </c:pt>
                <c:pt idx="3">
                  <c:v> ***  # ND3_MACSE_DEG_UB #  *** </c:v>
                </c:pt>
                <c:pt idx="4">
                  <c:v> # ND3_MAFFTGI_CDN_UB # </c:v>
                </c:pt>
              </c:strCache>
            </c:strRef>
          </c:cat>
          <c:val>
            <c:numRef>
              <c:f>ND3_CONSENSUS_PHYLOGENY_HISTG_!$B$2:$B$6</c:f>
              <c:numCache>
                <c:formatCode>General</c:formatCode>
                <c:ptCount val="5"/>
                <c:pt idx="0">
                  <c:v>6</c:v>
                </c:pt>
                <c:pt idx="1">
                  <c:v>5</c:v>
                </c:pt>
                <c:pt idx="2">
                  <c:v>3</c:v>
                </c:pt>
                <c:pt idx="3">
                  <c:v>2</c:v>
                </c:pt>
                <c:pt idx="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EAB6-4489-96B1-FF7764C67730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1678870253027891E-2"/>
          <c:y val="3.3731609700737748E-2"/>
          <c:w val="0.84739626245938593"/>
          <c:h val="0.94452358039480533"/>
        </c:manualLayout>
      </c:layout>
      <c:pieChart>
        <c:varyColors val="1"/>
        <c:ser>
          <c:idx val="0"/>
          <c:order val="0"/>
          <c:tx>
            <c:strRef>
              <c:f>ND3_CONSENSUS_PHYLOGENY_HISTG_!$B$1</c:f>
              <c:strCache>
                <c:ptCount val="1"/>
                <c:pt idx="0">
                  <c:v>Total Topological Support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BA0D-4897-9952-1F54F03B888A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BA0D-4897-9952-1F54F03B888A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BA0D-4897-9952-1F54F03B888A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BA0D-4897-9952-1F54F03B888A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BA0D-4897-9952-1F54F03B888A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BA0D-4897-9952-1F54F03B888A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BA0D-4897-9952-1F54F03B888A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BA0D-4897-9952-1F54F03B888A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BA0D-4897-9952-1F54F03B888A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BA0D-4897-9952-1F54F03B888A}"/>
              </c:ext>
            </c:extLst>
          </c:dPt>
          <c:dPt>
            <c:idx val="10"/>
            <c:bubble3D val="0"/>
            <c:spPr>
              <a:solidFill>
                <a:schemeClr val="accent5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BA0D-4897-9952-1F54F03B888A}"/>
              </c:ext>
            </c:extLst>
          </c:dPt>
          <c:dPt>
            <c:idx val="11"/>
            <c:bubble3D val="0"/>
            <c:spPr>
              <a:solidFill>
                <a:schemeClr val="accent6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BA0D-4897-9952-1F54F03B888A}"/>
              </c:ext>
            </c:extLst>
          </c:dPt>
          <c:dPt>
            <c:idx val="12"/>
            <c:bubble3D val="0"/>
            <c:spPr>
              <a:solidFill>
                <a:schemeClr val="accent1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BA0D-4897-9952-1F54F03B888A}"/>
              </c:ext>
            </c:extLst>
          </c:dPt>
          <c:dPt>
            <c:idx val="13"/>
            <c:bubble3D val="0"/>
            <c:spPr>
              <a:solidFill>
                <a:schemeClr val="accent2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BA0D-4897-9952-1F54F03B888A}"/>
              </c:ext>
            </c:extLst>
          </c:dPt>
          <c:dPt>
            <c:idx val="14"/>
            <c:bubble3D val="0"/>
            <c:spPr>
              <a:solidFill>
                <a:schemeClr val="accent3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BA0D-4897-9952-1F54F03B888A}"/>
              </c:ext>
            </c:extLst>
          </c:dPt>
          <c:dPt>
            <c:idx val="15"/>
            <c:bubble3D val="0"/>
            <c:spPr>
              <a:solidFill>
                <a:schemeClr val="accent4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F-BA0D-4897-9952-1F54F03B888A}"/>
              </c:ext>
            </c:extLst>
          </c:dPt>
          <c:dPt>
            <c:idx val="16"/>
            <c:bubble3D val="0"/>
            <c:spPr>
              <a:solidFill>
                <a:schemeClr val="accent5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1-BA0D-4897-9952-1F54F03B888A}"/>
              </c:ext>
            </c:extLst>
          </c:dPt>
          <c:dPt>
            <c:idx val="17"/>
            <c:bubble3D val="0"/>
            <c:spPr>
              <a:solidFill>
                <a:schemeClr val="accent6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3-BA0D-4897-9952-1F54F03B888A}"/>
              </c:ext>
            </c:extLst>
          </c:dPt>
          <c:dPt>
            <c:idx val="18"/>
            <c:bubble3D val="0"/>
            <c:spPr>
              <a:solidFill>
                <a:schemeClr val="accent1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5-BA0D-4897-9952-1F54F03B888A}"/>
              </c:ext>
            </c:extLst>
          </c:dPt>
          <c:dPt>
            <c:idx val="19"/>
            <c:bubble3D val="0"/>
            <c:spPr>
              <a:solidFill>
                <a:schemeClr val="accent2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7-BA0D-4897-9952-1F54F03B888A}"/>
              </c:ext>
            </c:extLst>
          </c:dPt>
          <c:dPt>
            <c:idx val="20"/>
            <c:bubble3D val="0"/>
            <c:spPr>
              <a:solidFill>
                <a:schemeClr val="accent3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9-BA0D-4897-9952-1F54F03B888A}"/>
              </c:ext>
            </c:extLst>
          </c:dPt>
          <c:dPt>
            <c:idx val="21"/>
            <c:bubble3D val="0"/>
            <c:spPr>
              <a:solidFill>
                <a:schemeClr val="accent4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B-BA0D-4897-9952-1F54F03B888A}"/>
              </c:ext>
            </c:extLst>
          </c:dPt>
          <c:dPt>
            <c:idx val="22"/>
            <c:bubble3D val="0"/>
            <c:spPr>
              <a:solidFill>
                <a:schemeClr val="accent5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D-BA0D-4897-9952-1F54F03B888A}"/>
              </c:ext>
            </c:extLst>
          </c:dPt>
          <c:dPt>
            <c:idx val="23"/>
            <c:bubble3D val="0"/>
            <c:spPr>
              <a:solidFill>
                <a:schemeClr val="accent6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F-BA0D-4897-9952-1F54F03B888A}"/>
              </c:ext>
            </c:extLst>
          </c:dPt>
          <c:dPt>
            <c:idx val="24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1-BA0D-4897-9952-1F54F03B888A}"/>
              </c:ext>
            </c:extLst>
          </c:dPt>
          <c:dPt>
            <c:idx val="25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3-BA0D-4897-9952-1F54F03B888A}"/>
              </c:ext>
            </c:extLst>
          </c:dPt>
          <c:dPt>
            <c:idx val="26"/>
            <c:bubble3D val="0"/>
            <c:spPr>
              <a:solidFill>
                <a:schemeClr val="accent3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5-BA0D-4897-9952-1F54F03B888A}"/>
              </c:ext>
            </c:extLst>
          </c:dPt>
          <c:dPt>
            <c:idx val="27"/>
            <c:bubble3D val="0"/>
            <c:spPr>
              <a:solidFill>
                <a:schemeClr val="accent4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7-BA0D-4897-9952-1F54F03B888A}"/>
              </c:ext>
            </c:extLst>
          </c:dPt>
          <c:dPt>
            <c:idx val="28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9-BA0D-4897-9952-1F54F03B888A}"/>
              </c:ext>
            </c:extLst>
          </c:dPt>
          <c:dPt>
            <c:idx val="29"/>
            <c:bubble3D val="0"/>
            <c:spPr>
              <a:solidFill>
                <a:schemeClr val="accent6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B-BA0D-4897-9952-1F54F03B888A}"/>
              </c:ext>
            </c:extLst>
          </c:dPt>
          <c:dPt>
            <c:idx val="30"/>
            <c:bubble3D val="0"/>
            <c:spPr>
              <a:solidFill>
                <a:schemeClr val="accent1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D-BA0D-4897-9952-1F54F03B888A}"/>
              </c:ext>
            </c:extLst>
          </c:dPt>
          <c:dPt>
            <c:idx val="31"/>
            <c:bubble3D val="0"/>
            <c:spPr>
              <a:solidFill>
                <a:schemeClr val="accent2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F-BA0D-4897-9952-1F54F03B888A}"/>
              </c:ext>
            </c:extLst>
          </c:dPt>
          <c:dPt>
            <c:idx val="32"/>
            <c:bubble3D val="0"/>
            <c:spPr>
              <a:solidFill>
                <a:schemeClr val="accent3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1-BA0D-4897-9952-1F54F03B888A}"/>
              </c:ext>
            </c:extLst>
          </c:dPt>
          <c:dPt>
            <c:idx val="33"/>
            <c:bubble3D val="0"/>
            <c:spPr>
              <a:solidFill>
                <a:schemeClr val="accent4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3-BA0D-4897-9952-1F54F03B888A}"/>
              </c:ext>
            </c:extLst>
          </c:dPt>
          <c:dPt>
            <c:idx val="34"/>
            <c:bubble3D val="0"/>
            <c:spPr>
              <a:solidFill>
                <a:schemeClr val="accent5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5-BA0D-4897-9952-1F54F03B888A}"/>
              </c:ext>
            </c:extLst>
          </c:dPt>
          <c:dPt>
            <c:idx val="35"/>
            <c:bubble3D val="0"/>
            <c:spPr>
              <a:solidFill>
                <a:schemeClr val="accent6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7-BA0D-4897-9952-1F54F03B888A}"/>
              </c:ext>
            </c:extLst>
          </c:dPt>
          <c:dPt>
            <c:idx val="36"/>
            <c:bubble3D val="0"/>
            <c:spPr>
              <a:solidFill>
                <a:schemeClr val="accent1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9-BA0D-4897-9952-1F54F03B888A}"/>
              </c:ext>
            </c:extLst>
          </c:dPt>
          <c:dPt>
            <c:idx val="37"/>
            <c:bubble3D val="0"/>
            <c:spPr>
              <a:solidFill>
                <a:schemeClr val="accent2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B-BA0D-4897-9952-1F54F03B888A}"/>
              </c:ext>
            </c:extLst>
          </c:dPt>
          <c:dPt>
            <c:idx val="38"/>
            <c:bubble3D val="0"/>
            <c:spPr>
              <a:solidFill>
                <a:schemeClr val="accent3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D-BA0D-4897-9952-1F54F03B888A}"/>
              </c:ext>
            </c:extLst>
          </c:dPt>
          <c:dPt>
            <c:idx val="39"/>
            <c:bubble3D val="0"/>
            <c:spPr>
              <a:solidFill>
                <a:schemeClr val="accent4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F-BA0D-4897-9952-1F54F03B888A}"/>
              </c:ext>
            </c:extLst>
          </c:dPt>
          <c:dPt>
            <c:idx val="40"/>
            <c:bubble3D val="0"/>
            <c:spPr>
              <a:solidFill>
                <a:schemeClr val="accent5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1-BA0D-4897-9952-1F54F03B888A}"/>
              </c:ext>
            </c:extLst>
          </c:dPt>
          <c:dPt>
            <c:idx val="41"/>
            <c:bubble3D val="0"/>
            <c:spPr>
              <a:solidFill>
                <a:schemeClr val="accent6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3-BA0D-4897-9952-1F54F03B888A}"/>
              </c:ext>
            </c:extLst>
          </c:dPt>
          <c:dPt>
            <c:idx val="42"/>
            <c:bubble3D val="0"/>
            <c:spPr>
              <a:solidFill>
                <a:schemeClr val="accent1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5-BA0D-4897-9952-1F54F03B888A}"/>
              </c:ext>
            </c:extLst>
          </c:dPt>
          <c:dPt>
            <c:idx val="43"/>
            <c:bubble3D val="0"/>
            <c:spPr>
              <a:solidFill>
                <a:schemeClr val="accent2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7-BA0D-4897-9952-1F54F03B888A}"/>
              </c:ext>
            </c:extLst>
          </c:dPt>
          <c:dPt>
            <c:idx val="44"/>
            <c:bubble3D val="0"/>
            <c:spPr>
              <a:solidFill>
                <a:schemeClr val="accent3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9-BA0D-4897-9952-1F54F03B888A}"/>
              </c:ext>
            </c:extLst>
          </c:dPt>
          <c:dPt>
            <c:idx val="45"/>
            <c:bubble3D val="0"/>
            <c:spPr>
              <a:solidFill>
                <a:schemeClr val="accent4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B-BA0D-4897-9952-1F54F03B888A}"/>
              </c:ext>
            </c:extLst>
          </c:dPt>
          <c:dPt>
            <c:idx val="46"/>
            <c:bubble3D val="0"/>
            <c:spPr>
              <a:solidFill>
                <a:schemeClr val="accent5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D-BA0D-4897-9952-1F54F03B888A}"/>
              </c:ext>
            </c:extLst>
          </c:dPt>
          <c:dPt>
            <c:idx val="47"/>
            <c:bubble3D val="0"/>
            <c:spPr>
              <a:solidFill>
                <a:schemeClr val="accent6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F-BA0D-4897-9952-1F54F03B888A}"/>
              </c:ext>
            </c:extLst>
          </c:dPt>
          <c:dPt>
            <c:idx val="48"/>
            <c:bubble3D val="0"/>
            <c:spPr>
              <a:solidFill>
                <a:schemeClr val="accent1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1-BA0D-4897-9952-1F54F03B888A}"/>
              </c:ext>
            </c:extLst>
          </c:dPt>
          <c:dPt>
            <c:idx val="49"/>
            <c:bubble3D val="0"/>
            <c:spPr>
              <a:solidFill>
                <a:schemeClr val="accent2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3-BA0D-4897-9952-1F54F03B888A}"/>
              </c:ext>
            </c:extLst>
          </c:dPt>
          <c:dPt>
            <c:idx val="50"/>
            <c:bubble3D val="0"/>
            <c:spPr>
              <a:solidFill>
                <a:schemeClr val="accent3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5-BA0D-4897-9952-1F54F03B888A}"/>
              </c:ext>
            </c:extLst>
          </c:dPt>
          <c:dPt>
            <c:idx val="51"/>
            <c:bubble3D val="0"/>
            <c:spPr>
              <a:solidFill>
                <a:schemeClr val="accent4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7-BA0D-4897-9952-1F54F03B888A}"/>
              </c:ext>
            </c:extLst>
          </c:dPt>
          <c:dPt>
            <c:idx val="52"/>
            <c:bubble3D val="0"/>
            <c:spPr>
              <a:solidFill>
                <a:schemeClr val="accent5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9-BA0D-4897-9952-1F54F03B888A}"/>
              </c:ext>
            </c:extLst>
          </c:dPt>
          <c:dPt>
            <c:idx val="53"/>
            <c:bubble3D val="0"/>
            <c:spPr>
              <a:solidFill>
                <a:schemeClr val="accent6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B-BA0D-4897-9952-1F54F03B888A}"/>
              </c:ext>
            </c:extLst>
          </c:dPt>
          <c:dPt>
            <c:idx val="54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D-BA0D-4897-9952-1F54F03B888A}"/>
              </c:ext>
            </c:extLst>
          </c:dPt>
          <c:dPt>
            <c:idx val="55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F-BA0D-4897-9952-1F54F03B888A}"/>
              </c:ext>
            </c:extLst>
          </c:dPt>
          <c:dPt>
            <c:idx val="56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1-BA0D-4897-9952-1F54F03B888A}"/>
              </c:ext>
            </c:extLst>
          </c:dPt>
          <c:dPt>
            <c:idx val="57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3-BA0D-4897-9952-1F54F03B888A}"/>
              </c:ext>
            </c:extLst>
          </c:dPt>
          <c:dPt>
            <c:idx val="58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5-BA0D-4897-9952-1F54F03B888A}"/>
              </c:ext>
            </c:extLst>
          </c:dPt>
          <c:dPt>
            <c:idx val="59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7-BA0D-4897-9952-1F54F03B888A}"/>
              </c:ext>
            </c:extLst>
          </c:dPt>
          <c:dPt>
            <c:idx val="60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9-BA0D-4897-9952-1F54F03B888A}"/>
              </c:ext>
            </c:extLst>
          </c:dPt>
          <c:dPt>
            <c:idx val="61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B-BA0D-4897-9952-1F54F03B888A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pPr>
                <a:endParaRPr lang="en-US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ND3_CONSENSUS_PHYLOGENY_HISTG_!$A$2:$A$63</c:f>
              <c:strCache>
                <c:ptCount val="62"/>
                <c:pt idx="0">
                  <c:v> ***  # ND3_CLUSTALO_GBLOCKSC_DEG_UB #  *** </c:v>
                </c:pt>
                <c:pt idx="1">
                  <c:v> ***  # ND3_FSANP_MAXALIGN_DEG_UB #  *** </c:v>
                </c:pt>
                <c:pt idx="2">
                  <c:v> ***  # ND3_FSANP_TCSFMf_DEG_UB #  *** </c:v>
                </c:pt>
                <c:pt idx="3">
                  <c:v> ***  # ND3_FSANP_TRIMAL_DEG_UB #  *** </c:v>
                </c:pt>
                <c:pt idx="4">
                  <c:v> *** ND3_ALL_MERGEALIGN_DEG_UB *** </c:v>
                </c:pt>
                <c:pt idx="5">
                  <c:v> *** ND3_ALL_WEAVEALIGN_DEG_UB *** </c:v>
                </c:pt>
                <c:pt idx="6">
                  <c:v> ***  # ND3_PROBCONS_MAXALIGN_CDN_UB #  *** </c:v>
                </c:pt>
                <c:pt idx="7">
                  <c:v> ***  # ND3_PROBCONS_PSARALIGN_CDN_UB #  *** </c:v>
                </c:pt>
                <c:pt idx="8">
                  <c:v> ***  # ND3_PROBCONS_TCSFMf_CDN_UB #  *** </c:v>
                </c:pt>
                <c:pt idx="9">
                  <c:v> ***  # ND3_PROBCONS_TRIMAL_CDN_UB #  *** </c:v>
                </c:pt>
                <c:pt idx="10">
                  <c:v> ***  # ND3_CLUSTALW_GBLOCKS_DNA_UB #  *** </c:v>
                </c:pt>
                <c:pt idx="11">
                  <c:v> ***  # ND3_MAFFTGI_TCSf_DNA_UB #  *** </c:v>
                </c:pt>
                <c:pt idx="12">
                  <c:v> ***  # ND3_OPAL_TCSFMf_DNA_UB #  *** </c:v>
                </c:pt>
                <c:pt idx="13">
                  <c:v> ***  # ND3_PROBCONS_PSARALIGN_DNA_UB #  *** </c:v>
                </c:pt>
                <c:pt idx="14">
                  <c:v> ***  # ND3_PROBCONS_TRIMAL_DNA_UB #  *** </c:v>
                </c:pt>
                <c:pt idx="15">
                  <c:v> ***  # ND3_CLUSTALO_TCSFMw_DEG_UB #  *** </c:v>
                </c:pt>
                <c:pt idx="16">
                  <c:v> ***  # ND3_GRAMALIGN_TCSFMw_RYt_UB #  *** </c:v>
                </c:pt>
                <c:pt idx="17">
                  <c:v> ***  # ND3_GRAMALIGN_TCSOGw_DNA_UB #  *** </c:v>
                </c:pt>
                <c:pt idx="18">
                  <c:v> ***  # ND3_MAFFTFI_TCSFMw_DNA_UB #  *** </c:v>
                </c:pt>
                <c:pt idx="19">
                  <c:v> ***  # ND3_OPAL_MAXALIGN_DNA_UB #  *** </c:v>
                </c:pt>
                <c:pt idx="20">
                  <c:v> *** ND3_ALL_WEAVEALIGN_DNA_UB *** </c:v>
                </c:pt>
                <c:pt idx="21">
                  <c:v> ***  # ND3_FSA_TRIMALA_2AA_UB #  *** </c:v>
                </c:pt>
                <c:pt idx="22">
                  <c:v> ***  # ND3_MAFFTGI_MAXALIGN_2AA_UB #  *** </c:v>
                </c:pt>
                <c:pt idx="23">
                  <c:v> ***  # ND3_OPAL_PSARALIGN_2AA_UB #  *** </c:v>
                </c:pt>
                <c:pt idx="24">
                  <c:v> ***  # ND3_OPAL_TCSFMf_2AA_UB #  *** </c:v>
                </c:pt>
                <c:pt idx="25">
                  <c:v> ***  # ND3_OPAL_TRIMAL_2AA_UB #  *** </c:v>
                </c:pt>
                <c:pt idx="26">
                  <c:v> ***  # ND3_PROBCONS_TCSf_2AA_UB #  *** </c:v>
                </c:pt>
                <c:pt idx="27">
                  <c:v> *** ND3_ALL_WEAVEALIGN_2AA_UB *** </c:v>
                </c:pt>
                <c:pt idx="28">
                  <c:v> ***  # ND3_CLUSTALW_TRIMAL_RYt_UB #  *** </c:v>
                </c:pt>
                <c:pt idx="29">
                  <c:v> ***  # ND3_FSANP_TCSFMf_RYt_UB #  *** </c:v>
                </c:pt>
                <c:pt idx="30">
                  <c:v> ***  # ND3_FSANP_TCSf_RYt_UB #  *** </c:v>
                </c:pt>
                <c:pt idx="31">
                  <c:v> ***  # ND3_MACSE_GBLOCKSC_RYt_UB #  *** </c:v>
                </c:pt>
                <c:pt idx="32">
                  <c:v> ***  # ND3_MACSE_GBLOCKS_RYt_UB #  *** </c:v>
                </c:pt>
                <c:pt idx="33">
                  <c:v> ***  # ND3_PRANKCD_TRIMALA_CDN_UB #  *** </c:v>
                </c:pt>
                <c:pt idx="34">
                  <c:v> ***  # ND3_PRANKCD_TRIMALG_CDN_UB #  *** </c:v>
                </c:pt>
                <c:pt idx="35">
                  <c:v> ***  # ND3_CLUSTALO_GBLOCKSC_2AA_UB #  *** </c:v>
                </c:pt>
                <c:pt idx="36">
                  <c:v> ***  # ND3_PRANKCD_TRIMALG_2AA_UB #  *** </c:v>
                </c:pt>
                <c:pt idx="37">
                  <c:v> ***  # ND3_FSANP_MAXALIGN_RYt_UB #  *** </c:v>
                </c:pt>
                <c:pt idx="38">
                  <c:v> ***  # ND3_CLUSTALO_TCSw_DEG_UB #  *** </c:v>
                </c:pt>
                <c:pt idx="39">
                  <c:v> ***  # ND3_MAFFTFI_TRIMALS_DNA_UB #  *** </c:v>
                </c:pt>
                <c:pt idx="40">
                  <c:v> ***  # ND3_MAFFTLI_TRIMALP_DNA_UB #  *** </c:v>
                </c:pt>
                <c:pt idx="41">
                  <c:v> ***  # ND3_MACSE_PSARALIGN_RYt_UB #  *** </c:v>
                </c:pt>
                <c:pt idx="42">
                  <c:v> ***  # ND3_CLUSTALW_TCSw_DNA_UB #  *** </c:v>
                </c:pt>
                <c:pt idx="43">
                  <c:v> ***  # ND3_CLUSTALW_TCSw_RYt_UB #  *** </c:v>
                </c:pt>
                <c:pt idx="44">
                  <c:v> ***  # ND3_MAFFTEI_TRIMALS_DEG_UB #  *** </c:v>
                </c:pt>
                <c:pt idx="45">
                  <c:v> *** ND3_ALL_WEAVEALIGN_CDN_UB *** </c:v>
                </c:pt>
                <c:pt idx="46">
                  <c:v> ***  # ND3_PROBCONS_TCSOGw_DEG_UB #  *** </c:v>
                </c:pt>
                <c:pt idx="47">
                  <c:v> ***  # ND3_MAFFTEI_GBLOCKSC_CDN_UB #  *** </c:v>
                </c:pt>
                <c:pt idx="48">
                  <c:v> ***  # ND3_MAFFTGI_TCSf_CDN_UB #  *** </c:v>
                </c:pt>
                <c:pt idx="49">
                  <c:v> ***  # ND3_CLUSTALW_TRIMALS_RYt_UB #  *** </c:v>
                </c:pt>
                <c:pt idx="50">
                  <c:v> ***  # ND3_PRANKCD_TRIMALA_DEG_UB #  *** </c:v>
                </c:pt>
                <c:pt idx="51">
                  <c:v> ***  # ND3_PRANKCD_TRIMALG_DEG_UB #  *** </c:v>
                </c:pt>
                <c:pt idx="52">
                  <c:v> ***  # ND3_CLUSTALW_TRIMALP_DEG_UB #  *** </c:v>
                </c:pt>
                <c:pt idx="53">
                  <c:v> ***  # ND3_CLUSTALW_PSARALIGN_DEG_UB #  *** </c:v>
                </c:pt>
                <c:pt idx="54">
                  <c:v> # ND3_GRAMALIGN_TCSOGw_RYt_UB # </c:v>
                </c:pt>
                <c:pt idx="55">
                  <c:v> # ND3_PRANKCD_TRIMALA_DNA_UB # </c:v>
                </c:pt>
                <c:pt idx="56">
                  <c:v> # ND3_PRANKCD_TRIMALG_DNA_UB # </c:v>
                </c:pt>
                <c:pt idx="57">
                  <c:v> # ND3_PRANKF_NOISY_DEG_UB # </c:v>
                </c:pt>
                <c:pt idx="58">
                  <c:v> # ND3_PRANKF_NOISY_DNA_UB # </c:v>
                </c:pt>
                <c:pt idx="59">
                  <c:v> # ND3_PRANKF_NOISY_RYt_UB # </c:v>
                </c:pt>
                <c:pt idx="60">
                  <c:v> # ND3_PRANKF_TRIMALA_RYt_UB # </c:v>
                </c:pt>
                <c:pt idx="61">
                  <c:v> # ND3_PRANKF_TRIMALG_RYt_UB # </c:v>
                </c:pt>
              </c:strCache>
            </c:strRef>
          </c:cat>
          <c:val>
            <c:numRef>
              <c:f>ND3_CONSENSUS_PHYLOGENY_HISTG_!$B$2:$B$63</c:f>
              <c:numCache>
                <c:formatCode>General</c:formatCode>
                <c:ptCount val="62"/>
                <c:pt idx="0">
                  <c:v>123</c:v>
                </c:pt>
                <c:pt idx="1">
                  <c:v>123</c:v>
                </c:pt>
                <c:pt idx="2">
                  <c:v>123</c:v>
                </c:pt>
                <c:pt idx="3">
                  <c:v>123</c:v>
                </c:pt>
                <c:pt idx="4">
                  <c:v>122</c:v>
                </c:pt>
                <c:pt idx="5">
                  <c:v>122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98</c:v>
                </c:pt>
                <c:pt idx="11">
                  <c:v>98</c:v>
                </c:pt>
                <c:pt idx="12">
                  <c:v>98</c:v>
                </c:pt>
                <c:pt idx="13">
                  <c:v>98</c:v>
                </c:pt>
                <c:pt idx="14">
                  <c:v>98</c:v>
                </c:pt>
                <c:pt idx="15">
                  <c:v>96</c:v>
                </c:pt>
                <c:pt idx="16">
                  <c:v>96</c:v>
                </c:pt>
                <c:pt idx="17">
                  <c:v>96</c:v>
                </c:pt>
                <c:pt idx="18">
                  <c:v>96</c:v>
                </c:pt>
                <c:pt idx="19">
                  <c:v>96</c:v>
                </c:pt>
                <c:pt idx="20">
                  <c:v>95</c:v>
                </c:pt>
                <c:pt idx="21">
                  <c:v>81</c:v>
                </c:pt>
                <c:pt idx="22">
                  <c:v>81</c:v>
                </c:pt>
                <c:pt idx="23">
                  <c:v>81</c:v>
                </c:pt>
                <c:pt idx="24">
                  <c:v>81</c:v>
                </c:pt>
                <c:pt idx="25">
                  <c:v>81</c:v>
                </c:pt>
                <c:pt idx="26">
                  <c:v>81</c:v>
                </c:pt>
                <c:pt idx="27">
                  <c:v>52</c:v>
                </c:pt>
                <c:pt idx="28">
                  <c:v>46</c:v>
                </c:pt>
                <c:pt idx="29">
                  <c:v>46</c:v>
                </c:pt>
                <c:pt idx="30">
                  <c:v>46</c:v>
                </c:pt>
                <c:pt idx="31">
                  <c:v>46</c:v>
                </c:pt>
                <c:pt idx="32">
                  <c:v>46</c:v>
                </c:pt>
                <c:pt idx="33">
                  <c:v>43</c:v>
                </c:pt>
                <c:pt idx="34">
                  <c:v>43</c:v>
                </c:pt>
                <c:pt idx="35">
                  <c:v>34</c:v>
                </c:pt>
                <c:pt idx="36">
                  <c:v>34</c:v>
                </c:pt>
                <c:pt idx="37">
                  <c:v>33</c:v>
                </c:pt>
                <c:pt idx="38">
                  <c:v>27</c:v>
                </c:pt>
                <c:pt idx="39">
                  <c:v>25</c:v>
                </c:pt>
                <c:pt idx="40">
                  <c:v>25</c:v>
                </c:pt>
                <c:pt idx="41">
                  <c:v>23</c:v>
                </c:pt>
                <c:pt idx="42">
                  <c:v>22</c:v>
                </c:pt>
                <c:pt idx="43">
                  <c:v>13</c:v>
                </c:pt>
                <c:pt idx="44">
                  <c:v>13</c:v>
                </c:pt>
                <c:pt idx="45">
                  <c:v>13</c:v>
                </c:pt>
                <c:pt idx="46">
                  <c:v>12</c:v>
                </c:pt>
                <c:pt idx="47">
                  <c:v>8</c:v>
                </c:pt>
                <c:pt idx="48">
                  <c:v>8</c:v>
                </c:pt>
                <c:pt idx="49">
                  <c:v>7</c:v>
                </c:pt>
                <c:pt idx="50">
                  <c:v>7</c:v>
                </c:pt>
                <c:pt idx="51">
                  <c:v>7</c:v>
                </c:pt>
                <c:pt idx="52">
                  <c:v>6</c:v>
                </c:pt>
                <c:pt idx="53">
                  <c:v>5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7C-BA0D-4897-9952-1F54F03B888A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1660774452828553E-2"/>
          <c:y val="3.8174198355433911E-2"/>
          <c:w val="0.82528161959528745"/>
          <c:h val="0.93338185690780973"/>
        </c:manualLayout>
      </c:layout>
      <c:pieChart>
        <c:varyColors val="1"/>
        <c:ser>
          <c:idx val="0"/>
          <c:order val="0"/>
          <c:tx>
            <c:strRef>
              <c:f>ND4_CONSENSUS_PHYLOGENY_HISTG_!$B$1</c:f>
              <c:strCache>
                <c:ptCount val="1"/>
                <c:pt idx="0">
                  <c:v>Total Topological Support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69F-4B27-B274-715DC9F4C72C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269F-4B27-B274-715DC9F4C72C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269F-4B27-B274-715DC9F4C72C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269F-4B27-B274-715DC9F4C72C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269F-4B27-B274-715DC9F4C72C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269F-4B27-B274-715DC9F4C72C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269F-4B27-B274-715DC9F4C72C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269F-4B27-B274-715DC9F4C72C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269F-4B27-B274-715DC9F4C72C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269F-4B27-B274-715DC9F4C72C}"/>
              </c:ext>
            </c:extLst>
          </c:dPt>
          <c:dPt>
            <c:idx val="10"/>
            <c:bubble3D val="0"/>
            <c:spPr>
              <a:solidFill>
                <a:schemeClr val="accent5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269F-4B27-B274-715DC9F4C72C}"/>
              </c:ext>
            </c:extLst>
          </c:dPt>
          <c:dPt>
            <c:idx val="11"/>
            <c:bubble3D val="0"/>
            <c:spPr>
              <a:solidFill>
                <a:schemeClr val="accent6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269F-4B27-B274-715DC9F4C72C}"/>
              </c:ext>
            </c:extLst>
          </c:dPt>
          <c:dPt>
            <c:idx val="12"/>
            <c:bubble3D val="0"/>
            <c:spPr>
              <a:solidFill>
                <a:schemeClr val="accent1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269F-4B27-B274-715DC9F4C72C}"/>
              </c:ext>
            </c:extLst>
          </c:dPt>
          <c:dPt>
            <c:idx val="13"/>
            <c:bubble3D val="0"/>
            <c:spPr>
              <a:solidFill>
                <a:schemeClr val="accent2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269F-4B27-B274-715DC9F4C72C}"/>
              </c:ext>
            </c:extLst>
          </c:dPt>
          <c:dPt>
            <c:idx val="14"/>
            <c:bubble3D val="0"/>
            <c:spPr>
              <a:solidFill>
                <a:schemeClr val="accent3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269F-4B27-B274-715DC9F4C72C}"/>
              </c:ext>
            </c:extLst>
          </c:dPt>
          <c:dPt>
            <c:idx val="15"/>
            <c:bubble3D val="0"/>
            <c:spPr>
              <a:solidFill>
                <a:schemeClr val="accent4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F-269F-4B27-B274-715DC9F4C72C}"/>
              </c:ext>
            </c:extLst>
          </c:dPt>
          <c:dPt>
            <c:idx val="16"/>
            <c:bubble3D val="0"/>
            <c:spPr>
              <a:solidFill>
                <a:schemeClr val="accent5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1-269F-4B27-B274-715DC9F4C72C}"/>
              </c:ext>
            </c:extLst>
          </c:dPt>
          <c:dPt>
            <c:idx val="17"/>
            <c:bubble3D val="0"/>
            <c:spPr>
              <a:solidFill>
                <a:schemeClr val="accent6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3-269F-4B27-B274-715DC9F4C72C}"/>
              </c:ext>
            </c:extLst>
          </c:dPt>
          <c:dPt>
            <c:idx val="18"/>
            <c:bubble3D val="0"/>
            <c:spPr>
              <a:solidFill>
                <a:schemeClr val="accent1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5-269F-4B27-B274-715DC9F4C72C}"/>
              </c:ext>
            </c:extLst>
          </c:dPt>
          <c:dPt>
            <c:idx val="19"/>
            <c:bubble3D val="0"/>
            <c:spPr>
              <a:solidFill>
                <a:schemeClr val="accent2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7-269F-4B27-B274-715DC9F4C72C}"/>
              </c:ext>
            </c:extLst>
          </c:dPt>
          <c:dPt>
            <c:idx val="20"/>
            <c:bubble3D val="0"/>
            <c:spPr>
              <a:solidFill>
                <a:schemeClr val="accent3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9-269F-4B27-B274-715DC9F4C72C}"/>
              </c:ext>
            </c:extLst>
          </c:dPt>
          <c:dPt>
            <c:idx val="21"/>
            <c:bubble3D val="0"/>
            <c:spPr>
              <a:solidFill>
                <a:schemeClr val="accent4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B-269F-4B27-B274-715DC9F4C72C}"/>
              </c:ext>
            </c:extLst>
          </c:dPt>
          <c:dPt>
            <c:idx val="22"/>
            <c:bubble3D val="0"/>
            <c:spPr>
              <a:solidFill>
                <a:schemeClr val="accent5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D-269F-4B27-B274-715DC9F4C72C}"/>
              </c:ext>
            </c:extLst>
          </c:dPt>
          <c:dPt>
            <c:idx val="23"/>
            <c:bubble3D val="0"/>
            <c:spPr>
              <a:solidFill>
                <a:schemeClr val="accent6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F-269F-4B27-B274-715DC9F4C72C}"/>
              </c:ext>
            </c:extLst>
          </c:dPt>
          <c:dPt>
            <c:idx val="24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1-269F-4B27-B274-715DC9F4C72C}"/>
              </c:ext>
            </c:extLst>
          </c:dPt>
          <c:dPt>
            <c:idx val="25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3-269F-4B27-B274-715DC9F4C72C}"/>
              </c:ext>
            </c:extLst>
          </c:dPt>
          <c:dPt>
            <c:idx val="26"/>
            <c:bubble3D val="0"/>
            <c:spPr>
              <a:solidFill>
                <a:schemeClr val="accent3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5-269F-4B27-B274-715DC9F4C72C}"/>
              </c:ext>
            </c:extLst>
          </c:dPt>
          <c:dPt>
            <c:idx val="27"/>
            <c:bubble3D val="0"/>
            <c:spPr>
              <a:solidFill>
                <a:schemeClr val="accent4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7-269F-4B27-B274-715DC9F4C72C}"/>
              </c:ext>
            </c:extLst>
          </c:dPt>
          <c:dPt>
            <c:idx val="28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9-269F-4B27-B274-715DC9F4C72C}"/>
              </c:ext>
            </c:extLst>
          </c:dPt>
          <c:dPt>
            <c:idx val="29"/>
            <c:bubble3D val="0"/>
            <c:spPr>
              <a:solidFill>
                <a:schemeClr val="accent6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B-269F-4B27-B274-715DC9F4C72C}"/>
              </c:ext>
            </c:extLst>
          </c:dPt>
          <c:dPt>
            <c:idx val="30"/>
            <c:bubble3D val="0"/>
            <c:spPr>
              <a:solidFill>
                <a:schemeClr val="accent1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D-269F-4B27-B274-715DC9F4C72C}"/>
              </c:ext>
            </c:extLst>
          </c:dPt>
          <c:dPt>
            <c:idx val="31"/>
            <c:bubble3D val="0"/>
            <c:spPr>
              <a:solidFill>
                <a:schemeClr val="accent2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F-269F-4B27-B274-715DC9F4C72C}"/>
              </c:ext>
            </c:extLst>
          </c:dPt>
          <c:dPt>
            <c:idx val="32"/>
            <c:bubble3D val="0"/>
            <c:spPr>
              <a:solidFill>
                <a:schemeClr val="accent3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1-269F-4B27-B274-715DC9F4C72C}"/>
              </c:ext>
            </c:extLst>
          </c:dPt>
          <c:dPt>
            <c:idx val="33"/>
            <c:bubble3D val="0"/>
            <c:spPr>
              <a:solidFill>
                <a:schemeClr val="accent4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3-269F-4B27-B274-715DC9F4C72C}"/>
              </c:ext>
            </c:extLst>
          </c:dPt>
          <c:dPt>
            <c:idx val="34"/>
            <c:bubble3D val="0"/>
            <c:spPr>
              <a:solidFill>
                <a:schemeClr val="accent5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5-269F-4B27-B274-715DC9F4C72C}"/>
              </c:ext>
            </c:extLst>
          </c:dPt>
          <c:dPt>
            <c:idx val="35"/>
            <c:bubble3D val="0"/>
            <c:spPr>
              <a:solidFill>
                <a:schemeClr val="accent6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7-269F-4B27-B274-715DC9F4C72C}"/>
              </c:ext>
            </c:extLst>
          </c:dPt>
          <c:dPt>
            <c:idx val="36"/>
            <c:bubble3D val="0"/>
            <c:spPr>
              <a:solidFill>
                <a:schemeClr val="accent1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9-269F-4B27-B274-715DC9F4C72C}"/>
              </c:ext>
            </c:extLst>
          </c:dPt>
          <c:dPt>
            <c:idx val="37"/>
            <c:bubble3D val="0"/>
            <c:spPr>
              <a:solidFill>
                <a:schemeClr val="accent2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B-269F-4B27-B274-715DC9F4C72C}"/>
              </c:ext>
            </c:extLst>
          </c:dPt>
          <c:dPt>
            <c:idx val="38"/>
            <c:bubble3D val="0"/>
            <c:spPr>
              <a:solidFill>
                <a:schemeClr val="accent3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D-269F-4B27-B274-715DC9F4C72C}"/>
              </c:ext>
            </c:extLst>
          </c:dPt>
          <c:dPt>
            <c:idx val="39"/>
            <c:bubble3D val="0"/>
            <c:spPr>
              <a:solidFill>
                <a:schemeClr val="accent4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F-269F-4B27-B274-715DC9F4C72C}"/>
              </c:ext>
            </c:extLst>
          </c:dPt>
          <c:dPt>
            <c:idx val="40"/>
            <c:bubble3D val="0"/>
            <c:spPr>
              <a:solidFill>
                <a:schemeClr val="accent5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1-269F-4B27-B274-715DC9F4C72C}"/>
              </c:ext>
            </c:extLst>
          </c:dPt>
          <c:dPt>
            <c:idx val="41"/>
            <c:bubble3D val="0"/>
            <c:spPr>
              <a:solidFill>
                <a:schemeClr val="accent6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3-269F-4B27-B274-715DC9F4C72C}"/>
              </c:ext>
            </c:extLst>
          </c:dPt>
          <c:dPt>
            <c:idx val="42"/>
            <c:bubble3D val="0"/>
            <c:spPr>
              <a:solidFill>
                <a:schemeClr val="accent1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5-269F-4B27-B274-715DC9F4C72C}"/>
              </c:ext>
            </c:extLst>
          </c:dPt>
          <c:dPt>
            <c:idx val="43"/>
            <c:bubble3D val="0"/>
            <c:spPr>
              <a:solidFill>
                <a:schemeClr val="accent2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7-269F-4B27-B274-715DC9F4C72C}"/>
              </c:ext>
            </c:extLst>
          </c:dPt>
          <c:dPt>
            <c:idx val="44"/>
            <c:bubble3D val="0"/>
            <c:spPr>
              <a:solidFill>
                <a:schemeClr val="accent3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9-269F-4B27-B274-715DC9F4C72C}"/>
              </c:ext>
            </c:extLst>
          </c:dPt>
          <c:dPt>
            <c:idx val="45"/>
            <c:bubble3D val="0"/>
            <c:spPr>
              <a:solidFill>
                <a:schemeClr val="accent4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B-269F-4B27-B274-715DC9F4C72C}"/>
              </c:ext>
            </c:extLst>
          </c:dPt>
          <c:dPt>
            <c:idx val="46"/>
            <c:bubble3D val="0"/>
            <c:spPr>
              <a:solidFill>
                <a:schemeClr val="accent5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D-269F-4B27-B274-715DC9F4C72C}"/>
              </c:ext>
            </c:extLst>
          </c:dPt>
          <c:dPt>
            <c:idx val="47"/>
            <c:bubble3D val="0"/>
            <c:spPr>
              <a:solidFill>
                <a:schemeClr val="accent6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F-269F-4B27-B274-715DC9F4C72C}"/>
              </c:ext>
            </c:extLst>
          </c:dPt>
          <c:dPt>
            <c:idx val="48"/>
            <c:bubble3D val="0"/>
            <c:spPr>
              <a:solidFill>
                <a:schemeClr val="accent1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1-269F-4B27-B274-715DC9F4C72C}"/>
              </c:ext>
            </c:extLst>
          </c:dPt>
          <c:dPt>
            <c:idx val="49"/>
            <c:bubble3D val="0"/>
            <c:spPr>
              <a:solidFill>
                <a:schemeClr val="accent2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3-269F-4B27-B274-715DC9F4C72C}"/>
              </c:ext>
            </c:extLst>
          </c:dPt>
          <c:dPt>
            <c:idx val="50"/>
            <c:bubble3D val="0"/>
            <c:spPr>
              <a:solidFill>
                <a:schemeClr val="accent3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5-269F-4B27-B274-715DC9F4C72C}"/>
              </c:ext>
            </c:extLst>
          </c:dPt>
          <c:dPt>
            <c:idx val="51"/>
            <c:bubble3D val="0"/>
            <c:spPr>
              <a:solidFill>
                <a:schemeClr val="accent4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7-269F-4B27-B274-715DC9F4C72C}"/>
              </c:ext>
            </c:extLst>
          </c:dPt>
          <c:dPt>
            <c:idx val="52"/>
            <c:bubble3D val="0"/>
            <c:spPr>
              <a:solidFill>
                <a:schemeClr val="accent5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9-269F-4B27-B274-715DC9F4C72C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pPr>
                <a:endParaRPr lang="en-US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ND4_CONSENSUS_PHYLOGENY_HISTG_!$A$2:$A$54</c:f>
              <c:strCache>
                <c:ptCount val="53"/>
                <c:pt idx="0">
                  <c:v> ***  # ND4_CLUSTALO_MAXALIGN_RYt_UB #  *** </c:v>
                </c:pt>
                <c:pt idx="1">
                  <c:v> ***  # ND4_CLUSTALO_TCSFMf_RYt_UB #  *** </c:v>
                </c:pt>
                <c:pt idx="2">
                  <c:v> ***  # ND4_CLUSTALO_TCSOGw_RYt_UB #  *** </c:v>
                </c:pt>
                <c:pt idx="3">
                  <c:v> ***  # ND4_MAFFTA_MAXALIGN_DNA_UB #  *** </c:v>
                </c:pt>
                <c:pt idx="4">
                  <c:v> ***  # ND4_MAFFTGI_TCSFMf_DNA_UB #  *** </c:v>
                </c:pt>
                <c:pt idx="5">
                  <c:v> *** ND4_ALL_TRIMALC_RYt_UB *** </c:v>
                </c:pt>
                <c:pt idx="6">
                  <c:v> ***  # ND4_MAFFTGI_TRIMAL_DNA_UB #  *** </c:v>
                </c:pt>
                <c:pt idx="7">
                  <c:v> ***  # ND4_MAFFTLI_TCSOGw_DNA_UB #  *** </c:v>
                </c:pt>
                <c:pt idx="8">
                  <c:v> ***  # ND4_MAFFTA_MAXALIGN_DEG_UB #  *** </c:v>
                </c:pt>
                <c:pt idx="9">
                  <c:v> ***  # ND4_MAFFTA_TCSFMf_DEG_UB #  *** </c:v>
                </c:pt>
                <c:pt idx="10">
                  <c:v> ***  # ND4_MAFFTA_TRIMAL_DEG_UB #  *** </c:v>
                </c:pt>
                <c:pt idx="11">
                  <c:v> ***  # ND4_MAFFTLI_MAXALIGN_DEG_UB #  *** </c:v>
                </c:pt>
                <c:pt idx="12">
                  <c:v> ***  # ND4_MAFFTLI_TRIMAL_DEG_UB #  *** </c:v>
                </c:pt>
                <c:pt idx="13">
                  <c:v> ***  # ND4_PROBCONS_TCSFMw_RYt_UB #  *** </c:v>
                </c:pt>
                <c:pt idx="14">
                  <c:v> ***  # ND4_TCOFFEE_PSARALIGN_DNA_UB #  *** </c:v>
                </c:pt>
                <c:pt idx="15">
                  <c:v> ***  # ND4_MAFFT_GBLOCKS_DNA_UB #  *** </c:v>
                </c:pt>
                <c:pt idx="16">
                  <c:v> ***  # ND4_MAFFT_GBLOCKS_RYt_UB #  *** </c:v>
                </c:pt>
                <c:pt idx="17">
                  <c:v> *** ND4_ALL_MERGEALIGN_DEG_UB *** </c:v>
                </c:pt>
                <c:pt idx="18">
                  <c:v> *** ND4_ALL_TRIMALC_DEG_UB *** </c:v>
                </c:pt>
                <c:pt idx="19">
                  <c:v> *** ND4_ALL_WEAVEALIGN_DEG_UB *** </c:v>
                </c:pt>
                <c:pt idx="20">
                  <c:v> ***  # ND4_OPAL_TCSFMw_DNA_UB #  *** </c:v>
                </c:pt>
                <c:pt idx="21">
                  <c:v> ***  # ND4_PRANK_TRIMALA_RYt_UB #  *** </c:v>
                </c:pt>
                <c:pt idx="22">
                  <c:v> ***  # ND4_PRANK_TRIMALG_RYt_UB #  *** </c:v>
                </c:pt>
                <c:pt idx="23">
                  <c:v> ***  # ND4_MACSE_TRIMALA_CDN_UB #  *** </c:v>
                </c:pt>
                <c:pt idx="24">
                  <c:v> ***  # ND4_MACSE_TRIMALG_CDN_UB #  *** </c:v>
                </c:pt>
                <c:pt idx="25">
                  <c:v> ***  # ND4_MACSE_TRIMALA_2AA_UB #  *** </c:v>
                </c:pt>
                <c:pt idx="26">
                  <c:v> ***  # ND4_MACSE_TRIMALG_2AA_UB #  *** </c:v>
                </c:pt>
                <c:pt idx="27">
                  <c:v> *** ND4_ALL_TRIMALC_CDN_UB *** </c:v>
                </c:pt>
                <c:pt idx="28">
                  <c:v> ***  # ND4_PRANKCD_GBLOCKSC_CDN_UB #  *** </c:v>
                </c:pt>
                <c:pt idx="29">
                  <c:v> ***  # ND4_TCOFFEETC_TCSw_DEG_UB #  *** </c:v>
                </c:pt>
                <c:pt idx="30">
                  <c:v> ***  # ND4_TCOFFEETC_TCSw_RYt_UB #  *** </c:v>
                </c:pt>
                <c:pt idx="31">
                  <c:v> ***  # ND4_TCOFFEE_PSARALIGN_RYt_UB #  *** </c:v>
                </c:pt>
                <c:pt idx="32">
                  <c:v> ***  # ND4_PRANK_TRIMALA_DNA_UB #  *** </c:v>
                </c:pt>
                <c:pt idx="33">
                  <c:v> ***  # ND4_PRANK_TRIMALG_DNA_UB #  *** </c:v>
                </c:pt>
                <c:pt idx="34">
                  <c:v> ***  # ND4_MAFFTLI_TCSFMf_2AA_UB #  *** </c:v>
                </c:pt>
                <c:pt idx="35">
                  <c:v> ***  # ND4_PRANKCDF_TCSFMw_DEG_UB #  *** </c:v>
                </c:pt>
                <c:pt idx="36">
                  <c:v> ***  # ND4_TCOFFEE_TCSw_DNA_UB #  *** </c:v>
                </c:pt>
                <c:pt idx="37">
                  <c:v> ***  # ND4_PRANKCDF_GBLOCKSC_2AA_UB #  *** </c:v>
                </c:pt>
                <c:pt idx="38">
                  <c:v> ***  # ND4_TCOFFEEPL_GBLOCKS_DEG_UB #  *** </c:v>
                </c:pt>
                <c:pt idx="39">
                  <c:v> ***  # ND4_PRANK_TRIMALA_DEG_UB #  *** </c:v>
                </c:pt>
                <c:pt idx="40">
                  <c:v> ***  # ND4_PRANK_TRIMALG_DEG_UB #  *** </c:v>
                </c:pt>
                <c:pt idx="41">
                  <c:v> *** ND4_ALL_TRIMALC_2AA_UB *** </c:v>
                </c:pt>
                <c:pt idx="42">
                  <c:v> ***  # ND4_CLUSTALO_TCSOGw_DEG_UB #  *** </c:v>
                </c:pt>
                <c:pt idx="43">
                  <c:v> ***  # ND4_TCOFFEE_TRIMALS_DNA_UB #  *** </c:v>
                </c:pt>
                <c:pt idx="44">
                  <c:v> ***  # ND4_MAFFTGI_NOISY_RYt_UB #  *** </c:v>
                </c:pt>
                <c:pt idx="45">
                  <c:v> ***  # ND4_TCOFFEEPL_PSARALIGN_DEG_UB #  *** </c:v>
                </c:pt>
                <c:pt idx="46">
                  <c:v> ***  # ND4_PRANKCDF_TRIMALP_DNA_UB #  *** </c:v>
                </c:pt>
                <c:pt idx="47">
                  <c:v> ***  # ND4_PRANKCDO_TRIMALP_DEG_UB #  *** </c:v>
                </c:pt>
                <c:pt idx="48">
                  <c:v> # ND4_GRAMALIGN_NOISY_DEG_UB # </c:v>
                </c:pt>
                <c:pt idx="49">
                  <c:v> # ND4_MUSCLE_NOISY_DNA_UB # </c:v>
                </c:pt>
                <c:pt idx="50">
                  <c:v> # ND4_MUSCLE_TRIMALS_DEG_UB # </c:v>
                </c:pt>
                <c:pt idx="51">
                  <c:v> # ND4_MUSCLE_TRIMALS_RYt_UB # </c:v>
                </c:pt>
                <c:pt idx="52">
                  <c:v> # ND4_PRANKCD_TRIMALP_RYt_UB # </c:v>
                </c:pt>
              </c:strCache>
            </c:strRef>
          </c:cat>
          <c:val>
            <c:numRef>
              <c:f>ND4_CONSENSUS_PHYLOGENY_HISTG_!$B$2:$B$54</c:f>
              <c:numCache>
                <c:formatCode>General</c:formatCode>
                <c:ptCount val="53"/>
                <c:pt idx="0">
                  <c:v>172</c:v>
                </c:pt>
                <c:pt idx="1">
                  <c:v>172</c:v>
                </c:pt>
                <c:pt idx="2">
                  <c:v>172</c:v>
                </c:pt>
                <c:pt idx="3">
                  <c:v>172</c:v>
                </c:pt>
                <c:pt idx="4">
                  <c:v>169</c:v>
                </c:pt>
                <c:pt idx="5">
                  <c:v>169</c:v>
                </c:pt>
                <c:pt idx="6">
                  <c:v>160</c:v>
                </c:pt>
                <c:pt idx="7">
                  <c:v>152</c:v>
                </c:pt>
                <c:pt idx="8">
                  <c:v>149</c:v>
                </c:pt>
                <c:pt idx="9">
                  <c:v>149</c:v>
                </c:pt>
                <c:pt idx="10">
                  <c:v>149</c:v>
                </c:pt>
                <c:pt idx="11">
                  <c:v>142</c:v>
                </c:pt>
                <c:pt idx="12">
                  <c:v>136</c:v>
                </c:pt>
                <c:pt idx="13">
                  <c:v>135</c:v>
                </c:pt>
                <c:pt idx="14">
                  <c:v>125</c:v>
                </c:pt>
                <c:pt idx="15">
                  <c:v>113</c:v>
                </c:pt>
                <c:pt idx="16">
                  <c:v>112</c:v>
                </c:pt>
                <c:pt idx="17">
                  <c:v>101</c:v>
                </c:pt>
                <c:pt idx="18">
                  <c:v>101</c:v>
                </c:pt>
                <c:pt idx="19">
                  <c:v>101</c:v>
                </c:pt>
                <c:pt idx="20">
                  <c:v>95</c:v>
                </c:pt>
                <c:pt idx="21">
                  <c:v>85</c:v>
                </c:pt>
                <c:pt idx="22">
                  <c:v>84</c:v>
                </c:pt>
                <c:pt idx="23">
                  <c:v>54</c:v>
                </c:pt>
                <c:pt idx="24">
                  <c:v>54</c:v>
                </c:pt>
                <c:pt idx="25">
                  <c:v>53</c:v>
                </c:pt>
                <c:pt idx="26">
                  <c:v>53</c:v>
                </c:pt>
                <c:pt idx="27">
                  <c:v>38</c:v>
                </c:pt>
                <c:pt idx="28">
                  <c:v>36</c:v>
                </c:pt>
                <c:pt idx="29">
                  <c:v>33</c:v>
                </c:pt>
                <c:pt idx="30">
                  <c:v>32</c:v>
                </c:pt>
                <c:pt idx="31">
                  <c:v>28</c:v>
                </c:pt>
                <c:pt idx="32">
                  <c:v>27</c:v>
                </c:pt>
                <c:pt idx="33">
                  <c:v>26</c:v>
                </c:pt>
                <c:pt idx="34">
                  <c:v>23</c:v>
                </c:pt>
                <c:pt idx="35">
                  <c:v>20</c:v>
                </c:pt>
                <c:pt idx="36">
                  <c:v>20</c:v>
                </c:pt>
                <c:pt idx="37">
                  <c:v>16</c:v>
                </c:pt>
                <c:pt idx="38">
                  <c:v>16</c:v>
                </c:pt>
                <c:pt idx="39">
                  <c:v>12</c:v>
                </c:pt>
                <c:pt idx="40">
                  <c:v>11</c:v>
                </c:pt>
                <c:pt idx="41">
                  <c:v>6</c:v>
                </c:pt>
                <c:pt idx="42">
                  <c:v>5</c:v>
                </c:pt>
                <c:pt idx="43">
                  <c:v>5</c:v>
                </c:pt>
                <c:pt idx="44">
                  <c:v>4</c:v>
                </c:pt>
                <c:pt idx="45">
                  <c:v>4</c:v>
                </c:pt>
                <c:pt idx="46">
                  <c:v>2</c:v>
                </c:pt>
                <c:pt idx="47">
                  <c:v>1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6A-269F-4B27-B274-715DC9F4C72C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1206610294526793E-2"/>
          <c:y val="3.8526329619250163E-2"/>
          <c:w val="0.90038213633777331"/>
          <c:h val="0.94692094035406171"/>
        </c:manualLayout>
      </c:layout>
      <c:pieChart>
        <c:varyColors val="1"/>
        <c:ser>
          <c:idx val="0"/>
          <c:order val="0"/>
          <c:tx>
            <c:strRef>
              <c:f>ATP6_CONSENSUS_PHYLOGENY_HISTG_!$B$1</c:f>
              <c:strCache>
                <c:ptCount val="1"/>
                <c:pt idx="0">
                  <c:v>Total Topological Support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47A-47D7-A30E-7FF1183A8908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47A-47D7-A30E-7FF1183A8908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147A-47D7-A30E-7FF1183A8908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147A-47D7-A30E-7FF1183A8908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147A-47D7-A30E-7FF1183A8908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147A-47D7-A30E-7FF1183A8908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147A-47D7-A30E-7FF1183A8908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147A-47D7-A30E-7FF1183A8908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147A-47D7-A30E-7FF1183A8908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147A-47D7-A30E-7FF1183A8908}"/>
              </c:ext>
            </c:extLst>
          </c:dPt>
          <c:dPt>
            <c:idx val="10"/>
            <c:bubble3D val="0"/>
            <c:spPr>
              <a:solidFill>
                <a:schemeClr val="accent5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147A-47D7-A30E-7FF1183A8908}"/>
              </c:ext>
            </c:extLst>
          </c:dPt>
          <c:dPt>
            <c:idx val="11"/>
            <c:bubble3D val="0"/>
            <c:spPr>
              <a:solidFill>
                <a:schemeClr val="accent6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147A-47D7-A30E-7FF1183A8908}"/>
              </c:ext>
            </c:extLst>
          </c:dPt>
          <c:dPt>
            <c:idx val="12"/>
            <c:bubble3D val="0"/>
            <c:spPr>
              <a:solidFill>
                <a:schemeClr val="accent1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147A-47D7-A30E-7FF1183A8908}"/>
              </c:ext>
            </c:extLst>
          </c:dPt>
          <c:dPt>
            <c:idx val="13"/>
            <c:bubble3D val="0"/>
            <c:spPr>
              <a:solidFill>
                <a:schemeClr val="accent2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147A-47D7-A30E-7FF1183A8908}"/>
              </c:ext>
            </c:extLst>
          </c:dPt>
          <c:dPt>
            <c:idx val="14"/>
            <c:bubble3D val="0"/>
            <c:spPr>
              <a:solidFill>
                <a:schemeClr val="accent3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147A-47D7-A30E-7FF1183A8908}"/>
              </c:ext>
            </c:extLst>
          </c:dPt>
          <c:dPt>
            <c:idx val="15"/>
            <c:bubble3D val="0"/>
            <c:spPr>
              <a:solidFill>
                <a:schemeClr val="accent4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F-147A-47D7-A30E-7FF1183A8908}"/>
              </c:ext>
            </c:extLst>
          </c:dPt>
          <c:dPt>
            <c:idx val="16"/>
            <c:bubble3D val="0"/>
            <c:spPr>
              <a:solidFill>
                <a:schemeClr val="accent5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1-147A-47D7-A30E-7FF1183A8908}"/>
              </c:ext>
            </c:extLst>
          </c:dPt>
          <c:dPt>
            <c:idx val="17"/>
            <c:bubble3D val="0"/>
            <c:spPr>
              <a:solidFill>
                <a:schemeClr val="accent6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3-147A-47D7-A30E-7FF1183A8908}"/>
              </c:ext>
            </c:extLst>
          </c:dPt>
          <c:dPt>
            <c:idx val="18"/>
            <c:bubble3D val="0"/>
            <c:spPr>
              <a:solidFill>
                <a:schemeClr val="accent1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5-147A-47D7-A30E-7FF1183A8908}"/>
              </c:ext>
            </c:extLst>
          </c:dPt>
          <c:dPt>
            <c:idx val="19"/>
            <c:bubble3D val="0"/>
            <c:spPr>
              <a:solidFill>
                <a:schemeClr val="accent2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7-147A-47D7-A30E-7FF1183A8908}"/>
              </c:ext>
            </c:extLst>
          </c:dPt>
          <c:dPt>
            <c:idx val="20"/>
            <c:bubble3D val="0"/>
            <c:spPr>
              <a:solidFill>
                <a:schemeClr val="accent3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9-147A-47D7-A30E-7FF1183A8908}"/>
              </c:ext>
            </c:extLst>
          </c:dPt>
          <c:dPt>
            <c:idx val="21"/>
            <c:bubble3D val="0"/>
            <c:spPr>
              <a:solidFill>
                <a:schemeClr val="accent4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B-147A-47D7-A30E-7FF1183A8908}"/>
              </c:ext>
            </c:extLst>
          </c:dPt>
          <c:dPt>
            <c:idx val="22"/>
            <c:bubble3D val="0"/>
            <c:spPr>
              <a:solidFill>
                <a:schemeClr val="accent5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D-147A-47D7-A30E-7FF1183A8908}"/>
              </c:ext>
            </c:extLst>
          </c:dPt>
          <c:dPt>
            <c:idx val="23"/>
            <c:bubble3D val="0"/>
            <c:spPr>
              <a:solidFill>
                <a:schemeClr val="accent6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F-147A-47D7-A30E-7FF1183A8908}"/>
              </c:ext>
            </c:extLst>
          </c:dPt>
          <c:dPt>
            <c:idx val="24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1-147A-47D7-A30E-7FF1183A8908}"/>
              </c:ext>
            </c:extLst>
          </c:dPt>
          <c:dPt>
            <c:idx val="25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3-147A-47D7-A30E-7FF1183A8908}"/>
              </c:ext>
            </c:extLst>
          </c:dPt>
          <c:dPt>
            <c:idx val="26"/>
            <c:bubble3D val="0"/>
            <c:spPr>
              <a:solidFill>
                <a:schemeClr val="accent3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5-147A-47D7-A30E-7FF1183A8908}"/>
              </c:ext>
            </c:extLst>
          </c:dPt>
          <c:dPt>
            <c:idx val="27"/>
            <c:bubble3D val="0"/>
            <c:spPr>
              <a:solidFill>
                <a:schemeClr val="accent4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7-147A-47D7-A30E-7FF1183A8908}"/>
              </c:ext>
            </c:extLst>
          </c:dPt>
          <c:dPt>
            <c:idx val="28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9-147A-47D7-A30E-7FF1183A8908}"/>
              </c:ext>
            </c:extLst>
          </c:dPt>
          <c:dPt>
            <c:idx val="29"/>
            <c:bubble3D val="0"/>
            <c:spPr>
              <a:solidFill>
                <a:schemeClr val="accent6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B-147A-47D7-A30E-7FF1183A8908}"/>
              </c:ext>
            </c:extLst>
          </c:dPt>
          <c:dPt>
            <c:idx val="30"/>
            <c:bubble3D val="0"/>
            <c:spPr>
              <a:solidFill>
                <a:schemeClr val="accent1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D-147A-47D7-A30E-7FF1183A8908}"/>
              </c:ext>
            </c:extLst>
          </c:dPt>
          <c:dPt>
            <c:idx val="31"/>
            <c:bubble3D val="0"/>
            <c:spPr>
              <a:solidFill>
                <a:schemeClr val="accent2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F-147A-47D7-A30E-7FF1183A8908}"/>
              </c:ext>
            </c:extLst>
          </c:dPt>
          <c:dPt>
            <c:idx val="32"/>
            <c:bubble3D val="0"/>
            <c:spPr>
              <a:solidFill>
                <a:schemeClr val="accent3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1-147A-47D7-A30E-7FF1183A8908}"/>
              </c:ext>
            </c:extLst>
          </c:dPt>
          <c:dPt>
            <c:idx val="33"/>
            <c:bubble3D val="0"/>
            <c:spPr>
              <a:solidFill>
                <a:schemeClr val="accent4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3-147A-47D7-A30E-7FF1183A8908}"/>
              </c:ext>
            </c:extLst>
          </c:dPt>
          <c:dPt>
            <c:idx val="34"/>
            <c:bubble3D val="0"/>
            <c:spPr>
              <a:solidFill>
                <a:schemeClr val="accent5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5-147A-47D7-A30E-7FF1183A8908}"/>
              </c:ext>
            </c:extLst>
          </c:dPt>
          <c:dPt>
            <c:idx val="35"/>
            <c:bubble3D val="0"/>
            <c:spPr>
              <a:solidFill>
                <a:schemeClr val="accent6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7-147A-47D7-A30E-7FF1183A8908}"/>
              </c:ext>
            </c:extLst>
          </c:dPt>
          <c:dPt>
            <c:idx val="36"/>
            <c:bubble3D val="0"/>
            <c:spPr>
              <a:solidFill>
                <a:schemeClr val="accent1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9-147A-47D7-A30E-7FF1183A8908}"/>
              </c:ext>
            </c:extLst>
          </c:dPt>
          <c:dPt>
            <c:idx val="37"/>
            <c:bubble3D val="0"/>
            <c:spPr>
              <a:solidFill>
                <a:schemeClr val="accent2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B-147A-47D7-A30E-7FF1183A8908}"/>
              </c:ext>
            </c:extLst>
          </c:dPt>
          <c:dPt>
            <c:idx val="38"/>
            <c:bubble3D val="0"/>
            <c:spPr>
              <a:solidFill>
                <a:schemeClr val="accent3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D-147A-47D7-A30E-7FF1183A8908}"/>
              </c:ext>
            </c:extLst>
          </c:dPt>
          <c:dPt>
            <c:idx val="39"/>
            <c:bubble3D val="0"/>
            <c:spPr>
              <a:solidFill>
                <a:schemeClr val="accent4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F-147A-47D7-A30E-7FF1183A8908}"/>
              </c:ext>
            </c:extLst>
          </c:dPt>
          <c:dPt>
            <c:idx val="40"/>
            <c:bubble3D val="0"/>
            <c:spPr>
              <a:solidFill>
                <a:schemeClr val="accent5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1-147A-47D7-A30E-7FF1183A8908}"/>
              </c:ext>
            </c:extLst>
          </c:dPt>
          <c:dPt>
            <c:idx val="41"/>
            <c:bubble3D val="0"/>
            <c:spPr>
              <a:solidFill>
                <a:schemeClr val="accent6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3-147A-47D7-A30E-7FF1183A8908}"/>
              </c:ext>
            </c:extLst>
          </c:dPt>
          <c:dPt>
            <c:idx val="42"/>
            <c:bubble3D val="0"/>
            <c:spPr>
              <a:solidFill>
                <a:schemeClr val="accent1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5-147A-47D7-A30E-7FF1183A8908}"/>
              </c:ext>
            </c:extLst>
          </c:dPt>
          <c:dPt>
            <c:idx val="43"/>
            <c:bubble3D val="0"/>
            <c:spPr>
              <a:solidFill>
                <a:schemeClr val="accent2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7-147A-47D7-A30E-7FF1183A8908}"/>
              </c:ext>
            </c:extLst>
          </c:dPt>
          <c:dPt>
            <c:idx val="44"/>
            <c:bubble3D val="0"/>
            <c:spPr>
              <a:solidFill>
                <a:schemeClr val="accent3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9-147A-47D7-A30E-7FF1183A8908}"/>
              </c:ext>
            </c:extLst>
          </c:dPt>
          <c:dPt>
            <c:idx val="45"/>
            <c:bubble3D val="0"/>
            <c:spPr>
              <a:solidFill>
                <a:schemeClr val="accent4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B-147A-47D7-A30E-7FF1183A8908}"/>
              </c:ext>
            </c:extLst>
          </c:dPt>
          <c:dPt>
            <c:idx val="46"/>
            <c:bubble3D val="0"/>
            <c:spPr>
              <a:solidFill>
                <a:schemeClr val="accent5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D-147A-47D7-A30E-7FF1183A8908}"/>
              </c:ext>
            </c:extLst>
          </c:dPt>
          <c:dPt>
            <c:idx val="47"/>
            <c:bubble3D val="0"/>
            <c:spPr>
              <a:solidFill>
                <a:schemeClr val="accent6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F-147A-47D7-A30E-7FF1183A8908}"/>
              </c:ext>
            </c:extLst>
          </c:dPt>
          <c:dPt>
            <c:idx val="48"/>
            <c:bubble3D val="0"/>
            <c:spPr>
              <a:solidFill>
                <a:schemeClr val="accent1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1-147A-47D7-A30E-7FF1183A8908}"/>
              </c:ext>
            </c:extLst>
          </c:dPt>
          <c:dPt>
            <c:idx val="49"/>
            <c:bubble3D val="0"/>
            <c:spPr>
              <a:solidFill>
                <a:schemeClr val="accent2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3-147A-47D7-A30E-7FF1183A8908}"/>
              </c:ext>
            </c:extLst>
          </c:dPt>
          <c:dPt>
            <c:idx val="50"/>
            <c:bubble3D val="0"/>
            <c:spPr>
              <a:solidFill>
                <a:schemeClr val="accent3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5-147A-47D7-A30E-7FF1183A8908}"/>
              </c:ext>
            </c:extLst>
          </c:dPt>
          <c:dPt>
            <c:idx val="51"/>
            <c:bubble3D val="0"/>
            <c:spPr>
              <a:solidFill>
                <a:schemeClr val="accent4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7-147A-47D7-A30E-7FF1183A8908}"/>
              </c:ext>
            </c:extLst>
          </c:dPt>
          <c:dPt>
            <c:idx val="52"/>
            <c:bubble3D val="0"/>
            <c:spPr>
              <a:solidFill>
                <a:schemeClr val="accent5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9-147A-47D7-A30E-7FF1183A8908}"/>
              </c:ext>
            </c:extLst>
          </c:dPt>
          <c:dPt>
            <c:idx val="53"/>
            <c:bubble3D val="0"/>
            <c:spPr>
              <a:solidFill>
                <a:schemeClr val="accent6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B-147A-47D7-A30E-7FF1183A8908}"/>
              </c:ext>
            </c:extLst>
          </c:dPt>
          <c:dPt>
            <c:idx val="54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D-147A-47D7-A30E-7FF1183A8908}"/>
              </c:ext>
            </c:extLst>
          </c:dPt>
          <c:dPt>
            <c:idx val="55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F-147A-47D7-A30E-7FF1183A8908}"/>
              </c:ext>
            </c:extLst>
          </c:dPt>
          <c:dPt>
            <c:idx val="56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1-147A-47D7-A30E-7FF1183A8908}"/>
              </c:ext>
            </c:extLst>
          </c:dPt>
          <c:dPt>
            <c:idx val="57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3-147A-47D7-A30E-7FF1183A8908}"/>
              </c:ext>
            </c:extLst>
          </c:dPt>
          <c:dPt>
            <c:idx val="58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5-147A-47D7-A30E-7FF1183A8908}"/>
              </c:ext>
            </c:extLst>
          </c:dPt>
          <c:dPt>
            <c:idx val="59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7-147A-47D7-A30E-7FF1183A8908}"/>
              </c:ext>
            </c:extLst>
          </c:dPt>
          <c:dPt>
            <c:idx val="60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9-147A-47D7-A30E-7FF1183A8908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pPr>
                <a:endParaRPr lang="en-US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ATP6_CONSENSUS_PHYLOGENY_HISTG_!$A$2:$A$62</c:f>
              <c:strCache>
                <c:ptCount val="61"/>
                <c:pt idx="0">
                  <c:v> ***  # ATP6_FSA_PSARALIGN_DNA_UB #  *** </c:v>
                </c:pt>
                <c:pt idx="1">
                  <c:v> ***  # ATP6_MAFFTA_TCSFMw_DNA_UB #  *** </c:v>
                </c:pt>
                <c:pt idx="2">
                  <c:v> *** ATP6_ALL_TRIMALC_DNA_UB *** </c:v>
                </c:pt>
                <c:pt idx="3">
                  <c:v> *** ATP6_ALL_WEAVEALIGN_DNA_UB *** </c:v>
                </c:pt>
                <c:pt idx="4">
                  <c:v> ***  # ATP6_FSA_TRIMALG_CDN_UB #  *** </c:v>
                </c:pt>
                <c:pt idx="5">
                  <c:v> ***  # ATP6_MAFFTA_MAXALIGN_CDN_UB #  *** </c:v>
                </c:pt>
                <c:pt idx="6">
                  <c:v> ***  # ATP6_MAFFTA_TCSFMf_CDN_UB #  *** </c:v>
                </c:pt>
                <c:pt idx="7">
                  <c:v> ***  # ATP6_MAFFTEI_TCSf_CDN_UB #  *** </c:v>
                </c:pt>
                <c:pt idx="8">
                  <c:v> ***  # ATP6_MAFFTEI_TRIMAL_CDN_UB #  *** </c:v>
                </c:pt>
                <c:pt idx="9">
                  <c:v> ***  # ATP6_CLUSTALO_PSARALIGN_DEG_UB #  *** </c:v>
                </c:pt>
                <c:pt idx="10">
                  <c:v> ***  # ATP6_FSANP_TCSOGw_RYt_UB #  *** </c:v>
                </c:pt>
                <c:pt idx="11">
                  <c:v> ***  # ATP6_FSANP_TRIMAL_DEG_UB #  *** </c:v>
                </c:pt>
                <c:pt idx="12">
                  <c:v> ***  # ATP6_FSA_TCSw_RYt_UB #  *** </c:v>
                </c:pt>
                <c:pt idx="13">
                  <c:v> ***  # ATP6_MAFFTGI_TRIMALA_DEG_UB #  *** </c:v>
                </c:pt>
                <c:pt idx="14">
                  <c:v> ***  # ATP6_MAFFTLI_TCSw_DEG_UB #  *** </c:v>
                </c:pt>
                <c:pt idx="15">
                  <c:v> ***  # ATP6_MAFFTLI_TCSw_DNA_UB #  *** </c:v>
                </c:pt>
                <c:pt idx="16">
                  <c:v> ***  # ATP6_MAFFTLI_TRIMALG_DEG_UB #  *** </c:v>
                </c:pt>
                <c:pt idx="17">
                  <c:v> *** ATP6_ALL_MERGEALIGN_DEG_UB *** </c:v>
                </c:pt>
                <c:pt idx="18">
                  <c:v> ***  # ATP6_FSANP_TCSFMf_2AA_UB #  *** </c:v>
                </c:pt>
                <c:pt idx="19">
                  <c:v> ***  # ATP6_GRAMALIGN_PSARALIGN_2AA_UB #  *** </c:v>
                </c:pt>
                <c:pt idx="20">
                  <c:v> ***  # ATP6_GRAMALIGN_TRIMAL_2AA_UB #  *** </c:v>
                </c:pt>
                <c:pt idx="21">
                  <c:v> ***  # ATP6_MAFFTEI_MAXALIGN_2AA_UB #  *** </c:v>
                </c:pt>
                <c:pt idx="22">
                  <c:v> ***  # ATP6_MAFFTGI_TCSf_2AA_UB #  *** </c:v>
                </c:pt>
                <c:pt idx="23">
                  <c:v> ***  # ATP6_MACSE_TRIMALA_DNA_UB #  *** </c:v>
                </c:pt>
                <c:pt idx="24">
                  <c:v> ***  # ATP6_MAFFTLI_GBLOCKS_DNA_UB #  *** </c:v>
                </c:pt>
                <c:pt idx="25">
                  <c:v> ***  # ATP6_PRANKCDO_GBLOCKSC_DNA_UB #  *** </c:v>
                </c:pt>
                <c:pt idx="26">
                  <c:v> ***  # ATP6_MACSE_GBLOCKS_2AA_UB #  *** </c:v>
                </c:pt>
                <c:pt idx="27">
                  <c:v> ***  # ATP6_MAFFTA_GBLOCKSC_2AA_UB #  *** </c:v>
                </c:pt>
                <c:pt idx="28">
                  <c:v> ***  # ATP6_MAFFTA_TRIMALA_2AA_UB #  *** </c:v>
                </c:pt>
                <c:pt idx="29">
                  <c:v> *** ATP6_ALL_TRIMALC_CDN_UB *** </c:v>
                </c:pt>
                <c:pt idx="30">
                  <c:v> ***  # ATP6_GRAMALIGN_TCSOGw_DNA_UB #  *** </c:v>
                </c:pt>
                <c:pt idx="31">
                  <c:v> ***  # ATP6_MAFFTEI_TCSFMf_DNA_UB #  *** </c:v>
                </c:pt>
                <c:pt idx="32">
                  <c:v> ***  # ATP6_MAFFTGI_MAXALIGN_DNA_UB #  *** </c:v>
                </c:pt>
                <c:pt idx="33">
                  <c:v> ***  # ATP6_MAFFTGI_TRIMAL_DNA_UB #  *** </c:v>
                </c:pt>
                <c:pt idx="34">
                  <c:v> ***  # ATP6_MAFFTLI_TCSf_DNA_UB #  *** </c:v>
                </c:pt>
                <c:pt idx="35">
                  <c:v> *** ATP6_ALL_TRIMALC_2AA_UB *** </c:v>
                </c:pt>
                <c:pt idx="36">
                  <c:v> ***  # ATP6_MAFFTEI_GBLOCKSC_CDN_UB #  *** </c:v>
                </c:pt>
                <c:pt idx="37">
                  <c:v> ***  # ATP6_FSANP_TRIMALG_RYt_UB #  *** </c:v>
                </c:pt>
                <c:pt idx="38">
                  <c:v> ***  # ATP6_FSA_TRIMALA_RYt_UB #  *** </c:v>
                </c:pt>
                <c:pt idx="39">
                  <c:v> ***  # ATP6_PRANKCDO_GBLOCKSC_RYt_UB #  *** </c:v>
                </c:pt>
                <c:pt idx="40">
                  <c:v> ***  # ATP6_FSA_TCSFMf_DEG_UB #  *** </c:v>
                </c:pt>
                <c:pt idx="41">
                  <c:v> ***  # ATP6_FSA_TCSf_DEG_UB #  *** </c:v>
                </c:pt>
                <c:pt idx="42">
                  <c:v> ***  # ATP6_FSA_PSARALIGN_RYt_UB #  *** </c:v>
                </c:pt>
                <c:pt idx="43">
                  <c:v> ***  # ATP6_FSA_TCSFMf_RYt_UB #  *** </c:v>
                </c:pt>
                <c:pt idx="44">
                  <c:v> ***  # ATP6_FSA_TCSf_RYt_UB #  *** </c:v>
                </c:pt>
                <c:pt idx="45">
                  <c:v> ***  # ATP6_FSA_TRIMAL_RYt_UB #  *** </c:v>
                </c:pt>
                <c:pt idx="46">
                  <c:v> ***  # ATP6_MACSE_NOISY_RYt_UB #  *** </c:v>
                </c:pt>
                <c:pt idx="47">
                  <c:v> ***  # ATP6_FSANP_TRIMALS_RYt_UB #  *** </c:v>
                </c:pt>
                <c:pt idx="48">
                  <c:v> ***  # ATP6_MACSE_TRIMALP_RYt_UB #  *** </c:v>
                </c:pt>
                <c:pt idx="49">
                  <c:v> ***  # ATP6_FSA_MAXALIGN_RYt_UB #  *** </c:v>
                </c:pt>
                <c:pt idx="50">
                  <c:v> ***  # ATP6_MACSE_TCSFMw_RYt_UB #  *** </c:v>
                </c:pt>
                <c:pt idx="51">
                  <c:v> ***  # ATP6_MAFFTA_GBLOCKS_DEG_UB #  *** </c:v>
                </c:pt>
                <c:pt idx="52">
                  <c:v> ***  # ATP6_MAFFTLI_NOISY_DNA_UB #  *** </c:v>
                </c:pt>
                <c:pt idx="53">
                  <c:v> ***  # ATP6_OPAL_TRIMALP_DNA_UB #  *** </c:v>
                </c:pt>
                <c:pt idx="54">
                  <c:v> *** ATP6_ALL_TRIMALC_RYt_UB *** </c:v>
                </c:pt>
                <c:pt idx="55">
                  <c:v> ***  # ATP6_MACSE_TRIMALP_DEG_UB #  *** </c:v>
                </c:pt>
                <c:pt idx="56">
                  <c:v> ***  # ATP6_MAFFTLI_NOISY_DEG_UB #  *** </c:v>
                </c:pt>
                <c:pt idx="57">
                  <c:v> ***  # ATP6_PRANKCDO_GBLOCKSC_DEG_UB #  *** </c:v>
                </c:pt>
                <c:pt idx="58">
                  <c:v> # ATP6_GRAMALIGN_GBLOCKS_RYt_UB # </c:v>
                </c:pt>
                <c:pt idx="59">
                  <c:v> # ATP6_MAFFTEI_TCSFMw_DEG_UB # </c:v>
                </c:pt>
                <c:pt idx="60">
                  <c:v> # ATP6_PRANKO_TRIMALS_DNA_UB # </c:v>
                </c:pt>
              </c:strCache>
            </c:strRef>
          </c:cat>
          <c:val>
            <c:numRef>
              <c:f>ATP6_CONSENSUS_PHYLOGENY_HISTG_!$B$2:$B$62</c:f>
              <c:numCache>
                <c:formatCode>General</c:formatCode>
                <c:ptCount val="61"/>
                <c:pt idx="0">
                  <c:v>161</c:v>
                </c:pt>
                <c:pt idx="1">
                  <c:v>161</c:v>
                </c:pt>
                <c:pt idx="2">
                  <c:v>138</c:v>
                </c:pt>
                <c:pt idx="3">
                  <c:v>138</c:v>
                </c:pt>
                <c:pt idx="4">
                  <c:v>89</c:v>
                </c:pt>
                <c:pt idx="5">
                  <c:v>89</c:v>
                </c:pt>
                <c:pt idx="6">
                  <c:v>89</c:v>
                </c:pt>
                <c:pt idx="7">
                  <c:v>89</c:v>
                </c:pt>
                <c:pt idx="8">
                  <c:v>89</c:v>
                </c:pt>
                <c:pt idx="9">
                  <c:v>71</c:v>
                </c:pt>
                <c:pt idx="10">
                  <c:v>71</c:v>
                </c:pt>
                <c:pt idx="11">
                  <c:v>71</c:v>
                </c:pt>
                <c:pt idx="12">
                  <c:v>71</c:v>
                </c:pt>
                <c:pt idx="13">
                  <c:v>71</c:v>
                </c:pt>
                <c:pt idx="14">
                  <c:v>71</c:v>
                </c:pt>
                <c:pt idx="15">
                  <c:v>71</c:v>
                </c:pt>
                <c:pt idx="16">
                  <c:v>71</c:v>
                </c:pt>
                <c:pt idx="17">
                  <c:v>68</c:v>
                </c:pt>
                <c:pt idx="18">
                  <c:v>58</c:v>
                </c:pt>
                <c:pt idx="19">
                  <c:v>58</c:v>
                </c:pt>
                <c:pt idx="20">
                  <c:v>58</c:v>
                </c:pt>
                <c:pt idx="21">
                  <c:v>58</c:v>
                </c:pt>
                <c:pt idx="22">
                  <c:v>58</c:v>
                </c:pt>
                <c:pt idx="23">
                  <c:v>54</c:v>
                </c:pt>
                <c:pt idx="24">
                  <c:v>54</c:v>
                </c:pt>
                <c:pt idx="25">
                  <c:v>54</c:v>
                </c:pt>
                <c:pt idx="26">
                  <c:v>47</c:v>
                </c:pt>
                <c:pt idx="27">
                  <c:v>47</c:v>
                </c:pt>
                <c:pt idx="28">
                  <c:v>47</c:v>
                </c:pt>
                <c:pt idx="29">
                  <c:v>46</c:v>
                </c:pt>
                <c:pt idx="30">
                  <c:v>38</c:v>
                </c:pt>
                <c:pt idx="31">
                  <c:v>38</c:v>
                </c:pt>
                <c:pt idx="32">
                  <c:v>38</c:v>
                </c:pt>
                <c:pt idx="33">
                  <c:v>38</c:v>
                </c:pt>
                <c:pt idx="34">
                  <c:v>38</c:v>
                </c:pt>
                <c:pt idx="35">
                  <c:v>38</c:v>
                </c:pt>
                <c:pt idx="36">
                  <c:v>34</c:v>
                </c:pt>
                <c:pt idx="37">
                  <c:v>30</c:v>
                </c:pt>
                <c:pt idx="38">
                  <c:v>30</c:v>
                </c:pt>
                <c:pt idx="39">
                  <c:v>30</c:v>
                </c:pt>
                <c:pt idx="40">
                  <c:v>26</c:v>
                </c:pt>
                <c:pt idx="41">
                  <c:v>26</c:v>
                </c:pt>
                <c:pt idx="42">
                  <c:v>22</c:v>
                </c:pt>
                <c:pt idx="43">
                  <c:v>22</c:v>
                </c:pt>
                <c:pt idx="44">
                  <c:v>22</c:v>
                </c:pt>
                <c:pt idx="45">
                  <c:v>22</c:v>
                </c:pt>
                <c:pt idx="46">
                  <c:v>12</c:v>
                </c:pt>
                <c:pt idx="47">
                  <c:v>9</c:v>
                </c:pt>
                <c:pt idx="48">
                  <c:v>9</c:v>
                </c:pt>
                <c:pt idx="49">
                  <c:v>8</c:v>
                </c:pt>
                <c:pt idx="50">
                  <c:v>7</c:v>
                </c:pt>
                <c:pt idx="51">
                  <c:v>4</c:v>
                </c:pt>
                <c:pt idx="52">
                  <c:v>4</c:v>
                </c:pt>
                <c:pt idx="53">
                  <c:v>4</c:v>
                </c:pt>
                <c:pt idx="54">
                  <c:v>4</c:v>
                </c:pt>
                <c:pt idx="55">
                  <c:v>2</c:v>
                </c:pt>
                <c:pt idx="56">
                  <c:v>1</c:v>
                </c:pt>
                <c:pt idx="57">
                  <c:v>1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7A-147A-47D7-A30E-7FF1183A8908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587570960022688"/>
          <c:y val="6.2499697896878904E-2"/>
          <c:w val="0.73488142035898485"/>
          <c:h val="0.88916591745092632"/>
        </c:manualLayout>
      </c:layout>
      <c:pieChart>
        <c:varyColors val="1"/>
        <c:ser>
          <c:idx val="0"/>
          <c:order val="0"/>
          <c:tx>
            <c:strRef>
              <c:f>ND4_CONSENSUS_PHYLOGENY_HISTG_!$B$1</c:f>
              <c:strCache>
                <c:ptCount val="1"/>
                <c:pt idx="0">
                  <c:v>Total Topological Support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D596-40BB-8235-7F17422DD4CC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D596-40BB-8235-7F17422DD4CC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pPr>
                <a:endParaRPr lang="en-US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ND4_CONSENSUS_PHYLOGENY_HISTG_!$A$2:$A$3</c:f>
              <c:strCache>
                <c:ptCount val="2"/>
                <c:pt idx="0">
                  <c:v> ***  # ND4_MAFFTLI_DEG_UB #  *** </c:v>
                </c:pt>
                <c:pt idx="1">
                  <c:v> ***  # ND4_CLUSTALO_RYt_UB #  *** </c:v>
                </c:pt>
              </c:strCache>
            </c:strRef>
          </c:cat>
          <c:val>
            <c:numRef>
              <c:f>ND4_CONSENSUS_PHYLOGENY_HISTG_!$B$2:$B$3</c:f>
              <c:numCache>
                <c:formatCode>General</c:formatCode>
                <c:ptCount val="2"/>
                <c:pt idx="0">
                  <c:v>16</c:v>
                </c:pt>
                <c:pt idx="1">
                  <c:v>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D596-40BB-8235-7F17422DD4CC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235703128433147"/>
          <c:y val="4.1510177249943207E-2"/>
          <c:w val="0.75458318851696049"/>
          <c:h val="0.91300396842659859"/>
        </c:manualLayout>
      </c:layout>
      <c:pieChart>
        <c:varyColors val="1"/>
        <c:ser>
          <c:idx val="0"/>
          <c:order val="0"/>
          <c:tx>
            <c:strRef>
              <c:f>ND4L_CONSENSUS_PHYLOGENY_HISTG_!$B$1</c:f>
              <c:strCache>
                <c:ptCount val="1"/>
                <c:pt idx="0">
                  <c:v>Total Topological Support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378-4CC2-AD39-8012193A74DA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2378-4CC2-AD39-8012193A74DA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2378-4CC2-AD39-8012193A74DA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2378-4CC2-AD39-8012193A74DA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2378-4CC2-AD39-8012193A74DA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pPr>
                <a:endParaRPr lang="en-US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ND4L_CONSENSUS_PHYLOGENY_HISTG_!$A$2:$A$6</c:f>
              <c:strCache>
                <c:ptCount val="5"/>
                <c:pt idx="0">
                  <c:v> ***  # ND4L_CLUSTALW_DNA_UB #  *** </c:v>
                </c:pt>
                <c:pt idx="1">
                  <c:v> ***  # ND4L_GRAMALIGN_CDN_UB #  *** </c:v>
                </c:pt>
                <c:pt idx="2">
                  <c:v> ***  # ND4L_KALIGN_DEG_UB #  *** </c:v>
                </c:pt>
                <c:pt idx="3">
                  <c:v> ***  # ND4L_OPAL_RYt_UB #  *** </c:v>
                </c:pt>
                <c:pt idx="4">
                  <c:v> # ND4L_GRAMALIGN_2AA_UB # </c:v>
                </c:pt>
              </c:strCache>
            </c:strRef>
          </c:cat>
          <c:val>
            <c:numRef>
              <c:f>ND4L_CONSENSUS_PHYLOGENY_HISTG_!$B$2:$B$6</c:f>
              <c:numCache>
                <c:formatCode>General</c:formatCode>
                <c:ptCount val="5"/>
                <c:pt idx="0">
                  <c:v>31</c:v>
                </c:pt>
                <c:pt idx="1">
                  <c:v>7</c:v>
                </c:pt>
                <c:pt idx="2">
                  <c:v>4</c:v>
                </c:pt>
                <c:pt idx="3">
                  <c:v>1</c:v>
                </c:pt>
                <c:pt idx="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2378-4CC2-AD39-8012193A74DA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939446468445176"/>
          <c:y val="4.8549265393549944E-2"/>
          <c:w val="0.80724706519893974"/>
          <c:h val="0.93250954083325788"/>
        </c:manualLayout>
      </c:layout>
      <c:pieChart>
        <c:varyColors val="1"/>
        <c:ser>
          <c:idx val="0"/>
          <c:order val="0"/>
          <c:tx>
            <c:strRef>
              <c:f>ND4L_CONSENSUS_PHYLOGENY_HISTG_!$B$1</c:f>
              <c:strCache>
                <c:ptCount val="1"/>
                <c:pt idx="0">
                  <c:v>Total Topological Support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E7D5-4B18-8C5E-10CC1EB62177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E7D5-4B18-8C5E-10CC1EB62177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E7D5-4B18-8C5E-10CC1EB62177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E7D5-4B18-8C5E-10CC1EB62177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E7D5-4B18-8C5E-10CC1EB62177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E7D5-4B18-8C5E-10CC1EB62177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E7D5-4B18-8C5E-10CC1EB62177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E7D5-4B18-8C5E-10CC1EB62177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E7D5-4B18-8C5E-10CC1EB62177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E7D5-4B18-8C5E-10CC1EB62177}"/>
              </c:ext>
            </c:extLst>
          </c:dPt>
          <c:dPt>
            <c:idx val="10"/>
            <c:bubble3D val="0"/>
            <c:spPr>
              <a:solidFill>
                <a:schemeClr val="accent5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E7D5-4B18-8C5E-10CC1EB62177}"/>
              </c:ext>
            </c:extLst>
          </c:dPt>
          <c:dPt>
            <c:idx val="11"/>
            <c:bubble3D val="0"/>
            <c:spPr>
              <a:solidFill>
                <a:schemeClr val="accent6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E7D5-4B18-8C5E-10CC1EB62177}"/>
              </c:ext>
            </c:extLst>
          </c:dPt>
          <c:dPt>
            <c:idx val="12"/>
            <c:bubble3D val="0"/>
            <c:spPr>
              <a:solidFill>
                <a:schemeClr val="accent1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E7D5-4B18-8C5E-10CC1EB62177}"/>
              </c:ext>
            </c:extLst>
          </c:dPt>
          <c:dPt>
            <c:idx val="13"/>
            <c:bubble3D val="0"/>
            <c:spPr>
              <a:solidFill>
                <a:schemeClr val="accent2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E7D5-4B18-8C5E-10CC1EB62177}"/>
              </c:ext>
            </c:extLst>
          </c:dPt>
          <c:dPt>
            <c:idx val="14"/>
            <c:bubble3D val="0"/>
            <c:spPr>
              <a:solidFill>
                <a:schemeClr val="accent3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E7D5-4B18-8C5E-10CC1EB62177}"/>
              </c:ext>
            </c:extLst>
          </c:dPt>
          <c:dPt>
            <c:idx val="15"/>
            <c:bubble3D val="0"/>
            <c:spPr>
              <a:solidFill>
                <a:schemeClr val="accent4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F-E7D5-4B18-8C5E-10CC1EB62177}"/>
              </c:ext>
            </c:extLst>
          </c:dPt>
          <c:dPt>
            <c:idx val="16"/>
            <c:bubble3D val="0"/>
            <c:spPr>
              <a:solidFill>
                <a:schemeClr val="accent5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1-E7D5-4B18-8C5E-10CC1EB62177}"/>
              </c:ext>
            </c:extLst>
          </c:dPt>
          <c:dPt>
            <c:idx val="17"/>
            <c:bubble3D val="0"/>
            <c:spPr>
              <a:solidFill>
                <a:schemeClr val="accent6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3-E7D5-4B18-8C5E-10CC1EB62177}"/>
              </c:ext>
            </c:extLst>
          </c:dPt>
          <c:dPt>
            <c:idx val="18"/>
            <c:bubble3D val="0"/>
            <c:spPr>
              <a:solidFill>
                <a:schemeClr val="accent1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5-E7D5-4B18-8C5E-10CC1EB62177}"/>
              </c:ext>
            </c:extLst>
          </c:dPt>
          <c:dPt>
            <c:idx val="19"/>
            <c:bubble3D val="0"/>
            <c:spPr>
              <a:solidFill>
                <a:schemeClr val="accent2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7-E7D5-4B18-8C5E-10CC1EB62177}"/>
              </c:ext>
            </c:extLst>
          </c:dPt>
          <c:dPt>
            <c:idx val="20"/>
            <c:bubble3D val="0"/>
            <c:spPr>
              <a:solidFill>
                <a:schemeClr val="accent3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9-E7D5-4B18-8C5E-10CC1EB62177}"/>
              </c:ext>
            </c:extLst>
          </c:dPt>
          <c:dPt>
            <c:idx val="21"/>
            <c:bubble3D val="0"/>
            <c:spPr>
              <a:solidFill>
                <a:schemeClr val="accent4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B-E7D5-4B18-8C5E-10CC1EB62177}"/>
              </c:ext>
            </c:extLst>
          </c:dPt>
          <c:dPt>
            <c:idx val="22"/>
            <c:bubble3D val="0"/>
            <c:spPr>
              <a:solidFill>
                <a:schemeClr val="accent5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D-E7D5-4B18-8C5E-10CC1EB62177}"/>
              </c:ext>
            </c:extLst>
          </c:dPt>
          <c:dPt>
            <c:idx val="23"/>
            <c:bubble3D val="0"/>
            <c:spPr>
              <a:solidFill>
                <a:schemeClr val="accent6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F-E7D5-4B18-8C5E-10CC1EB62177}"/>
              </c:ext>
            </c:extLst>
          </c:dPt>
          <c:dPt>
            <c:idx val="24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1-E7D5-4B18-8C5E-10CC1EB62177}"/>
              </c:ext>
            </c:extLst>
          </c:dPt>
          <c:dPt>
            <c:idx val="25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3-E7D5-4B18-8C5E-10CC1EB62177}"/>
              </c:ext>
            </c:extLst>
          </c:dPt>
          <c:dPt>
            <c:idx val="26"/>
            <c:bubble3D val="0"/>
            <c:spPr>
              <a:solidFill>
                <a:schemeClr val="accent3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5-E7D5-4B18-8C5E-10CC1EB62177}"/>
              </c:ext>
            </c:extLst>
          </c:dPt>
          <c:dPt>
            <c:idx val="27"/>
            <c:bubble3D val="0"/>
            <c:spPr>
              <a:solidFill>
                <a:schemeClr val="accent4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7-E7D5-4B18-8C5E-10CC1EB62177}"/>
              </c:ext>
            </c:extLst>
          </c:dPt>
          <c:dPt>
            <c:idx val="28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9-E7D5-4B18-8C5E-10CC1EB62177}"/>
              </c:ext>
            </c:extLst>
          </c:dPt>
          <c:dPt>
            <c:idx val="29"/>
            <c:bubble3D val="0"/>
            <c:spPr>
              <a:solidFill>
                <a:schemeClr val="accent6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B-E7D5-4B18-8C5E-10CC1EB62177}"/>
              </c:ext>
            </c:extLst>
          </c:dPt>
          <c:dPt>
            <c:idx val="30"/>
            <c:bubble3D val="0"/>
            <c:spPr>
              <a:solidFill>
                <a:schemeClr val="accent1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D-E7D5-4B18-8C5E-10CC1EB62177}"/>
              </c:ext>
            </c:extLst>
          </c:dPt>
          <c:dPt>
            <c:idx val="31"/>
            <c:bubble3D val="0"/>
            <c:spPr>
              <a:solidFill>
                <a:schemeClr val="accent2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F-E7D5-4B18-8C5E-10CC1EB62177}"/>
              </c:ext>
            </c:extLst>
          </c:dPt>
          <c:dPt>
            <c:idx val="32"/>
            <c:bubble3D val="0"/>
            <c:spPr>
              <a:solidFill>
                <a:schemeClr val="accent3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1-E7D5-4B18-8C5E-10CC1EB62177}"/>
              </c:ext>
            </c:extLst>
          </c:dPt>
          <c:dPt>
            <c:idx val="33"/>
            <c:bubble3D val="0"/>
            <c:spPr>
              <a:solidFill>
                <a:schemeClr val="accent4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3-E7D5-4B18-8C5E-10CC1EB62177}"/>
              </c:ext>
            </c:extLst>
          </c:dPt>
          <c:dPt>
            <c:idx val="34"/>
            <c:bubble3D val="0"/>
            <c:spPr>
              <a:solidFill>
                <a:schemeClr val="accent5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5-E7D5-4B18-8C5E-10CC1EB62177}"/>
              </c:ext>
            </c:extLst>
          </c:dPt>
          <c:dPt>
            <c:idx val="35"/>
            <c:bubble3D val="0"/>
            <c:spPr>
              <a:solidFill>
                <a:schemeClr val="accent6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7-E7D5-4B18-8C5E-10CC1EB62177}"/>
              </c:ext>
            </c:extLst>
          </c:dPt>
          <c:dPt>
            <c:idx val="36"/>
            <c:bubble3D val="0"/>
            <c:spPr>
              <a:solidFill>
                <a:schemeClr val="accent1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9-E7D5-4B18-8C5E-10CC1EB62177}"/>
              </c:ext>
            </c:extLst>
          </c:dPt>
          <c:dPt>
            <c:idx val="37"/>
            <c:bubble3D val="0"/>
            <c:spPr>
              <a:solidFill>
                <a:schemeClr val="accent2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B-E7D5-4B18-8C5E-10CC1EB62177}"/>
              </c:ext>
            </c:extLst>
          </c:dPt>
          <c:dPt>
            <c:idx val="38"/>
            <c:bubble3D val="0"/>
            <c:spPr>
              <a:solidFill>
                <a:schemeClr val="accent3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D-E7D5-4B18-8C5E-10CC1EB62177}"/>
              </c:ext>
            </c:extLst>
          </c:dPt>
          <c:dPt>
            <c:idx val="39"/>
            <c:bubble3D val="0"/>
            <c:spPr>
              <a:solidFill>
                <a:schemeClr val="accent4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F-E7D5-4B18-8C5E-10CC1EB62177}"/>
              </c:ext>
            </c:extLst>
          </c:dPt>
          <c:dPt>
            <c:idx val="40"/>
            <c:bubble3D val="0"/>
            <c:spPr>
              <a:solidFill>
                <a:schemeClr val="accent5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1-E7D5-4B18-8C5E-10CC1EB62177}"/>
              </c:ext>
            </c:extLst>
          </c:dPt>
          <c:dPt>
            <c:idx val="41"/>
            <c:bubble3D val="0"/>
            <c:spPr>
              <a:solidFill>
                <a:schemeClr val="accent6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3-E7D5-4B18-8C5E-10CC1EB62177}"/>
              </c:ext>
            </c:extLst>
          </c:dPt>
          <c:dPt>
            <c:idx val="42"/>
            <c:bubble3D val="0"/>
            <c:spPr>
              <a:solidFill>
                <a:schemeClr val="accent1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5-E7D5-4B18-8C5E-10CC1EB62177}"/>
              </c:ext>
            </c:extLst>
          </c:dPt>
          <c:dPt>
            <c:idx val="43"/>
            <c:bubble3D val="0"/>
            <c:spPr>
              <a:solidFill>
                <a:schemeClr val="accent2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7-E7D5-4B18-8C5E-10CC1EB62177}"/>
              </c:ext>
            </c:extLst>
          </c:dPt>
          <c:dPt>
            <c:idx val="44"/>
            <c:bubble3D val="0"/>
            <c:spPr>
              <a:solidFill>
                <a:schemeClr val="accent3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9-E7D5-4B18-8C5E-10CC1EB62177}"/>
              </c:ext>
            </c:extLst>
          </c:dPt>
          <c:dPt>
            <c:idx val="45"/>
            <c:bubble3D val="0"/>
            <c:spPr>
              <a:solidFill>
                <a:schemeClr val="accent4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B-E7D5-4B18-8C5E-10CC1EB62177}"/>
              </c:ext>
            </c:extLst>
          </c:dPt>
          <c:dPt>
            <c:idx val="46"/>
            <c:bubble3D val="0"/>
            <c:spPr>
              <a:solidFill>
                <a:schemeClr val="accent5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D-E7D5-4B18-8C5E-10CC1EB62177}"/>
              </c:ext>
            </c:extLst>
          </c:dPt>
          <c:dPt>
            <c:idx val="47"/>
            <c:bubble3D val="0"/>
            <c:spPr>
              <a:solidFill>
                <a:schemeClr val="accent6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F-E7D5-4B18-8C5E-10CC1EB62177}"/>
              </c:ext>
            </c:extLst>
          </c:dPt>
          <c:dPt>
            <c:idx val="48"/>
            <c:bubble3D val="0"/>
            <c:spPr>
              <a:solidFill>
                <a:schemeClr val="accent1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1-E7D5-4B18-8C5E-10CC1EB62177}"/>
              </c:ext>
            </c:extLst>
          </c:dPt>
          <c:dPt>
            <c:idx val="49"/>
            <c:bubble3D val="0"/>
            <c:spPr>
              <a:solidFill>
                <a:schemeClr val="accent2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3-E7D5-4B18-8C5E-10CC1EB62177}"/>
              </c:ext>
            </c:extLst>
          </c:dPt>
          <c:dPt>
            <c:idx val="50"/>
            <c:bubble3D val="0"/>
            <c:spPr>
              <a:solidFill>
                <a:schemeClr val="accent3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5-E7D5-4B18-8C5E-10CC1EB62177}"/>
              </c:ext>
            </c:extLst>
          </c:dPt>
          <c:dPt>
            <c:idx val="51"/>
            <c:bubble3D val="0"/>
            <c:spPr>
              <a:solidFill>
                <a:schemeClr val="accent4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7-E7D5-4B18-8C5E-10CC1EB62177}"/>
              </c:ext>
            </c:extLst>
          </c:dPt>
          <c:dPt>
            <c:idx val="52"/>
            <c:bubble3D val="0"/>
            <c:spPr>
              <a:solidFill>
                <a:schemeClr val="accent5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9-E7D5-4B18-8C5E-10CC1EB62177}"/>
              </c:ext>
            </c:extLst>
          </c:dPt>
          <c:dPt>
            <c:idx val="53"/>
            <c:bubble3D val="0"/>
            <c:spPr>
              <a:solidFill>
                <a:schemeClr val="accent6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B-E7D5-4B18-8C5E-10CC1EB62177}"/>
              </c:ext>
            </c:extLst>
          </c:dPt>
          <c:dPt>
            <c:idx val="54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D-E7D5-4B18-8C5E-10CC1EB62177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pPr>
                <a:endParaRPr lang="en-US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ND4L_CONSENSUS_PHYLOGENY_HISTG_!$A$2:$A$56</c:f>
              <c:strCache>
                <c:ptCount val="55"/>
                <c:pt idx="0">
                  <c:v> ***  # ND4L_CLUSTALW_PSARALIGN_DNA_UB #  *** </c:v>
                </c:pt>
                <c:pt idx="1">
                  <c:v> ***  # ND4L_CLUSTALW_TCSFMf_DNA_UB #  *** </c:v>
                </c:pt>
                <c:pt idx="2">
                  <c:v> ***  # ND4L_CLUSTALW_TCSf_DNA_UB #  *** </c:v>
                </c:pt>
                <c:pt idx="3">
                  <c:v> ***  # ND4L_CLUSTALW_TRIMAL_DNA_UB #  *** </c:v>
                </c:pt>
                <c:pt idx="4">
                  <c:v> ***  # ND4L_TCOFFEEPL_TCSFMw_DNA_UB #  *** </c:v>
                </c:pt>
                <c:pt idx="5">
                  <c:v> ***  # ND4L_TCOFFEEPL_TCSFMw_RYt_UB #  *** </c:v>
                </c:pt>
                <c:pt idx="6">
                  <c:v> ***  # ND4L_TCOFFEE_TCSFMw_DEG_UB #  *** </c:v>
                </c:pt>
                <c:pt idx="7">
                  <c:v> *** ND4L_ALL_TRIMALC_CDN_UB *** </c:v>
                </c:pt>
                <c:pt idx="8">
                  <c:v> *** ND4L_ALL_TRIMALC_DNA_UB *** </c:v>
                </c:pt>
                <c:pt idx="9">
                  <c:v> ***  # ND4L_MAFFTA_TCSw_DNA_UB #  *** </c:v>
                </c:pt>
                <c:pt idx="10">
                  <c:v> ***  # ND4L_MAFFTEI_TCSw_DEG_UB #  *** </c:v>
                </c:pt>
                <c:pt idx="11">
                  <c:v> ***  # ND4L_MAFFTLI_GBLOCKSC_DNA_UB #  *** </c:v>
                </c:pt>
                <c:pt idx="12">
                  <c:v> ***  # ND4L_MAFFTLI_TCSw_RYt_UB #  *** </c:v>
                </c:pt>
                <c:pt idx="13">
                  <c:v> ***  # ND4L_CLUSTALW_TCSOGw_DNA_UB #  *** </c:v>
                </c:pt>
                <c:pt idx="14">
                  <c:v> ***  # ND4L_MAFFT_TRIMALG_DNA_UB #  *** </c:v>
                </c:pt>
                <c:pt idx="15">
                  <c:v> ***  # ND4L_GRAMALIGN_PSARALIGN_CDN_UB #  *** </c:v>
                </c:pt>
                <c:pt idx="16">
                  <c:v> ***  # ND4L_GRAMALIGN_TCSFMf_CDN_UB #  *** </c:v>
                </c:pt>
                <c:pt idx="17">
                  <c:v> ***  # ND4L_GRAMALIGN_TCSf_CDN_UB #  *** </c:v>
                </c:pt>
                <c:pt idx="18">
                  <c:v> ***  # ND4L_GRAMALIGN_TRIMAL_CDN_UB #  *** </c:v>
                </c:pt>
                <c:pt idx="19">
                  <c:v> ***  # ND4L_CLUSTALW_TCSOGw_DEG_UB #  *** </c:v>
                </c:pt>
                <c:pt idx="20">
                  <c:v> ***  # ND4L_KALIGN_TCSFMf_DEG_UB #  *** </c:v>
                </c:pt>
                <c:pt idx="21">
                  <c:v> ***  # ND4L_KALIGN_TRIMAL_DEG_UB #  *** </c:v>
                </c:pt>
                <c:pt idx="22">
                  <c:v> *** ND4L_ALL_TRIMALC_DEG_UB *** </c:v>
                </c:pt>
                <c:pt idx="23">
                  <c:v> ***  # ND4L_OPAL_PSARALIGN_RYt_UB #  *** </c:v>
                </c:pt>
                <c:pt idx="24">
                  <c:v> ***  # ND4L_OPAL_TCSFMf_RYt_UB #  *** </c:v>
                </c:pt>
                <c:pt idx="25">
                  <c:v> ***  # ND4L_OPAL_TCSf_RYt_UB #  *** </c:v>
                </c:pt>
                <c:pt idx="26">
                  <c:v> ***  # ND4L_CLUSTALW_PSARALIGN_DEG_UB #  *** </c:v>
                </c:pt>
                <c:pt idx="27">
                  <c:v> ***  # ND4L_MUSCLE_TRIMALA_DNA_UB #  *** </c:v>
                </c:pt>
                <c:pt idx="28">
                  <c:v> ***  # ND4L_PRANKCD_TRIMALP_DEG_UB #  *** </c:v>
                </c:pt>
                <c:pt idx="29">
                  <c:v> ***  # ND4L_GRAMALIGN_PSARALIGN_2AA_UB #  *** </c:v>
                </c:pt>
                <c:pt idx="30">
                  <c:v> ***  # ND4L_GRAMALIGN_TCSFMf_2AA_UB #  *** </c:v>
                </c:pt>
                <c:pt idx="31">
                  <c:v> ***  # ND4L_GRAMALIGN_TCSf_2AA_UB #  *** </c:v>
                </c:pt>
                <c:pt idx="32">
                  <c:v> ***  # ND4L_KALIGN_TRIMAL_RYt_UB #  *** </c:v>
                </c:pt>
                <c:pt idx="33">
                  <c:v> ***  # ND4L_PRANKCDF_TRIMALA_2AA_UB #  *** </c:v>
                </c:pt>
                <c:pt idx="34">
                  <c:v> ***  # ND4L_PRANKCD_TRIMALG_2AA_UB #  *** </c:v>
                </c:pt>
                <c:pt idx="35">
                  <c:v> *** ND4L_ALL_TRIMALC_2AA_UB *** </c:v>
                </c:pt>
                <c:pt idx="36">
                  <c:v> ***  # ND4L_PRANKCD_TRIMALG_CDN_UB #  *** </c:v>
                </c:pt>
                <c:pt idx="37">
                  <c:v> ***  # ND4L_PRANKCD_TRIMALP_DNA_UB #  *** </c:v>
                </c:pt>
                <c:pt idx="38">
                  <c:v> ***  # ND4L_PRANKCD_TRIMALS_DNA_UB #  *** </c:v>
                </c:pt>
                <c:pt idx="39">
                  <c:v> ***  # ND4L_FSA_NOISY_RYt_UB #  *** </c:v>
                </c:pt>
                <c:pt idx="40">
                  <c:v> ***  # ND4L_GRAMALIGN_TRIMAL_2AA_UB #  *** </c:v>
                </c:pt>
                <c:pt idx="41">
                  <c:v> ***  # ND4L_KALIGN_TCSf_DEG_UB #  *** </c:v>
                </c:pt>
                <c:pt idx="42">
                  <c:v> ***  # ND4L_MAFFTLI_GBLOCKS_DEG_UB #  *** </c:v>
                </c:pt>
                <c:pt idx="43">
                  <c:v> ***  # ND4L_MAFFT_NOISY_DEG_UB #  *** </c:v>
                </c:pt>
                <c:pt idx="44">
                  <c:v> ***  # ND4L_MUSCLE_TRIMALA_DEG_UB #  *** </c:v>
                </c:pt>
                <c:pt idx="45">
                  <c:v> ***  # ND4L_MUSCLE_TRIMALA_RYt_UB #  *** </c:v>
                </c:pt>
                <c:pt idx="46">
                  <c:v> ***  # ND4L_MUSCLE_TRIMALG_DEG_UB #  *** </c:v>
                </c:pt>
                <c:pt idx="47">
                  <c:v> ***  # ND4L_MUSCLE_TRIMALG_RYt_UB #  *** </c:v>
                </c:pt>
                <c:pt idx="48">
                  <c:v> ***  # ND4L_PRANKCD_GBLOCKSC_2AA_UB #  *** </c:v>
                </c:pt>
                <c:pt idx="49">
                  <c:v> # ND4L_FSA_NOISY_DNA_UB # </c:v>
                </c:pt>
                <c:pt idx="50">
                  <c:v> # ND4L_GRAMALIGN_TRIMALP_RYt_UB # </c:v>
                </c:pt>
                <c:pt idx="51">
                  <c:v> # ND4L_MAFFTGI_TRIMALS_RYt_UB # </c:v>
                </c:pt>
                <c:pt idx="52">
                  <c:v> # ND4L_MAFFTLI_TRIMALS_DEG_UB # </c:v>
                </c:pt>
                <c:pt idx="53">
                  <c:v> # ND4L_PRANKCDF_GBLOCKSC_CDN_UB # </c:v>
                </c:pt>
                <c:pt idx="54">
                  <c:v> # ND4L_PRANKCD_TRIMALA_CDN_UB # </c:v>
                </c:pt>
              </c:strCache>
            </c:strRef>
          </c:cat>
          <c:val>
            <c:numRef>
              <c:f>ND4L_CONSENSUS_PHYLOGENY_HISTG_!$B$2:$B$56</c:f>
              <c:numCache>
                <c:formatCode>General</c:formatCode>
                <c:ptCount val="55"/>
                <c:pt idx="0">
                  <c:v>263</c:v>
                </c:pt>
                <c:pt idx="1">
                  <c:v>263</c:v>
                </c:pt>
                <c:pt idx="2">
                  <c:v>263</c:v>
                </c:pt>
                <c:pt idx="3">
                  <c:v>263</c:v>
                </c:pt>
                <c:pt idx="4">
                  <c:v>263</c:v>
                </c:pt>
                <c:pt idx="5">
                  <c:v>263</c:v>
                </c:pt>
                <c:pt idx="6">
                  <c:v>263</c:v>
                </c:pt>
                <c:pt idx="7">
                  <c:v>255</c:v>
                </c:pt>
                <c:pt idx="8">
                  <c:v>255</c:v>
                </c:pt>
                <c:pt idx="9">
                  <c:v>116</c:v>
                </c:pt>
                <c:pt idx="10">
                  <c:v>116</c:v>
                </c:pt>
                <c:pt idx="11">
                  <c:v>116</c:v>
                </c:pt>
                <c:pt idx="12">
                  <c:v>116</c:v>
                </c:pt>
                <c:pt idx="13">
                  <c:v>63</c:v>
                </c:pt>
                <c:pt idx="14">
                  <c:v>63</c:v>
                </c:pt>
                <c:pt idx="15">
                  <c:v>41</c:v>
                </c:pt>
                <c:pt idx="16">
                  <c:v>41</c:v>
                </c:pt>
                <c:pt idx="17">
                  <c:v>41</c:v>
                </c:pt>
                <c:pt idx="18">
                  <c:v>41</c:v>
                </c:pt>
                <c:pt idx="19">
                  <c:v>30</c:v>
                </c:pt>
                <c:pt idx="20">
                  <c:v>30</c:v>
                </c:pt>
                <c:pt idx="21">
                  <c:v>30</c:v>
                </c:pt>
                <c:pt idx="22">
                  <c:v>29</c:v>
                </c:pt>
                <c:pt idx="23">
                  <c:v>7</c:v>
                </c:pt>
                <c:pt idx="24">
                  <c:v>7</c:v>
                </c:pt>
                <c:pt idx="25">
                  <c:v>7</c:v>
                </c:pt>
                <c:pt idx="26">
                  <c:v>5</c:v>
                </c:pt>
                <c:pt idx="27">
                  <c:v>5</c:v>
                </c:pt>
                <c:pt idx="28">
                  <c:v>4</c:v>
                </c:pt>
                <c:pt idx="29">
                  <c:v>3</c:v>
                </c:pt>
                <c:pt idx="30">
                  <c:v>3</c:v>
                </c:pt>
                <c:pt idx="31">
                  <c:v>3</c:v>
                </c:pt>
                <c:pt idx="32">
                  <c:v>3</c:v>
                </c:pt>
                <c:pt idx="33">
                  <c:v>3</c:v>
                </c:pt>
                <c:pt idx="34">
                  <c:v>3</c:v>
                </c:pt>
                <c:pt idx="35">
                  <c:v>3</c:v>
                </c:pt>
                <c:pt idx="36">
                  <c:v>2</c:v>
                </c:pt>
                <c:pt idx="37">
                  <c:v>2</c:v>
                </c:pt>
                <c:pt idx="38">
                  <c:v>2</c:v>
                </c:pt>
                <c:pt idx="39">
                  <c:v>1</c:v>
                </c:pt>
                <c:pt idx="40">
                  <c:v>1</c:v>
                </c:pt>
                <c:pt idx="41">
                  <c:v>1</c:v>
                </c:pt>
                <c:pt idx="42">
                  <c:v>1</c:v>
                </c:pt>
                <c:pt idx="43">
                  <c:v>1</c:v>
                </c:pt>
                <c:pt idx="44">
                  <c:v>1</c:v>
                </c:pt>
                <c:pt idx="45">
                  <c:v>1</c:v>
                </c:pt>
                <c:pt idx="46">
                  <c:v>1</c:v>
                </c:pt>
                <c:pt idx="47">
                  <c:v>1</c:v>
                </c:pt>
                <c:pt idx="48">
                  <c:v>1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6E-E7D5-4B18-8C5E-10CC1EB62177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926855225186402"/>
          <c:y val="3.8176352801364416E-2"/>
          <c:w val="0.80712578838092996"/>
          <c:h val="0.9323694451986605"/>
        </c:manualLayout>
      </c:layout>
      <c:pieChart>
        <c:varyColors val="1"/>
        <c:ser>
          <c:idx val="0"/>
          <c:order val="0"/>
          <c:tx>
            <c:strRef>
              <c:f>ND5_CONSENSUS_PHYLOGENY_HISTG_!$B$1</c:f>
              <c:strCache>
                <c:ptCount val="1"/>
                <c:pt idx="0">
                  <c:v>Total Topological Support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E0E6-4E09-BF78-BD5889BB35B2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E0E6-4E09-BF78-BD5889BB35B2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E0E6-4E09-BF78-BD5889BB35B2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E0E6-4E09-BF78-BD5889BB35B2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E0E6-4E09-BF78-BD5889BB35B2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E0E6-4E09-BF78-BD5889BB35B2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E0E6-4E09-BF78-BD5889BB35B2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E0E6-4E09-BF78-BD5889BB35B2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E0E6-4E09-BF78-BD5889BB35B2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E0E6-4E09-BF78-BD5889BB35B2}"/>
              </c:ext>
            </c:extLst>
          </c:dPt>
          <c:dPt>
            <c:idx val="10"/>
            <c:bubble3D val="0"/>
            <c:spPr>
              <a:solidFill>
                <a:schemeClr val="accent5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E0E6-4E09-BF78-BD5889BB35B2}"/>
              </c:ext>
            </c:extLst>
          </c:dPt>
          <c:dPt>
            <c:idx val="11"/>
            <c:bubble3D val="0"/>
            <c:spPr>
              <a:solidFill>
                <a:schemeClr val="accent6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E0E6-4E09-BF78-BD5889BB35B2}"/>
              </c:ext>
            </c:extLst>
          </c:dPt>
          <c:dPt>
            <c:idx val="12"/>
            <c:bubble3D val="0"/>
            <c:spPr>
              <a:solidFill>
                <a:schemeClr val="accent1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E0E6-4E09-BF78-BD5889BB35B2}"/>
              </c:ext>
            </c:extLst>
          </c:dPt>
          <c:dPt>
            <c:idx val="13"/>
            <c:bubble3D val="0"/>
            <c:spPr>
              <a:solidFill>
                <a:schemeClr val="accent2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E0E6-4E09-BF78-BD5889BB35B2}"/>
              </c:ext>
            </c:extLst>
          </c:dPt>
          <c:dPt>
            <c:idx val="14"/>
            <c:bubble3D val="0"/>
            <c:spPr>
              <a:solidFill>
                <a:schemeClr val="accent3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E0E6-4E09-BF78-BD5889BB35B2}"/>
              </c:ext>
            </c:extLst>
          </c:dPt>
          <c:dPt>
            <c:idx val="15"/>
            <c:bubble3D val="0"/>
            <c:spPr>
              <a:solidFill>
                <a:schemeClr val="accent4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F-E0E6-4E09-BF78-BD5889BB35B2}"/>
              </c:ext>
            </c:extLst>
          </c:dPt>
          <c:dPt>
            <c:idx val="16"/>
            <c:bubble3D val="0"/>
            <c:spPr>
              <a:solidFill>
                <a:schemeClr val="accent5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1-E0E6-4E09-BF78-BD5889BB35B2}"/>
              </c:ext>
            </c:extLst>
          </c:dPt>
          <c:dPt>
            <c:idx val="17"/>
            <c:bubble3D val="0"/>
            <c:spPr>
              <a:solidFill>
                <a:schemeClr val="accent6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3-E0E6-4E09-BF78-BD5889BB35B2}"/>
              </c:ext>
            </c:extLst>
          </c:dPt>
          <c:dPt>
            <c:idx val="18"/>
            <c:bubble3D val="0"/>
            <c:spPr>
              <a:solidFill>
                <a:schemeClr val="accent1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5-E0E6-4E09-BF78-BD5889BB35B2}"/>
              </c:ext>
            </c:extLst>
          </c:dPt>
          <c:dPt>
            <c:idx val="19"/>
            <c:bubble3D val="0"/>
            <c:spPr>
              <a:solidFill>
                <a:schemeClr val="accent2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7-E0E6-4E09-BF78-BD5889BB35B2}"/>
              </c:ext>
            </c:extLst>
          </c:dPt>
          <c:dPt>
            <c:idx val="20"/>
            <c:bubble3D val="0"/>
            <c:spPr>
              <a:solidFill>
                <a:schemeClr val="accent3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9-E0E6-4E09-BF78-BD5889BB35B2}"/>
              </c:ext>
            </c:extLst>
          </c:dPt>
          <c:dPt>
            <c:idx val="21"/>
            <c:bubble3D val="0"/>
            <c:spPr>
              <a:solidFill>
                <a:schemeClr val="accent4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B-E0E6-4E09-BF78-BD5889BB35B2}"/>
              </c:ext>
            </c:extLst>
          </c:dPt>
          <c:dPt>
            <c:idx val="22"/>
            <c:bubble3D val="0"/>
            <c:spPr>
              <a:solidFill>
                <a:schemeClr val="accent5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D-E0E6-4E09-BF78-BD5889BB35B2}"/>
              </c:ext>
            </c:extLst>
          </c:dPt>
          <c:dPt>
            <c:idx val="23"/>
            <c:bubble3D val="0"/>
            <c:spPr>
              <a:solidFill>
                <a:schemeClr val="accent6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F-E0E6-4E09-BF78-BD5889BB35B2}"/>
              </c:ext>
            </c:extLst>
          </c:dPt>
          <c:dPt>
            <c:idx val="24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1-E0E6-4E09-BF78-BD5889BB35B2}"/>
              </c:ext>
            </c:extLst>
          </c:dPt>
          <c:dPt>
            <c:idx val="25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3-E0E6-4E09-BF78-BD5889BB35B2}"/>
              </c:ext>
            </c:extLst>
          </c:dPt>
          <c:dPt>
            <c:idx val="26"/>
            <c:bubble3D val="0"/>
            <c:spPr>
              <a:solidFill>
                <a:schemeClr val="accent3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5-E0E6-4E09-BF78-BD5889BB35B2}"/>
              </c:ext>
            </c:extLst>
          </c:dPt>
          <c:dPt>
            <c:idx val="27"/>
            <c:bubble3D val="0"/>
            <c:spPr>
              <a:solidFill>
                <a:schemeClr val="accent4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7-E0E6-4E09-BF78-BD5889BB35B2}"/>
              </c:ext>
            </c:extLst>
          </c:dPt>
          <c:dPt>
            <c:idx val="28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9-E0E6-4E09-BF78-BD5889BB35B2}"/>
              </c:ext>
            </c:extLst>
          </c:dPt>
          <c:dPt>
            <c:idx val="29"/>
            <c:bubble3D val="0"/>
            <c:spPr>
              <a:solidFill>
                <a:schemeClr val="accent6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B-E0E6-4E09-BF78-BD5889BB35B2}"/>
              </c:ext>
            </c:extLst>
          </c:dPt>
          <c:dPt>
            <c:idx val="30"/>
            <c:bubble3D val="0"/>
            <c:spPr>
              <a:solidFill>
                <a:schemeClr val="accent1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D-E0E6-4E09-BF78-BD5889BB35B2}"/>
              </c:ext>
            </c:extLst>
          </c:dPt>
          <c:dPt>
            <c:idx val="31"/>
            <c:bubble3D val="0"/>
            <c:spPr>
              <a:solidFill>
                <a:schemeClr val="accent2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F-E0E6-4E09-BF78-BD5889BB35B2}"/>
              </c:ext>
            </c:extLst>
          </c:dPt>
          <c:dPt>
            <c:idx val="32"/>
            <c:bubble3D val="0"/>
            <c:spPr>
              <a:solidFill>
                <a:schemeClr val="accent3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1-E0E6-4E09-BF78-BD5889BB35B2}"/>
              </c:ext>
            </c:extLst>
          </c:dPt>
          <c:dPt>
            <c:idx val="33"/>
            <c:bubble3D val="0"/>
            <c:spPr>
              <a:solidFill>
                <a:schemeClr val="accent4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3-E0E6-4E09-BF78-BD5889BB35B2}"/>
              </c:ext>
            </c:extLst>
          </c:dPt>
          <c:dPt>
            <c:idx val="34"/>
            <c:bubble3D val="0"/>
            <c:spPr>
              <a:solidFill>
                <a:schemeClr val="accent5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5-E0E6-4E09-BF78-BD5889BB35B2}"/>
              </c:ext>
            </c:extLst>
          </c:dPt>
          <c:dPt>
            <c:idx val="35"/>
            <c:bubble3D val="0"/>
            <c:spPr>
              <a:solidFill>
                <a:schemeClr val="accent6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7-E0E6-4E09-BF78-BD5889BB35B2}"/>
              </c:ext>
            </c:extLst>
          </c:dPt>
          <c:dPt>
            <c:idx val="36"/>
            <c:bubble3D val="0"/>
            <c:spPr>
              <a:solidFill>
                <a:schemeClr val="accent1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9-E0E6-4E09-BF78-BD5889BB35B2}"/>
              </c:ext>
            </c:extLst>
          </c:dPt>
          <c:dPt>
            <c:idx val="37"/>
            <c:bubble3D val="0"/>
            <c:spPr>
              <a:solidFill>
                <a:schemeClr val="accent2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B-E0E6-4E09-BF78-BD5889BB35B2}"/>
              </c:ext>
            </c:extLst>
          </c:dPt>
          <c:dPt>
            <c:idx val="38"/>
            <c:bubble3D val="0"/>
            <c:spPr>
              <a:solidFill>
                <a:schemeClr val="accent3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D-E0E6-4E09-BF78-BD5889BB35B2}"/>
              </c:ext>
            </c:extLst>
          </c:dPt>
          <c:dPt>
            <c:idx val="39"/>
            <c:bubble3D val="0"/>
            <c:spPr>
              <a:solidFill>
                <a:schemeClr val="accent4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F-E0E6-4E09-BF78-BD5889BB35B2}"/>
              </c:ext>
            </c:extLst>
          </c:dPt>
          <c:dPt>
            <c:idx val="40"/>
            <c:bubble3D val="0"/>
            <c:spPr>
              <a:solidFill>
                <a:schemeClr val="accent5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1-E0E6-4E09-BF78-BD5889BB35B2}"/>
              </c:ext>
            </c:extLst>
          </c:dPt>
          <c:dPt>
            <c:idx val="41"/>
            <c:bubble3D val="0"/>
            <c:spPr>
              <a:solidFill>
                <a:schemeClr val="accent6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3-E0E6-4E09-BF78-BD5889BB35B2}"/>
              </c:ext>
            </c:extLst>
          </c:dPt>
          <c:dPt>
            <c:idx val="42"/>
            <c:bubble3D val="0"/>
            <c:spPr>
              <a:solidFill>
                <a:schemeClr val="accent1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5-E0E6-4E09-BF78-BD5889BB35B2}"/>
              </c:ext>
            </c:extLst>
          </c:dPt>
          <c:dPt>
            <c:idx val="43"/>
            <c:bubble3D val="0"/>
            <c:spPr>
              <a:solidFill>
                <a:schemeClr val="accent2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7-E0E6-4E09-BF78-BD5889BB35B2}"/>
              </c:ext>
            </c:extLst>
          </c:dPt>
          <c:dPt>
            <c:idx val="44"/>
            <c:bubble3D val="0"/>
            <c:spPr>
              <a:solidFill>
                <a:schemeClr val="accent3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9-E0E6-4E09-BF78-BD5889BB35B2}"/>
              </c:ext>
            </c:extLst>
          </c:dPt>
          <c:dPt>
            <c:idx val="45"/>
            <c:bubble3D val="0"/>
            <c:spPr>
              <a:solidFill>
                <a:schemeClr val="accent4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B-E0E6-4E09-BF78-BD5889BB35B2}"/>
              </c:ext>
            </c:extLst>
          </c:dPt>
          <c:dPt>
            <c:idx val="46"/>
            <c:bubble3D val="0"/>
            <c:spPr>
              <a:solidFill>
                <a:schemeClr val="accent5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D-E0E6-4E09-BF78-BD5889BB35B2}"/>
              </c:ext>
            </c:extLst>
          </c:dPt>
          <c:dPt>
            <c:idx val="47"/>
            <c:bubble3D val="0"/>
            <c:spPr>
              <a:solidFill>
                <a:schemeClr val="accent6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F-E0E6-4E09-BF78-BD5889BB35B2}"/>
              </c:ext>
            </c:extLst>
          </c:dPt>
          <c:dPt>
            <c:idx val="48"/>
            <c:bubble3D val="0"/>
            <c:spPr>
              <a:solidFill>
                <a:schemeClr val="accent1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1-E0E6-4E09-BF78-BD5889BB35B2}"/>
              </c:ext>
            </c:extLst>
          </c:dPt>
          <c:dPt>
            <c:idx val="49"/>
            <c:bubble3D val="0"/>
            <c:spPr>
              <a:solidFill>
                <a:schemeClr val="accent2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3-E0E6-4E09-BF78-BD5889BB35B2}"/>
              </c:ext>
            </c:extLst>
          </c:dPt>
          <c:dPt>
            <c:idx val="50"/>
            <c:bubble3D val="0"/>
            <c:spPr>
              <a:solidFill>
                <a:schemeClr val="accent3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5-E0E6-4E09-BF78-BD5889BB35B2}"/>
              </c:ext>
            </c:extLst>
          </c:dPt>
          <c:dPt>
            <c:idx val="51"/>
            <c:bubble3D val="0"/>
            <c:spPr>
              <a:solidFill>
                <a:schemeClr val="accent4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7-E0E6-4E09-BF78-BD5889BB35B2}"/>
              </c:ext>
            </c:extLst>
          </c:dPt>
          <c:dPt>
            <c:idx val="52"/>
            <c:bubble3D val="0"/>
            <c:spPr>
              <a:solidFill>
                <a:schemeClr val="accent5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9-E0E6-4E09-BF78-BD5889BB35B2}"/>
              </c:ext>
            </c:extLst>
          </c:dPt>
          <c:dPt>
            <c:idx val="53"/>
            <c:bubble3D val="0"/>
            <c:spPr>
              <a:solidFill>
                <a:schemeClr val="accent6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B-E0E6-4E09-BF78-BD5889BB35B2}"/>
              </c:ext>
            </c:extLst>
          </c:dPt>
          <c:dPt>
            <c:idx val="54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D-E0E6-4E09-BF78-BD5889BB35B2}"/>
              </c:ext>
            </c:extLst>
          </c:dPt>
          <c:dPt>
            <c:idx val="55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F-E0E6-4E09-BF78-BD5889BB35B2}"/>
              </c:ext>
            </c:extLst>
          </c:dPt>
          <c:dPt>
            <c:idx val="56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1-E0E6-4E09-BF78-BD5889BB35B2}"/>
              </c:ext>
            </c:extLst>
          </c:dPt>
          <c:dPt>
            <c:idx val="57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3-E0E6-4E09-BF78-BD5889BB35B2}"/>
              </c:ext>
            </c:extLst>
          </c:dPt>
          <c:dPt>
            <c:idx val="58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5-E0E6-4E09-BF78-BD5889BB35B2}"/>
              </c:ext>
            </c:extLst>
          </c:dPt>
          <c:dPt>
            <c:idx val="59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7-E0E6-4E09-BF78-BD5889BB35B2}"/>
              </c:ext>
            </c:extLst>
          </c:dPt>
          <c:dPt>
            <c:idx val="60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9-E0E6-4E09-BF78-BD5889BB35B2}"/>
              </c:ext>
            </c:extLst>
          </c:dPt>
          <c:dPt>
            <c:idx val="61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B-E0E6-4E09-BF78-BD5889BB35B2}"/>
              </c:ext>
            </c:extLst>
          </c:dPt>
          <c:dPt>
            <c:idx val="62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D-E0E6-4E09-BF78-BD5889BB35B2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pPr>
                <a:endParaRPr lang="en-US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ND5_CONSENSUS_PHYLOGENY_HISTG_!$A$2:$A$64</c:f>
              <c:strCache>
                <c:ptCount val="63"/>
                <c:pt idx="0">
                  <c:v> ***  # ND5_CLUSTALW_GBLOCKSC_RYt_UB #  *** </c:v>
                </c:pt>
                <c:pt idx="1">
                  <c:v> ***  # ND5_FSA_TRIMALA_DNA_UB #  *** </c:v>
                </c:pt>
                <c:pt idx="2">
                  <c:v> ***  # ND5_FSA_TRIMALA_RYt_UB #  *** </c:v>
                </c:pt>
                <c:pt idx="3">
                  <c:v> ***  # ND5_FSA_TRIMALG_DNA_UB #  *** </c:v>
                </c:pt>
                <c:pt idx="4">
                  <c:v> ***  # ND5_FSA_TRIMALG_RYt_UB #  *** </c:v>
                </c:pt>
                <c:pt idx="5">
                  <c:v> ***  # ND5_GRAMALIGN_MAXALIGN_RYt_UB #  *** </c:v>
                </c:pt>
                <c:pt idx="6">
                  <c:v> ***  # ND5_GRAMALIGN_PSARALIGN_RYt_UB #  *** </c:v>
                </c:pt>
                <c:pt idx="7">
                  <c:v> ***  # ND5_GRAMALIGN_TCSFMf_RYt_UB #  *** </c:v>
                </c:pt>
                <c:pt idx="8">
                  <c:v> ***  # ND5_GRAMALIGN_TCSf_RYt_UB #  *** </c:v>
                </c:pt>
                <c:pt idx="9">
                  <c:v> ***  # ND5_GRAMALIGN_TRIMAL_RYt_UB #  *** </c:v>
                </c:pt>
                <c:pt idx="10">
                  <c:v> ***  # ND5_MACSE_GBLOCKS_RYt_UB #  *** </c:v>
                </c:pt>
                <c:pt idx="11">
                  <c:v> ***  # ND5_MACSE_MAXALIGN_DNA_UB #  *** </c:v>
                </c:pt>
                <c:pt idx="12">
                  <c:v> ***  # ND5_MACSE_PSARALIGN_DNA_UB #  *** </c:v>
                </c:pt>
                <c:pt idx="13">
                  <c:v> ***  # ND5_MACSE_TCSFMf_DNA_UB #  *** </c:v>
                </c:pt>
                <c:pt idx="14">
                  <c:v> ***  # ND5_MACSE_TCSf_DNA_UB #  *** </c:v>
                </c:pt>
                <c:pt idx="15">
                  <c:v> ***  # ND5_MACSE_TRIMAL_DNA_UB #  *** </c:v>
                </c:pt>
                <c:pt idx="16">
                  <c:v> ***  # ND5_MAFFTGI_GBLOCKS_DNA_UB #  *** </c:v>
                </c:pt>
                <c:pt idx="17">
                  <c:v> *** ND5_ALL_TRIMALC_DNA_UB *** </c:v>
                </c:pt>
                <c:pt idx="18">
                  <c:v> *** ND5_ALL_TRIMALC_RYt_UB *** </c:v>
                </c:pt>
                <c:pt idx="19">
                  <c:v> *** ND5_ALL_WEAVEALIGN_DNA_UB *** </c:v>
                </c:pt>
                <c:pt idx="20">
                  <c:v> ***  # ND5_TCOFFEEPL_TCSOGw_RYt_UB #  *** </c:v>
                </c:pt>
                <c:pt idx="21">
                  <c:v> ***  # ND5_TCOFFEE_TCSFMw_DEG_UB #  *** </c:v>
                </c:pt>
                <c:pt idx="22">
                  <c:v> ***  # ND5_TCOFFEE_TCSFMw_DNA_UB #  *** </c:v>
                </c:pt>
                <c:pt idx="23">
                  <c:v> ***  # ND5_TCOFFEE_TCSFMw_RYt_UB #  *** </c:v>
                </c:pt>
                <c:pt idx="24">
                  <c:v> ***  # ND5_MAFFTGI_GBLOCKSC_DNA_UB #  *** </c:v>
                </c:pt>
                <c:pt idx="25">
                  <c:v> ***  # ND5_TCOFFEEPL_TCSw_DEG_UB #  *** </c:v>
                </c:pt>
                <c:pt idx="26">
                  <c:v> ***  # ND5_TCOFFEEPL_TCSw_DNA_UB #  *** </c:v>
                </c:pt>
                <c:pt idx="27">
                  <c:v> ***  # ND5_TCOFFEEPL_TCSOGw_DNA_UB #  *** </c:v>
                </c:pt>
                <c:pt idx="28">
                  <c:v> ***  # ND5_TCOFFEEPL_TCSw_RYt_UB #  *** </c:v>
                </c:pt>
                <c:pt idx="29">
                  <c:v> ***  # ND5_TCOFFEE_GBLOCKS_DEG_UB #  *** </c:v>
                </c:pt>
                <c:pt idx="30">
                  <c:v> ***  # ND5_OPAL_MAXALIGN_CDN_UB #  *** </c:v>
                </c:pt>
                <c:pt idx="31">
                  <c:v> ***  # ND5_OPAL_PSARALIGN_CDN_UB #  *** </c:v>
                </c:pt>
                <c:pt idx="32">
                  <c:v> ***  # ND5_OPAL_TCSFMf_CDN_UB #  *** </c:v>
                </c:pt>
                <c:pt idx="33">
                  <c:v> ***  # ND5_OPAL_TCSf_CDN_UB #  *** </c:v>
                </c:pt>
                <c:pt idx="34">
                  <c:v> ***  # ND5_OPAL_TRIMAL_CDN_UB #  *** </c:v>
                </c:pt>
                <c:pt idx="35">
                  <c:v> ***  # ND5_OPAL_MAXALIGN_2AA_UB #  *** </c:v>
                </c:pt>
                <c:pt idx="36">
                  <c:v> ***  # ND5_OPAL_PSARALIGN_2AA_UB #  *** </c:v>
                </c:pt>
                <c:pt idx="37">
                  <c:v> ***  # ND5_MACSE_MAXALIGN_DEG_UB #  *** </c:v>
                </c:pt>
                <c:pt idx="38">
                  <c:v> ***  # ND5_MACSE_PSARALIGN_DEG_UB #  *** </c:v>
                </c:pt>
                <c:pt idx="39">
                  <c:v> ***  # ND5_MACSE_TCSFMf_DEG_UB #  *** </c:v>
                </c:pt>
                <c:pt idx="40">
                  <c:v> ***  # ND5_MACSE_TCSf_DEG_UB #  *** </c:v>
                </c:pt>
                <c:pt idx="41">
                  <c:v> ***  # ND5_MACSE_TRIMAL_DEG_UB #  *** </c:v>
                </c:pt>
                <c:pt idx="42">
                  <c:v> ***  # ND5_OPAL_TCSFMf_2AA_UB #  *** </c:v>
                </c:pt>
                <c:pt idx="43">
                  <c:v> ***  # ND5_OPAL_TCSf_2AA_UB #  *** </c:v>
                </c:pt>
                <c:pt idx="44">
                  <c:v> ***  # ND5_OPAL_TRIMAL_2AA_UB #  *** </c:v>
                </c:pt>
                <c:pt idx="45">
                  <c:v> ***  # ND5_FSA_TRIMALA_DEG_UB #  *** </c:v>
                </c:pt>
                <c:pt idx="46">
                  <c:v> ***  # ND5_FSA_TRIMALG_DEG_UB #  *** </c:v>
                </c:pt>
                <c:pt idx="47">
                  <c:v> ***  # ND5_MAFFTA_GBLOCKSC_2AA_UB #  *** </c:v>
                </c:pt>
                <c:pt idx="48">
                  <c:v> *** ND5_ALL_WEAVEALIGN_DEG_UB *** </c:v>
                </c:pt>
                <c:pt idx="49">
                  <c:v> ***  # ND5_GRAMALIGN_TRIMALS_DNA_UB #  *** </c:v>
                </c:pt>
                <c:pt idx="50">
                  <c:v> ***  # ND5_MAFFTGI_GBLOCKSC_CDN_UB #  *** </c:v>
                </c:pt>
                <c:pt idx="51">
                  <c:v> *** ND5_ALL_TRIMALC_2AA_UB *** </c:v>
                </c:pt>
                <c:pt idx="52">
                  <c:v> *** ND5_ALL_TRIMALC_CDN_UB *** </c:v>
                </c:pt>
                <c:pt idx="53">
                  <c:v> ***  # ND5_MAFFTGI_GBLOCKSC_DEG_UB #  *** </c:v>
                </c:pt>
                <c:pt idx="54">
                  <c:v> ***  # ND5_PROBCONS_TRIMALP_DNA_UB #  *** </c:v>
                </c:pt>
                <c:pt idx="55">
                  <c:v> ***  # ND5_MAFFTA_TRIMALS_DEG_UB #  *** </c:v>
                </c:pt>
                <c:pt idx="56">
                  <c:v> ***  # ND5_TCOFFEEPL_NOISY_DNA_UB #  *** </c:v>
                </c:pt>
                <c:pt idx="57">
                  <c:v> ***  # ND5_MAFFTF1_TRIMALA_2AA_UB #  *** </c:v>
                </c:pt>
                <c:pt idx="58">
                  <c:v> ***  # ND5_TCOFFEEPL_NOISY_DEG_UB #  *** </c:v>
                </c:pt>
                <c:pt idx="59">
                  <c:v> ***  # ND5_TCOFFEEPL_NOISY_RYt_UB #  *** </c:v>
                </c:pt>
                <c:pt idx="60">
                  <c:v> # ND5_PROBCONS_TRIMALP_DEG_UB # </c:v>
                </c:pt>
                <c:pt idx="61">
                  <c:v> # ND5_PROBCONS_TRIMALP_RYt_UB # </c:v>
                </c:pt>
                <c:pt idx="62">
                  <c:v> ***  # ND5_TCOFFEE_TRIMALS_RYt_UB #  *** </c:v>
                </c:pt>
              </c:strCache>
            </c:strRef>
          </c:cat>
          <c:val>
            <c:numRef>
              <c:f>ND5_CONSENSUS_PHYLOGENY_HISTG_!$B$2:$B$64</c:f>
              <c:numCache>
                <c:formatCode>General</c:formatCode>
                <c:ptCount val="63"/>
                <c:pt idx="0">
                  <c:v>351</c:v>
                </c:pt>
                <c:pt idx="1">
                  <c:v>351</c:v>
                </c:pt>
                <c:pt idx="2">
                  <c:v>351</c:v>
                </c:pt>
                <c:pt idx="3">
                  <c:v>351</c:v>
                </c:pt>
                <c:pt idx="4">
                  <c:v>351</c:v>
                </c:pt>
                <c:pt idx="5">
                  <c:v>351</c:v>
                </c:pt>
                <c:pt idx="6">
                  <c:v>351</c:v>
                </c:pt>
                <c:pt idx="7">
                  <c:v>351</c:v>
                </c:pt>
                <c:pt idx="8">
                  <c:v>351</c:v>
                </c:pt>
                <c:pt idx="9">
                  <c:v>351</c:v>
                </c:pt>
                <c:pt idx="10">
                  <c:v>351</c:v>
                </c:pt>
                <c:pt idx="11">
                  <c:v>351</c:v>
                </c:pt>
                <c:pt idx="12">
                  <c:v>351</c:v>
                </c:pt>
                <c:pt idx="13">
                  <c:v>351</c:v>
                </c:pt>
                <c:pt idx="14">
                  <c:v>351</c:v>
                </c:pt>
                <c:pt idx="15">
                  <c:v>351</c:v>
                </c:pt>
                <c:pt idx="16">
                  <c:v>351</c:v>
                </c:pt>
                <c:pt idx="17">
                  <c:v>346</c:v>
                </c:pt>
                <c:pt idx="18">
                  <c:v>346</c:v>
                </c:pt>
                <c:pt idx="19">
                  <c:v>346</c:v>
                </c:pt>
                <c:pt idx="20">
                  <c:v>242</c:v>
                </c:pt>
                <c:pt idx="21">
                  <c:v>222</c:v>
                </c:pt>
                <c:pt idx="22">
                  <c:v>221</c:v>
                </c:pt>
                <c:pt idx="23">
                  <c:v>220</c:v>
                </c:pt>
                <c:pt idx="24">
                  <c:v>93</c:v>
                </c:pt>
                <c:pt idx="25">
                  <c:v>67</c:v>
                </c:pt>
                <c:pt idx="26">
                  <c:v>66</c:v>
                </c:pt>
                <c:pt idx="27">
                  <c:v>64</c:v>
                </c:pt>
                <c:pt idx="28">
                  <c:v>47</c:v>
                </c:pt>
                <c:pt idx="29">
                  <c:v>42</c:v>
                </c:pt>
                <c:pt idx="30">
                  <c:v>38</c:v>
                </c:pt>
                <c:pt idx="31">
                  <c:v>37</c:v>
                </c:pt>
                <c:pt idx="32">
                  <c:v>36</c:v>
                </c:pt>
                <c:pt idx="33">
                  <c:v>35</c:v>
                </c:pt>
                <c:pt idx="34">
                  <c:v>34</c:v>
                </c:pt>
                <c:pt idx="35">
                  <c:v>23</c:v>
                </c:pt>
                <c:pt idx="36">
                  <c:v>22</c:v>
                </c:pt>
                <c:pt idx="37">
                  <c:v>21</c:v>
                </c:pt>
                <c:pt idx="38">
                  <c:v>21</c:v>
                </c:pt>
                <c:pt idx="39">
                  <c:v>21</c:v>
                </c:pt>
                <c:pt idx="40">
                  <c:v>21</c:v>
                </c:pt>
                <c:pt idx="41">
                  <c:v>21</c:v>
                </c:pt>
                <c:pt idx="42">
                  <c:v>21</c:v>
                </c:pt>
                <c:pt idx="43">
                  <c:v>20</c:v>
                </c:pt>
                <c:pt idx="44">
                  <c:v>19</c:v>
                </c:pt>
                <c:pt idx="45">
                  <c:v>12</c:v>
                </c:pt>
                <c:pt idx="46">
                  <c:v>12</c:v>
                </c:pt>
                <c:pt idx="47">
                  <c:v>8</c:v>
                </c:pt>
                <c:pt idx="48">
                  <c:v>7</c:v>
                </c:pt>
                <c:pt idx="49">
                  <c:v>6</c:v>
                </c:pt>
                <c:pt idx="50">
                  <c:v>5</c:v>
                </c:pt>
                <c:pt idx="51">
                  <c:v>5</c:v>
                </c:pt>
                <c:pt idx="52">
                  <c:v>5</c:v>
                </c:pt>
                <c:pt idx="53">
                  <c:v>4</c:v>
                </c:pt>
                <c:pt idx="54">
                  <c:v>4</c:v>
                </c:pt>
                <c:pt idx="55">
                  <c:v>2</c:v>
                </c:pt>
                <c:pt idx="56">
                  <c:v>2</c:v>
                </c:pt>
                <c:pt idx="57">
                  <c:v>1</c:v>
                </c:pt>
                <c:pt idx="58">
                  <c:v>1</c:v>
                </c:pt>
                <c:pt idx="59">
                  <c:v>1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7E-E0E6-4E09-BF78-BD5889BB35B2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070355788859725"/>
          <c:y val="3.1626873643556985E-2"/>
          <c:w val="0.78259142407427396"/>
          <c:h val="0.94689238603461878"/>
        </c:manualLayout>
      </c:layout>
      <c:pieChart>
        <c:varyColors val="1"/>
        <c:ser>
          <c:idx val="0"/>
          <c:order val="0"/>
          <c:tx>
            <c:strRef>
              <c:f>ND5_CONSENSUS_PHYLOGENY_HISTG_!$B$1</c:f>
              <c:strCache>
                <c:ptCount val="1"/>
                <c:pt idx="0">
                  <c:v>Total Topological Support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014-4E20-8E8C-F49929C55DAA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C014-4E20-8E8C-F49929C55DAA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C014-4E20-8E8C-F49929C55DAA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C014-4E20-8E8C-F49929C55DAA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C014-4E20-8E8C-F49929C55DAA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pPr>
                <a:endParaRPr lang="en-US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ND5_CONSENSUS_PHYLOGENY_HISTG_!$A$2:$A$6</c:f>
              <c:strCache>
                <c:ptCount val="5"/>
                <c:pt idx="0">
                  <c:v> ***  # ND5_GRAMALIGN_RYt_UB #  *** </c:v>
                </c:pt>
                <c:pt idx="1">
                  <c:v> ***  # ND5_MACSE_DNA_UB #  *** </c:v>
                </c:pt>
                <c:pt idx="2">
                  <c:v> ***  # ND5_OPAL_CDN_UB #  *** </c:v>
                </c:pt>
                <c:pt idx="3">
                  <c:v> ***  # ND5_MACSE_DEG_UB #  *** </c:v>
                </c:pt>
                <c:pt idx="4">
                  <c:v> ***  # ND5_OPAL_2AA_UB #  *** </c:v>
                </c:pt>
              </c:strCache>
            </c:strRef>
          </c:cat>
          <c:val>
            <c:numRef>
              <c:f>ND5_CONSENSUS_PHYLOGENY_HISTG_!$B$2:$B$6</c:f>
              <c:numCache>
                <c:formatCode>General</c:formatCode>
                <c:ptCount val="5"/>
                <c:pt idx="0">
                  <c:v>30</c:v>
                </c:pt>
                <c:pt idx="1">
                  <c:v>30</c:v>
                </c:pt>
                <c:pt idx="2">
                  <c:v>5</c:v>
                </c:pt>
                <c:pt idx="3">
                  <c:v>3</c:v>
                </c:pt>
                <c:pt idx="4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C014-4E20-8E8C-F49929C55DAA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254493188351456"/>
          <c:y val="4.3294238343335442E-2"/>
          <c:w val="0.76443394575678048"/>
          <c:h val="0.92493495762340217"/>
        </c:manualLayout>
      </c:layout>
      <c:pieChart>
        <c:varyColors val="1"/>
        <c:ser>
          <c:idx val="0"/>
          <c:order val="0"/>
          <c:tx>
            <c:strRef>
              <c:f>ND6_CONSENSUS_PHYLOGENY_HISTG_!$B$1</c:f>
              <c:strCache>
                <c:ptCount val="1"/>
                <c:pt idx="0">
                  <c:v>Total Topological Support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0F55-4F84-AC0B-0449A3C4433A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0F55-4F84-AC0B-0449A3C4433A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0F55-4F84-AC0B-0449A3C4433A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0F55-4F84-AC0B-0449A3C4433A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0F55-4F84-AC0B-0449A3C4433A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0F55-4F84-AC0B-0449A3C4433A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pPr>
                <a:endParaRPr lang="en-US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ND6_CONSENSUS_PHYLOGENY_HISTG_!$A$2:$A$7</c:f>
              <c:strCache>
                <c:ptCount val="6"/>
                <c:pt idx="0">
                  <c:v> ***  # ND6_GRAMALIGN_RYt_UB #  *** </c:v>
                </c:pt>
                <c:pt idx="1">
                  <c:v> ***  # ND6_TCOFFEEPL_DNA_UB #  *** </c:v>
                </c:pt>
                <c:pt idx="2">
                  <c:v> ***  # ND6_TCOFFEE_DNA_UB #  *** </c:v>
                </c:pt>
                <c:pt idx="3">
                  <c:v> ***  # ND6_MACSE_DEG_UB #  *** </c:v>
                </c:pt>
                <c:pt idx="4">
                  <c:v> ***  # ND6_MAFFTA_CDN_UB #  *** </c:v>
                </c:pt>
                <c:pt idx="5">
                  <c:v> ***  # ND6_GRAMALIGN_2AA_UB #  *** </c:v>
                </c:pt>
              </c:strCache>
            </c:strRef>
          </c:cat>
          <c:val>
            <c:numRef>
              <c:f>ND6_CONSENSUS_PHYLOGENY_HISTG_!$B$2:$B$7</c:f>
              <c:numCache>
                <c:formatCode>General</c:formatCode>
                <c:ptCount val="6"/>
                <c:pt idx="0">
                  <c:v>23</c:v>
                </c:pt>
                <c:pt idx="1">
                  <c:v>11</c:v>
                </c:pt>
                <c:pt idx="2">
                  <c:v>11</c:v>
                </c:pt>
                <c:pt idx="3">
                  <c:v>7</c:v>
                </c:pt>
                <c:pt idx="4">
                  <c:v>7</c:v>
                </c:pt>
                <c:pt idx="5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0F55-4F84-AC0B-0449A3C4433A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964880322795471"/>
          <c:y val="3.9367061875886206E-2"/>
          <c:w val="0.80970051318212088"/>
          <c:h val="0.93534369626210512"/>
        </c:manualLayout>
      </c:layout>
      <c:pieChart>
        <c:varyColors val="1"/>
        <c:ser>
          <c:idx val="0"/>
          <c:order val="0"/>
          <c:tx>
            <c:strRef>
              <c:f>ND6_CONSENSUS_PHYLOGENY_HISTG_!$B$1</c:f>
              <c:strCache>
                <c:ptCount val="1"/>
                <c:pt idx="0">
                  <c:v>Total Topological Support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17B-48B2-8E04-4F98FA861CAA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C17B-48B2-8E04-4F98FA861CAA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C17B-48B2-8E04-4F98FA861CAA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C17B-48B2-8E04-4F98FA861CAA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C17B-48B2-8E04-4F98FA861CAA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C17B-48B2-8E04-4F98FA861CAA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C17B-48B2-8E04-4F98FA861CAA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C17B-48B2-8E04-4F98FA861CAA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C17B-48B2-8E04-4F98FA861CAA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C17B-48B2-8E04-4F98FA861CAA}"/>
              </c:ext>
            </c:extLst>
          </c:dPt>
          <c:dPt>
            <c:idx val="10"/>
            <c:bubble3D val="0"/>
            <c:spPr>
              <a:solidFill>
                <a:schemeClr val="accent5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C17B-48B2-8E04-4F98FA861CAA}"/>
              </c:ext>
            </c:extLst>
          </c:dPt>
          <c:dPt>
            <c:idx val="11"/>
            <c:bubble3D val="0"/>
            <c:spPr>
              <a:solidFill>
                <a:schemeClr val="accent6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C17B-48B2-8E04-4F98FA861CAA}"/>
              </c:ext>
            </c:extLst>
          </c:dPt>
          <c:dPt>
            <c:idx val="12"/>
            <c:bubble3D val="0"/>
            <c:spPr>
              <a:solidFill>
                <a:schemeClr val="accent1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C17B-48B2-8E04-4F98FA861CAA}"/>
              </c:ext>
            </c:extLst>
          </c:dPt>
          <c:dPt>
            <c:idx val="13"/>
            <c:bubble3D val="0"/>
            <c:spPr>
              <a:solidFill>
                <a:schemeClr val="accent2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C17B-48B2-8E04-4F98FA861CAA}"/>
              </c:ext>
            </c:extLst>
          </c:dPt>
          <c:dPt>
            <c:idx val="14"/>
            <c:bubble3D val="0"/>
            <c:spPr>
              <a:solidFill>
                <a:schemeClr val="accent3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C17B-48B2-8E04-4F98FA861CAA}"/>
              </c:ext>
            </c:extLst>
          </c:dPt>
          <c:dPt>
            <c:idx val="15"/>
            <c:bubble3D val="0"/>
            <c:spPr>
              <a:solidFill>
                <a:schemeClr val="accent4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F-C17B-48B2-8E04-4F98FA861CAA}"/>
              </c:ext>
            </c:extLst>
          </c:dPt>
          <c:dPt>
            <c:idx val="16"/>
            <c:bubble3D val="0"/>
            <c:spPr>
              <a:solidFill>
                <a:schemeClr val="accent5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1-C17B-48B2-8E04-4F98FA861CAA}"/>
              </c:ext>
            </c:extLst>
          </c:dPt>
          <c:dPt>
            <c:idx val="17"/>
            <c:bubble3D val="0"/>
            <c:spPr>
              <a:solidFill>
                <a:schemeClr val="accent6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3-C17B-48B2-8E04-4F98FA861CAA}"/>
              </c:ext>
            </c:extLst>
          </c:dPt>
          <c:dPt>
            <c:idx val="18"/>
            <c:bubble3D val="0"/>
            <c:spPr>
              <a:solidFill>
                <a:schemeClr val="accent1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5-C17B-48B2-8E04-4F98FA861CAA}"/>
              </c:ext>
            </c:extLst>
          </c:dPt>
          <c:dPt>
            <c:idx val="19"/>
            <c:bubble3D val="0"/>
            <c:spPr>
              <a:solidFill>
                <a:schemeClr val="accent2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7-C17B-48B2-8E04-4F98FA861CAA}"/>
              </c:ext>
            </c:extLst>
          </c:dPt>
          <c:dPt>
            <c:idx val="20"/>
            <c:bubble3D val="0"/>
            <c:spPr>
              <a:solidFill>
                <a:schemeClr val="accent3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9-C17B-48B2-8E04-4F98FA861CAA}"/>
              </c:ext>
            </c:extLst>
          </c:dPt>
          <c:dPt>
            <c:idx val="21"/>
            <c:bubble3D val="0"/>
            <c:spPr>
              <a:solidFill>
                <a:schemeClr val="accent4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B-C17B-48B2-8E04-4F98FA861CAA}"/>
              </c:ext>
            </c:extLst>
          </c:dPt>
          <c:dPt>
            <c:idx val="22"/>
            <c:bubble3D val="0"/>
            <c:spPr>
              <a:solidFill>
                <a:schemeClr val="accent5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D-C17B-48B2-8E04-4F98FA861CAA}"/>
              </c:ext>
            </c:extLst>
          </c:dPt>
          <c:dPt>
            <c:idx val="23"/>
            <c:bubble3D val="0"/>
            <c:spPr>
              <a:solidFill>
                <a:schemeClr val="accent6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F-C17B-48B2-8E04-4F98FA861CAA}"/>
              </c:ext>
            </c:extLst>
          </c:dPt>
          <c:dPt>
            <c:idx val="24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1-C17B-48B2-8E04-4F98FA861CAA}"/>
              </c:ext>
            </c:extLst>
          </c:dPt>
          <c:dPt>
            <c:idx val="25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3-C17B-48B2-8E04-4F98FA861CAA}"/>
              </c:ext>
            </c:extLst>
          </c:dPt>
          <c:dPt>
            <c:idx val="26"/>
            <c:bubble3D val="0"/>
            <c:spPr>
              <a:solidFill>
                <a:schemeClr val="accent3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5-C17B-48B2-8E04-4F98FA861CAA}"/>
              </c:ext>
            </c:extLst>
          </c:dPt>
          <c:dPt>
            <c:idx val="27"/>
            <c:bubble3D val="0"/>
            <c:spPr>
              <a:solidFill>
                <a:schemeClr val="accent4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7-C17B-48B2-8E04-4F98FA861CAA}"/>
              </c:ext>
            </c:extLst>
          </c:dPt>
          <c:dPt>
            <c:idx val="28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9-C17B-48B2-8E04-4F98FA861CAA}"/>
              </c:ext>
            </c:extLst>
          </c:dPt>
          <c:dPt>
            <c:idx val="29"/>
            <c:bubble3D val="0"/>
            <c:spPr>
              <a:solidFill>
                <a:schemeClr val="accent6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B-C17B-48B2-8E04-4F98FA861CAA}"/>
              </c:ext>
            </c:extLst>
          </c:dPt>
          <c:dPt>
            <c:idx val="30"/>
            <c:bubble3D val="0"/>
            <c:spPr>
              <a:solidFill>
                <a:schemeClr val="accent1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D-C17B-48B2-8E04-4F98FA861CAA}"/>
              </c:ext>
            </c:extLst>
          </c:dPt>
          <c:dPt>
            <c:idx val="31"/>
            <c:bubble3D val="0"/>
            <c:spPr>
              <a:solidFill>
                <a:schemeClr val="accent2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F-C17B-48B2-8E04-4F98FA861CAA}"/>
              </c:ext>
            </c:extLst>
          </c:dPt>
          <c:dPt>
            <c:idx val="32"/>
            <c:bubble3D val="0"/>
            <c:spPr>
              <a:solidFill>
                <a:schemeClr val="accent3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1-C17B-48B2-8E04-4F98FA861CAA}"/>
              </c:ext>
            </c:extLst>
          </c:dPt>
          <c:dPt>
            <c:idx val="33"/>
            <c:bubble3D val="0"/>
            <c:spPr>
              <a:solidFill>
                <a:schemeClr val="accent4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3-C17B-48B2-8E04-4F98FA861CAA}"/>
              </c:ext>
            </c:extLst>
          </c:dPt>
          <c:dPt>
            <c:idx val="34"/>
            <c:bubble3D val="0"/>
            <c:spPr>
              <a:solidFill>
                <a:schemeClr val="accent5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5-C17B-48B2-8E04-4F98FA861CAA}"/>
              </c:ext>
            </c:extLst>
          </c:dPt>
          <c:dPt>
            <c:idx val="35"/>
            <c:bubble3D val="0"/>
            <c:spPr>
              <a:solidFill>
                <a:schemeClr val="accent6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7-C17B-48B2-8E04-4F98FA861CAA}"/>
              </c:ext>
            </c:extLst>
          </c:dPt>
          <c:dPt>
            <c:idx val="36"/>
            <c:bubble3D val="0"/>
            <c:spPr>
              <a:solidFill>
                <a:schemeClr val="accent1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9-C17B-48B2-8E04-4F98FA861CAA}"/>
              </c:ext>
            </c:extLst>
          </c:dPt>
          <c:dPt>
            <c:idx val="37"/>
            <c:bubble3D val="0"/>
            <c:spPr>
              <a:solidFill>
                <a:schemeClr val="accent2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B-C17B-48B2-8E04-4F98FA861CAA}"/>
              </c:ext>
            </c:extLst>
          </c:dPt>
          <c:dPt>
            <c:idx val="38"/>
            <c:bubble3D val="0"/>
            <c:spPr>
              <a:solidFill>
                <a:schemeClr val="accent3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D-C17B-48B2-8E04-4F98FA861CAA}"/>
              </c:ext>
            </c:extLst>
          </c:dPt>
          <c:dPt>
            <c:idx val="39"/>
            <c:bubble3D val="0"/>
            <c:spPr>
              <a:solidFill>
                <a:schemeClr val="accent4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F-C17B-48B2-8E04-4F98FA861CAA}"/>
              </c:ext>
            </c:extLst>
          </c:dPt>
          <c:dPt>
            <c:idx val="40"/>
            <c:bubble3D val="0"/>
            <c:spPr>
              <a:solidFill>
                <a:schemeClr val="accent5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1-C17B-48B2-8E04-4F98FA861CAA}"/>
              </c:ext>
            </c:extLst>
          </c:dPt>
          <c:dPt>
            <c:idx val="41"/>
            <c:bubble3D val="0"/>
            <c:spPr>
              <a:solidFill>
                <a:schemeClr val="accent6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3-C17B-48B2-8E04-4F98FA861CAA}"/>
              </c:ext>
            </c:extLst>
          </c:dPt>
          <c:dPt>
            <c:idx val="42"/>
            <c:bubble3D val="0"/>
            <c:spPr>
              <a:solidFill>
                <a:schemeClr val="accent1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5-C17B-48B2-8E04-4F98FA861CAA}"/>
              </c:ext>
            </c:extLst>
          </c:dPt>
          <c:dPt>
            <c:idx val="43"/>
            <c:bubble3D val="0"/>
            <c:spPr>
              <a:solidFill>
                <a:schemeClr val="accent2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7-C17B-48B2-8E04-4F98FA861CAA}"/>
              </c:ext>
            </c:extLst>
          </c:dPt>
          <c:dPt>
            <c:idx val="44"/>
            <c:bubble3D val="0"/>
            <c:spPr>
              <a:solidFill>
                <a:schemeClr val="accent3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9-C17B-48B2-8E04-4F98FA861CAA}"/>
              </c:ext>
            </c:extLst>
          </c:dPt>
          <c:dPt>
            <c:idx val="45"/>
            <c:bubble3D val="0"/>
            <c:spPr>
              <a:solidFill>
                <a:schemeClr val="accent4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B-C17B-48B2-8E04-4F98FA861CAA}"/>
              </c:ext>
            </c:extLst>
          </c:dPt>
          <c:dPt>
            <c:idx val="46"/>
            <c:bubble3D val="0"/>
            <c:spPr>
              <a:solidFill>
                <a:schemeClr val="accent5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D-C17B-48B2-8E04-4F98FA861CAA}"/>
              </c:ext>
            </c:extLst>
          </c:dPt>
          <c:dPt>
            <c:idx val="47"/>
            <c:bubble3D val="0"/>
            <c:spPr>
              <a:solidFill>
                <a:schemeClr val="accent6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F-C17B-48B2-8E04-4F98FA861CAA}"/>
              </c:ext>
            </c:extLst>
          </c:dPt>
          <c:dPt>
            <c:idx val="48"/>
            <c:bubble3D val="0"/>
            <c:spPr>
              <a:solidFill>
                <a:schemeClr val="accent1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1-C17B-48B2-8E04-4F98FA861CAA}"/>
              </c:ext>
            </c:extLst>
          </c:dPt>
          <c:dPt>
            <c:idx val="49"/>
            <c:bubble3D val="0"/>
            <c:spPr>
              <a:solidFill>
                <a:schemeClr val="accent2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3-C17B-48B2-8E04-4F98FA861CAA}"/>
              </c:ext>
            </c:extLst>
          </c:dPt>
          <c:dPt>
            <c:idx val="50"/>
            <c:bubble3D val="0"/>
            <c:spPr>
              <a:solidFill>
                <a:schemeClr val="accent3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5-C17B-48B2-8E04-4F98FA861CAA}"/>
              </c:ext>
            </c:extLst>
          </c:dPt>
          <c:dPt>
            <c:idx val="51"/>
            <c:bubble3D val="0"/>
            <c:spPr>
              <a:solidFill>
                <a:schemeClr val="accent4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7-C17B-48B2-8E04-4F98FA861CAA}"/>
              </c:ext>
            </c:extLst>
          </c:dPt>
          <c:dPt>
            <c:idx val="52"/>
            <c:bubble3D val="0"/>
            <c:spPr>
              <a:solidFill>
                <a:schemeClr val="accent5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9-C17B-48B2-8E04-4F98FA861CAA}"/>
              </c:ext>
            </c:extLst>
          </c:dPt>
          <c:dPt>
            <c:idx val="53"/>
            <c:bubble3D val="0"/>
            <c:spPr>
              <a:solidFill>
                <a:schemeClr val="accent6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B-C17B-48B2-8E04-4F98FA861CAA}"/>
              </c:ext>
            </c:extLst>
          </c:dPt>
          <c:dPt>
            <c:idx val="54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D-C17B-48B2-8E04-4F98FA861CAA}"/>
              </c:ext>
            </c:extLst>
          </c:dPt>
          <c:dPt>
            <c:idx val="55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F-C17B-48B2-8E04-4F98FA861CAA}"/>
              </c:ext>
            </c:extLst>
          </c:dPt>
          <c:dPt>
            <c:idx val="56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1-C17B-48B2-8E04-4F98FA861CAA}"/>
              </c:ext>
            </c:extLst>
          </c:dPt>
          <c:dPt>
            <c:idx val="57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3-C17B-48B2-8E04-4F98FA861CAA}"/>
              </c:ext>
            </c:extLst>
          </c:dPt>
          <c:dPt>
            <c:idx val="58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5-C17B-48B2-8E04-4F98FA861CAA}"/>
              </c:ext>
            </c:extLst>
          </c:dPt>
          <c:dPt>
            <c:idx val="59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7-C17B-48B2-8E04-4F98FA861CAA}"/>
              </c:ext>
            </c:extLst>
          </c:dPt>
          <c:dPt>
            <c:idx val="60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9-C17B-48B2-8E04-4F98FA861CAA}"/>
              </c:ext>
            </c:extLst>
          </c:dPt>
          <c:dPt>
            <c:idx val="61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B-C17B-48B2-8E04-4F98FA861CAA}"/>
              </c:ext>
            </c:extLst>
          </c:dPt>
          <c:dPt>
            <c:idx val="62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D-C17B-48B2-8E04-4F98FA861CAA}"/>
              </c:ext>
            </c:extLst>
          </c:dPt>
          <c:dPt>
            <c:idx val="63"/>
            <c:bubble3D val="0"/>
            <c:spPr>
              <a:solidFill>
                <a:schemeClr val="accent4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F-C17B-48B2-8E04-4F98FA861CAA}"/>
              </c:ext>
            </c:extLst>
          </c:dPt>
          <c:dPt>
            <c:idx val="64"/>
            <c:bubble3D val="0"/>
            <c:spPr>
              <a:solidFill>
                <a:schemeClr val="accent5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1-C17B-48B2-8E04-4F98FA861CAA}"/>
              </c:ext>
            </c:extLst>
          </c:dPt>
          <c:dPt>
            <c:idx val="65"/>
            <c:bubble3D val="0"/>
            <c:spPr>
              <a:solidFill>
                <a:schemeClr val="accent6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3-C17B-48B2-8E04-4F98FA861CAA}"/>
              </c:ext>
            </c:extLst>
          </c:dPt>
          <c:dPt>
            <c:idx val="66"/>
            <c:bubble3D val="0"/>
            <c:spPr>
              <a:solidFill>
                <a:schemeClr val="accent1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5-C17B-48B2-8E04-4F98FA861CAA}"/>
              </c:ext>
            </c:extLst>
          </c:dPt>
          <c:dPt>
            <c:idx val="67"/>
            <c:bubble3D val="0"/>
            <c:spPr>
              <a:solidFill>
                <a:schemeClr val="accent2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7-C17B-48B2-8E04-4F98FA861CAA}"/>
              </c:ext>
            </c:extLst>
          </c:dPt>
          <c:dPt>
            <c:idx val="68"/>
            <c:bubble3D val="0"/>
            <c:spPr>
              <a:solidFill>
                <a:schemeClr val="accent3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9-C17B-48B2-8E04-4F98FA861CAA}"/>
              </c:ext>
            </c:extLst>
          </c:dPt>
          <c:dPt>
            <c:idx val="69"/>
            <c:bubble3D val="0"/>
            <c:spPr>
              <a:solidFill>
                <a:schemeClr val="accent4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B-C17B-48B2-8E04-4F98FA861CAA}"/>
              </c:ext>
            </c:extLst>
          </c:dPt>
          <c:dPt>
            <c:idx val="70"/>
            <c:bubble3D val="0"/>
            <c:spPr>
              <a:solidFill>
                <a:schemeClr val="accent5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D-C17B-48B2-8E04-4F98FA861CAA}"/>
              </c:ext>
            </c:extLst>
          </c:dPt>
          <c:dPt>
            <c:idx val="71"/>
            <c:bubble3D val="0"/>
            <c:spPr>
              <a:solidFill>
                <a:schemeClr val="accent6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F-C17B-48B2-8E04-4F98FA861CAA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pPr>
                <a:endParaRPr lang="en-US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ND6_CONSENSUS_PHYLOGENY_HISTG_!$A$2:$A$73</c:f>
              <c:strCache>
                <c:ptCount val="72"/>
                <c:pt idx="0">
                  <c:v> ***  # ND6_GRAMALIGN_MAXALIGN_DNA_UB #  *** </c:v>
                </c:pt>
                <c:pt idx="1">
                  <c:v> ***  # ND6_GRAMALIGN_TCSFMw_DNA_UB #  *** </c:v>
                </c:pt>
                <c:pt idx="2">
                  <c:v> ***  # ND6_MAFFTA_GBLOCKS_DNA_UB #  *** </c:v>
                </c:pt>
                <c:pt idx="3">
                  <c:v> ***  # ND6_MAFFTA_TCSw_DNA_UB #  *** </c:v>
                </c:pt>
                <c:pt idx="4">
                  <c:v> ***  # ND6_MAFFTGI_TCSFMf_DNA_UB #  *** </c:v>
                </c:pt>
                <c:pt idx="5">
                  <c:v> ***  # ND6_OPAL_GBLOCKSC_RYt_UB #  *** </c:v>
                </c:pt>
                <c:pt idx="6">
                  <c:v> ***  # ND6_OPAL_GBLOCKS_RYt_UB #  *** </c:v>
                </c:pt>
                <c:pt idx="7">
                  <c:v> ***  # ND6_OPAL_PSARALIGN_RYt_UB #  *** </c:v>
                </c:pt>
                <c:pt idx="8">
                  <c:v> ***  # ND6_OPAL_TCSFMf_RYt_UB #  *** </c:v>
                </c:pt>
                <c:pt idx="9">
                  <c:v> ***  # ND6_OPAL_TCSFMw_RYt_UB #  *** </c:v>
                </c:pt>
                <c:pt idx="10">
                  <c:v> *** ND6_ALL_TRIMALC_DNA_UB *** </c:v>
                </c:pt>
                <c:pt idx="11">
                  <c:v> *** ND6_ALL_TRIMALC_RYt_UB *** </c:v>
                </c:pt>
                <c:pt idx="12">
                  <c:v> *** ND6_ALL_WEAVEALIGN_DNA_UB *** </c:v>
                </c:pt>
                <c:pt idx="13">
                  <c:v> *** ND6_ALL_WEAVEALIGN_RYt_UB *** </c:v>
                </c:pt>
                <c:pt idx="14">
                  <c:v> ***  # ND6_TCOFFEEPL_PSARALIGN_DNA_UB #  *** </c:v>
                </c:pt>
                <c:pt idx="15">
                  <c:v> ***  # ND6_TCOFFEEPL_TCSOGw_DNA_UB #  *** </c:v>
                </c:pt>
                <c:pt idx="16">
                  <c:v> ***  # ND6_TCOFFEEPL_TCSf_DNA_UB #  *** </c:v>
                </c:pt>
                <c:pt idx="17">
                  <c:v> ***  # ND6_TCOFFEEPL_TRIMAL_DNA_UB #  *** </c:v>
                </c:pt>
                <c:pt idx="18">
                  <c:v> ***  # ND6_MAFFTA_TCSFMw_DEG_UB #  *** </c:v>
                </c:pt>
                <c:pt idx="19">
                  <c:v> ***  # ND6_TCOFFEE_PSARALIGN_DNA_UB #  *** </c:v>
                </c:pt>
                <c:pt idx="20">
                  <c:v> ***  # ND6_TCOFFEE_TCSf_DNA_UB #  *** </c:v>
                </c:pt>
                <c:pt idx="21">
                  <c:v> ***  # ND6_TCOFFEE_TRIMAL_DNA_UB #  *** </c:v>
                </c:pt>
                <c:pt idx="22">
                  <c:v> ***  # ND6_MACSE_TCSFMf_DEG_UB #  *** </c:v>
                </c:pt>
                <c:pt idx="23">
                  <c:v> ***  # ND6_MACSE_TCSf_DEG_UB #  *** </c:v>
                </c:pt>
                <c:pt idx="24">
                  <c:v> ***  # ND6_MAFFTA_TCSFMf_CDN_UB #  *** </c:v>
                </c:pt>
                <c:pt idx="25">
                  <c:v> ***  # ND6_MAFFTA_TRIMAL_CDN_UB #  *** </c:v>
                </c:pt>
                <c:pt idx="26">
                  <c:v> ***  # ND6_MAFFTA_TRIMAL_DEG_UB #  *** </c:v>
                </c:pt>
                <c:pt idx="27">
                  <c:v> ***  # ND6_MAFFTGI_GBLOCKSC_CDN_UB #  *** </c:v>
                </c:pt>
                <c:pt idx="28">
                  <c:v> ***  # ND6_MAFFTGI_MAXALIGN_CDN_UB #  *** </c:v>
                </c:pt>
                <c:pt idx="29">
                  <c:v> ***  # ND6_MAFFTLI_GBLOCKS_DEG_UB #  *** </c:v>
                </c:pt>
                <c:pt idx="30">
                  <c:v> ***  # ND6_OPAL_PSARALIGN_CDN_UB #  *** </c:v>
                </c:pt>
                <c:pt idx="31">
                  <c:v> ***  # ND6_OPAL_PSARALIGN_DEG_UB #  *** </c:v>
                </c:pt>
                <c:pt idx="32">
                  <c:v> ***  # ND6_OPAL_TCSf_CDN_UB #  *** </c:v>
                </c:pt>
                <c:pt idx="33">
                  <c:v> ***  # ND6_GRAMALIGN_PSARALIGN_2AA_UB #  *** </c:v>
                </c:pt>
                <c:pt idx="34">
                  <c:v> ***  # ND6_MAFFTA_TCSFMf_2AA_UB #  *** </c:v>
                </c:pt>
                <c:pt idx="35">
                  <c:v> ***  # ND6_MAFFTA_TRIMAL_2AA_UB #  *** </c:v>
                </c:pt>
                <c:pt idx="36">
                  <c:v> ***  # ND6_MAFFTGI_MAXALIGN_2AA_UB #  *** </c:v>
                </c:pt>
                <c:pt idx="37">
                  <c:v> ***  # ND6_MAFFTGI_TCSf_2AA_UB #  *** </c:v>
                </c:pt>
                <c:pt idx="38">
                  <c:v> ***  # ND6_OPAL_GBLOCKSC_2AA_UB #  *** </c:v>
                </c:pt>
                <c:pt idx="39">
                  <c:v> *** ND6_ALL_TRIMALC_2AA_UB *** </c:v>
                </c:pt>
                <c:pt idx="40">
                  <c:v> *** ND6_ALL_WEAVEALIGN_2AA_UB *** </c:v>
                </c:pt>
                <c:pt idx="41">
                  <c:v> *** ND6_ALL_MERGEALIGN_DEG_UB *** </c:v>
                </c:pt>
                <c:pt idx="42">
                  <c:v> *** ND6_ALL_TRIMALC_DEG_UB *** </c:v>
                </c:pt>
                <c:pt idx="43">
                  <c:v> *** ND6_ALL_WEAVEALIGN_DEG_UB *** </c:v>
                </c:pt>
                <c:pt idx="44">
                  <c:v> *** ND6_ALL_TRIMALC_CDN_UB *** </c:v>
                </c:pt>
                <c:pt idx="45">
                  <c:v> *** ND6_ALL_WEAVEALIGN_CDN_UB *** </c:v>
                </c:pt>
                <c:pt idx="46">
                  <c:v> ***  # ND6_MACSE_MAXALIGN_RYt_UB #  *** </c:v>
                </c:pt>
                <c:pt idx="47">
                  <c:v> ***  # ND6_MACSE_TCSf_RYt_UB #  *** </c:v>
                </c:pt>
                <c:pt idx="48">
                  <c:v> ***  # ND6_MACSE_TRIMAL_RYt_UB #  *** </c:v>
                </c:pt>
                <c:pt idx="49">
                  <c:v> ***  # ND6_PRANKF_TRIMALP_DNA_UB #  *** </c:v>
                </c:pt>
                <c:pt idx="50">
                  <c:v> ***  # ND6_PRANKF_TRIMALS_DNA_UB #  *** </c:v>
                </c:pt>
                <c:pt idx="51">
                  <c:v> ***  # ND6_GRAMALIGN_TRIMALP_RYt_UB #  *** </c:v>
                </c:pt>
                <c:pt idx="52">
                  <c:v> ***  # ND6_OPAL_TRIMALS_RYt_UB #  *** </c:v>
                </c:pt>
                <c:pt idx="53">
                  <c:v> ***  # ND6_PRANKCDF_TRIMALA_CDN_UB #  *** </c:v>
                </c:pt>
                <c:pt idx="54">
                  <c:v> ***  # ND6_PRANKCDF_TRIMALG_CDN_UB #  *** </c:v>
                </c:pt>
                <c:pt idx="55">
                  <c:v> ***  # ND6_PRANKCDF_TRIMALA_2AA_UB #  *** </c:v>
                </c:pt>
                <c:pt idx="56">
                  <c:v> ***  # ND6_PRANKCDF_TRIMALG_2AA_UB #  *** </c:v>
                </c:pt>
                <c:pt idx="57">
                  <c:v> ***  # ND6_PRANKCDF_TRIMALA_DNA_UB #  *** </c:v>
                </c:pt>
                <c:pt idx="58">
                  <c:v> ***  # ND6_PRANKCDF_TRIMALA_RYt_UB #  *** </c:v>
                </c:pt>
                <c:pt idx="59">
                  <c:v> ***  # ND6_PRANKCDF_TRIMALG_DNA_UB #  *** </c:v>
                </c:pt>
                <c:pt idx="60">
                  <c:v> ***  # ND6_PRANKCDF_TRIMALG_RYt_UB #  *** </c:v>
                </c:pt>
                <c:pt idx="61">
                  <c:v> ***  # ND6_GRAMALIGN_TCSw_DEG_UB #  *** </c:v>
                </c:pt>
                <c:pt idx="62">
                  <c:v> ***  # ND6_OPAL_TCSw_RYt_UB #  *** </c:v>
                </c:pt>
                <c:pt idx="63">
                  <c:v> ***  # ND6_MAFFTLI_TRIMALP_DEG_UB #  *** </c:v>
                </c:pt>
                <c:pt idx="64">
                  <c:v> ***  # ND6_OPAL_TRIMALS_DEG_UB #  *** </c:v>
                </c:pt>
                <c:pt idx="65">
                  <c:v> ***  # ND6_MAFFTGI_TCSOGw_DEG_UB #  *** </c:v>
                </c:pt>
                <c:pt idx="66">
                  <c:v> ***  # ND6_MACSE_MAXALIGN_DEG_UB #  *** </c:v>
                </c:pt>
                <c:pt idx="67">
                  <c:v> ***  # ND6_PRANKCDF_TRIMALA_DEG_UB #  *** </c:v>
                </c:pt>
                <c:pt idx="68">
                  <c:v> ***  # ND6_MACSE_TCSOGw_RYt_UB #  *** </c:v>
                </c:pt>
                <c:pt idx="69">
                  <c:v> ***  # ND6_TCOFFEE_GBLOCKSC_DNA_UB #  *** </c:v>
                </c:pt>
                <c:pt idx="70">
                  <c:v> # ND6_PRANKCDF_TRIMALG_DEG_UB # </c:v>
                </c:pt>
                <c:pt idx="71">
                  <c:v> ***  # ND6_PRANK_GBLOCKSC_DEG_UB #  *** </c:v>
                </c:pt>
              </c:strCache>
            </c:strRef>
          </c:cat>
          <c:val>
            <c:numRef>
              <c:f>ND6_CONSENSUS_PHYLOGENY_HISTG_!$B$2:$B$73</c:f>
              <c:numCache>
                <c:formatCode>General</c:formatCode>
                <c:ptCount val="72"/>
                <c:pt idx="0">
                  <c:v>252</c:v>
                </c:pt>
                <c:pt idx="1">
                  <c:v>252</c:v>
                </c:pt>
                <c:pt idx="2">
                  <c:v>252</c:v>
                </c:pt>
                <c:pt idx="3">
                  <c:v>252</c:v>
                </c:pt>
                <c:pt idx="4">
                  <c:v>252</c:v>
                </c:pt>
                <c:pt idx="5">
                  <c:v>252</c:v>
                </c:pt>
                <c:pt idx="6">
                  <c:v>252</c:v>
                </c:pt>
                <c:pt idx="7">
                  <c:v>252</c:v>
                </c:pt>
                <c:pt idx="8">
                  <c:v>252</c:v>
                </c:pt>
                <c:pt idx="9">
                  <c:v>252</c:v>
                </c:pt>
                <c:pt idx="10">
                  <c:v>204</c:v>
                </c:pt>
                <c:pt idx="11">
                  <c:v>204</c:v>
                </c:pt>
                <c:pt idx="12">
                  <c:v>204</c:v>
                </c:pt>
                <c:pt idx="13">
                  <c:v>204</c:v>
                </c:pt>
                <c:pt idx="14">
                  <c:v>118</c:v>
                </c:pt>
                <c:pt idx="15">
                  <c:v>113</c:v>
                </c:pt>
                <c:pt idx="16">
                  <c:v>112</c:v>
                </c:pt>
                <c:pt idx="17">
                  <c:v>106</c:v>
                </c:pt>
                <c:pt idx="18">
                  <c:v>91</c:v>
                </c:pt>
                <c:pt idx="19">
                  <c:v>86</c:v>
                </c:pt>
                <c:pt idx="20">
                  <c:v>80</c:v>
                </c:pt>
                <c:pt idx="21">
                  <c:v>74</c:v>
                </c:pt>
                <c:pt idx="22">
                  <c:v>63</c:v>
                </c:pt>
                <c:pt idx="23">
                  <c:v>63</c:v>
                </c:pt>
                <c:pt idx="24">
                  <c:v>63</c:v>
                </c:pt>
                <c:pt idx="25">
                  <c:v>63</c:v>
                </c:pt>
                <c:pt idx="26">
                  <c:v>63</c:v>
                </c:pt>
                <c:pt idx="27">
                  <c:v>63</c:v>
                </c:pt>
                <c:pt idx="28">
                  <c:v>63</c:v>
                </c:pt>
                <c:pt idx="29">
                  <c:v>63</c:v>
                </c:pt>
                <c:pt idx="30">
                  <c:v>63</c:v>
                </c:pt>
                <c:pt idx="31">
                  <c:v>63</c:v>
                </c:pt>
                <c:pt idx="32">
                  <c:v>63</c:v>
                </c:pt>
                <c:pt idx="33">
                  <c:v>54</c:v>
                </c:pt>
                <c:pt idx="34">
                  <c:v>54</c:v>
                </c:pt>
                <c:pt idx="35">
                  <c:v>54</c:v>
                </c:pt>
                <c:pt idx="36">
                  <c:v>54</c:v>
                </c:pt>
                <c:pt idx="37">
                  <c:v>54</c:v>
                </c:pt>
                <c:pt idx="38">
                  <c:v>54</c:v>
                </c:pt>
                <c:pt idx="39">
                  <c:v>47</c:v>
                </c:pt>
                <c:pt idx="40">
                  <c:v>47</c:v>
                </c:pt>
                <c:pt idx="41">
                  <c:v>46</c:v>
                </c:pt>
                <c:pt idx="42">
                  <c:v>46</c:v>
                </c:pt>
                <c:pt idx="43">
                  <c:v>46</c:v>
                </c:pt>
                <c:pt idx="44">
                  <c:v>45</c:v>
                </c:pt>
                <c:pt idx="45">
                  <c:v>45</c:v>
                </c:pt>
                <c:pt idx="46">
                  <c:v>34</c:v>
                </c:pt>
                <c:pt idx="47">
                  <c:v>34</c:v>
                </c:pt>
                <c:pt idx="48">
                  <c:v>34</c:v>
                </c:pt>
                <c:pt idx="49">
                  <c:v>22</c:v>
                </c:pt>
                <c:pt idx="50">
                  <c:v>21</c:v>
                </c:pt>
                <c:pt idx="51">
                  <c:v>20</c:v>
                </c:pt>
                <c:pt idx="52">
                  <c:v>20</c:v>
                </c:pt>
                <c:pt idx="53">
                  <c:v>20</c:v>
                </c:pt>
                <c:pt idx="54">
                  <c:v>20</c:v>
                </c:pt>
                <c:pt idx="55">
                  <c:v>16</c:v>
                </c:pt>
                <c:pt idx="56">
                  <c:v>16</c:v>
                </c:pt>
                <c:pt idx="57">
                  <c:v>15</c:v>
                </c:pt>
                <c:pt idx="58">
                  <c:v>15</c:v>
                </c:pt>
                <c:pt idx="59">
                  <c:v>15</c:v>
                </c:pt>
                <c:pt idx="60">
                  <c:v>15</c:v>
                </c:pt>
                <c:pt idx="61">
                  <c:v>12</c:v>
                </c:pt>
                <c:pt idx="62">
                  <c:v>12</c:v>
                </c:pt>
                <c:pt idx="63">
                  <c:v>9</c:v>
                </c:pt>
                <c:pt idx="64">
                  <c:v>9</c:v>
                </c:pt>
                <c:pt idx="65">
                  <c:v>6</c:v>
                </c:pt>
                <c:pt idx="66">
                  <c:v>4</c:v>
                </c:pt>
                <c:pt idx="67">
                  <c:v>3</c:v>
                </c:pt>
                <c:pt idx="68">
                  <c:v>2</c:v>
                </c:pt>
                <c:pt idx="69">
                  <c:v>1</c:v>
                </c:pt>
                <c:pt idx="70">
                  <c:v>0</c:v>
                </c:pt>
                <c:pt idx="7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90-C17B-48B2-8E04-4F98FA861CAA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5952722925875394E-2"/>
          <c:y val="4.0923689578506367E-2"/>
          <c:w val="0.82708430075835049"/>
          <c:h val="0.93972886047629312"/>
        </c:manualLayout>
      </c:layout>
      <c:pieChart>
        <c:varyColors val="1"/>
        <c:ser>
          <c:idx val="0"/>
          <c:order val="0"/>
          <c:tx>
            <c:strRef>
              <c:f>ATP8_CONSENSUS_PHYLOGENY_HISTG_!$B$1</c:f>
              <c:strCache>
                <c:ptCount val="1"/>
                <c:pt idx="0">
                  <c:v>Total Topological Support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B62-4AFB-8DFA-901774104962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2B62-4AFB-8DFA-901774104962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2B62-4AFB-8DFA-901774104962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2B62-4AFB-8DFA-901774104962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2B62-4AFB-8DFA-901774104962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2B62-4AFB-8DFA-901774104962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2B62-4AFB-8DFA-901774104962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2B62-4AFB-8DFA-901774104962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2B62-4AFB-8DFA-901774104962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2B62-4AFB-8DFA-901774104962}"/>
              </c:ext>
            </c:extLst>
          </c:dPt>
          <c:dPt>
            <c:idx val="10"/>
            <c:bubble3D val="0"/>
            <c:spPr>
              <a:solidFill>
                <a:schemeClr val="accent5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2B62-4AFB-8DFA-901774104962}"/>
              </c:ext>
            </c:extLst>
          </c:dPt>
          <c:dPt>
            <c:idx val="11"/>
            <c:bubble3D val="0"/>
            <c:spPr>
              <a:solidFill>
                <a:schemeClr val="accent6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2B62-4AFB-8DFA-901774104962}"/>
              </c:ext>
            </c:extLst>
          </c:dPt>
          <c:dPt>
            <c:idx val="12"/>
            <c:bubble3D val="0"/>
            <c:spPr>
              <a:solidFill>
                <a:schemeClr val="accent1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2B62-4AFB-8DFA-901774104962}"/>
              </c:ext>
            </c:extLst>
          </c:dPt>
          <c:dPt>
            <c:idx val="13"/>
            <c:bubble3D val="0"/>
            <c:spPr>
              <a:solidFill>
                <a:schemeClr val="accent2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2B62-4AFB-8DFA-901774104962}"/>
              </c:ext>
            </c:extLst>
          </c:dPt>
          <c:dPt>
            <c:idx val="14"/>
            <c:bubble3D val="0"/>
            <c:spPr>
              <a:solidFill>
                <a:schemeClr val="accent3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2B62-4AFB-8DFA-901774104962}"/>
              </c:ext>
            </c:extLst>
          </c:dPt>
          <c:dPt>
            <c:idx val="15"/>
            <c:bubble3D val="0"/>
            <c:spPr>
              <a:solidFill>
                <a:schemeClr val="accent4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F-2B62-4AFB-8DFA-901774104962}"/>
              </c:ext>
            </c:extLst>
          </c:dPt>
          <c:dPt>
            <c:idx val="16"/>
            <c:bubble3D val="0"/>
            <c:spPr>
              <a:solidFill>
                <a:schemeClr val="accent5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1-2B62-4AFB-8DFA-901774104962}"/>
              </c:ext>
            </c:extLst>
          </c:dPt>
          <c:dPt>
            <c:idx val="17"/>
            <c:bubble3D val="0"/>
            <c:spPr>
              <a:solidFill>
                <a:schemeClr val="accent6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3-2B62-4AFB-8DFA-901774104962}"/>
              </c:ext>
            </c:extLst>
          </c:dPt>
          <c:dPt>
            <c:idx val="18"/>
            <c:bubble3D val="0"/>
            <c:spPr>
              <a:solidFill>
                <a:schemeClr val="accent1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5-2B62-4AFB-8DFA-901774104962}"/>
              </c:ext>
            </c:extLst>
          </c:dPt>
          <c:dPt>
            <c:idx val="19"/>
            <c:bubble3D val="0"/>
            <c:spPr>
              <a:solidFill>
                <a:schemeClr val="accent2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7-2B62-4AFB-8DFA-901774104962}"/>
              </c:ext>
            </c:extLst>
          </c:dPt>
          <c:dPt>
            <c:idx val="20"/>
            <c:bubble3D val="0"/>
            <c:spPr>
              <a:solidFill>
                <a:schemeClr val="accent3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9-2B62-4AFB-8DFA-901774104962}"/>
              </c:ext>
            </c:extLst>
          </c:dPt>
          <c:dPt>
            <c:idx val="21"/>
            <c:bubble3D val="0"/>
            <c:spPr>
              <a:solidFill>
                <a:schemeClr val="accent4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B-2B62-4AFB-8DFA-901774104962}"/>
              </c:ext>
            </c:extLst>
          </c:dPt>
          <c:dPt>
            <c:idx val="22"/>
            <c:bubble3D val="0"/>
            <c:spPr>
              <a:solidFill>
                <a:schemeClr val="accent5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D-2B62-4AFB-8DFA-901774104962}"/>
              </c:ext>
            </c:extLst>
          </c:dPt>
          <c:dPt>
            <c:idx val="23"/>
            <c:bubble3D val="0"/>
            <c:spPr>
              <a:solidFill>
                <a:schemeClr val="accent6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F-2B62-4AFB-8DFA-901774104962}"/>
              </c:ext>
            </c:extLst>
          </c:dPt>
          <c:dPt>
            <c:idx val="24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1-2B62-4AFB-8DFA-901774104962}"/>
              </c:ext>
            </c:extLst>
          </c:dPt>
          <c:dPt>
            <c:idx val="25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3-2B62-4AFB-8DFA-901774104962}"/>
              </c:ext>
            </c:extLst>
          </c:dPt>
          <c:dPt>
            <c:idx val="26"/>
            <c:bubble3D val="0"/>
            <c:spPr>
              <a:solidFill>
                <a:schemeClr val="accent3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5-2B62-4AFB-8DFA-901774104962}"/>
              </c:ext>
            </c:extLst>
          </c:dPt>
          <c:dPt>
            <c:idx val="27"/>
            <c:bubble3D val="0"/>
            <c:spPr>
              <a:solidFill>
                <a:schemeClr val="accent4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7-2B62-4AFB-8DFA-901774104962}"/>
              </c:ext>
            </c:extLst>
          </c:dPt>
          <c:dPt>
            <c:idx val="28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9-2B62-4AFB-8DFA-901774104962}"/>
              </c:ext>
            </c:extLst>
          </c:dPt>
          <c:dPt>
            <c:idx val="29"/>
            <c:bubble3D val="0"/>
            <c:spPr>
              <a:solidFill>
                <a:schemeClr val="accent6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B-2B62-4AFB-8DFA-901774104962}"/>
              </c:ext>
            </c:extLst>
          </c:dPt>
          <c:dPt>
            <c:idx val="30"/>
            <c:bubble3D val="0"/>
            <c:spPr>
              <a:solidFill>
                <a:schemeClr val="accent1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D-2B62-4AFB-8DFA-901774104962}"/>
              </c:ext>
            </c:extLst>
          </c:dPt>
          <c:dPt>
            <c:idx val="31"/>
            <c:bubble3D val="0"/>
            <c:spPr>
              <a:solidFill>
                <a:schemeClr val="accent2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F-2B62-4AFB-8DFA-901774104962}"/>
              </c:ext>
            </c:extLst>
          </c:dPt>
          <c:dPt>
            <c:idx val="32"/>
            <c:bubble3D val="0"/>
            <c:spPr>
              <a:solidFill>
                <a:schemeClr val="accent3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1-2B62-4AFB-8DFA-901774104962}"/>
              </c:ext>
            </c:extLst>
          </c:dPt>
          <c:dPt>
            <c:idx val="33"/>
            <c:bubble3D val="0"/>
            <c:spPr>
              <a:solidFill>
                <a:schemeClr val="accent4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3-2B62-4AFB-8DFA-901774104962}"/>
              </c:ext>
            </c:extLst>
          </c:dPt>
          <c:dPt>
            <c:idx val="34"/>
            <c:bubble3D val="0"/>
            <c:spPr>
              <a:solidFill>
                <a:schemeClr val="accent5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5-2B62-4AFB-8DFA-901774104962}"/>
              </c:ext>
            </c:extLst>
          </c:dPt>
          <c:dPt>
            <c:idx val="35"/>
            <c:bubble3D val="0"/>
            <c:spPr>
              <a:solidFill>
                <a:schemeClr val="accent6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7-2B62-4AFB-8DFA-901774104962}"/>
              </c:ext>
            </c:extLst>
          </c:dPt>
          <c:dPt>
            <c:idx val="36"/>
            <c:bubble3D val="0"/>
            <c:spPr>
              <a:solidFill>
                <a:schemeClr val="accent1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9-2B62-4AFB-8DFA-901774104962}"/>
              </c:ext>
            </c:extLst>
          </c:dPt>
          <c:dPt>
            <c:idx val="37"/>
            <c:bubble3D val="0"/>
            <c:spPr>
              <a:solidFill>
                <a:schemeClr val="accent2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B-2B62-4AFB-8DFA-901774104962}"/>
              </c:ext>
            </c:extLst>
          </c:dPt>
          <c:dPt>
            <c:idx val="38"/>
            <c:bubble3D val="0"/>
            <c:spPr>
              <a:solidFill>
                <a:schemeClr val="accent3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D-2B62-4AFB-8DFA-901774104962}"/>
              </c:ext>
            </c:extLst>
          </c:dPt>
          <c:dPt>
            <c:idx val="39"/>
            <c:bubble3D val="0"/>
            <c:spPr>
              <a:solidFill>
                <a:schemeClr val="accent4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F-2B62-4AFB-8DFA-901774104962}"/>
              </c:ext>
            </c:extLst>
          </c:dPt>
          <c:dPt>
            <c:idx val="40"/>
            <c:bubble3D val="0"/>
            <c:spPr>
              <a:solidFill>
                <a:schemeClr val="accent5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1-2B62-4AFB-8DFA-901774104962}"/>
              </c:ext>
            </c:extLst>
          </c:dPt>
          <c:dPt>
            <c:idx val="41"/>
            <c:bubble3D val="0"/>
            <c:spPr>
              <a:solidFill>
                <a:schemeClr val="accent6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3-2B62-4AFB-8DFA-901774104962}"/>
              </c:ext>
            </c:extLst>
          </c:dPt>
          <c:dPt>
            <c:idx val="42"/>
            <c:bubble3D val="0"/>
            <c:spPr>
              <a:solidFill>
                <a:schemeClr val="accent1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5-2B62-4AFB-8DFA-901774104962}"/>
              </c:ext>
            </c:extLst>
          </c:dPt>
          <c:dPt>
            <c:idx val="43"/>
            <c:bubble3D val="0"/>
            <c:spPr>
              <a:solidFill>
                <a:schemeClr val="accent2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7-2B62-4AFB-8DFA-901774104962}"/>
              </c:ext>
            </c:extLst>
          </c:dPt>
          <c:dPt>
            <c:idx val="44"/>
            <c:bubble3D val="0"/>
            <c:spPr>
              <a:solidFill>
                <a:schemeClr val="accent3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9-2B62-4AFB-8DFA-901774104962}"/>
              </c:ext>
            </c:extLst>
          </c:dPt>
          <c:dPt>
            <c:idx val="45"/>
            <c:bubble3D val="0"/>
            <c:spPr>
              <a:solidFill>
                <a:schemeClr val="accent4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B-2B62-4AFB-8DFA-901774104962}"/>
              </c:ext>
            </c:extLst>
          </c:dPt>
          <c:dPt>
            <c:idx val="46"/>
            <c:bubble3D val="0"/>
            <c:spPr>
              <a:solidFill>
                <a:schemeClr val="accent5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D-2B62-4AFB-8DFA-901774104962}"/>
              </c:ext>
            </c:extLst>
          </c:dPt>
          <c:dPt>
            <c:idx val="47"/>
            <c:bubble3D val="0"/>
            <c:spPr>
              <a:solidFill>
                <a:schemeClr val="accent6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F-2B62-4AFB-8DFA-901774104962}"/>
              </c:ext>
            </c:extLst>
          </c:dPt>
          <c:dPt>
            <c:idx val="48"/>
            <c:bubble3D val="0"/>
            <c:spPr>
              <a:solidFill>
                <a:schemeClr val="accent1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1-2B62-4AFB-8DFA-901774104962}"/>
              </c:ext>
            </c:extLst>
          </c:dPt>
          <c:dPt>
            <c:idx val="49"/>
            <c:bubble3D val="0"/>
            <c:spPr>
              <a:solidFill>
                <a:schemeClr val="accent2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3-2B62-4AFB-8DFA-901774104962}"/>
              </c:ext>
            </c:extLst>
          </c:dPt>
          <c:dPt>
            <c:idx val="50"/>
            <c:bubble3D val="0"/>
            <c:spPr>
              <a:solidFill>
                <a:schemeClr val="accent3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5-2B62-4AFB-8DFA-901774104962}"/>
              </c:ext>
            </c:extLst>
          </c:dPt>
          <c:dPt>
            <c:idx val="51"/>
            <c:bubble3D val="0"/>
            <c:spPr>
              <a:solidFill>
                <a:schemeClr val="accent4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7-2B62-4AFB-8DFA-901774104962}"/>
              </c:ext>
            </c:extLst>
          </c:dPt>
          <c:dPt>
            <c:idx val="52"/>
            <c:bubble3D val="0"/>
            <c:spPr>
              <a:solidFill>
                <a:schemeClr val="accent5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9-2B62-4AFB-8DFA-901774104962}"/>
              </c:ext>
            </c:extLst>
          </c:dPt>
          <c:dPt>
            <c:idx val="53"/>
            <c:bubble3D val="0"/>
            <c:spPr>
              <a:solidFill>
                <a:schemeClr val="accent6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B-2B62-4AFB-8DFA-901774104962}"/>
              </c:ext>
            </c:extLst>
          </c:dPt>
          <c:dPt>
            <c:idx val="54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D-2B62-4AFB-8DFA-901774104962}"/>
              </c:ext>
            </c:extLst>
          </c:dPt>
          <c:dPt>
            <c:idx val="55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F-2B62-4AFB-8DFA-901774104962}"/>
              </c:ext>
            </c:extLst>
          </c:dPt>
          <c:dPt>
            <c:idx val="56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1-2B62-4AFB-8DFA-901774104962}"/>
              </c:ext>
            </c:extLst>
          </c:dPt>
          <c:dPt>
            <c:idx val="57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3-2B62-4AFB-8DFA-901774104962}"/>
              </c:ext>
            </c:extLst>
          </c:dPt>
          <c:dPt>
            <c:idx val="58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5-2B62-4AFB-8DFA-901774104962}"/>
              </c:ext>
            </c:extLst>
          </c:dPt>
          <c:dPt>
            <c:idx val="59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7-2B62-4AFB-8DFA-901774104962}"/>
              </c:ext>
            </c:extLst>
          </c:dPt>
          <c:dPt>
            <c:idx val="60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9-2B62-4AFB-8DFA-901774104962}"/>
              </c:ext>
            </c:extLst>
          </c:dPt>
          <c:dPt>
            <c:idx val="61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B-2B62-4AFB-8DFA-901774104962}"/>
              </c:ext>
            </c:extLst>
          </c:dPt>
          <c:dPt>
            <c:idx val="62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D-2B62-4AFB-8DFA-901774104962}"/>
              </c:ext>
            </c:extLst>
          </c:dPt>
          <c:dPt>
            <c:idx val="63"/>
            <c:bubble3D val="0"/>
            <c:spPr>
              <a:solidFill>
                <a:schemeClr val="accent4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F-2B62-4AFB-8DFA-901774104962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pPr>
                <a:endParaRPr lang="en-US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ATP8_CONSENSUS_PHYLOGENY_HISTG_!$A$2:$A$65</c:f>
              <c:strCache>
                <c:ptCount val="64"/>
                <c:pt idx="0">
                  <c:v> ***  # ATP8_FSANP_GBLOCKSC_DNA_UB #  *** </c:v>
                </c:pt>
                <c:pt idx="1">
                  <c:v> ***  # ATP8_MAFFTGI_MAXALIGN_DNA_UB #  *** </c:v>
                </c:pt>
                <c:pt idx="2">
                  <c:v> ***  # ATP8_MAFFTGI_TCSf_DNA_UB #  *** </c:v>
                </c:pt>
                <c:pt idx="3">
                  <c:v> ***  # ATP8_MAFFTGI_TRIMAL_DNA_UB #  *** </c:v>
                </c:pt>
                <c:pt idx="4">
                  <c:v> ***  # ATP8_MAFFT_GBLOCKS_DNA_UB #  *** </c:v>
                </c:pt>
                <c:pt idx="5">
                  <c:v> *** ATP8_ALL_TRIMALC_DNA_UB *** </c:v>
                </c:pt>
                <c:pt idx="6">
                  <c:v> *** ATP8_ALL_TRIMALC_RYt_UB *** </c:v>
                </c:pt>
                <c:pt idx="7">
                  <c:v> ***  # ATP8_MACSE_GBLOCKS_DEG_UB #  *** </c:v>
                </c:pt>
                <c:pt idx="8">
                  <c:v> ***  # ATP8_MAFFTF1_TRIMAL_DEG_UB #  *** </c:v>
                </c:pt>
                <c:pt idx="9">
                  <c:v> ***  # ATP8_MAFFTF2_TCSFMf_DEG_UB #  *** </c:v>
                </c:pt>
                <c:pt idx="10">
                  <c:v> ***  # ATP8_MAFFTFI_PSARALIGN_DEG_UB #  *** </c:v>
                </c:pt>
                <c:pt idx="11">
                  <c:v> ***  # ATP8_MAFFTGI_MAXALIGN_DEG_UB #  *** </c:v>
                </c:pt>
                <c:pt idx="12">
                  <c:v> ***  # ATP8_MAFFTLI_TCSf_DEG_UB #  *** </c:v>
                </c:pt>
                <c:pt idx="13">
                  <c:v> ***  # ATP8_OPAL_GBLOCKSC_DEG_UB #  *** </c:v>
                </c:pt>
                <c:pt idx="14">
                  <c:v> ***  # ATP8_CLUSTALO_GBLOCKSC_2AA_UB #  *** </c:v>
                </c:pt>
                <c:pt idx="15">
                  <c:v> ***  # ATP8_FSANP_TCSFMf_2AA_UB #  *** </c:v>
                </c:pt>
                <c:pt idx="16">
                  <c:v> ***  # ATP8_MACSE_GBLOCKS_2AA_UB #  *** </c:v>
                </c:pt>
                <c:pt idx="17">
                  <c:v> ***  # ATP8_MACSE_PSARALIGN_2AA_UB #  *** </c:v>
                </c:pt>
                <c:pt idx="18">
                  <c:v> ***  # ATP8_MACSE_TCSf_2AA_UB #  *** </c:v>
                </c:pt>
                <c:pt idx="19">
                  <c:v> ***  # ATP8_MAFFTA_MAXALIGN_2AA_UB #  *** </c:v>
                </c:pt>
                <c:pt idx="20">
                  <c:v> ***  # ATP8_MAFFTA_TRIMAL_2AA_UB #  *** </c:v>
                </c:pt>
                <c:pt idx="21">
                  <c:v> *** ATP8_ALL_TRIMALC_2AA_UB *** </c:v>
                </c:pt>
                <c:pt idx="22">
                  <c:v> *** ATP8_ALL_WEAVEALIGN_2AA_UB *** </c:v>
                </c:pt>
                <c:pt idx="23">
                  <c:v> ***  # ATP8_KALIGN_GBLOCKS_CDN_UB #  *** </c:v>
                </c:pt>
                <c:pt idx="24">
                  <c:v> ***  # ATP8_MAFFTEI_PSARALIGN_CDN_UB #  *** </c:v>
                </c:pt>
                <c:pt idx="25">
                  <c:v> ***  # ATP8_MAFFTFI_GBLOCKSC_CDN_UB #  *** </c:v>
                </c:pt>
                <c:pt idx="26">
                  <c:v> ***  # ATP8_MAFFTFI_TRIMAL_CDN_UB #  *** </c:v>
                </c:pt>
                <c:pt idx="27">
                  <c:v> ***  # ATP8_MAFFTGI_TCSf_CDN_UB #  *** </c:v>
                </c:pt>
                <c:pt idx="28">
                  <c:v> ***  # ATP8_OPAL_MAXALIGN_CDN_UB #  *** </c:v>
                </c:pt>
                <c:pt idx="29">
                  <c:v> ***  # ATP8_OPAL_TCSFMf_CDN_UB #  *** </c:v>
                </c:pt>
                <c:pt idx="30">
                  <c:v> *** ATP8_ALL_MERGEALIGN_DEG_UB *** </c:v>
                </c:pt>
                <c:pt idx="31">
                  <c:v> *** ATP8_ALL_TRIMALC_DEG_UB *** </c:v>
                </c:pt>
                <c:pt idx="32">
                  <c:v> *** ATP8_ALL_TRIMALC_CDN_UB *** </c:v>
                </c:pt>
                <c:pt idx="33">
                  <c:v> *** ATP8_ALL_WEAVEALIGN_CDN_UB *** </c:v>
                </c:pt>
                <c:pt idx="34">
                  <c:v> ***  # ATP8_GRAMALIGN_GBLOCKSC_RYt_UB #  *** </c:v>
                </c:pt>
                <c:pt idx="35">
                  <c:v> ***  # ATP8_GRAMALIGN_MAXALIGN_RYt_UB #  *** </c:v>
                </c:pt>
                <c:pt idx="36">
                  <c:v> ***  # ATP8_GRAMALIGN_PSARALIGN_RYt_UB #  *** </c:v>
                </c:pt>
                <c:pt idx="37">
                  <c:v> ***  # ATP8_KALIGN_TRIMAL_RYt_UB #  *** </c:v>
                </c:pt>
                <c:pt idx="38">
                  <c:v> ***  # ATP8_MACSE_GBLOCKS_RYt_UB #  *** </c:v>
                </c:pt>
                <c:pt idx="39">
                  <c:v> ***  # ATP8_MACSE_TCSFMf_RYt_UB #  *** </c:v>
                </c:pt>
                <c:pt idx="40">
                  <c:v> ***  # ATP8_OPAL_TCSf_RYt_UB #  *** </c:v>
                </c:pt>
                <c:pt idx="41">
                  <c:v> ***  # ATP8_CLUSTALO_TCSFMw_RYt_UB #  *** </c:v>
                </c:pt>
                <c:pt idx="42">
                  <c:v> ***  # ATP8_KALIGN_TCSFMw_DEG_UB #  *** </c:v>
                </c:pt>
                <c:pt idx="43">
                  <c:v> ***  # ATP8_MAFFTF1_TCSFMw_DNA_UB #  *** </c:v>
                </c:pt>
                <c:pt idx="44">
                  <c:v> *** ATP8_ALL_WEAVEALIGN_RYt_UB *** </c:v>
                </c:pt>
                <c:pt idx="45">
                  <c:v> ***  # ATP8_MAFFTFI_TCSFMf_DNA_UB #  *** </c:v>
                </c:pt>
                <c:pt idx="46">
                  <c:v> ***  # ATP8_MAFFTLI_PSARALIGN_DNA_UB #  *** </c:v>
                </c:pt>
                <c:pt idx="47">
                  <c:v> ***  # ATP8_MAFFTF1_TCSw_DNA_UB #  *** </c:v>
                </c:pt>
                <c:pt idx="48">
                  <c:v> ***  # ATP8_OPAL_TCSw_DNA_UB #  *** </c:v>
                </c:pt>
                <c:pt idx="49">
                  <c:v> ***  # ATP8_CLUSTALO_TCSw_RYt_UB #  *** </c:v>
                </c:pt>
                <c:pt idx="50">
                  <c:v> ***  # ATP8_KALIGN_TCSw_DEG_UB #  *** </c:v>
                </c:pt>
                <c:pt idx="51">
                  <c:v> *** ATP8_ALL_WEAVEALIGN_DNA_UB *** </c:v>
                </c:pt>
                <c:pt idx="52">
                  <c:v> ***  # ATP8_CLUSTALO_TRIMALS_DEG_UB #  *** </c:v>
                </c:pt>
                <c:pt idx="53">
                  <c:v> ***  # ATP8_MAFFTA_TCSOGw_DNA_UB #  *** </c:v>
                </c:pt>
                <c:pt idx="54">
                  <c:v> ***  # ATP8_TCOFFEETC_NOISY_DEG_UB #  *** </c:v>
                </c:pt>
                <c:pt idx="55">
                  <c:v> ***  # ATP8_TCOFFEETC_NOISY_DNA_UB #  *** </c:v>
                </c:pt>
                <c:pt idx="56">
                  <c:v> ***  # ATP8_KALIGN_TCSOGw_RYt_UB #  *** </c:v>
                </c:pt>
                <c:pt idx="57">
                  <c:v> ***  # ATP8_TCOFFEE_NOISY_RYt_UB #  *** </c:v>
                </c:pt>
                <c:pt idx="58">
                  <c:v> # ATP8_GRAMALIGN_TRIMALS_RYt_UB # </c:v>
                </c:pt>
                <c:pt idx="59">
                  <c:v> # ATP8_OPAL_TCSOGw_DEG_UB # </c:v>
                </c:pt>
                <c:pt idx="60">
                  <c:v> # ATP8_OPAL_TRIMALS_DNA_UB # </c:v>
                </c:pt>
                <c:pt idx="61">
                  <c:v> # ATP8_PRANKCDO_TRIMALP_DEG_UB # </c:v>
                </c:pt>
                <c:pt idx="62">
                  <c:v> # ATP8_PRANKCDO_TRIMALP_RYt_UB # </c:v>
                </c:pt>
                <c:pt idx="63">
                  <c:v> # ATP8_PRANK_TRIMALP_DNA_UB # </c:v>
                </c:pt>
              </c:strCache>
            </c:strRef>
          </c:cat>
          <c:val>
            <c:numRef>
              <c:f>ATP8_CONSENSUS_PHYLOGENY_HISTG_!$B$2:$B$65</c:f>
              <c:numCache>
                <c:formatCode>General</c:formatCode>
                <c:ptCount val="64"/>
                <c:pt idx="0">
                  <c:v>161</c:v>
                </c:pt>
                <c:pt idx="1">
                  <c:v>161</c:v>
                </c:pt>
                <c:pt idx="2">
                  <c:v>161</c:v>
                </c:pt>
                <c:pt idx="3">
                  <c:v>161</c:v>
                </c:pt>
                <c:pt idx="4">
                  <c:v>161</c:v>
                </c:pt>
                <c:pt idx="5">
                  <c:v>153</c:v>
                </c:pt>
                <c:pt idx="6">
                  <c:v>153</c:v>
                </c:pt>
                <c:pt idx="7">
                  <c:v>136</c:v>
                </c:pt>
                <c:pt idx="8">
                  <c:v>136</c:v>
                </c:pt>
                <c:pt idx="9">
                  <c:v>136</c:v>
                </c:pt>
                <c:pt idx="10">
                  <c:v>136</c:v>
                </c:pt>
                <c:pt idx="11">
                  <c:v>136</c:v>
                </c:pt>
                <c:pt idx="12">
                  <c:v>136</c:v>
                </c:pt>
                <c:pt idx="13">
                  <c:v>136</c:v>
                </c:pt>
                <c:pt idx="14">
                  <c:v>130</c:v>
                </c:pt>
                <c:pt idx="15">
                  <c:v>130</c:v>
                </c:pt>
                <c:pt idx="16">
                  <c:v>130</c:v>
                </c:pt>
                <c:pt idx="17">
                  <c:v>130</c:v>
                </c:pt>
                <c:pt idx="18">
                  <c:v>130</c:v>
                </c:pt>
                <c:pt idx="19">
                  <c:v>130</c:v>
                </c:pt>
                <c:pt idx="20">
                  <c:v>130</c:v>
                </c:pt>
                <c:pt idx="21">
                  <c:v>129</c:v>
                </c:pt>
                <c:pt idx="22">
                  <c:v>129</c:v>
                </c:pt>
                <c:pt idx="23">
                  <c:v>113</c:v>
                </c:pt>
                <c:pt idx="24">
                  <c:v>113</c:v>
                </c:pt>
                <c:pt idx="25">
                  <c:v>113</c:v>
                </c:pt>
                <c:pt idx="26">
                  <c:v>113</c:v>
                </c:pt>
                <c:pt idx="27">
                  <c:v>113</c:v>
                </c:pt>
                <c:pt idx="28">
                  <c:v>113</c:v>
                </c:pt>
                <c:pt idx="29">
                  <c:v>113</c:v>
                </c:pt>
                <c:pt idx="30">
                  <c:v>87</c:v>
                </c:pt>
                <c:pt idx="31">
                  <c:v>87</c:v>
                </c:pt>
                <c:pt idx="32">
                  <c:v>86</c:v>
                </c:pt>
                <c:pt idx="33">
                  <c:v>86</c:v>
                </c:pt>
                <c:pt idx="34">
                  <c:v>50</c:v>
                </c:pt>
                <c:pt idx="35">
                  <c:v>50</c:v>
                </c:pt>
                <c:pt idx="36">
                  <c:v>50</c:v>
                </c:pt>
                <c:pt idx="37">
                  <c:v>50</c:v>
                </c:pt>
                <c:pt idx="38">
                  <c:v>50</c:v>
                </c:pt>
                <c:pt idx="39">
                  <c:v>50</c:v>
                </c:pt>
                <c:pt idx="40">
                  <c:v>50</c:v>
                </c:pt>
                <c:pt idx="41">
                  <c:v>44</c:v>
                </c:pt>
                <c:pt idx="42">
                  <c:v>44</c:v>
                </c:pt>
                <c:pt idx="43">
                  <c:v>44</c:v>
                </c:pt>
                <c:pt idx="44">
                  <c:v>33</c:v>
                </c:pt>
                <c:pt idx="45">
                  <c:v>29</c:v>
                </c:pt>
                <c:pt idx="46">
                  <c:v>18</c:v>
                </c:pt>
                <c:pt idx="47">
                  <c:v>10</c:v>
                </c:pt>
                <c:pt idx="48">
                  <c:v>10</c:v>
                </c:pt>
                <c:pt idx="49">
                  <c:v>8</c:v>
                </c:pt>
                <c:pt idx="50">
                  <c:v>8</c:v>
                </c:pt>
                <c:pt idx="51">
                  <c:v>8</c:v>
                </c:pt>
                <c:pt idx="52">
                  <c:v>7</c:v>
                </c:pt>
                <c:pt idx="53">
                  <c:v>7</c:v>
                </c:pt>
                <c:pt idx="54">
                  <c:v>4</c:v>
                </c:pt>
                <c:pt idx="55">
                  <c:v>4</c:v>
                </c:pt>
                <c:pt idx="56">
                  <c:v>3</c:v>
                </c:pt>
                <c:pt idx="57">
                  <c:v>2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80-2B62-4AFB-8DFA-901774104962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217133674500731"/>
          <c:y val="6.5454266421117249E-2"/>
          <c:w val="0.73964662807560022"/>
          <c:h val="0.89493155551688652"/>
        </c:manualLayout>
      </c:layout>
      <c:pieChart>
        <c:varyColors val="1"/>
        <c:ser>
          <c:idx val="0"/>
          <c:order val="0"/>
          <c:tx>
            <c:strRef>
              <c:f>ATP8_CONSENSUS_PHYLOGENY_HISTG_!$B$1</c:f>
              <c:strCache>
                <c:ptCount val="1"/>
                <c:pt idx="0">
                  <c:v>Total Topological Support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B617-417C-A090-D1372131F876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B617-417C-A090-D1372131F876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B617-417C-A090-D1372131F876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B617-417C-A090-D1372131F876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B617-417C-A090-D1372131F876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pPr>
                <a:endParaRPr lang="en-US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ATP8_CONSENSUS_PHYLOGENY_HISTG_!$A$2:$A$6</c:f>
              <c:strCache>
                <c:ptCount val="5"/>
                <c:pt idx="0">
                  <c:v> ***  # ATP8_MAFFTGI_DNA_UB #  *** </c:v>
                </c:pt>
                <c:pt idx="1">
                  <c:v> ***  # ATP8_CLUSTALO_2AA_UB #  *** </c:v>
                </c:pt>
                <c:pt idx="2">
                  <c:v> ***  # ATP8_GRAMALIGN_DEG_UB #  *** </c:v>
                </c:pt>
                <c:pt idx="3">
                  <c:v> ***  # ATP8_CLUSTALO_CDN_UB #  *** </c:v>
                </c:pt>
                <c:pt idx="4">
                  <c:v> ***  # ATP8_CLUSTALO_RYt_UB #  *** </c:v>
                </c:pt>
              </c:strCache>
            </c:strRef>
          </c:cat>
          <c:val>
            <c:numRef>
              <c:f>ATP8_CONSENSUS_PHYLOGENY_HISTG_!$B$2:$B$6</c:f>
              <c:numCache>
                <c:formatCode>General</c:formatCode>
                <c:ptCount val="5"/>
                <c:pt idx="0">
                  <c:v>18</c:v>
                </c:pt>
                <c:pt idx="1">
                  <c:v>14</c:v>
                </c:pt>
                <c:pt idx="2">
                  <c:v>14</c:v>
                </c:pt>
                <c:pt idx="3">
                  <c:v>12</c:v>
                </c:pt>
                <c:pt idx="4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B617-417C-A090-D1372131F876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255834601725013"/>
          <c:y val="4.3316451810926943E-2"/>
          <c:w val="0.75488330796549974"/>
          <c:h val="0.91336709637814606"/>
        </c:manualLayout>
      </c:layout>
      <c:pieChart>
        <c:varyColors val="1"/>
        <c:ser>
          <c:idx val="0"/>
          <c:order val="0"/>
          <c:tx>
            <c:strRef>
              <c:f>COX1_CONSENSUS_PHYLOGENY_HISTG_!$B$1</c:f>
              <c:strCache>
                <c:ptCount val="1"/>
                <c:pt idx="0">
                  <c:v>Total Topological Support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B32C-42A4-BF89-B6810915AB0B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B32C-42A4-BF89-B6810915AB0B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B32C-42A4-BF89-B6810915AB0B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B32C-42A4-BF89-B6810915AB0B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pPr>
                <a:endParaRPr lang="en-US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COX1_CONSENSUS_PHYLOGENY_HISTG_!$A$2:$A$5</c:f>
              <c:strCache>
                <c:ptCount val="4"/>
                <c:pt idx="0">
                  <c:v> ***  # COX1_PRANK_DNA_UB #  *** </c:v>
                </c:pt>
                <c:pt idx="1">
                  <c:v> ***  # COX1_TCOFFEETC_RYt_UB #  *** </c:v>
                </c:pt>
                <c:pt idx="2">
                  <c:v> ***  # COX1_PRANKCDO_2AA_UB #  *** </c:v>
                </c:pt>
                <c:pt idx="3">
                  <c:v> ***  # COX1_PRANKCD_CDN_UB #  *** </c:v>
                </c:pt>
              </c:strCache>
            </c:strRef>
          </c:cat>
          <c:val>
            <c:numRef>
              <c:f>COX1_CONSENSUS_PHYLOGENY_HISTG_!$B$2:$B$5</c:f>
              <c:numCache>
                <c:formatCode>General</c:formatCode>
                <c:ptCount val="4"/>
                <c:pt idx="0">
                  <c:v>7</c:v>
                </c:pt>
                <c:pt idx="1">
                  <c:v>6</c:v>
                </c:pt>
                <c:pt idx="2">
                  <c:v>2</c:v>
                </c:pt>
                <c:pt idx="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B32C-42A4-BF89-B6810915AB0B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7974570472219321E-2"/>
          <c:y val="3.8526329619250163E-2"/>
          <c:w val="0.8411746662037396"/>
          <c:h val="0.94212622043554939"/>
        </c:manualLayout>
      </c:layout>
      <c:pieChart>
        <c:varyColors val="1"/>
        <c:ser>
          <c:idx val="0"/>
          <c:order val="0"/>
          <c:tx>
            <c:strRef>
              <c:f>COX1_CONSENSUS_PHYLOGENY_HISTG_!$B$1</c:f>
              <c:strCache>
                <c:ptCount val="1"/>
                <c:pt idx="0">
                  <c:v>Total Topological Support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D913-4F4B-9DF1-33AA3E74F4E9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D913-4F4B-9DF1-33AA3E74F4E9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D913-4F4B-9DF1-33AA3E74F4E9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D913-4F4B-9DF1-33AA3E74F4E9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D913-4F4B-9DF1-33AA3E74F4E9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D913-4F4B-9DF1-33AA3E74F4E9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D913-4F4B-9DF1-33AA3E74F4E9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D913-4F4B-9DF1-33AA3E74F4E9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D913-4F4B-9DF1-33AA3E74F4E9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D913-4F4B-9DF1-33AA3E74F4E9}"/>
              </c:ext>
            </c:extLst>
          </c:dPt>
          <c:dPt>
            <c:idx val="10"/>
            <c:bubble3D val="0"/>
            <c:spPr>
              <a:solidFill>
                <a:schemeClr val="accent5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D913-4F4B-9DF1-33AA3E74F4E9}"/>
              </c:ext>
            </c:extLst>
          </c:dPt>
          <c:dPt>
            <c:idx val="11"/>
            <c:bubble3D val="0"/>
            <c:spPr>
              <a:solidFill>
                <a:schemeClr val="accent6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D913-4F4B-9DF1-33AA3E74F4E9}"/>
              </c:ext>
            </c:extLst>
          </c:dPt>
          <c:dPt>
            <c:idx val="12"/>
            <c:bubble3D val="0"/>
            <c:spPr>
              <a:solidFill>
                <a:schemeClr val="accent1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D913-4F4B-9DF1-33AA3E74F4E9}"/>
              </c:ext>
            </c:extLst>
          </c:dPt>
          <c:dPt>
            <c:idx val="13"/>
            <c:bubble3D val="0"/>
            <c:spPr>
              <a:solidFill>
                <a:schemeClr val="accent2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D913-4F4B-9DF1-33AA3E74F4E9}"/>
              </c:ext>
            </c:extLst>
          </c:dPt>
          <c:dPt>
            <c:idx val="14"/>
            <c:bubble3D val="0"/>
            <c:spPr>
              <a:solidFill>
                <a:schemeClr val="accent3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D913-4F4B-9DF1-33AA3E74F4E9}"/>
              </c:ext>
            </c:extLst>
          </c:dPt>
          <c:dPt>
            <c:idx val="15"/>
            <c:bubble3D val="0"/>
            <c:spPr>
              <a:solidFill>
                <a:schemeClr val="accent4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F-D913-4F4B-9DF1-33AA3E74F4E9}"/>
              </c:ext>
            </c:extLst>
          </c:dPt>
          <c:dPt>
            <c:idx val="16"/>
            <c:bubble3D val="0"/>
            <c:spPr>
              <a:solidFill>
                <a:schemeClr val="accent5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1-D913-4F4B-9DF1-33AA3E74F4E9}"/>
              </c:ext>
            </c:extLst>
          </c:dPt>
          <c:dPt>
            <c:idx val="17"/>
            <c:bubble3D val="0"/>
            <c:spPr>
              <a:solidFill>
                <a:schemeClr val="accent6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3-D913-4F4B-9DF1-33AA3E74F4E9}"/>
              </c:ext>
            </c:extLst>
          </c:dPt>
          <c:dPt>
            <c:idx val="18"/>
            <c:bubble3D val="0"/>
            <c:spPr>
              <a:solidFill>
                <a:schemeClr val="accent1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5-D913-4F4B-9DF1-33AA3E74F4E9}"/>
              </c:ext>
            </c:extLst>
          </c:dPt>
          <c:dPt>
            <c:idx val="19"/>
            <c:bubble3D val="0"/>
            <c:spPr>
              <a:solidFill>
                <a:schemeClr val="accent2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7-D913-4F4B-9DF1-33AA3E74F4E9}"/>
              </c:ext>
            </c:extLst>
          </c:dPt>
          <c:dPt>
            <c:idx val="20"/>
            <c:bubble3D val="0"/>
            <c:spPr>
              <a:solidFill>
                <a:schemeClr val="accent3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9-D913-4F4B-9DF1-33AA3E74F4E9}"/>
              </c:ext>
            </c:extLst>
          </c:dPt>
          <c:dPt>
            <c:idx val="21"/>
            <c:bubble3D val="0"/>
            <c:spPr>
              <a:solidFill>
                <a:schemeClr val="accent4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B-D913-4F4B-9DF1-33AA3E74F4E9}"/>
              </c:ext>
            </c:extLst>
          </c:dPt>
          <c:dPt>
            <c:idx val="22"/>
            <c:bubble3D val="0"/>
            <c:spPr>
              <a:solidFill>
                <a:schemeClr val="accent5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D-D913-4F4B-9DF1-33AA3E74F4E9}"/>
              </c:ext>
            </c:extLst>
          </c:dPt>
          <c:dPt>
            <c:idx val="23"/>
            <c:bubble3D val="0"/>
            <c:spPr>
              <a:solidFill>
                <a:schemeClr val="accent6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F-D913-4F4B-9DF1-33AA3E74F4E9}"/>
              </c:ext>
            </c:extLst>
          </c:dPt>
          <c:dPt>
            <c:idx val="24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1-D913-4F4B-9DF1-33AA3E74F4E9}"/>
              </c:ext>
            </c:extLst>
          </c:dPt>
          <c:dPt>
            <c:idx val="25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3-D913-4F4B-9DF1-33AA3E74F4E9}"/>
              </c:ext>
            </c:extLst>
          </c:dPt>
          <c:dPt>
            <c:idx val="26"/>
            <c:bubble3D val="0"/>
            <c:spPr>
              <a:solidFill>
                <a:schemeClr val="accent3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5-D913-4F4B-9DF1-33AA3E74F4E9}"/>
              </c:ext>
            </c:extLst>
          </c:dPt>
          <c:dPt>
            <c:idx val="27"/>
            <c:bubble3D val="0"/>
            <c:spPr>
              <a:solidFill>
                <a:schemeClr val="accent4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7-D913-4F4B-9DF1-33AA3E74F4E9}"/>
              </c:ext>
            </c:extLst>
          </c:dPt>
          <c:dPt>
            <c:idx val="28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9-D913-4F4B-9DF1-33AA3E74F4E9}"/>
              </c:ext>
            </c:extLst>
          </c:dPt>
          <c:dPt>
            <c:idx val="29"/>
            <c:bubble3D val="0"/>
            <c:spPr>
              <a:solidFill>
                <a:schemeClr val="accent6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B-D913-4F4B-9DF1-33AA3E74F4E9}"/>
              </c:ext>
            </c:extLst>
          </c:dPt>
          <c:dPt>
            <c:idx val="30"/>
            <c:bubble3D val="0"/>
            <c:spPr>
              <a:solidFill>
                <a:schemeClr val="accent1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D-D913-4F4B-9DF1-33AA3E74F4E9}"/>
              </c:ext>
            </c:extLst>
          </c:dPt>
          <c:dPt>
            <c:idx val="31"/>
            <c:bubble3D val="0"/>
            <c:spPr>
              <a:solidFill>
                <a:schemeClr val="accent2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F-D913-4F4B-9DF1-33AA3E74F4E9}"/>
              </c:ext>
            </c:extLst>
          </c:dPt>
          <c:dPt>
            <c:idx val="32"/>
            <c:bubble3D val="0"/>
            <c:spPr>
              <a:solidFill>
                <a:schemeClr val="accent3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1-D913-4F4B-9DF1-33AA3E74F4E9}"/>
              </c:ext>
            </c:extLst>
          </c:dPt>
          <c:dPt>
            <c:idx val="33"/>
            <c:bubble3D val="0"/>
            <c:spPr>
              <a:solidFill>
                <a:schemeClr val="accent4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3-D913-4F4B-9DF1-33AA3E74F4E9}"/>
              </c:ext>
            </c:extLst>
          </c:dPt>
          <c:dPt>
            <c:idx val="34"/>
            <c:bubble3D val="0"/>
            <c:spPr>
              <a:solidFill>
                <a:schemeClr val="accent5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5-D913-4F4B-9DF1-33AA3E74F4E9}"/>
              </c:ext>
            </c:extLst>
          </c:dPt>
          <c:dPt>
            <c:idx val="35"/>
            <c:bubble3D val="0"/>
            <c:spPr>
              <a:solidFill>
                <a:schemeClr val="accent6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7-D913-4F4B-9DF1-33AA3E74F4E9}"/>
              </c:ext>
            </c:extLst>
          </c:dPt>
          <c:dPt>
            <c:idx val="36"/>
            <c:bubble3D val="0"/>
            <c:spPr>
              <a:solidFill>
                <a:schemeClr val="accent1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9-D913-4F4B-9DF1-33AA3E74F4E9}"/>
              </c:ext>
            </c:extLst>
          </c:dPt>
          <c:dPt>
            <c:idx val="37"/>
            <c:bubble3D val="0"/>
            <c:spPr>
              <a:solidFill>
                <a:schemeClr val="accent2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B-D913-4F4B-9DF1-33AA3E74F4E9}"/>
              </c:ext>
            </c:extLst>
          </c:dPt>
          <c:dPt>
            <c:idx val="38"/>
            <c:bubble3D val="0"/>
            <c:spPr>
              <a:solidFill>
                <a:schemeClr val="accent3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D-D913-4F4B-9DF1-33AA3E74F4E9}"/>
              </c:ext>
            </c:extLst>
          </c:dPt>
          <c:dPt>
            <c:idx val="39"/>
            <c:bubble3D val="0"/>
            <c:spPr>
              <a:solidFill>
                <a:schemeClr val="accent4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F-D913-4F4B-9DF1-33AA3E74F4E9}"/>
              </c:ext>
            </c:extLst>
          </c:dPt>
          <c:dPt>
            <c:idx val="40"/>
            <c:bubble3D val="0"/>
            <c:spPr>
              <a:solidFill>
                <a:schemeClr val="accent5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1-D913-4F4B-9DF1-33AA3E74F4E9}"/>
              </c:ext>
            </c:extLst>
          </c:dPt>
          <c:dPt>
            <c:idx val="41"/>
            <c:bubble3D val="0"/>
            <c:spPr>
              <a:solidFill>
                <a:schemeClr val="accent6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3-D913-4F4B-9DF1-33AA3E74F4E9}"/>
              </c:ext>
            </c:extLst>
          </c:dPt>
          <c:dPt>
            <c:idx val="42"/>
            <c:bubble3D val="0"/>
            <c:spPr>
              <a:solidFill>
                <a:schemeClr val="accent1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5-D913-4F4B-9DF1-33AA3E74F4E9}"/>
              </c:ext>
            </c:extLst>
          </c:dPt>
          <c:dPt>
            <c:idx val="43"/>
            <c:bubble3D val="0"/>
            <c:spPr>
              <a:solidFill>
                <a:schemeClr val="accent2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7-D913-4F4B-9DF1-33AA3E74F4E9}"/>
              </c:ext>
            </c:extLst>
          </c:dPt>
          <c:dPt>
            <c:idx val="44"/>
            <c:bubble3D val="0"/>
            <c:spPr>
              <a:solidFill>
                <a:schemeClr val="accent3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9-D913-4F4B-9DF1-33AA3E74F4E9}"/>
              </c:ext>
            </c:extLst>
          </c:dPt>
          <c:dPt>
            <c:idx val="45"/>
            <c:bubble3D val="0"/>
            <c:spPr>
              <a:solidFill>
                <a:schemeClr val="accent4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B-D913-4F4B-9DF1-33AA3E74F4E9}"/>
              </c:ext>
            </c:extLst>
          </c:dPt>
          <c:dPt>
            <c:idx val="46"/>
            <c:bubble3D val="0"/>
            <c:spPr>
              <a:solidFill>
                <a:schemeClr val="accent5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D-D913-4F4B-9DF1-33AA3E74F4E9}"/>
              </c:ext>
            </c:extLst>
          </c:dPt>
          <c:dPt>
            <c:idx val="47"/>
            <c:bubble3D val="0"/>
            <c:spPr>
              <a:solidFill>
                <a:schemeClr val="accent6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F-D913-4F4B-9DF1-33AA3E74F4E9}"/>
              </c:ext>
            </c:extLst>
          </c:dPt>
          <c:dPt>
            <c:idx val="48"/>
            <c:bubble3D val="0"/>
            <c:spPr>
              <a:solidFill>
                <a:schemeClr val="accent1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1-D913-4F4B-9DF1-33AA3E74F4E9}"/>
              </c:ext>
            </c:extLst>
          </c:dPt>
          <c:dPt>
            <c:idx val="49"/>
            <c:bubble3D val="0"/>
            <c:spPr>
              <a:solidFill>
                <a:schemeClr val="accent2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3-D913-4F4B-9DF1-33AA3E74F4E9}"/>
              </c:ext>
            </c:extLst>
          </c:dPt>
          <c:dPt>
            <c:idx val="50"/>
            <c:bubble3D val="0"/>
            <c:spPr>
              <a:solidFill>
                <a:schemeClr val="accent3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5-D913-4F4B-9DF1-33AA3E74F4E9}"/>
              </c:ext>
            </c:extLst>
          </c:dPt>
          <c:dPt>
            <c:idx val="51"/>
            <c:bubble3D val="0"/>
            <c:spPr>
              <a:solidFill>
                <a:schemeClr val="accent4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7-D913-4F4B-9DF1-33AA3E74F4E9}"/>
              </c:ext>
            </c:extLst>
          </c:dPt>
          <c:dPt>
            <c:idx val="52"/>
            <c:bubble3D val="0"/>
            <c:spPr>
              <a:solidFill>
                <a:schemeClr val="accent5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9-D913-4F4B-9DF1-33AA3E74F4E9}"/>
              </c:ext>
            </c:extLst>
          </c:dPt>
          <c:dPt>
            <c:idx val="53"/>
            <c:bubble3D val="0"/>
            <c:spPr>
              <a:solidFill>
                <a:schemeClr val="accent6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B-D913-4F4B-9DF1-33AA3E74F4E9}"/>
              </c:ext>
            </c:extLst>
          </c:dPt>
          <c:dPt>
            <c:idx val="54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D-D913-4F4B-9DF1-33AA3E74F4E9}"/>
              </c:ext>
            </c:extLst>
          </c:dPt>
          <c:dPt>
            <c:idx val="55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F-D913-4F4B-9DF1-33AA3E74F4E9}"/>
              </c:ext>
            </c:extLst>
          </c:dPt>
          <c:dPt>
            <c:idx val="56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1-D913-4F4B-9DF1-33AA3E74F4E9}"/>
              </c:ext>
            </c:extLst>
          </c:dPt>
          <c:dPt>
            <c:idx val="57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3-D913-4F4B-9DF1-33AA3E74F4E9}"/>
              </c:ext>
            </c:extLst>
          </c:dPt>
          <c:dPt>
            <c:idx val="58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5-D913-4F4B-9DF1-33AA3E74F4E9}"/>
              </c:ext>
            </c:extLst>
          </c:dPt>
          <c:dPt>
            <c:idx val="59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7-D913-4F4B-9DF1-33AA3E74F4E9}"/>
              </c:ext>
            </c:extLst>
          </c:dPt>
          <c:dPt>
            <c:idx val="60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9-D913-4F4B-9DF1-33AA3E74F4E9}"/>
              </c:ext>
            </c:extLst>
          </c:dPt>
          <c:dPt>
            <c:idx val="61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B-D913-4F4B-9DF1-33AA3E74F4E9}"/>
              </c:ext>
            </c:extLst>
          </c:dPt>
          <c:dPt>
            <c:idx val="62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D-D913-4F4B-9DF1-33AA3E74F4E9}"/>
              </c:ext>
            </c:extLst>
          </c:dPt>
          <c:dPt>
            <c:idx val="63"/>
            <c:bubble3D val="0"/>
            <c:spPr>
              <a:solidFill>
                <a:schemeClr val="accent4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F-D913-4F4B-9DF1-33AA3E74F4E9}"/>
              </c:ext>
            </c:extLst>
          </c:dPt>
          <c:dPt>
            <c:idx val="64"/>
            <c:bubble3D val="0"/>
            <c:spPr>
              <a:solidFill>
                <a:schemeClr val="accent5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1-D913-4F4B-9DF1-33AA3E74F4E9}"/>
              </c:ext>
            </c:extLst>
          </c:dPt>
          <c:dPt>
            <c:idx val="65"/>
            <c:bubble3D val="0"/>
            <c:spPr>
              <a:solidFill>
                <a:schemeClr val="accent6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3-D913-4F4B-9DF1-33AA3E74F4E9}"/>
              </c:ext>
            </c:extLst>
          </c:dPt>
          <c:dPt>
            <c:idx val="66"/>
            <c:bubble3D val="0"/>
            <c:spPr>
              <a:solidFill>
                <a:schemeClr val="accent1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5-D913-4F4B-9DF1-33AA3E74F4E9}"/>
              </c:ext>
            </c:extLst>
          </c:dPt>
          <c:dPt>
            <c:idx val="67"/>
            <c:bubble3D val="0"/>
            <c:spPr>
              <a:solidFill>
                <a:schemeClr val="accent2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7-D913-4F4B-9DF1-33AA3E74F4E9}"/>
              </c:ext>
            </c:extLst>
          </c:dPt>
          <c:dPt>
            <c:idx val="68"/>
            <c:bubble3D val="0"/>
            <c:spPr>
              <a:solidFill>
                <a:schemeClr val="accent3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9-D913-4F4B-9DF1-33AA3E74F4E9}"/>
              </c:ext>
            </c:extLst>
          </c:dPt>
          <c:dPt>
            <c:idx val="69"/>
            <c:bubble3D val="0"/>
            <c:spPr>
              <a:solidFill>
                <a:schemeClr val="accent4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B-D913-4F4B-9DF1-33AA3E74F4E9}"/>
              </c:ext>
            </c:extLst>
          </c:dPt>
          <c:dPt>
            <c:idx val="70"/>
            <c:bubble3D val="0"/>
            <c:spPr>
              <a:solidFill>
                <a:schemeClr val="accent5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D-D913-4F4B-9DF1-33AA3E74F4E9}"/>
              </c:ext>
            </c:extLst>
          </c:dPt>
          <c:dPt>
            <c:idx val="71"/>
            <c:bubble3D val="0"/>
            <c:spPr>
              <a:solidFill>
                <a:schemeClr val="accent6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F-D913-4F4B-9DF1-33AA3E74F4E9}"/>
              </c:ext>
            </c:extLst>
          </c:dPt>
          <c:dPt>
            <c:idx val="72"/>
            <c:bubble3D val="0"/>
            <c:spPr>
              <a:solidFill>
                <a:schemeClr val="accent1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91-D913-4F4B-9DF1-33AA3E74F4E9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pPr>
                <a:endParaRPr lang="en-US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COX1_CONSENSUS_PHYLOGENY_HISTG_!$A$2:$A$74</c:f>
              <c:strCache>
                <c:ptCount val="73"/>
                <c:pt idx="0">
                  <c:v> ***  # COX1_KALIGN_GBLOCKSC_DNA_UB #  *** </c:v>
                </c:pt>
                <c:pt idx="1">
                  <c:v> ***  # COX1_KALIGN_GBLOCKS_DNA_UB #  *** </c:v>
                </c:pt>
                <c:pt idx="2">
                  <c:v> ***  # COX1_KALIGN_TCSFMw_DNA_UB #  *** </c:v>
                </c:pt>
                <c:pt idx="3">
                  <c:v> ***  # COX1_KALIGN_TCSFMw_RYt_UB #  *** </c:v>
                </c:pt>
                <c:pt idx="4">
                  <c:v> ***  # COX1_KALIGN_TCSw_DNA_UB #  *** </c:v>
                </c:pt>
                <c:pt idx="5">
                  <c:v> ***  # COX1_KALIGN_TCSw_RYt_UB #  *** </c:v>
                </c:pt>
                <c:pt idx="6">
                  <c:v> ***  # COX1_MAFFTA_PSARALIGN_DNA_UB #  *** </c:v>
                </c:pt>
                <c:pt idx="7">
                  <c:v> ***  # COX1_MAFFTA_TRIMAL_DNA_UB #  *** </c:v>
                </c:pt>
                <c:pt idx="8">
                  <c:v> ***  # COX1_MAFFTEI_MAXALIGN_DNA_UB #  *** </c:v>
                </c:pt>
                <c:pt idx="9">
                  <c:v> ***  # COX1_MAFFTEI_PSARALIGN_DNA_UB #  *** </c:v>
                </c:pt>
                <c:pt idx="10">
                  <c:v> ***  # COX1_MAFFTEI_TCSf_DNA_UB #  *** </c:v>
                </c:pt>
                <c:pt idx="11">
                  <c:v> ***  # COX1_MAFFTFI_MAXALIGN_DNA_UB #  *** </c:v>
                </c:pt>
                <c:pt idx="12">
                  <c:v> ***  # COX1_MAFFTFI_TCSFMf_DNA_UB #  *** </c:v>
                </c:pt>
                <c:pt idx="13">
                  <c:v> ***  # COX1_MAFFTFI_TRIMALA_DNA_UB #  *** </c:v>
                </c:pt>
                <c:pt idx="14">
                  <c:v> ***  # COX1_MAFFTGI_MAXALIGN_DNA_UB #  *** </c:v>
                </c:pt>
                <c:pt idx="15">
                  <c:v> ***  # COX1_MAFFTGI_TCSFMf_DNA_UB #  *** </c:v>
                </c:pt>
                <c:pt idx="16">
                  <c:v> ***  # COX1_MAFFTGI_TRIMALA_DNA_UB #  *** </c:v>
                </c:pt>
                <c:pt idx="17">
                  <c:v> ***  # COX1_MAFFTLI_MAXALIGN_DNA_UB #  *** </c:v>
                </c:pt>
                <c:pt idx="18">
                  <c:v> ***  # COX1_MAFFTLI_TCSFMf_DNA_UB #  *** </c:v>
                </c:pt>
                <c:pt idx="19">
                  <c:v> ***  # COX1_OPAL_TCSFMw_DEG_UB #  *** </c:v>
                </c:pt>
                <c:pt idx="20">
                  <c:v> ***  # COX1_PRANKF_TCSFMf_DNA_UB #  *** </c:v>
                </c:pt>
                <c:pt idx="21">
                  <c:v> ***  # COX1_PRANKF_TRIMALG_DNA_UB #  *** </c:v>
                </c:pt>
                <c:pt idx="22">
                  <c:v> ***  # COX1_PRANKO_GBLOCKSC_DNA_UB #  *** </c:v>
                </c:pt>
                <c:pt idx="23">
                  <c:v> ***  # COX1_PRANK_GBLOCKSC_DNA_UB #  *** </c:v>
                </c:pt>
                <c:pt idx="24">
                  <c:v> ***  # COX1_PRANK_GBLOCKS_DNA_UB #  *** </c:v>
                </c:pt>
                <c:pt idx="25">
                  <c:v> ***  # COX1_PROBCONS_GBLOCKSC_DNA_UB #  *** </c:v>
                </c:pt>
                <c:pt idx="26">
                  <c:v> ***  # COX1_TCOFFEEPL_GBLOCKSC_DNA_UB #  *** </c:v>
                </c:pt>
                <c:pt idx="27">
                  <c:v> ***  # COX1_TCOFFEETC_GBLOCKSC_DNA_UB #  *** </c:v>
                </c:pt>
                <c:pt idx="28">
                  <c:v> ***  # COX1_TCOFFEE_GBLOCKSC_DNA_UB #  *** </c:v>
                </c:pt>
                <c:pt idx="29">
                  <c:v> *** COX1_ALL_TRIMALC_DNA_UB *** </c:v>
                </c:pt>
                <c:pt idx="30">
                  <c:v> ***  # COX1_GRAMALIGN_MAXALIGN_RYt_UB #  *** </c:v>
                </c:pt>
                <c:pt idx="31">
                  <c:v> ***  # COX1_PROBCONS_MAXALIGN_RYt_UB #  *** </c:v>
                </c:pt>
                <c:pt idx="32">
                  <c:v> ***  # COX1_PROBCONS_TRIMAL_RYt_UB #  *** </c:v>
                </c:pt>
                <c:pt idx="33">
                  <c:v> ***  # COX1_TCOFFEETC_PSARALIGN_RYt_UB #  *** </c:v>
                </c:pt>
                <c:pt idx="34">
                  <c:v> ***  # COX1_FSA_GBLOCKS_DEG_UB #  *** </c:v>
                </c:pt>
                <c:pt idx="35">
                  <c:v> ***  # COX1_GRAMALIGN_TRIMALA_DEG_UB #  *** </c:v>
                </c:pt>
                <c:pt idx="36">
                  <c:v> ***  # COX1_GRAMALIGN_TRIMALG_DEG_UB #  *** </c:v>
                </c:pt>
                <c:pt idx="37">
                  <c:v> ***  # COX1_KALIGN_TRIMALS_DNA_UB #  *** </c:v>
                </c:pt>
                <c:pt idx="38">
                  <c:v> ***  # COX1_MAFFTF2_TRIMALP_DEG_UB #  *** </c:v>
                </c:pt>
                <c:pt idx="39">
                  <c:v> ***  # COX1_MAFFTGI_TRIMALP_DNA_UB #  *** </c:v>
                </c:pt>
                <c:pt idx="40">
                  <c:v> ***  # COX1_MAFFT_TCSOGw_DEG_UB #  *** </c:v>
                </c:pt>
                <c:pt idx="41">
                  <c:v> ***  # COX1_MUSCLE_TCSOGw_RYt_UB #  *** </c:v>
                </c:pt>
                <c:pt idx="42">
                  <c:v> *** COX1_ALL_TRIMALC_RYt_UB *** </c:v>
                </c:pt>
                <c:pt idx="43">
                  <c:v> ***  # COX1_GRAMALIGN_GBLOCKS_RYt_UB #  *** </c:v>
                </c:pt>
                <c:pt idx="44">
                  <c:v> ***  # COX1_GRAMALIGN_TRIMALA_RYt_UB #  *** </c:v>
                </c:pt>
                <c:pt idx="45">
                  <c:v> ***  # COX1_PRANKCDF_TCSFMf_2AA_UB #  *** </c:v>
                </c:pt>
                <c:pt idx="46">
                  <c:v> ***  # COX1_PRANKCDF_TRIMALA_2AA_UB #  *** </c:v>
                </c:pt>
                <c:pt idx="47">
                  <c:v> ***  # COX1_PRANKCDO_TRIMALG_2AA_UB #  *** </c:v>
                </c:pt>
                <c:pt idx="48">
                  <c:v> ***  # COX1_PRANKCDO_TRIMAL_2AA_UB #  *** </c:v>
                </c:pt>
                <c:pt idx="49">
                  <c:v> ***  # COX1_PRANKCD_GBLOCKSC_2AA_UB #  *** </c:v>
                </c:pt>
                <c:pt idx="50">
                  <c:v> ***  # COX1_PRANKCD_MAXALIGN_2AA_UB #  *** </c:v>
                </c:pt>
                <c:pt idx="51">
                  <c:v> ***  # COX1_PRANKCD_PSARALIGN_2AA_UB #  *** </c:v>
                </c:pt>
                <c:pt idx="52">
                  <c:v> ***  # COX1_PRANKCD_TCSf_2AA_UB #  *** </c:v>
                </c:pt>
                <c:pt idx="53">
                  <c:v> ***  # COX1_FSA_NOISY_DNA_UB #  *** </c:v>
                </c:pt>
                <c:pt idx="54">
                  <c:v> ***  # COX1_KALIGN_NOISY_DNA_UB #  *** </c:v>
                </c:pt>
                <c:pt idx="55">
                  <c:v> ***  # COX1_MAFFTA_NOISY_DNA_UB #  *** </c:v>
                </c:pt>
                <c:pt idx="56">
                  <c:v> ***  # COX1_MAFFTEI_NOISY_DNA_UB #  *** </c:v>
                </c:pt>
                <c:pt idx="57">
                  <c:v> ***  # COX1_OPAL_NOISY_DNA_UB #  *** </c:v>
                </c:pt>
                <c:pt idx="58">
                  <c:v> ***  # COX1_PRANKF_NOISY_DNA_UB #  *** </c:v>
                </c:pt>
                <c:pt idx="59">
                  <c:v> ***  # COX1_KALIGN_TCSw_DEG_UB #  *** </c:v>
                </c:pt>
                <c:pt idx="60">
                  <c:v> ***  # COX1_MAFFT_TCSOGw_DNA_UB #  *** </c:v>
                </c:pt>
                <c:pt idx="61">
                  <c:v> ***  # COX1_TCOFFEE_TRIMALS_RYt_UB #  *** </c:v>
                </c:pt>
                <c:pt idx="62">
                  <c:v> ***  # COX1_PRANKCDO_MAXALIGN_CDN_UB #  *** </c:v>
                </c:pt>
                <c:pt idx="63">
                  <c:v> ***  # COX1_PRANKCDO_TCSFMf_CDN_UB #  *** </c:v>
                </c:pt>
                <c:pt idx="64">
                  <c:v> ***  # COX1_FSA_TRIMALG_RYt_UB #  *** </c:v>
                </c:pt>
                <c:pt idx="65">
                  <c:v> ***  # COX1_PRANKCDF_TCSf_CDN_UB #  *** </c:v>
                </c:pt>
                <c:pt idx="66">
                  <c:v> ***  # COX1_PRANKCDF_TRIMALG_CDN_UB #  *** </c:v>
                </c:pt>
                <c:pt idx="67">
                  <c:v> ***  # COX1_PRANKCDO_GBLOCKSC_CDN_UB #  *** </c:v>
                </c:pt>
                <c:pt idx="68">
                  <c:v> ***  # COX1_PRANKCDO_TRIMAL_CDN_UB #  *** </c:v>
                </c:pt>
                <c:pt idx="69">
                  <c:v> ***  # COX1_PRANKCD_TRIMALA_CDN_UB #  *** </c:v>
                </c:pt>
                <c:pt idx="70">
                  <c:v> ***  # COX1_TCOFFEEPL_TRIMALS_DEG_UB #  *** </c:v>
                </c:pt>
                <c:pt idx="71">
                  <c:v> ***  # COX1_PRANKCDF_PSARALIGN_CDN_UB #  *** </c:v>
                </c:pt>
                <c:pt idx="72">
                  <c:v> ***  # COX1_PRANKF_TRIMALP_RYt_UB #  *** </c:v>
                </c:pt>
              </c:strCache>
            </c:strRef>
          </c:cat>
          <c:val>
            <c:numRef>
              <c:f>COX1_CONSENSUS_PHYLOGENY_HISTG_!$B$2:$B$74</c:f>
              <c:numCache>
                <c:formatCode>General</c:formatCode>
                <c:ptCount val="73"/>
                <c:pt idx="0">
                  <c:v>401</c:v>
                </c:pt>
                <c:pt idx="1">
                  <c:v>401</c:v>
                </c:pt>
                <c:pt idx="2">
                  <c:v>401</c:v>
                </c:pt>
                <c:pt idx="3">
                  <c:v>401</c:v>
                </c:pt>
                <c:pt idx="4">
                  <c:v>401</c:v>
                </c:pt>
                <c:pt idx="5">
                  <c:v>401</c:v>
                </c:pt>
                <c:pt idx="6">
                  <c:v>401</c:v>
                </c:pt>
                <c:pt idx="7">
                  <c:v>401</c:v>
                </c:pt>
                <c:pt idx="8">
                  <c:v>401</c:v>
                </c:pt>
                <c:pt idx="9">
                  <c:v>401</c:v>
                </c:pt>
                <c:pt idx="10">
                  <c:v>401</c:v>
                </c:pt>
                <c:pt idx="11">
                  <c:v>401</c:v>
                </c:pt>
                <c:pt idx="12">
                  <c:v>401</c:v>
                </c:pt>
                <c:pt idx="13">
                  <c:v>401</c:v>
                </c:pt>
                <c:pt idx="14">
                  <c:v>401</c:v>
                </c:pt>
                <c:pt idx="15">
                  <c:v>401</c:v>
                </c:pt>
                <c:pt idx="16">
                  <c:v>401</c:v>
                </c:pt>
                <c:pt idx="17">
                  <c:v>401</c:v>
                </c:pt>
                <c:pt idx="18">
                  <c:v>401</c:v>
                </c:pt>
                <c:pt idx="19">
                  <c:v>401</c:v>
                </c:pt>
                <c:pt idx="20">
                  <c:v>401</c:v>
                </c:pt>
                <c:pt idx="21">
                  <c:v>401</c:v>
                </c:pt>
                <c:pt idx="22">
                  <c:v>401</c:v>
                </c:pt>
                <c:pt idx="23">
                  <c:v>401</c:v>
                </c:pt>
                <c:pt idx="24">
                  <c:v>401</c:v>
                </c:pt>
                <c:pt idx="25">
                  <c:v>401</c:v>
                </c:pt>
                <c:pt idx="26">
                  <c:v>401</c:v>
                </c:pt>
                <c:pt idx="27">
                  <c:v>400</c:v>
                </c:pt>
                <c:pt idx="28">
                  <c:v>386</c:v>
                </c:pt>
                <c:pt idx="29">
                  <c:v>339</c:v>
                </c:pt>
                <c:pt idx="30">
                  <c:v>96</c:v>
                </c:pt>
                <c:pt idx="31">
                  <c:v>96</c:v>
                </c:pt>
                <c:pt idx="32">
                  <c:v>96</c:v>
                </c:pt>
                <c:pt idx="33">
                  <c:v>93</c:v>
                </c:pt>
                <c:pt idx="34">
                  <c:v>75</c:v>
                </c:pt>
                <c:pt idx="35">
                  <c:v>75</c:v>
                </c:pt>
                <c:pt idx="36">
                  <c:v>75</c:v>
                </c:pt>
                <c:pt idx="37">
                  <c:v>71</c:v>
                </c:pt>
                <c:pt idx="38">
                  <c:v>71</c:v>
                </c:pt>
                <c:pt idx="39">
                  <c:v>71</c:v>
                </c:pt>
                <c:pt idx="40">
                  <c:v>69</c:v>
                </c:pt>
                <c:pt idx="41">
                  <c:v>69</c:v>
                </c:pt>
                <c:pt idx="42">
                  <c:v>65</c:v>
                </c:pt>
                <c:pt idx="43">
                  <c:v>38</c:v>
                </c:pt>
                <c:pt idx="44">
                  <c:v>38</c:v>
                </c:pt>
                <c:pt idx="45">
                  <c:v>29</c:v>
                </c:pt>
                <c:pt idx="46">
                  <c:v>29</c:v>
                </c:pt>
                <c:pt idx="47">
                  <c:v>29</c:v>
                </c:pt>
                <c:pt idx="48">
                  <c:v>29</c:v>
                </c:pt>
                <c:pt idx="49">
                  <c:v>29</c:v>
                </c:pt>
                <c:pt idx="50">
                  <c:v>29</c:v>
                </c:pt>
                <c:pt idx="51">
                  <c:v>29</c:v>
                </c:pt>
                <c:pt idx="52">
                  <c:v>29</c:v>
                </c:pt>
                <c:pt idx="53">
                  <c:v>24</c:v>
                </c:pt>
                <c:pt idx="54">
                  <c:v>24</c:v>
                </c:pt>
                <c:pt idx="55">
                  <c:v>24</c:v>
                </c:pt>
                <c:pt idx="56">
                  <c:v>24</c:v>
                </c:pt>
                <c:pt idx="57">
                  <c:v>24</c:v>
                </c:pt>
                <c:pt idx="58">
                  <c:v>24</c:v>
                </c:pt>
                <c:pt idx="59">
                  <c:v>15</c:v>
                </c:pt>
                <c:pt idx="60">
                  <c:v>10</c:v>
                </c:pt>
                <c:pt idx="61">
                  <c:v>10</c:v>
                </c:pt>
                <c:pt idx="62">
                  <c:v>8</c:v>
                </c:pt>
                <c:pt idx="63">
                  <c:v>8</c:v>
                </c:pt>
                <c:pt idx="64">
                  <c:v>7</c:v>
                </c:pt>
                <c:pt idx="65">
                  <c:v>7</c:v>
                </c:pt>
                <c:pt idx="66">
                  <c:v>7</c:v>
                </c:pt>
                <c:pt idx="67">
                  <c:v>7</c:v>
                </c:pt>
                <c:pt idx="68">
                  <c:v>7</c:v>
                </c:pt>
                <c:pt idx="69">
                  <c:v>7</c:v>
                </c:pt>
                <c:pt idx="70">
                  <c:v>6</c:v>
                </c:pt>
                <c:pt idx="71">
                  <c:v>2</c:v>
                </c:pt>
                <c:pt idx="72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92-D913-4F4B-9DF1-33AA3E74F4E9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58726479152792466"/>
          <c:y val="3.290022475638820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bg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0040837320691728"/>
          <c:y val="7.0793284522832872E-2"/>
          <c:w val="0.79918341739411047"/>
          <c:h val="0.92096055229132867"/>
        </c:manualLayout>
      </c:layout>
      <c:pieChart>
        <c:varyColors val="1"/>
        <c:ser>
          <c:idx val="0"/>
          <c:order val="0"/>
          <c:tx>
            <c:strRef>
              <c:f>COX2_CONSENSUS_PHYLOGENY_HISTG_!$B$1</c:f>
              <c:strCache>
                <c:ptCount val="1"/>
                <c:pt idx="0">
                  <c:v>Total Topological Support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BE39-40B1-B014-8342183708AA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BE39-40B1-B014-8342183708AA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BE39-40B1-B014-8342183708AA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BE39-40B1-B014-8342183708AA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BE39-40B1-B014-8342183708AA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BE39-40B1-B014-8342183708AA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BE39-40B1-B014-8342183708AA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BE39-40B1-B014-8342183708AA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BE39-40B1-B014-8342183708AA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BE39-40B1-B014-8342183708AA}"/>
              </c:ext>
            </c:extLst>
          </c:dPt>
          <c:dPt>
            <c:idx val="10"/>
            <c:bubble3D val="0"/>
            <c:spPr>
              <a:solidFill>
                <a:schemeClr val="accent5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BE39-40B1-B014-8342183708AA}"/>
              </c:ext>
            </c:extLst>
          </c:dPt>
          <c:dPt>
            <c:idx val="11"/>
            <c:bubble3D val="0"/>
            <c:spPr>
              <a:solidFill>
                <a:schemeClr val="accent6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BE39-40B1-B014-8342183708AA}"/>
              </c:ext>
            </c:extLst>
          </c:dPt>
          <c:dPt>
            <c:idx val="12"/>
            <c:bubble3D val="0"/>
            <c:spPr>
              <a:solidFill>
                <a:schemeClr val="accent1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BE39-40B1-B014-8342183708AA}"/>
              </c:ext>
            </c:extLst>
          </c:dPt>
          <c:dPt>
            <c:idx val="13"/>
            <c:bubble3D val="0"/>
            <c:spPr>
              <a:solidFill>
                <a:schemeClr val="accent2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BE39-40B1-B014-8342183708AA}"/>
              </c:ext>
            </c:extLst>
          </c:dPt>
          <c:dPt>
            <c:idx val="14"/>
            <c:bubble3D val="0"/>
            <c:spPr>
              <a:solidFill>
                <a:schemeClr val="accent3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BE39-40B1-B014-8342183708AA}"/>
              </c:ext>
            </c:extLst>
          </c:dPt>
          <c:dPt>
            <c:idx val="15"/>
            <c:bubble3D val="0"/>
            <c:spPr>
              <a:solidFill>
                <a:schemeClr val="accent4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F-BE39-40B1-B014-8342183708AA}"/>
              </c:ext>
            </c:extLst>
          </c:dPt>
          <c:dPt>
            <c:idx val="16"/>
            <c:bubble3D val="0"/>
            <c:spPr>
              <a:solidFill>
                <a:schemeClr val="accent5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1-BE39-40B1-B014-8342183708AA}"/>
              </c:ext>
            </c:extLst>
          </c:dPt>
          <c:dPt>
            <c:idx val="17"/>
            <c:bubble3D val="0"/>
            <c:spPr>
              <a:solidFill>
                <a:schemeClr val="accent6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3-BE39-40B1-B014-8342183708AA}"/>
              </c:ext>
            </c:extLst>
          </c:dPt>
          <c:dPt>
            <c:idx val="18"/>
            <c:bubble3D val="0"/>
            <c:spPr>
              <a:solidFill>
                <a:schemeClr val="accent1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5-BE39-40B1-B014-8342183708AA}"/>
              </c:ext>
            </c:extLst>
          </c:dPt>
          <c:dPt>
            <c:idx val="19"/>
            <c:bubble3D val="0"/>
            <c:spPr>
              <a:solidFill>
                <a:schemeClr val="accent2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7-BE39-40B1-B014-8342183708AA}"/>
              </c:ext>
            </c:extLst>
          </c:dPt>
          <c:dPt>
            <c:idx val="20"/>
            <c:bubble3D val="0"/>
            <c:spPr>
              <a:solidFill>
                <a:schemeClr val="accent3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9-BE39-40B1-B014-8342183708AA}"/>
              </c:ext>
            </c:extLst>
          </c:dPt>
          <c:dPt>
            <c:idx val="21"/>
            <c:bubble3D val="0"/>
            <c:spPr>
              <a:solidFill>
                <a:schemeClr val="accent4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B-BE39-40B1-B014-8342183708AA}"/>
              </c:ext>
            </c:extLst>
          </c:dPt>
          <c:dPt>
            <c:idx val="22"/>
            <c:bubble3D val="0"/>
            <c:spPr>
              <a:solidFill>
                <a:schemeClr val="accent5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D-BE39-40B1-B014-8342183708AA}"/>
              </c:ext>
            </c:extLst>
          </c:dPt>
          <c:dPt>
            <c:idx val="23"/>
            <c:bubble3D val="0"/>
            <c:spPr>
              <a:solidFill>
                <a:schemeClr val="accent6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F-BE39-40B1-B014-8342183708AA}"/>
              </c:ext>
            </c:extLst>
          </c:dPt>
          <c:dPt>
            <c:idx val="24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1-BE39-40B1-B014-8342183708AA}"/>
              </c:ext>
            </c:extLst>
          </c:dPt>
          <c:dPt>
            <c:idx val="25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3-BE39-40B1-B014-8342183708AA}"/>
              </c:ext>
            </c:extLst>
          </c:dPt>
          <c:dPt>
            <c:idx val="26"/>
            <c:bubble3D val="0"/>
            <c:spPr>
              <a:solidFill>
                <a:schemeClr val="accent3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5-BE39-40B1-B014-8342183708AA}"/>
              </c:ext>
            </c:extLst>
          </c:dPt>
          <c:dPt>
            <c:idx val="27"/>
            <c:bubble3D val="0"/>
            <c:spPr>
              <a:solidFill>
                <a:schemeClr val="accent4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7-BE39-40B1-B014-8342183708AA}"/>
              </c:ext>
            </c:extLst>
          </c:dPt>
          <c:dPt>
            <c:idx val="28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9-BE39-40B1-B014-8342183708AA}"/>
              </c:ext>
            </c:extLst>
          </c:dPt>
          <c:dPt>
            <c:idx val="29"/>
            <c:bubble3D val="0"/>
            <c:spPr>
              <a:solidFill>
                <a:schemeClr val="accent6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B-BE39-40B1-B014-8342183708AA}"/>
              </c:ext>
            </c:extLst>
          </c:dPt>
          <c:dPt>
            <c:idx val="30"/>
            <c:bubble3D val="0"/>
            <c:spPr>
              <a:solidFill>
                <a:schemeClr val="accent1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D-BE39-40B1-B014-8342183708AA}"/>
              </c:ext>
            </c:extLst>
          </c:dPt>
          <c:dPt>
            <c:idx val="31"/>
            <c:bubble3D val="0"/>
            <c:spPr>
              <a:solidFill>
                <a:schemeClr val="accent2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F-BE39-40B1-B014-8342183708AA}"/>
              </c:ext>
            </c:extLst>
          </c:dPt>
          <c:dPt>
            <c:idx val="32"/>
            <c:bubble3D val="0"/>
            <c:spPr>
              <a:solidFill>
                <a:schemeClr val="accent3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1-BE39-40B1-B014-8342183708AA}"/>
              </c:ext>
            </c:extLst>
          </c:dPt>
          <c:dPt>
            <c:idx val="33"/>
            <c:bubble3D val="0"/>
            <c:spPr>
              <a:solidFill>
                <a:schemeClr val="accent4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3-BE39-40B1-B014-8342183708AA}"/>
              </c:ext>
            </c:extLst>
          </c:dPt>
          <c:dPt>
            <c:idx val="34"/>
            <c:bubble3D val="0"/>
            <c:spPr>
              <a:solidFill>
                <a:schemeClr val="accent5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5-BE39-40B1-B014-8342183708AA}"/>
              </c:ext>
            </c:extLst>
          </c:dPt>
          <c:dPt>
            <c:idx val="35"/>
            <c:bubble3D val="0"/>
            <c:spPr>
              <a:solidFill>
                <a:schemeClr val="accent6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7-BE39-40B1-B014-8342183708AA}"/>
              </c:ext>
            </c:extLst>
          </c:dPt>
          <c:dPt>
            <c:idx val="36"/>
            <c:bubble3D val="0"/>
            <c:spPr>
              <a:solidFill>
                <a:schemeClr val="accent1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9-BE39-40B1-B014-8342183708AA}"/>
              </c:ext>
            </c:extLst>
          </c:dPt>
          <c:dPt>
            <c:idx val="37"/>
            <c:bubble3D val="0"/>
            <c:spPr>
              <a:solidFill>
                <a:schemeClr val="accent2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B-BE39-40B1-B014-8342183708AA}"/>
              </c:ext>
            </c:extLst>
          </c:dPt>
          <c:dPt>
            <c:idx val="38"/>
            <c:bubble3D val="0"/>
            <c:spPr>
              <a:solidFill>
                <a:schemeClr val="accent3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D-BE39-40B1-B014-8342183708AA}"/>
              </c:ext>
            </c:extLst>
          </c:dPt>
          <c:dPt>
            <c:idx val="39"/>
            <c:bubble3D val="0"/>
            <c:spPr>
              <a:solidFill>
                <a:schemeClr val="accent4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F-BE39-40B1-B014-8342183708AA}"/>
              </c:ext>
            </c:extLst>
          </c:dPt>
          <c:dPt>
            <c:idx val="40"/>
            <c:bubble3D val="0"/>
            <c:spPr>
              <a:solidFill>
                <a:schemeClr val="accent5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1-BE39-40B1-B014-8342183708AA}"/>
              </c:ext>
            </c:extLst>
          </c:dPt>
          <c:dPt>
            <c:idx val="41"/>
            <c:bubble3D val="0"/>
            <c:spPr>
              <a:solidFill>
                <a:schemeClr val="accent6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3-BE39-40B1-B014-8342183708AA}"/>
              </c:ext>
            </c:extLst>
          </c:dPt>
          <c:dPt>
            <c:idx val="42"/>
            <c:bubble3D val="0"/>
            <c:spPr>
              <a:solidFill>
                <a:schemeClr val="accent1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5-BE39-40B1-B014-8342183708AA}"/>
              </c:ext>
            </c:extLst>
          </c:dPt>
          <c:dPt>
            <c:idx val="43"/>
            <c:bubble3D val="0"/>
            <c:spPr>
              <a:solidFill>
                <a:schemeClr val="accent2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7-BE39-40B1-B014-8342183708AA}"/>
              </c:ext>
            </c:extLst>
          </c:dPt>
          <c:dPt>
            <c:idx val="44"/>
            <c:bubble3D val="0"/>
            <c:spPr>
              <a:solidFill>
                <a:schemeClr val="accent3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9-BE39-40B1-B014-8342183708AA}"/>
              </c:ext>
            </c:extLst>
          </c:dPt>
          <c:dPt>
            <c:idx val="45"/>
            <c:bubble3D val="0"/>
            <c:spPr>
              <a:solidFill>
                <a:schemeClr val="accent4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B-BE39-40B1-B014-8342183708AA}"/>
              </c:ext>
            </c:extLst>
          </c:dPt>
          <c:dPt>
            <c:idx val="46"/>
            <c:bubble3D val="0"/>
            <c:spPr>
              <a:solidFill>
                <a:schemeClr val="accent5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D-BE39-40B1-B014-8342183708AA}"/>
              </c:ext>
            </c:extLst>
          </c:dPt>
          <c:dPt>
            <c:idx val="47"/>
            <c:bubble3D val="0"/>
            <c:spPr>
              <a:solidFill>
                <a:schemeClr val="accent6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5F-BE39-40B1-B014-8342183708AA}"/>
              </c:ext>
            </c:extLst>
          </c:dPt>
          <c:dPt>
            <c:idx val="48"/>
            <c:bubble3D val="0"/>
            <c:spPr>
              <a:solidFill>
                <a:schemeClr val="accent1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1-BE39-40B1-B014-8342183708AA}"/>
              </c:ext>
            </c:extLst>
          </c:dPt>
          <c:dPt>
            <c:idx val="49"/>
            <c:bubble3D val="0"/>
            <c:spPr>
              <a:solidFill>
                <a:schemeClr val="accent2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3-BE39-40B1-B014-8342183708AA}"/>
              </c:ext>
            </c:extLst>
          </c:dPt>
          <c:dPt>
            <c:idx val="50"/>
            <c:bubble3D val="0"/>
            <c:spPr>
              <a:solidFill>
                <a:schemeClr val="accent3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5-BE39-40B1-B014-8342183708AA}"/>
              </c:ext>
            </c:extLst>
          </c:dPt>
          <c:dPt>
            <c:idx val="51"/>
            <c:bubble3D val="0"/>
            <c:spPr>
              <a:solidFill>
                <a:schemeClr val="accent4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7-BE39-40B1-B014-8342183708AA}"/>
              </c:ext>
            </c:extLst>
          </c:dPt>
          <c:dPt>
            <c:idx val="52"/>
            <c:bubble3D val="0"/>
            <c:spPr>
              <a:solidFill>
                <a:schemeClr val="accent5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9-BE39-40B1-B014-8342183708AA}"/>
              </c:ext>
            </c:extLst>
          </c:dPt>
          <c:dPt>
            <c:idx val="53"/>
            <c:bubble3D val="0"/>
            <c:spPr>
              <a:solidFill>
                <a:schemeClr val="accent6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B-BE39-40B1-B014-8342183708AA}"/>
              </c:ext>
            </c:extLst>
          </c:dPt>
          <c:dPt>
            <c:idx val="54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D-BE39-40B1-B014-8342183708AA}"/>
              </c:ext>
            </c:extLst>
          </c:dPt>
          <c:dPt>
            <c:idx val="55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6F-BE39-40B1-B014-8342183708AA}"/>
              </c:ext>
            </c:extLst>
          </c:dPt>
          <c:dPt>
            <c:idx val="56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1-BE39-40B1-B014-8342183708AA}"/>
              </c:ext>
            </c:extLst>
          </c:dPt>
          <c:dPt>
            <c:idx val="57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3-BE39-40B1-B014-8342183708AA}"/>
              </c:ext>
            </c:extLst>
          </c:dPt>
          <c:dPt>
            <c:idx val="58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5-BE39-40B1-B014-8342183708AA}"/>
              </c:ext>
            </c:extLst>
          </c:dPt>
          <c:dPt>
            <c:idx val="59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7-BE39-40B1-B014-8342183708AA}"/>
              </c:ext>
            </c:extLst>
          </c:dPt>
          <c:dPt>
            <c:idx val="60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9-BE39-40B1-B014-8342183708AA}"/>
              </c:ext>
            </c:extLst>
          </c:dPt>
          <c:dPt>
            <c:idx val="61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B-BE39-40B1-B014-8342183708AA}"/>
              </c:ext>
            </c:extLst>
          </c:dPt>
          <c:dPt>
            <c:idx val="62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D-BE39-40B1-B014-8342183708AA}"/>
              </c:ext>
            </c:extLst>
          </c:dPt>
          <c:dPt>
            <c:idx val="63"/>
            <c:bubble3D val="0"/>
            <c:spPr>
              <a:solidFill>
                <a:schemeClr val="accent4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7F-BE39-40B1-B014-8342183708AA}"/>
              </c:ext>
            </c:extLst>
          </c:dPt>
          <c:dPt>
            <c:idx val="64"/>
            <c:bubble3D val="0"/>
            <c:spPr>
              <a:solidFill>
                <a:schemeClr val="accent5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1-BE39-40B1-B014-8342183708AA}"/>
              </c:ext>
            </c:extLst>
          </c:dPt>
          <c:dPt>
            <c:idx val="65"/>
            <c:bubble3D val="0"/>
            <c:spPr>
              <a:solidFill>
                <a:schemeClr val="accent6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3-BE39-40B1-B014-8342183708AA}"/>
              </c:ext>
            </c:extLst>
          </c:dPt>
          <c:dPt>
            <c:idx val="66"/>
            <c:bubble3D val="0"/>
            <c:spPr>
              <a:solidFill>
                <a:schemeClr val="accent1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5-BE39-40B1-B014-8342183708AA}"/>
              </c:ext>
            </c:extLst>
          </c:dPt>
          <c:dPt>
            <c:idx val="67"/>
            <c:bubble3D val="0"/>
            <c:spPr>
              <a:solidFill>
                <a:schemeClr val="accent2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7-BE39-40B1-B014-8342183708AA}"/>
              </c:ext>
            </c:extLst>
          </c:dPt>
          <c:dPt>
            <c:idx val="68"/>
            <c:bubble3D val="0"/>
            <c:spPr>
              <a:solidFill>
                <a:schemeClr val="accent3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9-BE39-40B1-B014-8342183708AA}"/>
              </c:ext>
            </c:extLst>
          </c:dPt>
          <c:dPt>
            <c:idx val="69"/>
            <c:bubble3D val="0"/>
            <c:spPr>
              <a:solidFill>
                <a:schemeClr val="accent4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B-BE39-40B1-B014-8342183708AA}"/>
              </c:ext>
            </c:extLst>
          </c:dPt>
          <c:dPt>
            <c:idx val="70"/>
            <c:bubble3D val="0"/>
            <c:spPr>
              <a:solidFill>
                <a:schemeClr val="accent5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D-BE39-40B1-B014-8342183708AA}"/>
              </c:ext>
            </c:extLst>
          </c:dPt>
          <c:dPt>
            <c:idx val="71"/>
            <c:bubble3D val="0"/>
            <c:spPr>
              <a:solidFill>
                <a:schemeClr val="accent6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8F-BE39-40B1-B014-8342183708AA}"/>
              </c:ext>
            </c:extLst>
          </c:dPt>
          <c:dPt>
            <c:idx val="72"/>
            <c:bubble3D val="0"/>
            <c:spPr>
              <a:solidFill>
                <a:schemeClr val="accent1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91-BE39-40B1-B014-8342183708AA}"/>
              </c:ext>
            </c:extLst>
          </c:dPt>
          <c:dPt>
            <c:idx val="73"/>
            <c:bubble3D val="0"/>
            <c:spPr>
              <a:solidFill>
                <a:schemeClr val="accent2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93-BE39-40B1-B014-8342183708AA}"/>
              </c:ext>
            </c:extLst>
          </c:dPt>
          <c:dPt>
            <c:idx val="74"/>
            <c:bubble3D val="0"/>
            <c:spPr>
              <a:solidFill>
                <a:schemeClr val="accent3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95-BE39-40B1-B014-8342183708AA}"/>
              </c:ext>
            </c:extLst>
          </c:dPt>
          <c:dPt>
            <c:idx val="75"/>
            <c:bubble3D val="0"/>
            <c:spPr>
              <a:solidFill>
                <a:schemeClr val="accent4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97-BE39-40B1-B014-8342183708AA}"/>
              </c:ext>
            </c:extLst>
          </c:dPt>
          <c:dPt>
            <c:idx val="76"/>
            <c:bubble3D val="0"/>
            <c:spPr>
              <a:solidFill>
                <a:schemeClr val="accent5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99-BE39-40B1-B014-8342183708AA}"/>
              </c:ext>
            </c:extLst>
          </c:dPt>
          <c:dPt>
            <c:idx val="77"/>
            <c:bubble3D val="0"/>
            <c:spPr>
              <a:solidFill>
                <a:schemeClr val="accent6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9B-BE39-40B1-B014-8342183708AA}"/>
              </c:ext>
            </c:extLst>
          </c:dPt>
          <c:dPt>
            <c:idx val="78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9D-BE39-40B1-B014-8342183708AA}"/>
              </c:ext>
            </c:extLst>
          </c:dPt>
          <c:dPt>
            <c:idx val="79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9F-BE39-40B1-B014-8342183708AA}"/>
              </c:ext>
            </c:extLst>
          </c:dPt>
          <c:dPt>
            <c:idx val="80"/>
            <c:bubble3D val="0"/>
            <c:spPr>
              <a:solidFill>
                <a:schemeClr val="accent3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A1-BE39-40B1-B014-8342183708AA}"/>
              </c:ext>
            </c:extLst>
          </c:dPt>
          <c:dPt>
            <c:idx val="81"/>
            <c:bubble3D val="0"/>
            <c:spPr>
              <a:solidFill>
                <a:schemeClr val="accent4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A3-BE39-40B1-B014-8342183708AA}"/>
              </c:ext>
            </c:extLst>
          </c:dPt>
          <c:dPt>
            <c:idx val="82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A5-BE39-40B1-B014-8342183708AA}"/>
              </c:ext>
            </c:extLst>
          </c:dPt>
          <c:dPt>
            <c:idx val="83"/>
            <c:bubble3D val="0"/>
            <c:spPr>
              <a:solidFill>
                <a:schemeClr val="accent6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A7-BE39-40B1-B014-8342183708AA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pPr>
                <a:endParaRPr lang="en-US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COX2_CONSENSUS_PHYLOGENY_HISTG_!$A$2:$A$85</c:f>
              <c:strCache>
                <c:ptCount val="84"/>
                <c:pt idx="0">
                  <c:v> ***  # COX2_CLUSTALO_TCSFMw_RYt_UB #  *** </c:v>
                </c:pt>
                <c:pt idx="1">
                  <c:v> ***  # COX2_CLUSTALO_TCSw_DNA_UB #  *** </c:v>
                </c:pt>
                <c:pt idx="2">
                  <c:v> ***  # COX2_CLUSTALO_TCSw_RYt_UB #  *** </c:v>
                </c:pt>
                <c:pt idx="3">
                  <c:v> ***  # COX2_CLUSTALW_TCSFMw_RYt_UB #  *** </c:v>
                </c:pt>
                <c:pt idx="4">
                  <c:v> ***  # COX2_CLUSTALW_TCSw_RYt_UB #  *** </c:v>
                </c:pt>
                <c:pt idx="5">
                  <c:v> ***  # COX2_MAFFTA_TCSFMw_DNA_UB #  *** </c:v>
                </c:pt>
                <c:pt idx="6">
                  <c:v> ***  # COX2_MAFFTEI_TCSFMw_DEG_UB #  *** </c:v>
                </c:pt>
                <c:pt idx="7">
                  <c:v> ***  # COX2_MAFFTF1_TCSFMw_DEG_UB #  *** </c:v>
                </c:pt>
                <c:pt idx="8">
                  <c:v> ***  # COX2_MAFFTF1_TCSw_DEG_UB #  *** </c:v>
                </c:pt>
                <c:pt idx="9">
                  <c:v> ***  # COX2_MAFFTF2_TCSFMw_DNA_UB #  *** </c:v>
                </c:pt>
                <c:pt idx="10">
                  <c:v> ***  # COX2_MAFFTFI_TRIMALP_DEG_UB #  *** </c:v>
                </c:pt>
                <c:pt idx="11">
                  <c:v> ***  # COX2_MAFFT_TCSw_DNA_UB #  *** </c:v>
                </c:pt>
                <c:pt idx="12">
                  <c:v> ***  # COX2_PRANKCDF_GBLOCKSC_DNA_UB #  *** </c:v>
                </c:pt>
                <c:pt idx="13">
                  <c:v> ***  # COX2_PRANKCDO_GBLOCKSC_DNA_UB #  *** </c:v>
                </c:pt>
                <c:pt idx="14">
                  <c:v> *** COX2_ALL_TRIMALC_DNA_UB *** </c:v>
                </c:pt>
                <c:pt idx="15">
                  <c:v> *** COX2_ALL_WEAVEALIGN_DNA_UB *** </c:v>
                </c:pt>
                <c:pt idx="16">
                  <c:v> ***  # COX2_PRANKCDO_TRIMALA_DNA_UB #  *** </c:v>
                </c:pt>
                <c:pt idx="17">
                  <c:v> ***  # COX2_PRANKCDO_TRIMALG_DNA_UB #  *** </c:v>
                </c:pt>
                <c:pt idx="18">
                  <c:v> ***  # COX2_PROBCONS_PSARALIGN_DNA_UB #  *** </c:v>
                </c:pt>
                <c:pt idx="19">
                  <c:v> ***  # COX2_PROBCONS_TCSf_DNA_UB #  *** </c:v>
                </c:pt>
                <c:pt idx="20">
                  <c:v> ***  # COX2_TCOFFEEPL_MAXALIGN_DNA_UB #  *** </c:v>
                </c:pt>
                <c:pt idx="21">
                  <c:v> ***  # COX2_TCOFFEEPL_TCSFMf_DNA_UB #  *** </c:v>
                </c:pt>
                <c:pt idx="22">
                  <c:v> ***  # COX2_PRANKCDO_GBLOCKSC_2AA_UB #  *** </c:v>
                </c:pt>
                <c:pt idx="23">
                  <c:v> ***  # COX2_PRANKCDO_GBLOCKS_2AA_UB #  *** </c:v>
                </c:pt>
                <c:pt idx="24">
                  <c:v> ***  # COX2_PRANKCDO_TRIMALA_2AA_UB #  *** </c:v>
                </c:pt>
                <c:pt idx="25">
                  <c:v> ***  # COX2_TCOFFEEPL_TRIMAL_DNA_UB #  *** </c:v>
                </c:pt>
                <c:pt idx="26">
                  <c:v> ***  # COX2_PRANKCDO_TRIMALG_2AA_UB #  *** </c:v>
                </c:pt>
                <c:pt idx="27">
                  <c:v> ***  # COX2_PRANKCD_TRIMALA_CDN_UB #  *** </c:v>
                </c:pt>
                <c:pt idx="28">
                  <c:v> ***  # COX2_PRANKCD_TRIMALG_CDN_UB #  *** </c:v>
                </c:pt>
                <c:pt idx="29">
                  <c:v> ***  # COX2_PROBCONS_TCSf_CDN_UB #  *** </c:v>
                </c:pt>
                <c:pt idx="30">
                  <c:v> ***  # COX2_PROBCONS_TRIMAL_CDN_UB #  *** </c:v>
                </c:pt>
                <c:pt idx="31">
                  <c:v> ***  # COX2_TCOFFEEPL_MAXALIGN_CDN_UB #  *** </c:v>
                </c:pt>
                <c:pt idx="32">
                  <c:v> ***  # COX2_TCOFFEEPL_PSARALIGN_CDN_UB #  *** </c:v>
                </c:pt>
                <c:pt idx="33">
                  <c:v> ***  # COX2_TCOFFEEPL_PSARALIGN_2AA_UB #  *** </c:v>
                </c:pt>
                <c:pt idx="34">
                  <c:v> ***  # COX2_TCOFFEEPL_TCSFMf_2AA_UB #  *** </c:v>
                </c:pt>
                <c:pt idx="35">
                  <c:v> ***  # COX2_TCOFFEETC_MAXALIGN_2AA_UB #  *** </c:v>
                </c:pt>
                <c:pt idx="36">
                  <c:v> ***  # COX2_TCOFFEETC_PSARALIGN_2AA_UB #  *** </c:v>
                </c:pt>
                <c:pt idx="37">
                  <c:v> ***  # COX2_TCOFFEETC_TCSFMf_2AA_UB #  *** </c:v>
                </c:pt>
                <c:pt idx="38">
                  <c:v> ***  # COX2_TCOFFEETC_TRIMAL_2AA_UB #  *** </c:v>
                </c:pt>
                <c:pt idx="39">
                  <c:v> ***  # COX2_TCOFFEE_MAXALIGN_2AA_UB #  *** </c:v>
                </c:pt>
                <c:pt idx="40">
                  <c:v> ***  # COX2_TCOFFEE_TCSFMf_CDN_UB #  *** </c:v>
                </c:pt>
                <c:pt idx="41">
                  <c:v> ***  # COX2_TCOFFEE_TCSf_2AA_UB #  *** </c:v>
                </c:pt>
                <c:pt idx="42">
                  <c:v> ***  # COX2_TCOFFEE_TRIMAL_2AA_UB #  *** </c:v>
                </c:pt>
                <c:pt idx="43">
                  <c:v> ***  # COX2_CLUSTALW_TRIMALS_RYt_UB #  *** </c:v>
                </c:pt>
                <c:pt idx="44">
                  <c:v> ***  # COX2_GRAMALIGN_TRIMALP_DNA_UB #  *** </c:v>
                </c:pt>
                <c:pt idx="45">
                  <c:v> ***  # COX2_MAFFTGI_TRIMALS_DEG_UB #  *** </c:v>
                </c:pt>
                <c:pt idx="46">
                  <c:v> ***  # COX2_MAFFTGI_TRIMALS_DNA_UB #  *** </c:v>
                </c:pt>
                <c:pt idx="47">
                  <c:v> ***  # COX2_CLUSTALW_GBLOCKS_DEG_UB #  *** </c:v>
                </c:pt>
                <c:pt idx="48">
                  <c:v> *** COX2_ALL_MERGEALIGN_DEG_UB *** </c:v>
                </c:pt>
                <c:pt idx="49">
                  <c:v> *** COX2_ALL_TRIMALC_DEG_UB *** </c:v>
                </c:pt>
                <c:pt idx="50">
                  <c:v> *** COX2_ALL_WEAVEALIGN_DEG_UB *** </c:v>
                </c:pt>
                <c:pt idx="51">
                  <c:v> ***  # COX2_MAFFTEI_GBLOCKS_DNA_UB #  *** </c:v>
                </c:pt>
                <c:pt idx="52">
                  <c:v> ***  # COX2_FSA_GBLOCKSC_DEG_UB #  *** </c:v>
                </c:pt>
                <c:pt idx="53">
                  <c:v> ***  # COX2_KALIGN_TCSFMf_DEG_UB #  *** </c:v>
                </c:pt>
                <c:pt idx="54">
                  <c:v> ***  # COX2_KALIGN_TRIMAL_DEG_UB #  *** </c:v>
                </c:pt>
                <c:pt idx="55">
                  <c:v> ***  # COX2_MUSCLE_TRIMALA_DEG_UB #  *** </c:v>
                </c:pt>
                <c:pt idx="56">
                  <c:v> ***  # COX2_PROBCONS_MAXALIGN_DEG_UB #  *** </c:v>
                </c:pt>
                <c:pt idx="57">
                  <c:v> ***  # COX2_PROBCONS_PSARALIGN_DEG_UB #  *** </c:v>
                </c:pt>
                <c:pt idx="58">
                  <c:v> *** COX2_ALL_TRIMALC_2AA_UB *** </c:v>
                </c:pt>
                <c:pt idx="59">
                  <c:v> *** COX2_ALL_TRIMALC_CDN_UB *** </c:v>
                </c:pt>
                <c:pt idx="60">
                  <c:v> *** COX2_ALL_WEAVEALIGN_2AA_UB *** </c:v>
                </c:pt>
                <c:pt idx="61">
                  <c:v> *** COX2_ALL_WEAVEALIGN_CDN_UB *** </c:v>
                </c:pt>
                <c:pt idx="62">
                  <c:v> ***  # COX2_PROBCONS_TCSf_DEG_UB #  *** </c:v>
                </c:pt>
                <c:pt idx="63">
                  <c:v> ***  # COX2_PROBCONS_TRIMAL_DEG_UB #  *** </c:v>
                </c:pt>
                <c:pt idx="64">
                  <c:v> ***  # COX2_TCOFFEEPL_MAXALIGN_RYt_UB #  *** </c:v>
                </c:pt>
                <c:pt idx="65">
                  <c:v> ***  # COX2_PRANKCD_GBLOCKSC_RYt_UB #  *** </c:v>
                </c:pt>
                <c:pt idx="66">
                  <c:v> ***  # COX2_TCOFFEEPL_TCSf_RYt_UB #  *** </c:v>
                </c:pt>
                <c:pt idx="67">
                  <c:v> ***  # COX2_TCOFFEEPL_TRIMAL_RYt_UB #  *** </c:v>
                </c:pt>
                <c:pt idx="68">
                  <c:v> ***  # COX2_TCOFFEETC_TCSFMf_RYt_UB #  *** </c:v>
                </c:pt>
                <c:pt idx="69">
                  <c:v> ***  # COX2_KALIGN_TCSOGw_DEG_UB #  *** </c:v>
                </c:pt>
                <c:pt idx="70">
                  <c:v> ***  # COX2_TCOFFEE_PSARALIGN_RYt_UB #  *** </c:v>
                </c:pt>
                <c:pt idx="71">
                  <c:v> ***  # COX2_PRANKCDF_GBLOCKSC_CDN_UB #  *** </c:v>
                </c:pt>
                <c:pt idx="72">
                  <c:v> ***  # COX2_PRANKCDF_GBLOCKS_CDN_UB #  *** </c:v>
                </c:pt>
                <c:pt idx="73">
                  <c:v> ***  # COX2_TCOFFEEPL_TCSOGw_RYt_UB #  *** </c:v>
                </c:pt>
                <c:pt idx="74">
                  <c:v> ***  # COX2_MAFFTA_NOISY_DEG_UB #  *** </c:v>
                </c:pt>
                <c:pt idx="75">
                  <c:v> ***  # COX2_MAFFTF1_NOISY_DNA_UB #  *** </c:v>
                </c:pt>
                <c:pt idx="76">
                  <c:v> *** COX2_ALL_TRIMALC_RYt_UB *** </c:v>
                </c:pt>
                <c:pt idx="77">
                  <c:v> *** COX2_ALL_WEAVEALIGN_RYt_UB *** </c:v>
                </c:pt>
                <c:pt idx="78">
                  <c:v> ***  # COX2_CLUSTALO_NOISY_RYt_UB #  *** </c:v>
                </c:pt>
                <c:pt idx="79">
                  <c:v> ***  # COX2_CLUSTALW_NOISY_RYt_UB #  *** </c:v>
                </c:pt>
                <c:pt idx="80">
                  <c:v> ***  # COX2_PRANKCD_TRIMALG_DEG_UB #  *** </c:v>
                </c:pt>
                <c:pt idx="81">
                  <c:v> ***  # COX2_TCOFFEE_TCSOGw_DNA_UB #  *** </c:v>
                </c:pt>
                <c:pt idx="82">
                  <c:v> ***  # COX2_PRANKCD_TRIMALA_RYt_UB #  *** </c:v>
                </c:pt>
                <c:pt idx="83">
                  <c:v> ***  # COX2_PRANKCDO_TRIMALG_RYt_UB #  *** </c:v>
                </c:pt>
              </c:strCache>
            </c:strRef>
          </c:cat>
          <c:val>
            <c:numRef>
              <c:f>COX2_CONSENSUS_PHYLOGENY_HISTG_!$B$2:$B$85</c:f>
              <c:numCache>
                <c:formatCode>General</c:formatCode>
                <c:ptCount val="84"/>
                <c:pt idx="0">
                  <c:v>476</c:v>
                </c:pt>
                <c:pt idx="1">
                  <c:v>476</c:v>
                </c:pt>
                <c:pt idx="2">
                  <c:v>476</c:v>
                </c:pt>
                <c:pt idx="3">
                  <c:v>476</c:v>
                </c:pt>
                <c:pt idx="4">
                  <c:v>476</c:v>
                </c:pt>
                <c:pt idx="5">
                  <c:v>476</c:v>
                </c:pt>
                <c:pt idx="6">
                  <c:v>476</c:v>
                </c:pt>
                <c:pt idx="7">
                  <c:v>476</c:v>
                </c:pt>
                <c:pt idx="8">
                  <c:v>476</c:v>
                </c:pt>
                <c:pt idx="9">
                  <c:v>476</c:v>
                </c:pt>
                <c:pt idx="10">
                  <c:v>476</c:v>
                </c:pt>
                <c:pt idx="11">
                  <c:v>476</c:v>
                </c:pt>
                <c:pt idx="12">
                  <c:v>476</c:v>
                </c:pt>
                <c:pt idx="13">
                  <c:v>476</c:v>
                </c:pt>
                <c:pt idx="14">
                  <c:v>470</c:v>
                </c:pt>
                <c:pt idx="15">
                  <c:v>470</c:v>
                </c:pt>
                <c:pt idx="16">
                  <c:v>469</c:v>
                </c:pt>
                <c:pt idx="17">
                  <c:v>468</c:v>
                </c:pt>
                <c:pt idx="18">
                  <c:v>398</c:v>
                </c:pt>
                <c:pt idx="19">
                  <c:v>393</c:v>
                </c:pt>
                <c:pt idx="20">
                  <c:v>382</c:v>
                </c:pt>
                <c:pt idx="21">
                  <c:v>380</c:v>
                </c:pt>
                <c:pt idx="22">
                  <c:v>372</c:v>
                </c:pt>
                <c:pt idx="23">
                  <c:v>372</c:v>
                </c:pt>
                <c:pt idx="24">
                  <c:v>368</c:v>
                </c:pt>
                <c:pt idx="25">
                  <c:v>368</c:v>
                </c:pt>
                <c:pt idx="26">
                  <c:v>366</c:v>
                </c:pt>
                <c:pt idx="27">
                  <c:v>353</c:v>
                </c:pt>
                <c:pt idx="28">
                  <c:v>351</c:v>
                </c:pt>
                <c:pt idx="29">
                  <c:v>340</c:v>
                </c:pt>
                <c:pt idx="30">
                  <c:v>334</c:v>
                </c:pt>
                <c:pt idx="31">
                  <c:v>331</c:v>
                </c:pt>
                <c:pt idx="32">
                  <c:v>329</c:v>
                </c:pt>
                <c:pt idx="33">
                  <c:v>328</c:v>
                </c:pt>
                <c:pt idx="34">
                  <c:v>326</c:v>
                </c:pt>
                <c:pt idx="35">
                  <c:v>319</c:v>
                </c:pt>
                <c:pt idx="36">
                  <c:v>317</c:v>
                </c:pt>
                <c:pt idx="37">
                  <c:v>315</c:v>
                </c:pt>
                <c:pt idx="38">
                  <c:v>311</c:v>
                </c:pt>
                <c:pt idx="39">
                  <c:v>308</c:v>
                </c:pt>
                <c:pt idx="40">
                  <c:v>305</c:v>
                </c:pt>
                <c:pt idx="41">
                  <c:v>302</c:v>
                </c:pt>
                <c:pt idx="42">
                  <c:v>300</c:v>
                </c:pt>
                <c:pt idx="43">
                  <c:v>128</c:v>
                </c:pt>
                <c:pt idx="44">
                  <c:v>128</c:v>
                </c:pt>
                <c:pt idx="45">
                  <c:v>128</c:v>
                </c:pt>
                <c:pt idx="46">
                  <c:v>128</c:v>
                </c:pt>
                <c:pt idx="47">
                  <c:v>119</c:v>
                </c:pt>
                <c:pt idx="48">
                  <c:v>108</c:v>
                </c:pt>
                <c:pt idx="49">
                  <c:v>108</c:v>
                </c:pt>
                <c:pt idx="50">
                  <c:v>108</c:v>
                </c:pt>
                <c:pt idx="51">
                  <c:v>99</c:v>
                </c:pt>
                <c:pt idx="52">
                  <c:v>97</c:v>
                </c:pt>
                <c:pt idx="53">
                  <c:v>97</c:v>
                </c:pt>
                <c:pt idx="54">
                  <c:v>97</c:v>
                </c:pt>
                <c:pt idx="55">
                  <c:v>97</c:v>
                </c:pt>
                <c:pt idx="56">
                  <c:v>81</c:v>
                </c:pt>
                <c:pt idx="57">
                  <c:v>80</c:v>
                </c:pt>
                <c:pt idx="58">
                  <c:v>80</c:v>
                </c:pt>
                <c:pt idx="59">
                  <c:v>80</c:v>
                </c:pt>
                <c:pt idx="60">
                  <c:v>80</c:v>
                </c:pt>
                <c:pt idx="61">
                  <c:v>80</c:v>
                </c:pt>
                <c:pt idx="62">
                  <c:v>78</c:v>
                </c:pt>
                <c:pt idx="63">
                  <c:v>75</c:v>
                </c:pt>
                <c:pt idx="64">
                  <c:v>74</c:v>
                </c:pt>
                <c:pt idx="65">
                  <c:v>72</c:v>
                </c:pt>
                <c:pt idx="66">
                  <c:v>71</c:v>
                </c:pt>
                <c:pt idx="67">
                  <c:v>68</c:v>
                </c:pt>
                <c:pt idx="68">
                  <c:v>66</c:v>
                </c:pt>
                <c:pt idx="69">
                  <c:v>57</c:v>
                </c:pt>
                <c:pt idx="70">
                  <c:v>57</c:v>
                </c:pt>
                <c:pt idx="71">
                  <c:v>48</c:v>
                </c:pt>
                <c:pt idx="72">
                  <c:v>48</c:v>
                </c:pt>
                <c:pt idx="73">
                  <c:v>48</c:v>
                </c:pt>
                <c:pt idx="74">
                  <c:v>45</c:v>
                </c:pt>
                <c:pt idx="75">
                  <c:v>45</c:v>
                </c:pt>
                <c:pt idx="76">
                  <c:v>19</c:v>
                </c:pt>
                <c:pt idx="77">
                  <c:v>19</c:v>
                </c:pt>
                <c:pt idx="78">
                  <c:v>17</c:v>
                </c:pt>
                <c:pt idx="79">
                  <c:v>17</c:v>
                </c:pt>
                <c:pt idx="80">
                  <c:v>16</c:v>
                </c:pt>
                <c:pt idx="81">
                  <c:v>16</c:v>
                </c:pt>
                <c:pt idx="82">
                  <c:v>6</c:v>
                </c:pt>
                <c:pt idx="83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A8-BE39-40B1-B014-8342183708AA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416074417638435"/>
          <c:y val="5.5815666342812119E-2"/>
          <c:w val="0.75363039665703901"/>
          <c:h val="0.9118511429165278"/>
        </c:manualLayout>
      </c:layout>
      <c:pieChart>
        <c:varyColors val="1"/>
        <c:ser>
          <c:idx val="0"/>
          <c:order val="0"/>
          <c:tx>
            <c:strRef>
              <c:f>COX2_CONSENSUS_PHYLOGENY_HISTG_!$B$1</c:f>
              <c:strCache>
                <c:ptCount val="1"/>
                <c:pt idx="0">
                  <c:v>Total Topological Support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000-4568-ABA5-A0379DC6CA52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C000-4568-ABA5-A0379DC6CA52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C000-4568-ABA5-A0379DC6CA52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C000-4568-ABA5-A0379DC6CA52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C000-4568-ABA5-A0379DC6CA52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C000-4568-ABA5-A0379DC6CA52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pPr>
                <a:endParaRPr lang="en-US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COX2_CONSENSUS_PHYLOGENY_HISTG_!$A$2:$A$7</c:f>
              <c:strCache>
                <c:ptCount val="6"/>
                <c:pt idx="0">
                  <c:v> ***  # COX2_FSANP_DNA_UB #  *** </c:v>
                </c:pt>
                <c:pt idx="1">
                  <c:v> ***  # COX2_TCOFFEEPL_CDN_UB #  *** </c:v>
                </c:pt>
                <c:pt idx="2">
                  <c:v> ***  # COX2_TCOFFEEPL_2AA_UB #  *** </c:v>
                </c:pt>
                <c:pt idx="3">
                  <c:v> ***  # COX2_TCOFFEE_2AA_UB #  *** </c:v>
                </c:pt>
                <c:pt idx="4">
                  <c:v> ***  # COX2_PROBCONS_DEG_UB #  *** </c:v>
                </c:pt>
                <c:pt idx="5">
                  <c:v> ***  # COX2_TCOFFEE_RYt_UB #  *** </c:v>
                </c:pt>
              </c:strCache>
            </c:strRef>
          </c:cat>
          <c:val>
            <c:numRef>
              <c:f>COX2_CONSENSUS_PHYLOGENY_HISTG_!$B$2:$B$7</c:f>
              <c:numCache>
                <c:formatCode>General</c:formatCode>
                <c:ptCount val="6"/>
                <c:pt idx="0">
                  <c:v>37</c:v>
                </c:pt>
                <c:pt idx="1">
                  <c:v>33</c:v>
                </c:pt>
                <c:pt idx="2">
                  <c:v>32</c:v>
                </c:pt>
                <c:pt idx="3">
                  <c:v>28</c:v>
                </c:pt>
                <c:pt idx="4">
                  <c:v>8</c:v>
                </c:pt>
                <c:pt idx="5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C000-4568-ABA5-A0379DC6CA52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546547977164958"/>
          <c:y val="6.5433421305762199E-2"/>
          <c:w val="0.75488355764890114"/>
          <c:h val="0.91336739848126713"/>
        </c:manualLayout>
      </c:layout>
      <c:pieChart>
        <c:varyColors val="1"/>
        <c:ser>
          <c:idx val="0"/>
          <c:order val="0"/>
          <c:tx>
            <c:strRef>
              <c:f>COX3_CONSENSUS_PHYLOGENY_HISTG_!$B$1</c:f>
              <c:strCache>
                <c:ptCount val="1"/>
                <c:pt idx="0">
                  <c:v>Total Topological Support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4AE4-443B-B31F-3A0F3CD16CB5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4AE4-443B-B31F-3A0F3CD16CB5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4AE4-443B-B31F-3A0F3CD16CB5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4AE4-443B-B31F-3A0F3CD16CB5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4AE4-443B-B31F-3A0F3CD16CB5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pPr>
                <a:endParaRPr lang="en-US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COX3_CONSENSUS_PHYLOGENY_HISTG_!$A$2:$A$6</c:f>
              <c:strCache>
                <c:ptCount val="5"/>
                <c:pt idx="0">
                  <c:v> ***  # COX3_MAFFTF1_DNA_UB #  *** </c:v>
                </c:pt>
                <c:pt idx="1">
                  <c:v> ***  # COX3_GRAMALIGN_DEG_UB #  *** </c:v>
                </c:pt>
                <c:pt idx="2">
                  <c:v> ***  # COX3_MAFFTLI_CDN_UB #  *** </c:v>
                </c:pt>
                <c:pt idx="3">
                  <c:v> ***  # COX3_PROBCONS_2AA_UB #  *** </c:v>
                </c:pt>
                <c:pt idx="4">
                  <c:v> ***  # COX3_PRANKF_RYt_UB #  *** </c:v>
                </c:pt>
              </c:strCache>
            </c:strRef>
          </c:cat>
          <c:val>
            <c:numRef>
              <c:f>COX3_CONSENSUS_PHYLOGENY_HISTG_!$B$2:$B$6</c:f>
              <c:numCache>
                <c:formatCode>General</c:formatCode>
                <c:ptCount val="5"/>
                <c:pt idx="0">
                  <c:v>34</c:v>
                </c:pt>
                <c:pt idx="1">
                  <c:v>26</c:v>
                </c:pt>
                <c:pt idx="2">
                  <c:v>26</c:v>
                </c:pt>
                <c:pt idx="3">
                  <c:v>17</c:v>
                </c:pt>
                <c:pt idx="4">
                  <c:v>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4AE4-443B-B31F-3A0F3CD16CB5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0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2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3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4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5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6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67155C-BC3C-41A8-8CBE-B5C00F7AA269}" type="datetimeFigureOut">
              <a:rPr lang="en-US" smtClean="0"/>
              <a:t>18-Jun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DBAC8-9932-448C-BB7A-0275AB196C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68801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67155C-BC3C-41A8-8CBE-B5C00F7AA269}" type="datetimeFigureOut">
              <a:rPr lang="en-US" smtClean="0"/>
              <a:t>18-Jun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DBAC8-9932-448C-BB7A-0275AB196C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29338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67155C-BC3C-41A8-8CBE-B5C00F7AA269}" type="datetimeFigureOut">
              <a:rPr lang="en-US" smtClean="0"/>
              <a:t>18-Jun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DBAC8-9932-448C-BB7A-0275AB196C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54507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67155C-BC3C-41A8-8CBE-B5C00F7AA269}" type="datetimeFigureOut">
              <a:rPr lang="en-US" smtClean="0"/>
              <a:t>18-Jun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DBAC8-9932-448C-BB7A-0275AB196C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85794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67155C-BC3C-41A8-8CBE-B5C00F7AA269}" type="datetimeFigureOut">
              <a:rPr lang="en-US" smtClean="0"/>
              <a:t>18-Jun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DBAC8-9932-448C-BB7A-0275AB196C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21459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67155C-BC3C-41A8-8CBE-B5C00F7AA269}" type="datetimeFigureOut">
              <a:rPr lang="en-US" smtClean="0"/>
              <a:t>18-Jun-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DBAC8-9932-448C-BB7A-0275AB196C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83746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67155C-BC3C-41A8-8CBE-B5C00F7AA269}" type="datetimeFigureOut">
              <a:rPr lang="en-US" smtClean="0"/>
              <a:t>18-Jun-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DBAC8-9932-448C-BB7A-0275AB196C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7679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67155C-BC3C-41A8-8CBE-B5C00F7AA269}" type="datetimeFigureOut">
              <a:rPr lang="en-US" smtClean="0"/>
              <a:t>18-Jun-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DBAC8-9932-448C-BB7A-0275AB196C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74962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67155C-BC3C-41A8-8CBE-B5C00F7AA269}" type="datetimeFigureOut">
              <a:rPr lang="en-US" smtClean="0"/>
              <a:t>18-Jun-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DBAC8-9932-448C-BB7A-0275AB196C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51862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67155C-BC3C-41A8-8CBE-B5C00F7AA269}" type="datetimeFigureOut">
              <a:rPr lang="en-US" smtClean="0"/>
              <a:t>18-Jun-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DBAC8-9932-448C-BB7A-0275AB196C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53908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67155C-BC3C-41A8-8CBE-B5C00F7AA269}" type="datetimeFigureOut">
              <a:rPr lang="en-US" smtClean="0"/>
              <a:t>18-Jun-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DBAC8-9932-448C-BB7A-0275AB196C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45993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67155C-BC3C-41A8-8CBE-B5C00F7AA269}" type="datetimeFigureOut">
              <a:rPr lang="en-US" smtClean="0"/>
              <a:t>18-Jun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5DBAC8-9932-448C-BB7A-0275AB196C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51569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0.xml"/><Relationship Id="rId2" Type="http://schemas.openxmlformats.org/officeDocument/2006/relationships/chart" Target="../charts/chart19.xml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2.xml"/><Relationship Id="rId2" Type="http://schemas.openxmlformats.org/officeDocument/2006/relationships/chart" Target="../charts/chart21.xml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4.xml"/><Relationship Id="rId2" Type="http://schemas.openxmlformats.org/officeDocument/2006/relationships/chart" Target="../charts/chart23.xml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6.xml"/><Relationship Id="rId2" Type="http://schemas.openxmlformats.org/officeDocument/2006/relationships/chart" Target="../charts/chart25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0.xml"/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2.xml"/><Relationship Id="rId2" Type="http://schemas.openxmlformats.org/officeDocument/2006/relationships/chart" Target="../charts/chart11.xml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4.xml"/><Relationship Id="rId2" Type="http://schemas.openxmlformats.org/officeDocument/2006/relationships/chart" Target="../charts/chart13.xml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6.xml"/><Relationship Id="rId2" Type="http://schemas.openxmlformats.org/officeDocument/2006/relationships/chart" Target="../charts/chart15.xml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8.xml"/><Relationship Id="rId2" Type="http://schemas.openxmlformats.org/officeDocument/2006/relationships/chart" Target="../charts/chart17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763147" y="261771"/>
            <a:ext cx="47937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TP6 Total Topological Support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42875" y="6020930"/>
            <a:ext cx="25314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phaResults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(File 3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8978611" y="6020930"/>
            <a:ext cx="30315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phaResultsARC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(File 4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100012"/>
              </p:ext>
            </p:extLst>
          </p:nvPr>
        </p:nvGraphicFramePr>
        <p:xfrm>
          <a:off x="142875" y="2710802"/>
          <a:ext cx="4005072" cy="33101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3" name="Chart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73897734"/>
              </p:ext>
            </p:extLst>
          </p:nvPr>
        </p:nvGraphicFramePr>
        <p:xfrm>
          <a:off x="5883730" y="720423"/>
          <a:ext cx="6126480" cy="53035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4" name="TextBox 13"/>
          <p:cNvSpPr txBox="1"/>
          <p:nvPr/>
        </p:nvSpPr>
        <p:spPr>
          <a:xfrm>
            <a:off x="10051986" y="589895"/>
            <a:ext cx="6254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2/61</a:t>
            </a:r>
            <a:endParaRPr 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3770560" y="4656551"/>
            <a:ext cx="5084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2/5</a:t>
            </a:r>
            <a:endParaRPr lang="en-US" dirty="0"/>
          </a:p>
        </p:txBody>
      </p:sp>
      <p:sp>
        <p:nvSpPr>
          <p:cNvPr id="16" name="Arc 15"/>
          <p:cNvSpPr/>
          <p:nvPr/>
        </p:nvSpPr>
        <p:spPr>
          <a:xfrm>
            <a:off x="523875" y="2767952"/>
            <a:ext cx="3239271" cy="3223273"/>
          </a:xfrm>
          <a:prstGeom prst="arc">
            <a:avLst>
              <a:gd name="adj1" fmla="val 19470784"/>
              <a:gd name="adj2" fmla="val 4210013"/>
            </a:avLst>
          </a:prstGeom>
          <a:ln w="38100" cap="sq">
            <a:solidFill>
              <a:schemeClr val="tx1"/>
            </a:solidFill>
            <a:bevel/>
            <a:headEnd type="oval"/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Arc 16"/>
          <p:cNvSpPr/>
          <p:nvPr/>
        </p:nvSpPr>
        <p:spPr>
          <a:xfrm>
            <a:off x="6201855" y="777574"/>
            <a:ext cx="5485320" cy="5243356"/>
          </a:xfrm>
          <a:prstGeom prst="arc">
            <a:avLst>
              <a:gd name="adj1" fmla="val 16760630"/>
              <a:gd name="adj2" fmla="val 18105516"/>
            </a:avLst>
          </a:prstGeom>
          <a:ln w="38100" cap="sq">
            <a:solidFill>
              <a:schemeClr val="tx1"/>
            </a:solidFill>
            <a:bevel/>
            <a:headEnd type="oval"/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87477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763147" y="261771"/>
            <a:ext cx="46466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D4 Total Topological Support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42875" y="6020930"/>
            <a:ext cx="25314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phaResults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(File 3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8978611" y="6020930"/>
            <a:ext cx="30315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phaResultsARC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(File 4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56103503"/>
              </p:ext>
            </p:extLst>
          </p:nvPr>
        </p:nvGraphicFramePr>
        <p:xfrm>
          <a:off x="5883730" y="720423"/>
          <a:ext cx="6126480" cy="53035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07016175"/>
              </p:ext>
            </p:extLst>
          </p:nvPr>
        </p:nvGraphicFramePr>
        <p:xfrm>
          <a:off x="142875" y="2710802"/>
          <a:ext cx="4005072" cy="33101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10586102" y="877430"/>
            <a:ext cx="6254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4/53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3378179" y="5344655"/>
            <a:ext cx="5084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/2</a:t>
            </a:r>
            <a:endParaRPr lang="en-US" dirty="0"/>
          </a:p>
        </p:txBody>
      </p:sp>
      <p:sp>
        <p:nvSpPr>
          <p:cNvPr id="14" name="Arc 13"/>
          <p:cNvSpPr/>
          <p:nvPr/>
        </p:nvSpPr>
        <p:spPr>
          <a:xfrm>
            <a:off x="6245747" y="720423"/>
            <a:ext cx="5373450" cy="5300507"/>
          </a:xfrm>
          <a:prstGeom prst="arc">
            <a:avLst>
              <a:gd name="adj1" fmla="val 16780325"/>
              <a:gd name="adj2" fmla="val 19913459"/>
            </a:avLst>
          </a:prstGeom>
          <a:ln w="38100" cap="sq">
            <a:solidFill>
              <a:schemeClr val="tx1"/>
            </a:solidFill>
            <a:bevel/>
            <a:headEnd type="oval"/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Arc 14"/>
          <p:cNvSpPr/>
          <p:nvPr/>
        </p:nvSpPr>
        <p:spPr>
          <a:xfrm>
            <a:off x="533400" y="2777477"/>
            <a:ext cx="3248797" cy="3204223"/>
          </a:xfrm>
          <a:prstGeom prst="arc">
            <a:avLst>
              <a:gd name="adj1" fmla="val 494868"/>
              <a:gd name="adj2" fmla="val 6242108"/>
            </a:avLst>
          </a:prstGeom>
          <a:ln w="38100" cap="sq">
            <a:solidFill>
              <a:schemeClr val="tx1"/>
            </a:solidFill>
            <a:bevel/>
            <a:headEnd type="oval"/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02889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763147" y="261771"/>
            <a:ext cx="48286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D4L Total Topological Support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42875" y="6020930"/>
            <a:ext cx="25314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phaResults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(File 3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8978611" y="6020930"/>
            <a:ext cx="30315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phaResultsARC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(File 4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01957240"/>
              </p:ext>
            </p:extLst>
          </p:nvPr>
        </p:nvGraphicFramePr>
        <p:xfrm>
          <a:off x="142875" y="2740520"/>
          <a:ext cx="4005072" cy="33101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69743643"/>
              </p:ext>
            </p:extLst>
          </p:nvPr>
        </p:nvGraphicFramePr>
        <p:xfrm>
          <a:off x="5883730" y="747128"/>
          <a:ext cx="6126480" cy="53035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10985484" y="1067930"/>
            <a:ext cx="6254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7/55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3226099" y="5535887"/>
            <a:ext cx="5084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</a:t>
            </a:r>
            <a:r>
              <a:rPr lang="en-US" dirty="0" smtClean="0"/>
              <a:t>/5</a:t>
            </a:r>
            <a:endParaRPr lang="en-US" dirty="0"/>
          </a:p>
        </p:txBody>
      </p:sp>
      <p:sp>
        <p:nvSpPr>
          <p:cNvPr id="14" name="Arc 13"/>
          <p:cNvSpPr/>
          <p:nvPr/>
        </p:nvSpPr>
        <p:spPr>
          <a:xfrm>
            <a:off x="6438900" y="800099"/>
            <a:ext cx="5267325" cy="5334001"/>
          </a:xfrm>
          <a:prstGeom prst="arc">
            <a:avLst>
              <a:gd name="adj1" fmla="val 17031175"/>
              <a:gd name="adj2" fmla="val 5835174"/>
            </a:avLst>
          </a:prstGeom>
          <a:ln w="38100" cap="sq">
            <a:solidFill>
              <a:schemeClr val="tx1"/>
            </a:solidFill>
            <a:bevel/>
            <a:headEnd type="oval"/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Arc 14"/>
          <p:cNvSpPr/>
          <p:nvPr/>
        </p:nvSpPr>
        <p:spPr>
          <a:xfrm>
            <a:off x="476250" y="2825102"/>
            <a:ext cx="3258322" cy="3204223"/>
          </a:xfrm>
          <a:prstGeom prst="arc">
            <a:avLst>
              <a:gd name="adj1" fmla="val 2100429"/>
              <a:gd name="adj2" fmla="val 9937318"/>
            </a:avLst>
          </a:prstGeom>
          <a:ln w="38100" cap="sq">
            <a:solidFill>
              <a:schemeClr val="tx1"/>
            </a:solidFill>
            <a:bevel/>
            <a:headEnd type="oval"/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26049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763147" y="261771"/>
            <a:ext cx="46466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D5 Total Topological Support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42875" y="6020930"/>
            <a:ext cx="25314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phaResults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(File 3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8978611" y="6020930"/>
            <a:ext cx="30315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phaResultsARC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(File 4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75876067"/>
              </p:ext>
            </p:extLst>
          </p:nvPr>
        </p:nvGraphicFramePr>
        <p:xfrm>
          <a:off x="5883730" y="720423"/>
          <a:ext cx="6126480" cy="53035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88677118"/>
              </p:ext>
            </p:extLst>
          </p:nvPr>
        </p:nvGraphicFramePr>
        <p:xfrm>
          <a:off x="142875" y="2710802"/>
          <a:ext cx="4005072" cy="33101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11043302" y="972680"/>
            <a:ext cx="7425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7/63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3790949" y="4696955"/>
            <a:ext cx="5084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2/5</a:t>
            </a:r>
            <a:endParaRPr lang="en-US" dirty="0"/>
          </a:p>
        </p:txBody>
      </p:sp>
      <p:sp>
        <p:nvSpPr>
          <p:cNvPr id="14" name="Arc 13"/>
          <p:cNvSpPr/>
          <p:nvPr/>
        </p:nvSpPr>
        <p:spPr>
          <a:xfrm>
            <a:off x="6515101" y="720423"/>
            <a:ext cx="5372100" cy="5319557"/>
          </a:xfrm>
          <a:prstGeom prst="arc">
            <a:avLst>
              <a:gd name="adj1" fmla="val 16646379"/>
              <a:gd name="adj2" fmla="val 8889716"/>
            </a:avLst>
          </a:prstGeom>
          <a:ln w="38100" cap="sq">
            <a:solidFill>
              <a:schemeClr val="tx1"/>
            </a:solidFill>
            <a:bevel/>
            <a:headEnd type="oval"/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Arc 14"/>
          <p:cNvSpPr/>
          <p:nvPr/>
        </p:nvSpPr>
        <p:spPr>
          <a:xfrm>
            <a:off x="447674" y="2729852"/>
            <a:ext cx="3362325" cy="3310128"/>
          </a:xfrm>
          <a:prstGeom prst="arc">
            <a:avLst>
              <a:gd name="adj1" fmla="val 20601029"/>
              <a:gd name="adj2" fmla="val 3705612"/>
            </a:avLst>
          </a:prstGeom>
          <a:ln w="38100" cap="sq">
            <a:solidFill>
              <a:schemeClr val="tx1"/>
            </a:solidFill>
            <a:bevel/>
            <a:headEnd type="oval"/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04561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12871590"/>
              </p:ext>
            </p:extLst>
          </p:nvPr>
        </p:nvGraphicFramePr>
        <p:xfrm>
          <a:off x="142875" y="2638425"/>
          <a:ext cx="4000500" cy="33063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763147" y="261771"/>
            <a:ext cx="46466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D6 Total Topological Support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85107553"/>
              </p:ext>
            </p:extLst>
          </p:nvPr>
        </p:nvGraphicFramePr>
        <p:xfrm>
          <a:off x="5883730" y="720423"/>
          <a:ext cx="6126480" cy="53035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142875" y="6020930"/>
            <a:ext cx="25314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phaResults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(File 3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8978611" y="6020930"/>
            <a:ext cx="30315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phaResultsARC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(File 4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0753976" y="915530"/>
            <a:ext cx="7425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0/72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3922584" y="4120634"/>
            <a:ext cx="5084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/6</a:t>
            </a:r>
            <a:endParaRPr lang="en-US" dirty="0"/>
          </a:p>
        </p:txBody>
      </p:sp>
      <p:sp>
        <p:nvSpPr>
          <p:cNvPr id="12" name="Arc 11"/>
          <p:cNvSpPr/>
          <p:nvPr/>
        </p:nvSpPr>
        <p:spPr>
          <a:xfrm>
            <a:off x="6445771" y="752475"/>
            <a:ext cx="5346179" cy="5353050"/>
          </a:xfrm>
          <a:prstGeom prst="arc">
            <a:avLst>
              <a:gd name="adj1" fmla="val 16745621"/>
              <a:gd name="adj2" fmla="val 3372073"/>
            </a:avLst>
          </a:prstGeom>
          <a:ln w="38100" cap="sq">
            <a:solidFill>
              <a:schemeClr val="tx1"/>
            </a:solidFill>
            <a:bevel/>
            <a:headEnd type="oval"/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Arc 12"/>
          <p:cNvSpPr/>
          <p:nvPr/>
        </p:nvSpPr>
        <p:spPr>
          <a:xfrm>
            <a:off x="476250" y="2638425"/>
            <a:ext cx="3371850" cy="3333751"/>
          </a:xfrm>
          <a:prstGeom prst="arc">
            <a:avLst>
              <a:gd name="adj1" fmla="val 19722835"/>
              <a:gd name="adj2" fmla="val 1993031"/>
            </a:avLst>
          </a:prstGeom>
          <a:ln w="38100" cap="sq">
            <a:solidFill>
              <a:schemeClr val="tx1"/>
            </a:solidFill>
            <a:bevel/>
            <a:headEnd type="oval"/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86281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763147" y="261771"/>
            <a:ext cx="496527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TP8 Total Topological Support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42875" y="6020930"/>
            <a:ext cx="25314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phaResults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(File 3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8978611" y="6020930"/>
            <a:ext cx="30315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phaResultsARC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(File 4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94081768"/>
              </p:ext>
            </p:extLst>
          </p:nvPr>
        </p:nvGraphicFramePr>
        <p:xfrm>
          <a:off x="5883730" y="717410"/>
          <a:ext cx="6126480" cy="53035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09651768"/>
              </p:ext>
            </p:extLst>
          </p:nvPr>
        </p:nvGraphicFramePr>
        <p:xfrm>
          <a:off x="143647" y="2710802"/>
          <a:ext cx="4005072" cy="33101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10405127" y="771525"/>
            <a:ext cx="6254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5</a:t>
            </a:r>
            <a:r>
              <a:rPr lang="en-US" dirty="0" smtClean="0"/>
              <a:t>/64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3811288" y="3706355"/>
            <a:ext cx="5084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</a:t>
            </a:r>
            <a:r>
              <a:rPr lang="en-US" dirty="0" smtClean="0"/>
              <a:t>/5</a:t>
            </a:r>
            <a:endParaRPr lang="en-US" dirty="0"/>
          </a:p>
        </p:txBody>
      </p:sp>
      <p:sp>
        <p:nvSpPr>
          <p:cNvPr id="14" name="Arc 13"/>
          <p:cNvSpPr/>
          <p:nvPr/>
        </p:nvSpPr>
        <p:spPr>
          <a:xfrm>
            <a:off x="6245746" y="771525"/>
            <a:ext cx="5422379" cy="5230355"/>
          </a:xfrm>
          <a:prstGeom prst="arc">
            <a:avLst>
              <a:gd name="adj1" fmla="val 16646379"/>
              <a:gd name="adj2" fmla="val 19439160"/>
            </a:avLst>
          </a:prstGeom>
          <a:ln w="38100" cap="sq">
            <a:solidFill>
              <a:schemeClr val="tx1"/>
            </a:solidFill>
            <a:bevel/>
            <a:headEnd type="oval"/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Arc 14"/>
          <p:cNvSpPr/>
          <p:nvPr/>
        </p:nvSpPr>
        <p:spPr>
          <a:xfrm>
            <a:off x="476250" y="2767952"/>
            <a:ext cx="3258322" cy="3204223"/>
          </a:xfrm>
          <a:prstGeom prst="arc">
            <a:avLst>
              <a:gd name="adj1" fmla="val 19283293"/>
              <a:gd name="adj2" fmla="val 658952"/>
            </a:avLst>
          </a:prstGeom>
          <a:ln w="38100" cap="sq">
            <a:solidFill>
              <a:schemeClr val="tx1"/>
            </a:solidFill>
            <a:bevel/>
            <a:headEnd type="oval"/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81269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763147" y="261771"/>
            <a:ext cx="486787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X1 Total Topological Support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42875" y="6020930"/>
            <a:ext cx="25314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phaResults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(File 3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8978611" y="6020930"/>
            <a:ext cx="30315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phaResultsARC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(File 4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41575240"/>
              </p:ext>
            </p:extLst>
          </p:nvPr>
        </p:nvGraphicFramePr>
        <p:xfrm>
          <a:off x="142875" y="2710802"/>
          <a:ext cx="4005072" cy="33101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04783691"/>
              </p:ext>
            </p:extLst>
          </p:nvPr>
        </p:nvGraphicFramePr>
        <p:xfrm>
          <a:off x="5883730" y="717410"/>
          <a:ext cx="6126480" cy="53035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10711114" y="1039355"/>
            <a:ext cx="7425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27/73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3582400" y="4973180"/>
            <a:ext cx="5084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/4</a:t>
            </a:r>
            <a:endParaRPr lang="en-US" dirty="0"/>
          </a:p>
        </p:txBody>
      </p:sp>
      <p:sp>
        <p:nvSpPr>
          <p:cNvPr id="14" name="Arc 13"/>
          <p:cNvSpPr/>
          <p:nvPr/>
        </p:nvSpPr>
        <p:spPr>
          <a:xfrm>
            <a:off x="6391274" y="771525"/>
            <a:ext cx="5229225" cy="5249405"/>
          </a:xfrm>
          <a:prstGeom prst="arc">
            <a:avLst>
              <a:gd name="adj1" fmla="val 16646379"/>
              <a:gd name="adj2" fmla="val 11522626"/>
            </a:avLst>
          </a:prstGeom>
          <a:ln w="38100" cap="sq">
            <a:solidFill>
              <a:schemeClr val="tx1"/>
            </a:solidFill>
            <a:bevel/>
            <a:headEnd type="oval"/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Arc 14"/>
          <p:cNvSpPr/>
          <p:nvPr/>
        </p:nvSpPr>
        <p:spPr>
          <a:xfrm>
            <a:off x="495300" y="2758427"/>
            <a:ext cx="3258322" cy="3204223"/>
          </a:xfrm>
          <a:prstGeom prst="arc">
            <a:avLst>
              <a:gd name="adj1" fmla="val 20710260"/>
              <a:gd name="adj2" fmla="val 3771784"/>
            </a:avLst>
          </a:prstGeom>
          <a:ln w="38100" cap="sq">
            <a:solidFill>
              <a:schemeClr val="tx1"/>
            </a:solidFill>
            <a:bevel/>
            <a:headEnd type="oval"/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74649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763147" y="261771"/>
            <a:ext cx="486787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X2 Total Topological Support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42875" y="6020930"/>
            <a:ext cx="25314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phaResults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(File 3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8978611" y="6020930"/>
            <a:ext cx="30315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phaResultsARC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(File 4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51082357"/>
              </p:ext>
            </p:extLst>
          </p:nvPr>
        </p:nvGraphicFramePr>
        <p:xfrm>
          <a:off x="5962650" y="723436"/>
          <a:ext cx="6126480" cy="53035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66299319"/>
              </p:ext>
            </p:extLst>
          </p:nvPr>
        </p:nvGraphicFramePr>
        <p:xfrm>
          <a:off x="142875" y="2710802"/>
          <a:ext cx="4005072" cy="33101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10849413" y="1277480"/>
            <a:ext cx="7425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4/84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3719414" y="3529012"/>
            <a:ext cx="5084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</a:t>
            </a:r>
            <a:r>
              <a:rPr lang="en-US" dirty="0" smtClean="0"/>
              <a:t>/6</a:t>
            </a:r>
            <a:endParaRPr lang="en-US" dirty="0"/>
          </a:p>
        </p:txBody>
      </p:sp>
      <p:sp>
        <p:nvSpPr>
          <p:cNvPr id="14" name="Arc 13"/>
          <p:cNvSpPr/>
          <p:nvPr/>
        </p:nvSpPr>
        <p:spPr>
          <a:xfrm>
            <a:off x="6376023" y="942975"/>
            <a:ext cx="5263527" cy="5133975"/>
          </a:xfrm>
          <a:prstGeom prst="arc">
            <a:avLst>
              <a:gd name="adj1" fmla="val 16505514"/>
              <a:gd name="adj2" fmla="val 1553030"/>
            </a:avLst>
          </a:prstGeom>
          <a:ln w="38100" cap="sq">
            <a:solidFill>
              <a:schemeClr val="tx1"/>
            </a:solidFill>
            <a:bevel/>
            <a:headEnd type="oval"/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Arc 14"/>
          <p:cNvSpPr/>
          <p:nvPr/>
        </p:nvSpPr>
        <p:spPr>
          <a:xfrm>
            <a:off x="466725" y="2767952"/>
            <a:ext cx="3258322" cy="3204223"/>
          </a:xfrm>
          <a:prstGeom prst="arc">
            <a:avLst>
              <a:gd name="adj1" fmla="val 19010139"/>
              <a:gd name="adj2" fmla="val 21591392"/>
            </a:avLst>
          </a:prstGeom>
          <a:ln w="38100" cap="sq">
            <a:solidFill>
              <a:schemeClr val="tx1"/>
            </a:solidFill>
            <a:bevel/>
            <a:headEnd type="oval"/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61802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763147" y="261771"/>
            <a:ext cx="486787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X3 Total Topological Support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42875" y="6020930"/>
            <a:ext cx="25314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phaResults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(File 3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8978611" y="6020930"/>
            <a:ext cx="30315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phaResultsARC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(File 4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52565907"/>
              </p:ext>
            </p:extLst>
          </p:nvPr>
        </p:nvGraphicFramePr>
        <p:xfrm>
          <a:off x="142875" y="2710802"/>
          <a:ext cx="4005072" cy="33101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41947001"/>
              </p:ext>
            </p:extLst>
          </p:nvPr>
        </p:nvGraphicFramePr>
        <p:xfrm>
          <a:off x="5883730" y="720423"/>
          <a:ext cx="6126480" cy="53035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3" name="TextBox 12"/>
          <p:cNvSpPr txBox="1"/>
          <p:nvPr/>
        </p:nvSpPr>
        <p:spPr>
          <a:xfrm>
            <a:off x="10806364" y="867905"/>
            <a:ext cx="7425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5/83</a:t>
            </a:r>
            <a:endParaRPr 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3829049" y="3630155"/>
            <a:ext cx="5084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</a:t>
            </a:r>
            <a:r>
              <a:rPr lang="en-US" dirty="0" smtClean="0"/>
              <a:t>/5</a:t>
            </a:r>
            <a:endParaRPr lang="en-US" dirty="0"/>
          </a:p>
        </p:txBody>
      </p:sp>
      <p:sp>
        <p:nvSpPr>
          <p:cNvPr id="15" name="Arc 14"/>
          <p:cNvSpPr/>
          <p:nvPr/>
        </p:nvSpPr>
        <p:spPr>
          <a:xfrm>
            <a:off x="6483872" y="790574"/>
            <a:ext cx="5346178" cy="5334001"/>
          </a:xfrm>
          <a:prstGeom prst="arc">
            <a:avLst>
              <a:gd name="adj1" fmla="val 16522970"/>
              <a:gd name="adj2" fmla="val 1622735"/>
            </a:avLst>
          </a:prstGeom>
          <a:ln w="38100" cap="sq">
            <a:solidFill>
              <a:schemeClr val="tx1"/>
            </a:solidFill>
            <a:bevel/>
            <a:headEnd type="oval"/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Arc 15"/>
          <p:cNvSpPr/>
          <p:nvPr/>
        </p:nvSpPr>
        <p:spPr>
          <a:xfrm>
            <a:off x="428624" y="2767952"/>
            <a:ext cx="3400425" cy="3204223"/>
          </a:xfrm>
          <a:prstGeom prst="arc">
            <a:avLst>
              <a:gd name="adj1" fmla="val 19385927"/>
              <a:gd name="adj2" fmla="val 658952"/>
            </a:avLst>
          </a:prstGeom>
          <a:ln w="38100" cap="sq">
            <a:solidFill>
              <a:schemeClr val="tx1"/>
            </a:solidFill>
            <a:bevel/>
            <a:headEnd type="oval"/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2388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763147" y="261771"/>
            <a:ext cx="486787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YTB Total Topological Support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42875" y="6020930"/>
            <a:ext cx="25314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phaResults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(File 3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8978611" y="6020930"/>
            <a:ext cx="30315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phaResultsARC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(File 4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84878400"/>
              </p:ext>
            </p:extLst>
          </p:nvPr>
        </p:nvGraphicFramePr>
        <p:xfrm>
          <a:off x="5883730" y="720423"/>
          <a:ext cx="6126480" cy="53035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25286094"/>
              </p:ext>
            </p:extLst>
          </p:nvPr>
        </p:nvGraphicFramePr>
        <p:xfrm>
          <a:off x="142875" y="2710802"/>
          <a:ext cx="4005072" cy="33101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10630339" y="801230"/>
            <a:ext cx="7425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3/76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3922584" y="4087355"/>
            <a:ext cx="5084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/5</a:t>
            </a:r>
            <a:endParaRPr lang="en-US" dirty="0"/>
          </a:p>
        </p:txBody>
      </p:sp>
      <p:sp>
        <p:nvSpPr>
          <p:cNvPr id="14" name="Arc 13"/>
          <p:cNvSpPr/>
          <p:nvPr/>
        </p:nvSpPr>
        <p:spPr>
          <a:xfrm>
            <a:off x="6312421" y="739473"/>
            <a:ext cx="5327129" cy="5300507"/>
          </a:xfrm>
          <a:prstGeom prst="arc">
            <a:avLst>
              <a:gd name="adj1" fmla="val 16597164"/>
              <a:gd name="adj2" fmla="val 3853147"/>
            </a:avLst>
          </a:prstGeom>
          <a:ln w="38100" cap="sq">
            <a:solidFill>
              <a:schemeClr val="tx1"/>
            </a:solidFill>
            <a:bevel/>
            <a:headEnd type="oval"/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Arc 14"/>
          <p:cNvSpPr/>
          <p:nvPr/>
        </p:nvSpPr>
        <p:spPr>
          <a:xfrm>
            <a:off x="476249" y="2767952"/>
            <a:ext cx="3362325" cy="3204223"/>
          </a:xfrm>
          <a:prstGeom prst="arc">
            <a:avLst>
              <a:gd name="adj1" fmla="val 19737518"/>
              <a:gd name="adj2" fmla="val 1630299"/>
            </a:avLst>
          </a:prstGeom>
          <a:ln w="38100" cap="sq">
            <a:solidFill>
              <a:schemeClr val="tx1"/>
            </a:solidFill>
            <a:bevel/>
            <a:headEnd type="oval"/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45577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763147" y="261771"/>
            <a:ext cx="46466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D1 Total Topological Support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42875" y="6020930"/>
            <a:ext cx="25314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phaResults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(File 3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8978611" y="6020930"/>
            <a:ext cx="30315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phaResultsARC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(File 4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59323823"/>
              </p:ext>
            </p:extLst>
          </p:nvPr>
        </p:nvGraphicFramePr>
        <p:xfrm>
          <a:off x="142875" y="2710802"/>
          <a:ext cx="4005072" cy="33101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93305175"/>
              </p:ext>
            </p:extLst>
          </p:nvPr>
        </p:nvGraphicFramePr>
        <p:xfrm>
          <a:off x="5883730" y="720423"/>
          <a:ext cx="6126480" cy="53035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10739689" y="720423"/>
            <a:ext cx="7425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3/72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3753622" y="4223497"/>
            <a:ext cx="5084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</a:t>
            </a:r>
            <a:r>
              <a:rPr lang="en-US" dirty="0" smtClean="0"/>
              <a:t>/5</a:t>
            </a:r>
            <a:endParaRPr lang="en-US" dirty="0"/>
          </a:p>
        </p:txBody>
      </p:sp>
      <p:sp>
        <p:nvSpPr>
          <p:cNvPr id="14" name="Arc 13"/>
          <p:cNvSpPr/>
          <p:nvPr/>
        </p:nvSpPr>
        <p:spPr>
          <a:xfrm>
            <a:off x="6245745" y="710898"/>
            <a:ext cx="5450955" cy="5394627"/>
          </a:xfrm>
          <a:prstGeom prst="arc">
            <a:avLst>
              <a:gd name="adj1" fmla="val 16646379"/>
              <a:gd name="adj2" fmla="val 4402633"/>
            </a:avLst>
          </a:prstGeom>
          <a:ln w="38100" cap="sq">
            <a:solidFill>
              <a:schemeClr val="tx1"/>
            </a:solidFill>
            <a:bevel/>
            <a:headEnd type="oval"/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Arc 14"/>
          <p:cNvSpPr/>
          <p:nvPr/>
        </p:nvSpPr>
        <p:spPr>
          <a:xfrm>
            <a:off x="495300" y="2806052"/>
            <a:ext cx="3258322" cy="3204223"/>
          </a:xfrm>
          <a:prstGeom prst="arc">
            <a:avLst>
              <a:gd name="adj1" fmla="val 19757187"/>
              <a:gd name="adj2" fmla="val 1728174"/>
            </a:avLst>
          </a:prstGeom>
          <a:ln w="38100" cap="sq">
            <a:solidFill>
              <a:schemeClr val="tx1"/>
            </a:solidFill>
            <a:bevel/>
            <a:headEnd type="oval"/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58107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763147" y="261771"/>
            <a:ext cx="46466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D2 Total Topological Support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42875" y="6020930"/>
            <a:ext cx="25314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phaResults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(File 3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8978611" y="6020930"/>
            <a:ext cx="30315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phaResultsARC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(File 4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44187861"/>
              </p:ext>
            </p:extLst>
          </p:nvPr>
        </p:nvGraphicFramePr>
        <p:xfrm>
          <a:off x="5883730" y="717410"/>
          <a:ext cx="6126480" cy="53035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9719588"/>
              </p:ext>
            </p:extLst>
          </p:nvPr>
        </p:nvGraphicFramePr>
        <p:xfrm>
          <a:off x="142875" y="2710802"/>
          <a:ext cx="4005072" cy="33101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10786127" y="944105"/>
            <a:ext cx="6254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2/53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3316553" y="5363705"/>
            <a:ext cx="5084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</a:t>
            </a:r>
            <a:r>
              <a:rPr lang="en-US" dirty="0" smtClean="0"/>
              <a:t>/5</a:t>
            </a:r>
            <a:endParaRPr lang="en-US" dirty="0"/>
          </a:p>
        </p:txBody>
      </p:sp>
      <p:sp>
        <p:nvSpPr>
          <p:cNvPr id="14" name="Arc 13"/>
          <p:cNvSpPr/>
          <p:nvPr/>
        </p:nvSpPr>
        <p:spPr>
          <a:xfrm>
            <a:off x="6160021" y="717410"/>
            <a:ext cx="5527154" cy="5303520"/>
          </a:xfrm>
          <a:prstGeom prst="arc">
            <a:avLst>
              <a:gd name="adj1" fmla="val 17351129"/>
              <a:gd name="adj2" fmla="val 19928727"/>
            </a:avLst>
          </a:prstGeom>
          <a:ln w="38100" cap="sq">
            <a:solidFill>
              <a:schemeClr val="tx1"/>
            </a:solidFill>
            <a:bevel/>
            <a:headEnd type="oval"/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Arc 14"/>
          <p:cNvSpPr/>
          <p:nvPr/>
        </p:nvSpPr>
        <p:spPr>
          <a:xfrm>
            <a:off x="476250" y="2767952"/>
            <a:ext cx="3258322" cy="3204223"/>
          </a:xfrm>
          <a:prstGeom prst="arc">
            <a:avLst>
              <a:gd name="adj1" fmla="val 21552969"/>
              <a:gd name="adj2" fmla="val 5080984"/>
            </a:avLst>
          </a:prstGeom>
          <a:ln w="38100" cap="sq">
            <a:solidFill>
              <a:schemeClr val="tx1"/>
            </a:solidFill>
            <a:bevel/>
            <a:headEnd type="oval"/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23653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763147" y="261771"/>
            <a:ext cx="46466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D3 Total Topological Support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42875" y="6020930"/>
            <a:ext cx="25314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phaResults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(File 3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8978611" y="6020930"/>
            <a:ext cx="30315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phaResultsARC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(File 4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99376107"/>
              </p:ext>
            </p:extLst>
          </p:nvPr>
        </p:nvGraphicFramePr>
        <p:xfrm>
          <a:off x="142875" y="2710802"/>
          <a:ext cx="4005072" cy="33101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35196885"/>
              </p:ext>
            </p:extLst>
          </p:nvPr>
        </p:nvGraphicFramePr>
        <p:xfrm>
          <a:off x="5883730" y="720423"/>
          <a:ext cx="6126480" cy="53035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10181664" y="532744"/>
            <a:ext cx="6254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  <a:r>
              <a:rPr lang="en-US" dirty="0" smtClean="0"/>
              <a:t>/62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3909026" y="4365866"/>
            <a:ext cx="5084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</a:t>
            </a:r>
            <a:r>
              <a:rPr lang="en-US" dirty="0" smtClean="0"/>
              <a:t>/5</a:t>
            </a:r>
            <a:endParaRPr lang="en-US" dirty="0"/>
          </a:p>
        </p:txBody>
      </p:sp>
      <p:sp>
        <p:nvSpPr>
          <p:cNvPr id="14" name="Arc 13"/>
          <p:cNvSpPr/>
          <p:nvPr/>
        </p:nvSpPr>
        <p:spPr>
          <a:xfrm>
            <a:off x="6226696" y="720423"/>
            <a:ext cx="5441429" cy="5300507"/>
          </a:xfrm>
          <a:prstGeom prst="arc">
            <a:avLst>
              <a:gd name="adj1" fmla="val 16646379"/>
              <a:gd name="adj2" fmla="val 19085312"/>
            </a:avLst>
          </a:prstGeom>
          <a:ln w="38100" cap="sq">
            <a:solidFill>
              <a:schemeClr val="tx1"/>
            </a:solidFill>
            <a:bevel/>
            <a:headEnd type="oval"/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Arc 14"/>
          <p:cNvSpPr/>
          <p:nvPr/>
        </p:nvSpPr>
        <p:spPr>
          <a:xfrm>
            <a:off x="561975" y="2767952"/>
            <a:ext cx="3258322" cy="3252978"/>
          </a:xfrm>
          <a:prstGeom prst="arc">
            <a:avLst>
              <a:gd name="adj1" fmla="val 20030823"/>
              <a:gd name="adj2" fmla="val 2485038"/>
            </a:avLst>
          </a:prstGeom>
          <a:ln w="38100" cap="sq">
            <a:solidFill>
              <a:schemeClr val="tx1"/>
            </a:solidFill>
            <a:bevel/>
            <a:headEnd type="oval"/>
            <a:tail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86967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0</TotalTime>
  <Words>214</Words>
  <Application>Microsoft Office PowerPoint</Application>
  <PresentationFormat>Widescreen</PresentationFormat>
  <Paragraphs>67</Paragraphs>
  <Slides>1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dade do Port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P</dc:creator>
  <cp:lastModifiedBy>UP</cp:lastModifiedBy>
  <cp:revision>23</cp:revision>
  <dcterms:created xsi:type="dcterms:W3CDTF">2019-06-18T18:14:59Z</dcterms:created>
  <dcterms:modified xsi:type="dcterms:W3CDTF">2019-06-18T20:45:29Z</dcterms:modified>
</cp:coreProperties>
</file>